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1224" y="7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36A5B6-8878-4A71-B108-355BF3253F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69A40FD7-40A3-4A4F-BD6B-426FF38FBC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F1488AF-80D4-4692-97DB-1A213C917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4268E9E-61B2-42B8-BD66-4E9EC0C75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E5E2B56-2340-4110-8677-405DFAB0A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951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56E9B61-161A-426E-B9BB-D0629BCA49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488BC9B-CEB2-46CD-9F88-B1867EC308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F3F5FCD-48E1-42D0-84E9-4C7AA6F54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AC9FBAF-9168-4DA2-9F3A-22B157E47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893323-50F2-4F5E-99B2-95D17C6CC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66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56AA4CF-FAC7-4437-9ECD-10CA39EB90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8D7B83E-ABAC-428D-B164-40EEE343AE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DDC85A-530E-4174-96E3-06E9E73D4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F0A18B2-C999-4B18-B812-58D1FDBFE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0A88BDB-DF80-44FB-BE82-03697D596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681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65403F-321C-4662-8D43-75F970EC0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3F21FD2-3EC1-4F06-9C64-8B56BBA0EA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3D3D689-0C8D-408E-9A5F-FB6EAA66C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1E60C5B-A6D3-401C-BB63-8F21EE923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6EA12A1-D4EA-4BCF-8910-65FF994B1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68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F296A7-49D5-42E1-ADF1-39F50AD87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B4A7589-DBD1-414F-92AB-573121D03A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8B2E2D6-50D5-48D8-9D80-10941F9D8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8A231EE-DA4A-459A-A0B7-31AA78D7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A61B1D-6203-4369-8C84-447993493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58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255C8F-5C30-4355-9102-8909005A52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0E8F41D-2077-47B2-9B60-EFB95B96E8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943070C-84D3-47D3-B969-49D8BD09C2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7709057-A18F-441E-B6E4-BFF9F85DC2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B5CFEA4-F927-464C-9075-FAF2FBA89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8C7F3D1-2A46-4775-93F4-CF694E819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97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E4E18F-D55F-46FB-99EE-DD3225062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E7AC9F3-C1BF-46FA-B6A5-D567B75930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3510365-93D3-4AD9-88A7-3A109AE52E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8EA7854-7A7B-4EFA-8E8B-CFC0B21C42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107A9F6-163A-4323-99B4-1A96D13F5C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494632E-FB8E-498B-9A01-2F6B1F1D1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77013E3-02EC-4137-B367-FA2CD69C3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A920C32-2B12-4F36-BF66-470A9BA4A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22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B69866-571E-4CD1-AEB3-7336BED570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A1574BA-0B98-4461-8FFB-E194FBDD4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C54160B-4074-4924-AAE3-F9C322887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13AB193-6C6D-4C8E-99D6-6F07D0ADD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249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3D14CDCB-FCFD-4A81-9647-BC645301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C5869F9-4A06-4A38-8F40-03DF11EC1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7855DA2-6C9B-4EEA-9413-C32C12223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9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4EAD25-741D-422E-9FEF-DC10CCBAD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377D144-CAAD-44F7-A7F6-76E00EB882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56E78FD-406D-4C74-B37E-6D4F0EB278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9222253-9146-4562-8800-171EBDE46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46D9D77-744B-4D40-8D01-CD26C0B1A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465ACE0-FCF5-4D64-BD04-FB36C9BF9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97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BA466F-E10F-435F-90BB-DE6DBBE5D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22FB51A-43E2-43CE-84D0-13865DAFCF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0C4DDF3-A063-4872-9762-DC98DB5BE5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A1E36B9-EB31-4608-AB09-008AF580A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E9A8883-CBAF-4348-A55E-D93866407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60C9D99-1959-4B5C-85D5-359AEB523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177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AD94524-8AC3-4A6C-8E7E-F64A4C7C5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3287015-3633-456C-A198-B300AE2AA9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3D7673D-31FD-4822-8775-2E4A40EDB6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37999-96FD-4CB1-B0A2-B5A92935E967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86D2390-DC34-45C2-A126-624B50E89E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609B900-BE89-4E0A-B572-8968892B44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136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AB782A6B-F1BE-4E23-B947-B13C2AD2E26D}"/>
              </a:ext>
            </a:extLst>
          </p:cNvPr>
          <p:cNvSpPr/>
          <p:nvPr/>
        </p:nvSpPr>
        <p:spPr>
          <a:xfrm>
            <a:off x="-209798" y="434108"/>
            <a:ext cx="14243297" cy="71245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2" name="Gruppieren 271">
            <a:extLst>
              <a:ext uri="{FF2B5EF4-FFF2-40B4-BE49-F238E27FC236}">
                <a16:creationId xmlns:a16="http://schemas.microsoft.com/office/drawing/2014/main" id="{5240D099-5F0E-4F0F-9C37-CC085114A541}"/>
              </a:ext>
            </a:extLst>
          </p:cNvPr>
          <p:cNvGrpSpPr/>
          <p:nvPr/>
        </p:nvGrpSpPr>
        <p:grpSpPr>
          <a:xfrm>
            <a:off x="-140390" y="543960"/>
            <a:ext cx="14008790" cy="5494400"/>
            <a:chOff x="-140390" y="543960"/>
            <a:chExt cx="14008790" cy="5494400"/>
          </a:xfrm>
        </p:grpSpPr>
        <p:sp>
          <p:nvSpPr>
            <p:cNvPr id="189" name="Rechteck 188">
              <a:extLst>
                <a:ext uri="{FF2B5EF4-FFF2-40B4-BE49-F238E27FC236}">
                  <a16:creationId xmlns:a16="http://schemas.microsoft.com/office/drawing/2014/main" id="{0B20FF93-BD89-4F91-A54F-0BF04F45A07D}"/>
                </a:ext>
              </a:extLst>
            </p:cNvPr>
            <p:cNvSpPr/>
            <p:nvPr/>
          </p:nvSpPr>
          <p:spPr>
            <a:xfrm>
              <a:off x="-140390" y="543960"/>
              <a:ext cx="14008790" cy="5494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269" name="Grafik 268">
              <a:extLst>
                <a:ext uri="{FF2B5EF4-FFF2-40B4-BE49-F238E27FC236}">
                  <a16:creationId xmlns:a16="http://schemas.microsoft.com/office/drawing/2014/main" id="{882F9F4A-641E-4CCD-B500-9EC2E8CE22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r="7631" b="3954"/>
            <a:stretch/>
          </p:blipFill>
          <p:spPr>
            <a:xfrm>
              <a:off x="6957299" y="952540"/>
              <a:ext cx="6810875" cy="5058620"/>
            </a:xfrm>
            <a:prstGeom prst="rect">
              <a:avLst/>
            </a:prstGeom>
          </p:spPr>
        </p:pic>
        <p:sp>
          <p:nvSpPr>
            <p:cNvPr id="190" name="Textfeld 189">
              <a:extLst>
                <a:ext uri="{FF2B5EF4-FFF2-40B4-BE49-F238E27FC236}">
                  <a16:creationId xmlns:a16="http://schemas.microsoft.com/office/drawing/2014/main" id="{AF2CB657-471F-479C-9078-2B83EDD6FF3F}"/>
                </a:ext>
              </a:extLst>
            </p:cNvPr>
            <p:cNvSpPr txBox="1"/>
            <p:nvPr/>
          </p:nvSpPr>
          <p:spPr>
            <a:xfrm>
              <a:off x="-114990" y="583860"/>
              <a:ext cx="326392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200" dirty="0"/>
                <a:t>A</a:t>
              </a:r>
            </a:p>
          </p:txBody>
        </p:sp>
        <p:grpSp>
          <p:nvGrpSpPr>
            <p:cNvPr id="267" name="Gruppieren 266">
              <a:extLst>
                <a:ext uri="{FF2B5EF4-FFF2-40B4-BE49-F238E27FC236}">
                  <a16:creationId xmlns:a16="http://schemas.microsoft.com/office/drawing/2014/main" id="{6BC235DD-E7FB-4EE6-B04B-D309F7EF4818}"/>
                </a:ext>
              </a:extLst>
            </p:cNvPr>
            <p:cNvGrpSpPr/>
            <p:nvPr/>
          </p:nvGrpSpPr>
          <p:grpSpPr>
            <a:xfrm>
              <a:off x="-26871" y="1098916"/>
              <a:ext cx="5734691" cy="4765869"/>
              <a:chOff x="-30410" y="1100933"/>
              <a:chExt cx="6699165" cy="5303471"/>
            </a:xfrm>
          </p:grpSpPr>
          <p:grpSp>
            <p:nvGrpSpPr>
              <p:cNvPr id="192" name="Grafik 3">
                <a:extLst>
                  <a:ext uri="{FF2B5EF4-FFF2-40B4-BE49-F238E27FC236}">
                    <a16:creationId xmlns:a16="http://schemas.microsoft.com/office/drawing/2014/main" id="{1B7F4E76-2AEC-47F9-AF46-F3B081837B8A}"/>
                  </a:ext>
                </a:extLst>
              </p:cNvPr>
              <p:cNvGrpSpPr/>
              <p:nvPr/>
            </p:nvGrpSpPr>
            <p:grpSpPr>
              <a:xfrm>
                <a:off x="2561566" y="6208749"/>
                <a:ext cx="1793940" cy="195655"/>
                <a:chOff x="5207721" y="6658311"/>
                <a:chExt cx="1335246" cy="145628"/>
              </a:xfrm>
              <a:solidFill>
                <a:srgbClr val="000000"/>
              </a:solidFill>
            </p:grpSpPr>
            <p:sp>
              <p:nvSpPr>
                <p:cNvPr id="193" name="Freihandform: Form 192">
                  <a:extLst>
                    <a:ext uri="{FF2B5EF4-FFF2-40B4-BE49-F238E27FC236}">
                      <a16:creationId xmlns:a16="http://schemas.microsoft.com/office/drawing/2014/main" id="{6FD53FEB-9EEA-42D3-9C45-4121C9465FE8}"/>
                    </a:ext>
                  </a:extLst>
                </p:cNvPr>
                <p:cNvSpPr/>
                <p:nvPr/>
              </p:nvSpPr>
              <p:spPr>
                <a:xfrm>
                  <a:off x="5207721" y="6660208"/>
                  <a:ext cx="85874" cy="112514"/>
                </a:xfrm>
                <a:custGeom>
                  <a:avLst/>
                  <a:gdLst>
                    <a:gd name="connsiteX0" fmla="*/ 409 w 85874"/>
                    <a:gd name="connsiteY0" fmla="*/ 113225 h 112514"/>
                    <a:gd name="connsiteX1" fmla="*/ 409 w 85874"/>
                    <a:gd name="connsiteY1" fmla="*/ 711 h 112514"/>
                    <a:gd name="connsiteX2" fmla="*/ 42825 w 85874"/>
                    <a:gd name="connsiteY2" fmla="*/ 711 h 112514"/>
                    <a:gd name="connsiteX3" fmla="*/ 59941 w 85874"/>
                    <a:gd name="connsiteY3" fmla="*/ 1790 h 112514"/>
                    <a:gd name="connsiteX4" fmla="*/ 73819 w 85874"/>
                    <a:gd name="connsiteY4" fmla="*/ 7074 h 112514"/>
                    <a:gd name="connsiteX5" fmla="*/ 82860 w 85874"/>
                    <a:gd name="connsiteY5" fmla="*/ 17938 h 112514"/>
                    <a:gd name="connsiteX6" fmla="*/ 86284 w 85874"/>
                    <a:gd name="connsiteY6" fmla="*/ 33267 h 112514"/>
                    <a:gd name="connsiteX7" fmla="*/ 77130 w 85874"/>
                    <a:gd name="connsiteY7" fmla="*/ 57563 h 112514"/>
                    <a:gd name="connsiteX8" fmla="*/ 44165 w 85874"/>
                    <a:gd name="connsiteY8" fmla="*/ 67498 h 112514"/>
                    <a:gd name="connsiteX9" fmla="*/ 15292 w 85874"/>
                    <a:gd name="connsiteY9" fmla="*/ 67498 h 112514"/>
                    <a:gd name="connsiteX10" fmla="*/ 15292 w 85874"/>
                    <a:gd name="connsiteY10" fmla="*/ 113225 h 112514"/>
                    <a:gd name="connsiteX11" fmla="*/ 15292 w 85874"/>
                    <a:gd name="connsiteY11" fmla="*/ 54215 h 112514"/>
                    <a:gd name="connsiteX12" fmla="*/ 44388 w 85874"/>
                    <a:gd name="connsiteY12" fmla="*/ 54215 h 112514"/>
                    <a:gd name="connsiteX13" fmla="*/ 64852 w 85874"/>
                    <a:gd name="connsiteY13" fmla="*/ 48857 h 112514"/>
                    <a:gd name="connsiteX14" fmla="*/ 70917 w 85874"/>
                    <a:gd name="connsiteY14" fmla="*/ 33714 h 112514"/>
                    <a:gd name="connsiteX15" fmla="*/ 67345 w 85874"/>
                    <a:gd name="connsiteY15" fmla="*/ 21659 h 112514"/>
                    <a:gd name="connsiteX16" fmla="*/ 57969 w 85874"/>
                    <a:gd name="connsiteY16" fmla="*/ 14999 h 112514"/>
                    <a:gd name="connsiteX17" fmla="*/ 44053 w 85874"/>
                    <a:gd name="connsiteY17" fmla="*/ 13994 h 112514"/>
                    <a:gd name="connsiteX18" fmla="*/ 15292 w 85874"/>
                    <a:gd name="connsiteY18" fmla="*/ 13994 h 11251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85874" h="112514">
                      <a:moveTo>
                        <a:pt x="409" y="113225"/>
                      </a:moveTo>
                      <a:lnTo>
                        <a:pt x="409" y="711"/>
                      </a:lnTo>
                      <a:lnTo>
                        <a:pt x="42825" y="711"/>
                      </a:lnTo>
                      <a:cubicBezTo>
                        <a:pt x="50267" y="711"/>
                        <a:pt x="55997" y="1083"/>
                        <a:pt x="59941" y="1790"/>
                      </a:cubicBezTo>
                      <a:cubicBezTo>
                        <a:pt x="65447" y="2720"/>
                        <a:pt x="70061" y="4469"/>
                        <a:pt x="73819" y="7074"/>
                      </a:cubicBezTo>
                      <a:cubicBezTo>
                        <a:pt x="77540" y="9678"/>
                        <a:pt x="80553" y="13324"/>
                        <a:pt x="82860" y="17938"/>
                      </a:cubicBezTo>
                      <a:cubicBezTo>
                        <a:pt x="85130" y="22626"/>
                        <a:pt x="86284" y="27723"/>
                        <a:pt x="86284" y="33267"/>
                      </a:cubicBezTo>
                      <a:cubicBezTo>
                        <a:pt x="86284" y="42867"/>
                        <a:pt x="83232" y="50978"/>
                        <a:pt x="77130" y="57563"/>
                      </a:cubicBezTo>
                      <a:cubicBezTo>
                        <a:pt x="71028" y="64223"/>
                        <a:pt x="60015" y="67535"/>
                        <a:pt x="44165" y="67498"/>
                      </a:cubicBezTo>
                      <a:lnTo>
                        <a:pt x="15292" y="67498"/>
                      </a:lnTo>
                      <a:lnTo>
                        <a:pt x="15292" y="113225"/>
                      </a:lnTo>
                      <a:close/>
                      <a:moveTo>
                        <a:pt x="15292" y="54215"/>
                      </a:moveTo>
                      <a:lnTo>
                        <a:pt x="44388" y="54215"/>
                      </a:lnTo>
                      <a:cubicBezTo>
                        <a:pt x="53950" y="54252"/>
                        <a:pt x="60796" y="52466"/>
                        <a:pt x="64852" y="48857"/>
                      </a:cubicBezTo>
                      <a:cubicBezTo>
                        <a:pt x="68870" y="45285"/>
                        <a:pt x="70880" y="40225"/>
                        <a:pt x="70917" y="33714"/>
                      </a:cubicBezTo>
                      <a:cubicBezTo>
                        <a:pt x="70880" y="29063"/>
                        <a:pt x="69689" y="25044"/>
                        <a:pt x="67345" y="21659"/>
                      </a:cubicBezTo>
                      <a:cubicBezTo>
                        <a:pt x="64964" y="18310"/>
                        <a:pt x="61838" y="16078"/>
                        <a:pt x="57969" y="14999"/>
                      </a:cubicBezTo>
                      <a:cubicBezTo>
                        <a:pt x="55439" y="14329"/>
                        <a:pt x="50788" y="13994"/>
                        <a:pt x="44053" y="13994"/>
                      </a:cubicBezTo>
                      <a:lnTo>
                        <a:pt x="15292" y="1399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4" name="Freihandform: Form 193">
                  <a:extLst>
                    <a:ext uri="{FF2B5EF4-FFF2-40B4-BE49-F238E27FC236}">
                      <a16:creationId xmlns:a16="http://schemas.microsoft.com/office/drawing/2014/main" id="{552A7EA4-B0A7-4684-B01C-6C91C3775A0A}"/>
                    </a:ext>
                  </a:extLst>
                </p:cNvPr>
                <p:cNvSpPr/>
                <p:nvPr/>
              </p:nvSpPr>
              <p:spPr>
                <a:xfrm>
                  <a:off x="5308228" y="6658311"/>
                  <a:ext cx="99454" cy="116346"/>
                </a:xfrm>
                <a:custGeom>
                  <a:avLst/>
                  <a:gdLst>
                    <a:gd name="connsiteX0" fmla="*/ 84992 w 99454"/>
                    <a:gd name="connsiteY0" fmla="*/ 75683 h 116346"/>
                    <a:gd name="connsiteX1" fmla="*/ 99875 w 99454"/>
                    <a:gd name="connsiteY1" fmla="*/ 79441 h 116346"/>
                    <a:gd name="connsiteX2" fmla="*/ 83057 w 99454"/>
                    <a:gd name="connsiteY2" fmla="*/ 107421 h 116346"/>
                    <a:gd name="connsiteX3" fmla="*/ 53292 w 99454"/>
                    <a:gd name="connsiteY3" fmla="*/ 117057 h 116346"/>
                    <a:gd name="connsiteX4" fmla="*/ 23712 w 99454"/>
                    <a:gd name="connsiteY4" fmla="*/ 109653 h 116346"/>
                    <a:gd name="connsiteX5" fmla="*/ 6374 w 99454"/>
                    <a:gd name="connsiteY5" fmla="*/ 88222 h 116346"/>
                    <a:gd name="connsiteX6" fmla="*/ 420 w 99454"/>
                    <a:gd name="connsiteY6" fmla="*/ 58047 h 116346"/>
                    <a:gd name="connsiteX7" fmla="*/ 7118 w 99454"/>
                    <a:gd name="connsiteY7" fmla="*/ 27388 h 116346"/>
                    <a:gd name="connsiteX8" fmla="*/ 26242 w 99454"/>
                    <a:gd name="connsiteY8" fmla="*/ 7520 h 116346"/>
                    <a:gd name="connsiteX9" fmla="*/ 53552 w 99454"/>
                    <a:gd name="connsiteY9" fmla="*/ 711 h 116346"/>
                    <a:gd name="connsiteX10" fmla="*/ 81904 w 99454"/>
                    <a:gd name="connsiteY10" fmla="*/ 9305 h 116346"/>
                    <a:gd name="connsiteX11" fmla="*/ 97977 w 99454"/>
                    <a:gd name="connsiteY11" fmla="*/ 33490 h 116346"/>
                    <a:gd name="connsiteX12" fmla="*/ 83318 w 99454"/>
                    <a:gd name="connsiteY12" fmla="*/ 36913 h 116346"/>
                    <a:gd name="connsiteX13" fmla="*/ 71970 w 99454"/>
                    <a:gd name="connsiteY13" fmla="*/ 19054 h 116346"/>
                    <a:gd name="connsiteX14" fmla="*/ 53217 w 99454"/>
                    <a:gd name="connsiteY14" fmla="*/ 13435 h 116346"/>
                    <a:gd name="connsiteX15" fmla="*/ 31563 w 99454"/>
                    <a:gd name="connsiteY15" fmla="*/ 19650 h 116346"/>
                    <a:gd name="connsiteX16" fmla="*/ 19322 w 99454"/>
                    <a:gd name="connsiteY16" fmla="*/ 36355 h 116346"/>
                    <a:gd name="connsiteX17" fmla="*/ 15787 w 99454"/>
                    <a:gd name="connsiteY17" fmla="*/ 57935 h 116346"/>
                    <a:gd name="connsiteX18" fmla="*/ 19954 w 99454"/>
                    <a:gd name="connsiteY18" fmla="*/ 83013 h 116346"/>
                    <a:gd name="connsiteX19" fmla="*/ 32977 w 99454"/>
                    <a:gd name="connsiteY19" fmla="*/ 99012 h 116346"/>
                    <a:gd name="connsiteX20" fmla="*/ 52064 w 99454"/>
                    <a:gd name="connsiteY20" fmla="*/ 104295 h 116346"/>
                    <a:gd name="connsiteX21" fmla="*/ 73272 w 99454"/>
                    <a:gd name="connsiteY21" fmla="*/ 97077 h 116346"/>
                    <a:gd name="connsiteX22" fmla="*/ 84992 w 99454"/>
                    <a:gd name="connsiteY22" fmla="*/ 75683 h 11634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</a:cxnLst>
                  <a:rect l="l" t="t" r="r" b="b"/>
                  <a:pathLst>
                    <a:path w="99454" h="116346">
                      <a:moveTo>
                        <a:pt x="84992" y="75683"/>
                      </a:moveTo>
                      <a:lnTo>
                        <a:pt x="99875" y="79441"/>
                      </a:lnTo>
                      <a:cubicBezTo>
                        <a:pt x="96750" y="91719"/>
                        <a:pt x="91132" y="101021"/>
                        <a:pt x="83057" y="107421"/>
                      </a:cubicBezTo>
                      <a:cubicBezTo>
                        <a:pt x="74909" y="113820"/>
                        <a:pt x="64975" y="117020"/>
                        <a:pt x="53292" y="117057"/>
                      </a:cubicBezTo>
                      <a:cubicBezTo>
                        <a:pt x="41162" y="117020"/>
                        <a:pt x="31302" y="114564"/>
                        <a:pt x="23712" y="109653"/>
                      </a:cubicBezTo>
                      <a:cubicBezTo>
                        <a:pt x="16085" y="104742"/>
                        <a:pt x="10318" y="97598"/>
                        <a:pt x="6374" y="88222"/>
                      </a:cubicBezTo>
                      <a:cubicBezTo>
                        <a:pt x="2392" y="78846"/>
                        <a:pt x="420" y="68800"/>
                        <a:pt x="420" y="58047"/>
                      </a:cubicBezTo>
                      <a:cubicBezTo>
                        <a:pt x="420" y="46327"/>
                        <a:pt x="2653" y="36095"/>
                        <a:pt x="7118" y="27388"/>
                      </a:cubicBezTo>
                      <a:cubicBezTo>
                        <a:pt x="11583" y="18682"/>
                        <a:pt x="17945" y="12059"/>
                        <a:pt x="26242" y="7520"/>
                      </a:cubicBezTo>
                      <a:cubicBezTo>
                        <a:pt x="34502" y="2981"/>
                        <a:pt x="43618" y="711"/>
                        <a:pt x="53552" y="711"/>
                      </a:cubicBezTo>
                      <a:cubicBezTo>
                        <a:pt x="64789" y="711"/>
                        <a:pt x="74239" y="3576"/>
                        <a:pt x="81904" y="9305"/>
                      </a:cubicBezTo>
                      <a:cubicBezTo>
                        <a:pt x="89569" y="15036"/>
                        <a:pt x="94926" y="23109"/>
                        <a:pt x="97977" y="33490"/>
                      </a:cubicBezTo>
                      <a:lnTo>
                        <a:pt x="83318" y="36913"/>
                      </a:lnTo>
                      <a:cubicBezTo>
                        <a:pt x="80676" y="28765"/>
                        <a:pt x="76918" y="22812"/>
                        <a:pt x="71970" y="19054"/>
                      </a:cubicBezTo>
                      <a:cubicBezTo>
                        <a:pt x="66984" y="15333"/>
                        <a:pt x="60733" y="13435"/>
                        <a:pt x="53217" y="13435"/>
                      </a:cubicBezTo>
                      <a:cubicBezTo>
                        <a:pt x="44585" y="13435"/>
                        <a:pt x="37367" y="15520"/>
                        <a:pt x="31563" y="19650"/>
                      </a:cubicBezTo>
                      <a:cubicBezTo>
                        <a:pt x="25758" y="23816"/>
                        <a:pt x="21666" y="29397"/>
                        <a:pt x="19322" y="36355"/>
                      </a:cubicBezTo>
                      <a:cubicBezTo>
                        <a:pt x="16940" y="43350"/>
                        <a:pt x="15750" y="50531"/>
                        <a:pt x="15787" y="57935"/>
                      </a:cubicBezTo>
                      <a:cubicBezTo>
                        <a:pt x="15750" y="67535"/>
                        <a:pt x="17164" y="75906"/>
                        <a:pt x="19954" y="83013"/>
                      </a:cubicBezTo>
                      <a:cubicBezTo>
                        <a:pt x="22745" y="90194"/>
                        <a:pt x="27061" y="95514"/>
                        <a:pt x="32977" y="99012"/>
                      </a:cubicBezTo>
                      <a:cubicBezTo>
                        <a:pt x="38818" y="102547"/>
                        <a:pt x="45181" y="104295"/>
                        <a:pt x="52064" y="104295"/>
                      </a:cubicBezTo>
                      <a:cubicBezTo>
                        <a:pt x="60398" y="104295"/>
                        <a:pt x="67468" y="101914"/>
                        <a:pt x="73272" y="97077"/>
                      </a:cubicBezTo>
                      <a:cubicBezTo>
                        <a:pt x="79002" y="92315"/>
                        <a:pt x="82908" y="85171"/>
                        <a:pt x="84992" y="75683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5" name="Freihandform: Form 194">
                  <a:extLst>
                    <a:ext uri="{FF2B5EF4-FFF2-40B4-BE49-F238E27FC236}">
                      <a16:creationId xmlns:a16="http://schemas.microsoft.com/office/drawing/2014/main" id="{C192B52D-A8D5-4436-A273-DBABD534942E}"/>
                    </a:ext>
                  </a:extLst>
                </p:cNvPr>
                <p:cNvSpPr/>
                <p:nvPr/>
              </p:nvSpPr>
              <p:spPr>
                <a:xfrm>
                  <a:off x="5431030" y="6659761"/>
                  <a:ext cx="41448" cy="112960"/>
                </a:xfrm>
                <a:custGeom>
                  <a:avLst/>
                  <a:gdLst>
                    <a:gd name="connsiteX0" fmla="*/ 41881 w 41448"/>
                    <a:gd name="connsiteY0" fmla="*/ 113672 h 112960"/>
                    <a:gd name="connsiteX1" fmla="*/ 28040 w 41448"/>
                    <a:gd name="connsiteY1" fmla="*/ 113672 h 112960"/>
                    <a:gd name="connsiteX2" fmla="*/ 28040 w 41448"/>
                    <a:gd name="connsiteY2" fmla="*/ 25640 h 112960"/>
                    <a:gd name="connsiteX3" fmla="*/ 14943 w 41448"/>
                    <a:gd name="connsiteY3" fmla="*/ 35165 h 112960"/>
                    <a:gd name="connsiteX4" fmla="*/ 432 w 41448"/>
                    <a:gd name="connsiteY4" fmla="*/ 42309 h 112960"/>
                    <a:gd name="connsiteX5" fmla="*/ 432 w 41448"/>
                    <a:gd name="connsiteY5" fmla="*/ 28951 h 112960"/>
                    <a:gd name="connsiteX6" fmla="*/ 20673 w 41448"/>
                    <a:gd name="connsiteY6" fmla="*/ 15781 h 112960"/>
                    <a:gd name="connsiteX7" fmla="*/ 32951 w 41448"/>
                    <a:gd name="connsiteY7" fmla="*/ 711 h 112960"/>
                    <a:gd name="connsiteX8" fmla="*/ 41881 w 41448"/>
                    <a:gd name="connsiteY8" fmla="*/ 711 h 1129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41448" h="112960">
                      <a:moveTo>
                        <a:pt x="41881" y="113672"/>
                      </a:moveTo>
                      <a:lnTo>
                        <a:pt x="28040" y="113672"/>
                      </a:lnTo>
                      <a:lnTo>
                        <a:pt x="28040" y="25640"/>
                      </a:lnTo>
                      <a:cubicBezTo>
                        <a:pt x="24691" y="28840"/>
                        <a:pt x="20338" y="32002"/>
                        <a:pt x="14943" y="35165"/>
                      </a:cubicBezTo>
                      <a:cubicBezTo>
                        <a:pt x="9548" y="38365"/>
                        <a:pt x="4711" y="40746"/>
                        <a:pt x="432" y="42309"/>
                      </a:cubicBezTo>
                      <a:lnTo>
                        <a:pt x="432" y="28951"/>
                      </a:lnTo>
                      <a:cubicBezTo>
                        <a:pt x="8134" y="25342"/>
                        <a:pt x="14869" y="20952"/>
                        <a:pt x="20673" y="15781"/>
                      </a:cubicBezTo>
                      <a:cubicBezTo>
                        <a:pt x="26440" y="10608"/>
                        <a:pt x="30533" y="5585"/>
                        <a:pt x="32951" y="711"/>
                      </a:cubicBezTo>
                      <a:lnTo>
                        <a:pt x="41881" y="711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6" name="Freihandform: Form 195">
                  <a:extLst>
                    <a:ext uri="{FF2B5EF4-FFF2-40B4-BE49-F238E27FC236}">
                      <a16:creationId xmlns:a16="http://schemas.microsoft.com/office/drawing/2014/main" id="{4EAAA319-367A-4604-8A3E-71EEF941F91A}"/>
                    </a:ext>
                  </a:extLst>
                </p:cNvPr>
                <p:cNvSpPr/>
                <p:nvPr/>
              </p:nvSpPr>
              <p:spPr>
                <a:xfrm>
                  <a:off x="5515529" y="6691239"/>
                  <a:ext cx="15701" cy="81483"/>
                </a:xfrm>
                <a:custGeom>
                  <a:avLst/>
                  <a:gdLst>
                    <a:gd name="connsiteX0" fmla="*/ 442 w 15701"/>
                    <a:gd name="connsiteY0" fmla="*/ 16412 h 81483"/>
                    <a:gd name="connsiteX1" fmla="*/ 442 w 15701"/>
                    <a:gd name="connsiteY1" fmla="*/ 711 h 81483"/>
                    <a:gd name="connsiteX2" fmla="*/ 16143 w 15701"/>
                    <a:gd name="connsiteY2" fmla="*/ 711 h 81483"/>
                    <a:gd name="connsiteX3" fmla="*/ 16143 w 15701"/>
                    <a:gd name="connsiteY3" fmla="*/ 16412 h 81483"/>
                    <a:gd name="connsiteX4" fmla="*/ 442 w 15701"/>
                    <a:gd name="connsiteY4" fmla="*/ 82194 h 81483"/>
                    <a:gd name="connsiteX5" fmla="*/ 442 w 15701"/>
                    <a:gd name="connsiteY5" fmla="*/ 66456 h 81483"/>
                    <a:gd name="connsiteX6" fmla="*/ 16143 w 15701"/>
                    <a:gd name="connsiteY6" fmla="*/ 66456 h 81483"/>
                    <a:gd name="connsiteX7" fmla="*/ 16143 w 15701"/>
                    <a:gd name="connsiteY7" fmla="*/ 82194 h 814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15701" h="81483">
                      <a:moveTo>
                        <a:pt x="442" y="16412"/>
                      </a:moveTo>
                      <a:lnTo>
                        <a:pt x="442" y="711"/>
                      </a:lnTo>
                      <a:lnTo>
                        <a:pt x="16143" y="711"/>
                      </a:lnTo>
                      <a:lnTo>
                        <a:pt x="16143" y="16412"/>
                      </a:lnTo>
                      <a:close/>
                      <a:moveTo>
                        <a:pt x="442" y="82194"/>
                      </a:moveTo>
                      <a:lnTo>
                        <a:pt x="442" y="66456"/>
                      </a:lnTo>
                      <a:lnTo>
                        <a:pt x="16143" y="66456"/>
                      </a:lnTo>
                      <a:lnTo>
                        <a:pt x="16143" y="8219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7" name="Freihandform: Form 196">
                  <a:extLst>
                    <a:ext uri="{FF2B5EF4-FFF2-40B4-BE49-F238E27FC236}">
                      <a16:creationId xmlns:a16="http://schemas.microsoft.com/office/drawing/2014/main" id="{2861B25A-5346-45E0-B032-84C6C8AA5825}"/>
                    </a:ext>
                  </a:extLst>
                </p:cNvPr>
                <p:cNvSpPr/>
                <p:nvPr/>
              </p:nvSpPr>
              <p:spPr>
                <a:xfrm>
                  <a:off x="5544988" y="6772722"/>
                  <a:ext cx="9525" cy="9525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525" h="9525"/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9" name="Freihandform: Form 198">
                  <a:extLst>
                    <a:ext uri="{FF2B5EF4-FFF2-40B4-BE49-F238E27FC236}">
                      <a16:creationId xmlns:a16="http://schemas.microsoft.com/office/drawing/2014/main" id="{D862C147-13FA-4B8E-89DA-50363E09E562}"/>
                    </a:ext>
                  </a:extLst>
                </p:cNvPr>
                <p:cNvSpPr/>
                <p:nvPr/>
              </p:nvSpPr>
              <p:spPr>
                <a:xfrm>
                  <a:off x="5595236" y="6659761"/>
                  <a:ext cx="73669" cy="114969"/>
                </a:xfrm>
                <a:custGeom>
                  <a:avLst/>
                  <a:gdLst>
                    <a:gd name="connsiteX0" fmla="*/ 451 w 73669"/>
                    <a:gd name="connsiteY0" fmla="*/ 83981 h 114969"/>
                    <a:gd name="connsiteX1" fmla="*/ 14292 w 73669"/>
                    <a:gd name="connsiteY1" fmla="*/ 82120 h 114969"/>
                    <a:gd name="connsiteX2" fmla="*/ 22366 w 73669"/>
                    <a:gd name="connsiteY2" fmla="*/ 99049 h 114969"/>
                    <a:gd name="connsiteX3" fmla="*/ 36318 w 73669"/>
                    <a:gd name="connsiteY3" fmla="*/ 104221 h 114969"/>
                    <a:gd name="connsiteX4" fmla="*/ 52727 w 73669"/>
                    <a:gd name="connsiteY4" fmla="*/ 97487 h 114969"/>
                    <a:gd name="connsiteX5" fmla="*/ 59461 w 73669"/>
                    <a:gd name="connsiteY5" fmla="*/ 80744 h 114969"/>
                    <a:gd name="connsiteX6" fmla="*/ 53248 w 73669"/>
                    <a:gd name="connsiteY6" fmla="*/ 65042 h 114969"/>
                    <a:gd name="connsiteX7" fmla="*/ 37472 w 73669"/>
                    <a:gd name="connsiteY7" fmla="*/ 58866 h 114969"/>
                    <a:gd name="connsiteX8" fmla="*/ 27724 w 73669"/>
                    <a:gd name="connsiteY8" fmla="*/ 60429 h 114969"/>
                    <a:gd name="connsiteX9" fmla="*/ 29249 w 73669"/>
                    <a:gd name="connsiteY9" fmla="*/ 48299 h 114969"/>
                    <a:gd name="connsiteX10" fmla="*/ 31481 w 73669"/>
                    <a:gd name="connsiteY10" fmla="*/ 48448 h 114969"/>
                    <a:gd name="connsiteX11" fmla="*/ 47332 w 73669"/>
                    <a:gd name="connsiteY11" fmla="*/ 43834 h 114969"/>
                    <a:gd name="connsiteX12" fmla="*/ 54401 w 73669"/>
                    <a:gd name="connsiteY12" fmla="*/ 29658 h 114969"/>
                    <a:gd name="connsiteX13" fmla="*/ 49266 w 73669"/>
                    <a:gd name="connsiteY13" fmla="*/ 17045 h 114969"/>
                    <a:gd name="connsiteX14" fmla="*/ 35983 w 73669"/>
                    <a:gd name="connsiteY14" fmla="*/ 12059 h 114969"/>
                    <a:gd name="connsiteX15" fmla="*/ 22552 w 73669"/>
                    <a:gd name="connsiteY15" fmla="*/ 17157 h 114969"/>
                    <a:gd name="connsiteX16" fmla="*/ 15668 w 73669"/>
                    <a:gd name="connsiteY16" fmla="*/ 32337 h 114969"/>
                    <a:gd name="connsiteX17" fmla="*/ 1827 w 73669"/>
                    <a:gd name="connsiteY17" fmla="*/ 29882 h 114969"/>
                    <a:gd name="connsiteX18" fmla="*/ 13362 w 73669"/>
                    <a:gd name="connsiteY18" fmla="*/ 8339 h 114969"/>
                    <a:gd name="connsiteX19" fmla="*/ 35686 w 73669"/>
                    <a:gd name="connsiteY19" fmla="*/ 711 h 114969"/>
                    <a:gd name="connsiteX20" fmla="*/ 52652 w 73669"/>
                    <a:gd name="connsiteY20" fmla="*/ 4655 h 114969"/>
                    <a:gd name="connsiteX21" fmla="*/ 64484 w 73669"/>
                    <a:gd name="connsiteY21" fmla="*/ 15445 h 114969"/>
                    <a:gd name="connsiteX22" fmla="*/ 68614 w 73669"/>
                    <a:gd name="connsiteY22" fmla="*/ 29956 h 114969"/>
                    <a:gd name="connsiteX23" fmla="*/ 64670 w 73669"/>
                    <a:gd name="connsiteY23" fmla="*/ 43239 h 114969"/>
                    <a:gd name="connsiteX24" fmla="*/ 53099 w 73669"/>
                    <a:gd name="connsiteY24" fmla="*/ 52727 h 114969"/>
                    <a:gd name="connsiteX25" fmla="*/ 68577 w 73669"/>
                    <a:gd name="connsiteY25" fmla="*/ 62289 h 114969"/>
                    <a:gd name="connsiteX26" fmla="*/ 74121 w 73669"/>
                    <a:gd name="connsiteY26" fmla="*/ 80446 h 114969"/>
                    <a:gd name="connsiteX27" fmla="*/ 63368 w 73669"/>
                    <a:gd name="connsiteY27" fmla="*/ 105449 h 114969"/>
                    <a:gd name="connsiteX28" fmla="*/ 36207 w 73669"/>
                    <a:gd name="connsiteY28" fmla="*/ 115681 h 114969"/>
                    <a:gd name="connsiteX29" fmla="*/ 11613 w 73669"/>
                    <a:gd name="connsiteY29" fmla="*/ 106863 h 114969"/>
                    <a:gd name="connsiteX30" fmla="*/ 451 w 73669"/>
                    <a:gd name="connsiteY30" fmla="*/ 83981 h 1149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</a:cxnLst>
                  <a:rect l="l" t="t" r="r" b="b"/>
                  <a:pathLst>
                    <a:path w="73669" h="114969">
                      <a:moveTo>
                        <a:pt x="451" y="83981"/>
                      </a:moveTo>
                      <a:lnTo>
                        <a:pt x="14292" y="82120"/>
                      </a:lnTo>
                      <a:cubicBezTo>
                        <a:pt x="15854" y="90008"/>
                        <a:pt x="18533" y="95626"/>
                        <a:pt x="22366" y="99049"/>
                      </a:cubicBezTo>
                      <a:cubicBezTo>
                        <a:pt x="26161" y="102510"/>
                        <a:pt x="30812" y="104258"/>
                        <a:pt x="36318" y="104221"/>
                      </a:cubicBezTo>
                      <a:cubicBezTo>
                        <a:pt x="42755" y="104258"/>
                        <a:pt x="48225" y="101989"/>
                        <a:pt x="52727" y="97487"/>
                      </a:cubicBezTo>
                      <a:cubicBezTo>
                        <a:pt x="57191" y="92985"/>
                        <a:pt x="59424" y="87404"/>
                        <a:pt x="59461" y="80744"/>
                      </a:cubicBezTo>
                      <a:cubicBezTo>
                        <a:pt x="59424" y="74418"/>
                        <a:pt x="57378" y="69209"/>
                        <a:pt x="53248" y="65042"/>
                      </a:cubicBezTo>
                      <a:cubicBezTo>
                        <a:pt x="49080" y="60949"/>
                        <a:pt x="43797" y="58866"/>
                        <a:pt x="37472" y="58866"/>
                      </a:cubicBezTo>
                      <a:cubicBezTo>
                        <a:pt x="34793" y="58866"/>
                        <a:pt x="31556" y="59387"/>
                        <a:pt x="27724" y="60429"/>
                      </a:cubicBezTo>
                      <a:lnTo>
                        <a:pt x="29249" y="48299"/>
                      </a:lnTo>
                      <a:cubicBezTo>
                        <a:pt x="30142" y="48448"/>
                        <a:pt x="30886" y="48485"/>
                        <a:pt x="31481" y="48448"/>
                      </a:cubicBezTo>
                      <a:cubicBezTo>
                        <a:pt x="37360" y="48485"/>
                        <a:pt x="42643" y="46960"/>
                        <a:pt x="47332" y="43834"/>
                      </a:cubicBezTo>
                      <a:cubicBezTo>
                        <a:pt x="52020" y="40783"/>
                        <a:pt x="54364" y="36058"/>
                        <a:pt x="54401" y="29658"/>
                      </a:cubicBezTo>
                      <a:cubicBezTo>
                        <a:pt x="54364" y="24598"/>
                        <a:pt x="52652" y="20394"/>
                        <a:pt x="49266" y="17045"/>
                      </a:cubicBezTo>
                      <a:cubicBezTo>
                        <a:pt x="45806" y="13771"/>
                        <a:pt x="41378" y="12096"/>
                        <a:pt x="35983" y="12059"/>
                      </a:cubicBezTo>
                      <a:cubicBezTo>
                        <a:pt x="30588" y="12096"/>
                        <a:pt x="26124" y="13808"/>
                        <a:pt x="22552" y="17157"/>
                      </a:cubicBezTo>
                      <a:cubicBezTo>
                        <a:pt x="18980" y="20580"/>
                        <a:pt x="16673" y="25640"/>
                        <a:pt x="15668" y="32337"/>
                      </a:cubicBezTo>
                      <a:lnTo>
                        <a:pt x="1827" y="29882"/>
                      </a:lnTo>
                      <a:cubicBezTo>
                        <a:pt x="3502" y="20654"/>
                        <a:pt x="7334" y="13474"/>
                        <a:pt x="13362" y="8339"/>
                      </a:cubicBezTo>
                      <a:cubicBezTo>
                        <a:pt x="19315" y="3279"/>
                        <a:pt x="26756" y="711"/>
                        <a:pt x="35686" y="711"/>
                      </a:cubicBezTo>
                      <a:cubicBezTo>
                        <a:pt x="41788" y="711"/>
                        <a:pt x="47443" y="2050"/>
                        <a:pt x="52652" y="4655"/>
                      </a:cubicBezTo>
                      <a:cubicBezTo>
                        <a:pt x="57787" y="7334"/>
                        <a:pt x="61731" y="10906"/>
                        <a:pt x="64484" y="15445"/>
                      </a:cubicBezTo>
                      <a:cubicBezTo>
                        <a:pt x="67200" y="20022"/>
                        <a:pt x="68577" y="24859"/>
                        <a:pt x="68614" y="29956"/>
                      </a:cubicBezTo>
                      <a:cubicBezTo>
                        <a:pt x="68577" y="34830"/>
                        <a:pt x="67275" y="39258"/>
                        <a:pt x="64670" y="43239"/>
                      </a:cubicBezTo>
                      <a:cubicBezTo>
                        <a:pt x="62028" y="47257"/>
                        <a:pt x="58159" y="50420"/>
                        <a:pt x="53099" y="52727"/>
                      </a:cubicBezTo>
                      <a:cubicBezTo>
                        <a:pt x="59722" y="54289"/>
                        <a:pt x="64893" y="57489"/>
                        <a:pt x="68577" y="62289"/>
                      </a:cubicBezTo>
                      <a:cubicBezTo>
                        <a:pt x="72260" y="67163"/>
                        <a:pt x="74121" y="73228"/>
                        <a:pt x="74121" y="80446"/>
                      </a:cubicBezTo>
                      <a:cubicBezTo>
                        <a:pt x="74121" y="90306"/>
                        <a:pt x="70512" y="98640"/>
                        <a:pt x="63368" y="105449"/>
                      </a:cubicBezTo>
                      <a:cubicBezTo>
                        <a:pt x="56187" y="112295"/>
                        <a:pt x="47146" y="115681"/>
                        <a:pt x="36207" y="115681"/>
                      </a:cubicBezTo>
                      <a:cubicBezTo>
                        <a:pt x="26310" y="115681"/>
                        <a:pt x="18124" y="112742"/>
                        <a:pt x="11613" y="106863"/>
                      </a:cubicBezTo>
                      <a:cubicBezTo>
                        <a:pt x="5064" y="100984"/>
                        <a:pt x="1344" y="93357"/>
                        <a:pt x="451" y="83981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0" name="Freihandform: Form 199">
                  <a:extLst>
                    <a:ext uri="{FF2B5EF4-FFF2-40B4-BE49-F238E27FC236}">
                      <a16:creationId xmlns:a16="http://schemas.microsoft.com/office/drawing/2014/main" id="{B5800C90-D29F-4223-A17F-ABCC84318748}"/>
                    </a:ext>
                  </a:extLst>
                </p:cNvPr>
                <p:cNvSpPr/>
                <p:nvPr/>
              </p:nvSpPr>
              <p:spPr>
                <a:xfrm>
                  <a:off x="5680791" y="6659761"/>
                  <a:ext cx="74363" cy="112960"/>
                </a:xfrm>
                <a:custGeom>
                  <a:avLst/>
                  <a:gdLst>
                    <a:gd name="connsiteX0" fmla="*/ 74823 w 74363"/>
                    <a:gd name="connsiteY0" fmla="*/ 100389 h 112960"/>
                    <a:gd name="connsiteX1" fmla="*/ 74823 w 74363"/>
                    <a:gd name="connsiteY1" fmla="*/ 113672 h 112960"/>
                    <a:gd name="connsiteX2" fmla="*/ 483 w 74363"/>
                    <a:gd name="connsiteY2" fmla="*/ 113672 h 112960"/>
                    <a:gd name="connsiteX3" fmla="*/ 2083 w 74363"/>
                    <a:gd name="connsiteY3" fmla="*/ 104072 h 112960"/>
                    <a:gd name="connsiteX4" fmla="*/ 11199 w 74363"/>
                    <a:gd name="connsiteY4" fmla="*/ 89115 h 112960"/>
                    <a:gd name="connsiteX5" fmla="*/ 29245 w 74363"/>
                    <a:gd name="connsiteY5" fmla="*/ 72074 h 112960"/>
                    <a:gd name="connsiteX6" fmla="*/ 54024 w 74363"/>
                    <a:gd name="connsiteY6" fmla="*/ 48262 h 112960"/>
                    <a:gd name="connsiteX7" fmla="*/ 60498 w 74363"/>
                    <a:gd name="connsiteY7" fmla="*/ 31630 h 112960"/>
                    <a:gd name="connsiteX8" fmla="*/ 54620 w 74363"/>
                    <a:gd name="connsiteY8" fmla="*/ 17789 h 112960"/>
                    <a:gd name="connsiteX9" fmla="*/ 39328 w 74363"/>
                    <a:gd name="connsiteY9" fmla="*/ 12133 h 112960"/>
                    <a:gd name="connsiteX10" fmla="*/ 23329 w 74363"/>
                    <a:gd name="connsiteY10" fmla="*/ 18125 h 112960"/>
                    <a:gd name="connsiteX11" fmla="*/ 17301 w 74363"/>
                    <a:gd name="connsiteY11" fmla="*/ 34719 h 112960"/>
                    <a:gd name="connsiteX12" fmla="*/ 3088 w 74363"/>
                    <a:gd name="connsiteY12" fmla="*/ 33230 h 112960"/>
                    <a:gd name="connsiteX13" fmla="*/ 14064 w 74363"/>
                    <a:gd name="connsiteY13" fmla="*/ 9045 h 112960"/>
                    <a:gd name="connsiteX14" fmla="*/ 39625 w 74363"/>
                    <a:gd name="connsiteY14" fmla="*/ 711 h 112960"/>
                    <a:gd name="connsiteX15" fmla="*/ 65224 w 74363"/>
                    <a:gd name="connsiteY15" fmla="*/ 9715 h 112960"/>
                    <a:gd name="connsiteX16" fmla="*/ 74674 w 74363"/>
                    <a:gd name="connsiteY16" fmla="*/ 31928 h 112960"/>
                    <a:gd name="connsiteX17" fmla="*/ 71921 w 74363"/>
                    <a:gd name="connsiteY17" fmla="*/ 45248 h 112960"/>
                    <a:gd name="connsiteX18" fmla="*/ 62731 w 74363"/>
                    <a:gd name="connsiteY18" fmla="*/ 58977 h 112960"/>
                    <a:gd name="connsiteX19" fmla="*/ 41448 w 74363"/>
                    <a:gd name="connsiteY19" fmla="*/ 78772 h 112960"/>
                    <a:gd name="connsiteX20" fmla="*/ 25487 w 74363"/>
                    <a:gd name="connsiteY20" fmla="*/ 92910 h 112960"/>
                    <a:gd name="connsiteX21" fmla="*/ 19682 w 74363"/>
                    <a:gd name="connsiteY21" fmla="*/ 100389 h 1129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74363" h="112960">
                      <a:moveTo>
                        <a:pt x="74823" y="100389"/>
                      </a:moveTo>
                      <a:lnTo>
                        <a:pt x="74823" y="113672"/>
                      </a:lnTo>
                      <a:lnTo>
                        <a:pt x="483" y="113672"/>
                      </a:lnTo>
                      <a:cubicBezTo>
                        <a:pt x="335" y="110360"/>
                        <a:pt x="893" y="107161"/>
                        <a:pt x="2083" y="104072"/>
                      </a:cubicBezTo>
                      <a:cubicBezTo>
                        <a:pt x="3981" y="99012"/>
                        <a:pt x="6995" y="94027"/>
                        <a:pt x="11199" y="89115"/>
                      </a:cubicBezTo>
                      <a:cubicBezTo>
                        <a:pt x="15329" y="84204"/>
                        <a:pt x="21357" y="78548"/>
                        <a:pt x="29245" y="72074"/>
                      </a:cubicBezTo>
                      <a:cubicBezTo>
                        <a:pt x="41448" y="62103"/>
                        <a:pt x="49708" y="54141"/>
                        <a:pt x="54024" y="48262"/>
                      </a:cubicBezTo>
                      <a:cubicBezTo>
                        <a:pt x="58303" y="42420"/>
                        <a:pt x="60461" y="36877"/>
                        <a:pt x="60498" y="31630"/>
                      </a:cubicBezTo>
                      <a:cubicBezTo>
                        <a:pt x="60461" y="26161"/>
                        <a:pt x="58489" y="21547"/>
                        <a:pt x="54620" y="17789"/>
                      </a:cubicBezTo>
                      <a:cubicBezTo>
                        <a:pt x="50676" y="14032"/>
                        <a:pt x="45578" y="12172"/>
                        <a:pt x="39328" y="12133"/>
                      </a:cubicBezTo>
                      <a:cubicBezTo>
                        <a:pt x="32630" y="12172"/>
                        <a:pt x="27310" y="14143"/>
                        <a:pt x="23329" y="18125"/>
                      </a:cubicBezTo>
                      <a:cubicBezTo>
                        <a:pt x="19347" y="22142"/>
                        <a:pt x="17338" y="27686"/>
                        <a:pt x="17301" y="34719"/>
                      </a:cubicBezTo>
                      <a:lnTo>
                        <a:pt x="3088" y="33230"/>
                      </a:lnTo>
                      <a:cubicBezTo>
                        <a:pt x="4055" y="22701"/>
                        <a:pt x="7702" y="14627"/>
                        <a:pt x="14064" y="9045"/>
                      </a:cubicBezTo>
                      <a:cubicBezTo>
                        <a:pt x="20389" y="3502"/>
                        <a:pt x="28910" y="711"/>
                        <a:pt x="39625" y="711"/>
                      </a:cubicBezTo>
                      <a:cubicBezTo>
                        <a:pt x="50378" y="711"/>
                        <a:pt x="58899" y="3725"/>
                        <a:pt x="65224" y="9715"/>
                      </a:cubicBezTo>
                      <a:cubicBezTo>
                        <a:pt x="71474" y="15705"/>
                        <a:pt x="74637" y="23110"/>
                        <a:pt x="74674" y="31928"/>
                      </a:cubicBezTo>
                      <a:cubicBezTo>
                        <a:pt x="74637" y="36467"/>
                        <a:pt x="73707" y="40895"/>
                        <a:pt x="71921" y="45248"/>
                      </a:cubicBezTo>
                      <a:cubicBezTo>
                        <a:pt x="70061" y="49601"/>
                        <a:pt x="67010" y="54178"/>
                        <a:pt x="62731" y="58977"/>
                      </a:cubicBezTo>
                      <a:cubicBezTo>
                        <a:pt x="58452" y="63777"/>
                        <a:pt x="51345" y="70400"/>
                        <a:pt x="41448" y="78772"/>
                      </a:cubicBezTo>
                      <a:cubicBezTo>
                        <a:pt x="33114" y="85767"/>
                        <a:pt x="27793" y="90455"/>
                        <a:pt x="25487" y="92910"/>
                      </a:cubicBezTo>
                      <a:cubicBezTo>
                        <a:pt x="23105" y="95403"/>
                        <a:pt x="21171" y="97896"/>
                        <a:pt x="19682" y="100389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1" name="Freihandform: Form 200">
                  <a:extLst>
                    <a:ext uri="{FF2B5EF4-FFF2-40B4-BE49-F238E27FC236}">
                      <a16:creationId xmlns:a16="http://schemas.microsoft.com/office/drawing/2014/main" id="{26AB0785-21D3-42D8-8E05-B4EBC98BB965}"/>
                    </a:ext>
                  </a:extLst>
                </p:cNvPr>
                <p:cNvSpPr/>
                <p:nvPr/>
              </p:nvSpPr>
              <p:spPr>
                <a:xfrm>
                  <a:off x="5772578" y="6658311"/>
                  <a:ext cx="120960" cy="118541"/>
                </a:xfrm>
                <a:custGeom>
                  <a:avLst/>
                  <a:gdLst>
                    <a:gd name="connsiteX0" fmla="*/ 470 w 120960"/>
                    <a:gd name="connsiteY0" fmla="*/ 29621 h 118541"/>
                    <a:gd name="connsiteX1" fmla="*/ 6534 w 120960"/>
                    <a:gd name="connsiteY1" fmla="*/ 9157 h 118541"/>
                    <a:gd name="connsiteX2" fmla="*/ 24133 w 120960"/>
                    <a:gd name="connsiteY2" fmla="*/ 711 h 118541"/>
                    <a:gd name="connsiteX3" fmla="*/ 41658 w 120960"/>
                    <a:gd name="connsiteY3" fmla="*/ 8263 h 118541"/>
                    <a:gd name="connsiteX4" fmla="*/ 48616 w 120960"/>
                    <a:gd name="connsiteY4" fmla="*/ 30476 h 118541"/>
                    <a:gd name="connsiteX5" fmla="*/ 41583 w 120960"/>
                    <a:gd name="connsiteY5" fmla="*/ 52466 h 118541"/>
                    <a:gd name="connsiteX6" fmla="*/ 24282 w 120960"/>
                    <a:gd name="connsiteY6" fmla="*/ 60168 h 118541"/>
                    <a:gd name="connsiteX7" fmla="*/ 7241 w 120960"/>
                    <a:gd name="connsiteY7" fmla="*/ 52577 h 118541"/>
                    <a:gd name="connsiteX8" fmla="*/ 470 w 120960"/>
                    <a:gd name="connsiteY8" fmla="*/ 29621 h 118541"/>
                    <a:gd name="connsiteX9" fmla="*/ 24505 w 120960"/>
                    <a:gd name="connsiteY9" fmla="*/ 10236 h 118541"/>
                    <a:gd name="connsiteX10" fmla="*/ 15948 w 120960"/>
                    <a:gd name="connsiteY10" fmla="*/ 14700 h 118541"/>
                    <a:gd name="connsiteX11" fmla="*/ 12525 w 120960"/>
                    <a:gd name="connsiteY11" fmla="*/ 31035 h 118541"/>
                    <a:gd name="connsiteX12" fmla="*/ 15985 w 120960"/>
                    <a:gd name="connsiteY12" fmla="*/ 46252 h 118541"/>
                    <a:gd name="connsiteX13" fmla="*/ 24505 w 120960"/>
                    <a:gd name="connsiteY13" fmla="*/ 50680 h 118541"/>
                    <a:gd name="connsiteX14" fmla="*/ 33137 w 120960"/>
                    <a:gd name="connsiteY14" fmla="*/ 46215 h 118541"/>
                    <a:gd name="connsiteX15" fmla="*/ 36560 w 120960"/>
                    <a:gd name="connsiteY15" fmla="*/ 29956 h 118541"/>
                    <a:gd name="connsiteX16" fmla="*/ 33100 w 120960"/>
                    <a:gd name="connsiteY16" fmla="*/ 14663 h 118541"/>
                    <a:gd name="connsiteX17" fmla="*/ 24505 w 120960"/>
                    <a:gd name="connsiteY17" fmla="*/ 10236 h 118541"/>
                    <a:gd name="connsiteX18" fmla="*/ 24580 w 120960"/>
                    <a:gd name="connsiteY18" fmla="*/ 119252 h 118541"/>
                    <a:gd name="connsiteX19" fmla="*/ 86120 w 120960"/>
                    <a:gd name="connsiteY19" fmla="*/ 711 h 118541"/>
                    <a:gd name="connsiteX20" fmla="*/ 97319 w 120960"/>
                    <a:gd name="connsiteY20" fmla="*/ 711 h 118541"/>
                    <a:gd name="connsiteX21" fmla="*/ 36002 w 120960"/>
                    <a:gd name="connsiteY21" fmla="*/ 119252 h 118541"/>
                    <a:gd name="connsiteX22" fmla="*/ 73247 w 120960"/>
                    <a:gd name="connsiteY22" fmla="*/ 88705 h 118541"/>
                    <a:gd name="connsiteX23" fmla="*/ 79311 w 120960"/>
                    <a:gd name="connsiteY23" fmla="*/ 68204 h 118541"/>
                    <a:gd name="connsiteX24" fmla="*/ 96947 w 120960"/>
                    <a:gd name="connsiteY24" fmla="*/ 59796 h 118541"/>
                    <a:gd name="connsiteX25" fmla="*/ 114472 w 120960"/>
                    <a:gd name="connsiteY25" fmla="*/ 67349 h 118541"/>
                    <a:gd name="connsiteX26" fmla="*/ 121429 w 120960"/>
                    <a:gd name="connsiteY26" fmla="*/ 89561 h 118541"/>
                    <a:gd name="connsiteX27" fmla="*/ 114398 w 120960"/>
                    <a:gd name="connsiteY27" fmla="*/ 111551 h 118541"/>
                    <a:gd name="connsiteX28" fmla="*/ 97022 w 120960"/>
                    <a:gd name="connsiteY28" fmla="*/ 119252 h 118541"/>
                    <a:gd name="connsiteX29" fmla="*/ 80018 w 120960"/>
                    <a:gd name="connsiteY29" fmla="*/ 111625 h 118541"/>
                    <a:gd name="connsiteX30" fmla="*/ 73247 w 120960"/>
                    <a:gd name="connsiteY30" fmla="*/ 88705 h 118541"/>
                    <a:gd name="connsiteX31" fmla="*/ 97319 w 120960"/>
                    <a:gd name="connsiteY31" fmla="*/ 69321 h 118541"/>
                    <a:gd name="connsiteX32" fmla="*/ 88688 w 120960"/>
                    <a:gd name="connsiteY32" fmla="*/ 73786 h 118541"/>
                    <a:gd name="connsiteX33" fmla="*/ 85264 w 120960"/>
                    <a:gd name="connsiteY33" fmla="*/ 90119 h 118541"/>
                    <a:gd name="connsiteX34" fmla="*/ 88725 w 120960"/>
                    <a:gd name="connsiteY34" fmla="*/ 105300 h 118541"/>
                    <a:gd name="connsiteX35" fmla="*/ 97245 w 120960"/>
                    <a:gd name="connsiteY35" fmla="*/ 109765 h 118541"/>
                    <a:gd name="connsiteX36" fmla="*/ 105951 w 120960"/>
                    <a:gd name="connsiteY36" fmla="*/ 105300 h 118541"/>
                    <a:gd name="connsiteX37" fmla="*/ 109374 w 120960"/>
                    <a:gd name="connsiteY37" fmla="*/ 89040 h 118541"/>
                    <a:gd name="connsiteX38" fmla="*/ 105914 w 120960"/>
                    <a:gd name="connsiteY38" fmla="*/ 73748 h 118541"/>
                    <a:gd name="connsiteX39" fmla="*/ 97319 w 120960"/>
                    <a:gd name="connsiteY39" fmla="*/ 69321 h 1185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</a:cxnLst>
                  <a:rect l="l" t="t" r="r" b="b"/>
                  <a:pathLst>
                    <a:path w="120960" h="118541">
                      <a:moveTo>
                        <a:pt x="470" y="29621"/>
                      </a:moveTo>
                      <a:cubicBezTo>
                        <a:pt x="432" y="21621"/>
                        <a:pt x="2479" y="14813"/>
                        <a:pt x="6534" y="9157"/>
                      </a:cubicBezTo>
                      <a:cubicBezTo>
                        <a:pt x="10553" y="3539"/>
                        <a:pt x="16394" y="711"/>
                        <a:pt x="24133" y="711"/>
                      </a:cubicBezTo>
                      <a:cubicBezTo>
                        <a:pt x="31128" y="711"/>
                        <a:pt x="36970" y="3241"/>
                        <a:pt x="41658" y="8263"/>
                      </a:cubicBezTo>
                      <a:cubicBezTo>
                        <a:pt x="46271" y="13324"/>
                        <a:pt x="48616" y="20728"/>
                        <a:pt x="48616" y="30476"/>
                      </a:cubicBezTo>
                      <a:cubicBezTo>
                        <a:pt x="48616" y="40039"/>
                        <a:pt x="46271" y="47368"/>
                        <a:pt x="41583" y="52466"/>
                      </a:cubicBezTo>
                      <a:cubicBezTo>
                        <a:pt x="36895" y="57638"/>
                        <a:pt x="31128" y="60205"/>
                        <a:pt x="24282" y="60168"/>
                      </a:cubicBezTo>
                      <a:cubicBezTo>
                        <a:pt x="17436" y="60205"/>
                        <a:pt x="11743" y="57675"/>
                        <a:pt x="7241" y="52577"/>
                      </a:cubicBezTo>
                      <a:cubicBezTo>
                        <a:pt x="2702" y="47555"/>
                        <a:pt x="432" y="39890"/>
                        <a:pt x="470" y="29621"/>
                      </a:cubicBezTo>
                      <a:close/>
                      <a:moveTo>
                        <a:pt x="24505" y="10236"/>
                      </a:moveTo>
                      <a:cubicBezTo>
                        <a:pt x="21082" y="10273"/>
                        <a:pt x="18217" y="11761"/>
                        <a:pt x="15948" y="14700"/>
                      </a:cubicBezTo>
                      <a:cubicBezTo>
                        <a:pt x="13641" y="17677"/>
                        <a:pt x="12487" y="23109"/>
                        <a:pt x="12525" y="31035"/>
                      </a:cubicBezTo>
                      <a:cubicBezTo>
                        <a:pt x="12487" y="38253"/>
                        <a:pt x="13641" y="43313"/>
                        <a:pt x="15985" y="46252"/>
                      </a:cubicBezTo>
                      <a:cubicBezTo>
                        <a:pt x="18255" y="49229"/>
                        <a:pt x="21119" y="50717"/>
                        <a:pt x="24505" y="50680"/>
                      </a:cubicBezTo>
                      <a:cubicBezTo>
                        <a:pt x="27966" y="50717"/>
                        <a:pt x="30831" y="49229"/>
                        <a:pt x="33137" y="46215"/>
                      </a:cubicBezTo>
                      <a:cubicBezTo>
                        <a:pt x="35407" y="43276"/>
                        <a:pt x="36560" y="37843"/>
                        <a:pt x="36560" y="29956"/>
                      </a:cubicBezTo>
                      <a:cubicBezTo>
                        <a:pt x="36560" y="22700"/>
                        <a:pt x="35407" y="17603"/>
                        <a:pt x="33100" y="14663"/>
                      </a:cubicBezTo>
                      <a:cubicBezTo>
                        <a:pt x="30793" y="11724"/>
                        <a:pt x="27928" y="10273"/>
                        <a:pt x="24505" y="10236"/>
                      </a:cubicBezTo>
                      <a:close/>
                      <a:moveTo>
                        <a:pt x="24580" y="119252"/>
                      </a:moveTo>
                      <a:lnTo>
                        <a:pt x="86120" y="711"/>
                      </a:lnTo>
                      <a:lnTo>
                        <a:pt x="97319" y="711"/>
                      </a:lnTo>
                      <a:lnTo>
                        <a:pt x="36002" y="119252"/>
                      </a:lnTo>
                      <a:close/>
                      <a:moveTo>
                        <a:pt x="73247" y="88705"/>
                      </a:moveTo>
                      <a:cubicBezTo>
                        <a:pt x="73209" y="80669"/>
                        <a:pt x="75256" y="73823"/>
                        <a:pt x="79311" y="68204"/>
                      </a:cubicBezTo>
                      <a:cubicBezTo>
                        <a:pt x="83330" y="62623"/>
                        <a:pt x="89208" y="59833"/>
                        <a:pt x="96947" y="59796"/>
                      </a:cubicBezTo>
                      <a:cubicBezTo>
                        <a:pt x="104017" y="59833"/>
                        <a:pt x="109858" y="62326"/>
                        <a:pt x="114472" y="67349"/>
                      </a:cubicBezTo>
                      <a:cubicBezTo>
                        <a:pt x="119086" y="72409"/>
                        <a:pt x="121392" y="79813"/>
                        <a:pt x="121429" y="89561"/>
                      </a:cubicBezTo>
                      <a:cubicBezTo>
                        <a:pt x="121392" y="99086"/>
                        <a:pt x="119048" y="106416"/>
                        <a:pt x="114398" y="111551"/>
                      </a:cubicBezTo>
                      <a:cubicBezTo>
                        <a:pt x="109672" y="116685"/>
                        <a:pt x="103868" y="119252"/>
                        <a:pt x="97022" y="119252"/>
                      </a:cubicBezTo>
                      <a:cubicBezTo>
                        <a:pt x="90176" y="119252"/>
                        <a:pt x="84520" y="116722"/>
                        <a:pt x="80018" y="111625"/>
                      </a:cubicBezTo>
                      <a:cubicBezTo>
                        <a:pt x="75479" y="106565"/>
                        <a:pt x="73209" y="98937"/>
                        <a:pt x="73247" y="88705"/>
                      </a:cubicBezTo>
                      <a:close/>
                      <a:moveTo>
                        <a:pt x="97319" y="69321"/>
                      </a:moveTo>
                      <a:cubicBezTo>
                        <a:pt x="93822" y="69358"/>
                        <a:pt x="90957" y="70846"/>
                        <a:pt x="88688" y="73786"/>
                      </a:cubicBezTo>
                      <a:cubicBezTo>
                        <a:pt x="86381" y="76762"/>
                        <a:pt x="85227" y="82194"/>
                        <a:pt x="85264" y="90119"/>
                      </a:cubicBezTo>
                      <a:cubicBezTo>
                        <a:pt x="85227" y="97263"/>
                        <a:pt x="86381" y="102323"/>
                        <a:pt x="88725" y="105300"/>
                      </a:cubicBezTo>
                      <a:cubicBezTo>
                        <a:pt x="90994" y="108276"/>
                        <a:pt x="93822" y="109765"/>
                        <a:pt x="97245" y="109765"/>
                      </a:cubicBezTo>
                      <a:cubicBezTo>
                        <a:pt x="100743" y="109765"/>
                        <a:pt x="103645" y="108276"/>
                        <a:pt x="105951" y="105300"/>
                      </a:cubicBezTo>
                      <a:cubicBezTo>
                        <a:pt x="108184" y="102323"/>
                        <a:pt x="109337" y="96928"/>
                        <a:pt x="109374" y="89040"/>
                      </a:cubicBezTo>
                      <a:cubicBezTo>
                        <a:pt x="109337" y="81822"/>
                        <a:pt x="108184" y="76725"/>
                        <a:pt x="105914" y="73748"/>
                      </a:cubicBezTo>
                      <a:cubicBezTo>
                        <a:pt x="103570" y="70846"/>
                        <a:pt x="100706" y="69358"/>
                        <a:pt x="97319" y="69321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2" name="Freihandform: Form 201">
                  <a:extLst>
                    <a:ext uri="{FF2B5EF4-FFF2-40B4-BE49-F238E27FC236}">
                      <a16:creationId xmlns:a16="http://schemas.microsoft.com/office/drawing/2014/main" id="{59636847-C7B5-47F9-A4A5-3BB89D0739ED}"/>
                    </a:ext>
                  </a:extLst>
                </p:cNvPr>
                <p:cNvSpPr/>
                <p:nvPr/>
              </p:nvSpPr>
              <p:spPr>
                <a:xfrm>
                  <a:off x="5903204" y="6772722"/>
                  <a:ext cx="9525" cy="9525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525" h="9525"/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3" name="Freihandform: Form 202">
                  <a:extLst>
                    <a:ext uri="{FF2B5EF4-FFF2-40B4-BE49-F238E27FC236}">
                      <a16:creationId xmlns:a16="http://schemas.microsoft.com/office/drawing/2014/main" id="{F593DE79-6B77-4374-8DF6-513F6B41308B}"/>
                    </a:ext>
                  </a:extLst>
                </p:cNvPr>
                <p:cNvSpPr/>
                <p:nvPr/>
              </p:nvSpPr>
              <p:spPr>
                <a:xfrm>
                  <a:off x="5952633" y="6689378"/>
                  <a:ext cx="75121" cy="85204"/>
                </a:xfrm>
                <a:custGeom>
                  <a:avLst/>
                  <a:gdLst>
                    <a:gd name="connsiteX0" fmla="*/ 60876 w 75121"/>
                    <a:gd name="connsiteY0" fmla="*/ 57824 h 85204"/>
                    <a:gd name="connsiteX1" fmla="*/ 75163 w 75121"/>
                    <a:gd name="connsiteY1" fmla="*/ 59573 h 85204"/>
                    <a:gd name="connsiteX2" fmla="*/ 62624 w 75121"/>
                    <a:gd name="connsiteY2" fmla="*/ 78995 h 85204"/>
                    <a:gd name="connsiteX3" fmla="*/ 39296 w 75121"/>
                    <a:gd name="connsiteY3" fmla="*/ 85915 h 85204"/>
                    <a:gd name="connsiteX4" fmla="*/ 10944 w 75121"/>
                    <a:gd name="connsiteY4" fmla="*/ 74902 h 85204"/>
                    <a:gd name="connsiteX5" fmla="*/ 489 w 75121"/>
                    <a:gd name="connsiteY5" fmla="*/ 43983 h 85204"/>
                    <a:gd name="connsiteX6" fmla="*/ 11055 w 75121"/>
                    <a:gd name="connsiteY6" fmla="*/ 12096 h 85204"/>
                    <a:gd name="connsiteX7" fmla="*/ 38551 w 75121"/>
                    <a:gd name="connsiteY7" fmla="*/ 711 h 85204"/>
                    <a:gd name="connsiteX8" fmla="*/ 65229 w 75121"/>
                    <a:gd name="connsiteY8" fmla="*/ 11836 h 85204"/>
                    <a:gd name="connsiteX9" fmla="*/ 75610 w 75121"/>
                    <a:gd name="connsiteY9" fmla="*/ 43164 h 85204"/>
                    <a:gd name="connsiteX10" fmla="*/ 75535 w 75121"/>
                    <a:gd name="connsiteY10" fmla="*/ 46848 h 85204"/>
                    <a:gd name="connsiteX11" fmla="*/ 14739 w 75121"/>
                    <a:gd name="connsiteY11" fmla="*/ 46848 h 85204"/>
                    <a:gd name="connsiteX12" fmla="*/ 22329 w 75121"/>
                    <a:gd name="connsiteY12" fmla="*/ 67423 h 85204"/>
                    <a:gd name="connsiteX13" fmla="*/ 39370 w 75121"/>
                    <a:gd name="connsiteY13" fmla="*/ 74530 h 85204"/>
                    <a:gd name="connsiteX14" fmla="*/ 52355 w 75121"/>
                    <a:gd name="connsiteY14" fmla="*/ 70549 h 85204"/>
                    <a:gd name="connsiteX15" fmla="*/ 60876 w 75121"/>
                    <a:gd name="connsiteY15" fmla="*/ 57824 h 85204"/>
                    <a:gd name="connsiteX16" fmla="*/ 15520 w 75121"/>
                    <a:gd name="connsiteY16" fmla="*/ 35462 h 85204"/>
                    <a:gd name="connsiteX17" fmla="*/ 61024 w 75121"/>
                    <a:gd name="connsiteY17" fmla="*/ 35462 h 85204"/>
                    <a:gd name="connsiteX18" fmla="*/ 55815 w 75121"/>
                    <a:gd name="connsiteY18" fmla="*/ 20059 h 85204"/>
                    <a:gd name="connsiteX19" fmla="*/ 38700 w 75121"/>
                    <a:gd name="connsiteY19" fmla="*/ 12059 h 85204"/>
                    <a:gd name="connsiteX20" fmla="*/ 22701 w 75121"/>
                    <a:gd name="connsiteY20" fmla="*/ 18459 h 85204"/>
                    <a:gd name="connsiteX21" fmla="*/ 15520 w 75121"/>
                    <a:gd name="connsiteY21" fmla="*/ 35462 h 8520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75121" h="85204">
                      <a:moveTo>
                        <a:pt x="60876" y="57824"/>
                      </a:moveTo>
                      <a:lnTo>
                        <a:pt x="75163" y="59573"/>
                      </a:lnTo>
                      <a:cubicBezTo>
                        <a:pt x="72856" y="67944"/>
                        <a:pt x="68689" y="74418"/>
                        <a:pt x="62624" y="78995"/>
                      </a:cubicBezTo>
                      <a:cubicBezTo>
                        <a:pt x="56522" y="83608"/>
                        <a:pt x="48746" y="85878"/>
                        <a:pt x="39296" y="85915"/>
                      </a:cubicBezTo>
                      <a:cubicBezTo>
                        <a:pt x="27352" y="85878"/>
                        <a:pt x="17901" y="82232"/>
                        <a:pt x="10944" y="74902"/>
                      </a:cubicBezTo>
                      <a:cubicBezTo>
                        <a:pt x="3949" y="67572"/>
                        <a:pt x="451" y="57266"/>
                        <a:pt x="489" y="43983"/>
                      </a:cubicBezTo>
                      <a:cubicBezTo>
                        <a:pt x="451" y="30291"/>
                        <a:pt x="3986" y="19687"/>
                        <a:pt x="11055" y="12096"/>
                      </a:cubicBezTo>
                      <a:cubicBezTo>
                        <a:pt x="18088" y="4543"/>
                        <a:pt x="27240" y="748"/>
                        <a:pt x="38551" y="711"/>
                      </a:cubicBezTo>
                      <a:cubicBezTo>
                        <a:pt x="49416" y="748"/>
                        <a:pt x="58308" y="4432"/>
                        <a:pt x="65229" y="11836"/>
                      </a:cubicBezTo>
                      <a:cubicBezTo>
                        <a:pt x="72112" y="19277"/>
                        <a:pt x="75572" y="29733"/>
                        <a:pt x="75610" y="43164"/>
                      </a:cubicBezTo>
                      <a:cubicBezTo>
                        <a:pt x="75572" y="44020"/>
                        <a:pt x="75572" y="45248"/>
                        <a:pt x="75535" y="46848"/>
                      </a:cubicBezTo>
                      <a:lnTo>
                        <a:pt x="14739" y="46848"/>
                      </a:lnTo>
                      <a:cubicBezTo>
                        <a:pt x="15223" y="55815"/>
                        <a:pt x="17753" y="62661"/>
                        <a:pt x="22329" y="67423"/>
                      </a:cubicBezTo>
                      <a:cubicBezTo>
                        <a:pt x="26868" y="72186"/>
                        <a:pt x="32561" y="74567"/>
                        <a:pt x="39370" y="74530"/>
                      </a:cubicBezTo>
                      <a:cubicBezTo>
                        <a:pt x="44430" y="74567"/>
                        <a:pt x="48746" y="73228"/>
                        <a:pt x="52355" y="70549"/>
                      </a:cubicBezTo>
                      <a:cubicBezTo>
                        <a:pt x="55890" y="67907"/>
                        <a:pt x="58718" y="63665"/>
                        <a:pt x="60876" y="57824"/>
                      </a:cubicBezTo>
                      <a:close/>
                      <a:moveTo>
                        <a:pt x="15520" y="35462"/>
                      </a:moveTo>
                      <a:lnTo>
                        <a:pt x="61024" y="35462"/>
                      </a:lnTo>
                      <a:cubicBezTo>
                        <a:pt x="60392" y="28653"/>
                        <a:pt x="58643" y="23519"/>
                        <a:pt x="55815" y="20059"/>
                      </a:cubicBezTo>
                      <a:cubicBezTo>
                        <a:pt x="51388" y="14738"/>
                        <a:pt x="45695" y="12059"/>
                        <a:pt x="38700" y="12059"/>
                      </a:cubicBezTo>
                      <a:cubicBezTo>
                        <a:pt x="32338" y="12059"/>
                        <a:pt x="26980" y="14217"/>
                        <a:pt x="22701" y="18459"/>
                      </a:cubicBezTo>
                      <a:cubicBezTo>
                        <a:pt x="18348" y="22738"/>
                        <a:pt x="15967" y="28393"/>
                        <a:pt x="15520" y="35462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4" name="Freihandform: Form 203">
                  <a:extLst>
                    <a:ext uri="{FF2B5EF4-FFF2-40B4-BE49-F238E27FC236}">
                      <a16:creationId xmlns:a16="http://schemas.microsoft.com/office/drawing/2014/main" id="{66166289-6156-4E43-BA18-EB0F312C87BA}"/>
                    </a:ext>
                  </a:extLst>
                </p:cNvPr>
                <p:cNvSpPr/>
                <p:nvPr/>
              </p:nvSpPr>
              <p:spPr>
                <a:xfrm>
                  <a:off x="6035431" y="6691239"/>
                  <a:ext cx="76274" cy="81483"/>
                </a:xfrm>
                <a:custGeom>
                  <a:avLst/>
                  <a:gdLst>
                    <a:gd name="connsiteX0" fmla="*/ 498 w 76274"/>
                    <a:gd name="connsiteY0" fmla="*/ 82194 h 81483"/>
                    <a:gd name="connsiteX1" fmla="*/ 30263 w 76274"/>
                    <a:gd name="connsiteY1" fmla="*/ 39853 h 81483"/>
                    <a:gd name="connsiteX2" fmla="*/ 2730 w 76274"/>
                    <a:gd name="connsiteY2" fmla="*/ 711 h 81483"/>
                    <a:gd name="connsiteX3" fmla="*/ 19994 w 76274"/>
                    <a:gd name="connsiteY3" fmla="*/ 711 h 81483"/>
                    <a:gd name="connsiteX4" fmla="*/ 32496 w 76274"/>
                    <a:gd name="connsiteY4" fmla="*/ 19798 h 81483"/>
                    <a:gd name="connsiteX5" fmla="*/ 38188 w 76274"/>
                    <a:gd name="connsiteY5" fmla="*/ 28951 h 81483"/>
                    <a:gd name="connsiteX6" fmla="*/ 44402 w 76274"/>
                    <a:gd name="connsiteY6" fmla="*/ 19947 h 81483"/>
                    <a:gd name="connsiteX7" fmla="*/ 58131 w 76274"/>
                    <a:gd name="connsiteY7" fmla="*/ 711 h 81483"/>
                    <a:gd name="connsiteX8" fmla="*/ 74614 w 76274"/>
                    <a:gd name="connsiteY8" fmla="*/ 711 h 81483"/>
                    <a:gd name="connsiteX9" fmla="*/ 46448 w 76274"/>
                    <a:gd name="connsiteY9" fmla="*/ 39072 h 81483"/>
                    <a:gd name="connsiteX10" fmla="*/ 76772 w 76274"/>
                    <a:gd name="connsiteY10" fmla="*/ 82194 h 81483"/>
                    <a:gd name="connsiteX11" fmla="*/ 59806 w 76274"/>
                    <a:gd name="connsiteY11" fmla="*/ 82194 h 81483"/>
                    <a:gd name="connsiteX12" fmla="*/ 43100 w 76274"/>
                    <a:gd name="connsiteY12" fmla="*/ 56856 h 81483"/>
                    <a:gd name="connsiteX13" fmla="*/ 38635 w 76274"/>
                    <a:gd name="connsiteY13" fmla="*/ 50048 h 81483"/>
                    <a:gd name="connsiteX14" fmla="*/ 17241 w 76274"/>
                    <a:gd name="connsiteY14" fmla="*/ 82194 h 814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</a:cxnLst>
                  <a:rect l="l" t="t" r="r" b="b"/>
                  <a:pathLst>
                    <a:path w="76274" h="81483">
                      <a:moveTo>
                        <a:pt x="498" y="82194"/>
                      </a:moveTo>
                      <a:lnTo>
                        <a:pt x="30263" y="39853"/>
                      </a:lnTo>
                      <a:lnTo>
                        <a:pt x="2730" y="711"/>
                      </a:lnTo>
                      <a:lnTo>
                        <a:pt x="19994" y="711"/>
                      </a:lnTo>
                      <a:lnTo>
                        <a:pt x="32496" y="19798"/>
                      </a:lnTo>
                      <a:cubicBezTo>
                        <a:pt x="34840" y="23445"/>
                        <a:pt x="36737" y="26496"/>
                        <a:pt x="38188" y="28951"/>
                      </a:cubicBezTo>
                      <a:cubicBezTo>
                        <a:pt x="40421" y="25565"/>
                        <a:pt x="42467" y="22589"/>
                        <a:pt x="44402" y="19947"/>
                      </a:cubicBezTo>
                      <a:lnTo>
                        <a:pt x="58131" y="711"/>
                      </a:lnTo>
                      <a:lnTo>
                        <a:pt x="74614" y="711"/>
                      </a:lnTo>
                      <a:lnTo>
                        <a:pt x="46448" y="39072"/>
                      </a:lnTo>
                      <a:lnTo>
                        <a:pt x="76772" y="82194"/>
                      </a:lnTo>
                      <a:lnTo>
                        <a:pt x="59806" y="82194"/>
                      </a:lnTo>
                      <a:lnTo>
                        <a:pt x="43100" y="56856"/>
                      </a:lnTo>
                      <a:lnTo>
                        <a:pt x="38635" y="50048"/>
                      </a:lnTo>
                      <a:lnTo>
                        <a:pt x="17241" y="8219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5" name="Freihandform: Form 204">
                  <a:extLst>
                    <a:ext uri="{FF2B5EF4-FFF2-40B4-BE49-F238E27FC236}">
                      <a16:creationId xmlns:a16="http://schemas.microsoft.com/office/drawing/2014/main" id="{68C56EF8-14CA-4C18-BC95-EFADD799CA02}"/>
                    </a:ext>
                  </a:extLst>
                </p:cNvPr>
                <p:cNvSpPr/>
                <p:nvPr/>
              </p:nvSpPr>
              <p:spPr>
                <a:xfrm>
                  <a:off x="6123202" y="6689378"/>
                  <a:ext cx="70767" cy="114560"/>
                </a:xfrm>
                <a:custGeom>
                  <a:avLst/>
                  <a:gdLst>
                    <a:gd name="connsiteX0" fmla="*/ 506 w 70767"/>
                    <a:gd name="connsiteY0" fmla="*/ 115271 h 114560"/>
                    <a:gd name="connsiteX1" fmla="*/ 506 w 70767"/>
                    <a:gd name="connsiteY1" fmla="*/ 2571 h 114560"/>
                    <a:gd name="connsiteX2" fmla="*/ 13119 w 70767"/>
                    <a:gd name="connsiteY2" fmla="*/ 2571 h 114560"/>
                    <a:gd name="connsiteX3" fmla="*/ 13119 w 70767"/>
                    <a:gd name="connsiteY3" fmla="*/ 13138 h 114560"/>
                    <a:gd name="connsiteX4" fmla="*/ 23128 w 70767"/>
                    <a:gd name="connsiteY4" fmla="*/ 3836 h 114560"/>
                    <a:gd name="connsiteX5" fmla="*/ 36745 w 70767"/>
                    <a:gd name="connsiteY5" fmla="*/ 711 h 114560"/>
                    <a:gd name="connsiteX6" fmla="*/ 55126 w 70767"/>
                    <a:gd name="connsiteY6" fmla="*/ 6106 h 114560"/>
                    <a:gd name="connsiteX7" fmla="*/ 67181 w 70767"/>
                    <a:gd name="connsiteY7" fmla="*/ 21249 h 114560"/>
                    <a:gd name="connsiteX8" fmla="*/ 71273 w 70767"/>
                    <a:gd name="connsiteY8" fmla="*/ 42681 h 114560"/>
                    <a:gd name="connsiteX9" fmla="*/ 66771 w 70767"/>
                    <a:gd name="connsiteY9" fmla="*/ 65228 h 114560"/>
                    <a:gd name="connsiteX10" fmla="*/ 53749 w 70767"/>
                    <a:gd name="connsiteY10" fmla="*/ 80595 h 114560"/>
                    <a:gd name="connsiteX11" fmla="*/ 35741 w 70767"/>
                    <a:gd name="connsiteY11" fmla="*/ 85915 h 114560"/>
                    <a:gd name="connsiteX12" fmla="*/ 23351 w 70767"/>
                    <a:gd name="connsiteY12" fmla="*/ 83013 h 114560"/>
                    <a:gd name="connsiteX13" fmla="*/ 14347 w 70767"/>
                    <a:gd name="connsiteY13" fmla="*/ 75609 h 114560"/>
                    <a:gd name="connsiteX14" fmla="*/ 14347 w 70767"/>
                    <a:gd name="connsiteY14" fmla="*/ 115271 h 114560"/>
                    <a:gd name="connsiteX15" fmla="*/ 13044 w 70767"/>
                    <a:gd name="connsiteY15" fmla="*/ 43760 h 114560"/>
                    <a:gd name="connsiteX16" fmla="*/ 19407 w 70767"/>
                    <a:gd name="connsiteY16" fmla="*/ 67014 h 114560"/>
                    <a:gd name="connsiteX17" fmla="*/ 34811 w 70767"/>
                    <a:gd name="connsiteY17" fmla="*/ 74530 h 114560"/>
                    <a:gd name="connsiteX18" fmla="*/ 50586 w 70767"/>
                    <a:gd name="connsiteY18" fmla="*/ 66753 h 114560"/>
                    <a:gd name="connsiteX19" fmla="*/ 57172 w 70767"/>
                    <a:gd name="connsiteY19" fmla="*/ 42606 h 114560"/>
                    <a:gd name="connsiteX20" fmla="*/ 50735 w 70767"/>
                    <a:gd name="connsiteY20" fmla="*/ 19315 h 114560"/>
                    <a:gd name="connsiteX21" fmla="*/ 35443 w 70767"/>
                    <a:gd name="connsiteY21" fmla="*/ 11538 h 114560"/>
                    <a:gd name="connsiteX22" fmla="*/ 19816 w 70767"/>
                    <a:gd name="connsiteY22" fmla="*/ 19798 h 114560"/>
                    <a:gd name="connsiteX23" fmla="*/ 13044 w 70767"/>
                    <a:gd name="connsiteY23" fmla="*/ 43760 h 114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</a:cxnLst>
                  <a:rect l="l" t="t" r="r" b="b"/>
                  <a:pathLst>
                    <a:path w="70767" h="114560">
                      <a:moveTo>
                        <a:pt x="506" y="115271"/>
                      </a:moveTo>
                      <a:lnTo>
                        <a:pt x="506" y="2571"/>
                      </a:lnTo>
                      <a:lnTo>
                        <a:pt x="13119" y="2571"/>
                      </a:lnTo>
                      <a:lnTo>
                        <a:pt x="13119" y="13138"/>
                      </a:lnTo>
                      <a:cubicBezTo>
                        <a:pt x="16021" y="9008"/>
                        <a:pt x="19370" y="5920"/>
                        <a:pt x="23128" y="3836"/>
                      </a:cubicBezTo>
                      <a:cubicBezTo>
                        <a:pt x="26848" y="1790"/>
                        <a:pt x="31388" y="748"/>
                        <a:pt x="36745" y="711"/>
                      </a:cubicBezTo>
                      <a:cubicBezTo>
                        <a:pt x="43666" y="748"/>
                        <a:pt x="49805" y="2534"/>
                        <a:pt x="55126" y="6106"/>
                      </a:cubicBezTo>
                      <a:cubicBezTo>
                        <a:pt x="60446" y="9715"/>
                        <a:pt x="64465" y="14775"/>
                        <a:pt x="67181" y="21249"/>
                      </a:cubicBezTo>
                      <a:cubicBezTo>
                        <a:pt x="69897" y="27798"/>
                        <a:pt x="71236" y="34942"/>
                        <a:pt x="71273" y="42681"/>
                      </a:cubicBezTo>
                      <a:cubicBezTo>
                        <a:pt x="71236" y="51052"/>
                        <a:pt x="69748" y="58568"/>
                        <a:pt x="66771" y="65228"/>
                      </a:cubicBezTo>
                      <a:cubicBezTo>
                        <a:pt x="63758" y="71925"/>
                        <a:pt x="59404" y="77023"/>
                        <a:pt x="53749" y="80595"/>
                      </a:cubicBezTo>
                      <a:cubicBezTo>
                        <a:pt x="48019" y="84129"/>
                        <a:pt x="42029" y="85878"/>
                        <a:pt x="35741" y="85915"/>
                      </a:cubicBezTo>
                      <a:cubicBezTo>
                        <a:pt x="31127" y="85878"/>
                        <a:pt x="26997" y="84948"/>
                        <a:pt x="23351" y="83013"/>
                      </a:cubicBezTo>
                      <a:cubicBezTo>
                        <a:pt x="19667" y="81078"/>
                        <a:pt x="16654" y="78623"/>
                        <a:pt x="14347" y="75609"/>
                      </a:cubicBezTo>
                      <a:lnTo>
                        <a:pt x="14347" y="115271"/>
                      </a:lnTo>
                      <a:close/>
                      <a:moveTo>
                        <a:pt x="13044" y="43760"/>
                      </a:moveTo>
                      <a:cubicBezTo>
                        <a:pt x="13044" y="54252"/>
                        <a:pt x="15165" y="62028"/>
                        <a:pt x="19407" y="67014"/>
                      </a:cubicBezTo>
                      <a:cubicBezTo>
                        <a:pt x="23648" y="72074"/>
                        <a:pt x="28783" y="74567"/>
                        <a:pt x="34811" y="74530"/>
                      </a:cubicBezTo>
                      <a:cubicBezTo>
                        <a:pt x="40950" y="74567"/>
                        <a:pt x="46196" y="71963"/>
                        <a:pt x="50586" y="66753"/>
                      </a:cubicBezTo>
                      <a:cubicBezTo>
                        <a:pt x="54940" y="61582"/>
                        <a:pt x="57135" y="53545"/>
                        <a:pt x="57172" y="42606"/>
                      </a:cubicBezTo>
                      <a:cubicBezTo>
                        <a:pt x="57135" y="32263"/>
                        <a:pt x="54977" y="24486"/>
                        <a:pt x="50735" y="19315"/>
                      </a:cubicBezTo>
                      <a:cubicBezTo>
                        <a:pt x="46419" y="14143"/>
                        <a:pt x="41322" y="11575"/>
                        <a:pt x="35443" y="11538"/>
                      </a:cubicBezTo>
                      <a:cubicBezTo>
                        <a:pt x="29527" y="11575"/>
                        <a:pt x="24318" y="14329"/>
                        <a:pt x="19816" y="19798"/>
                      </a:cubicBezTo>
                      <a:cubicBezTo>
                        <a:pt x="15277" y="25305"/>
                        <a:pt x="13044" y="33267"/>
                        <a:pt x="13044" y="43760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6" name="Freihandform: Form 205">
                  <a:extLst>
                    <a:ext uri="{FF2B5EF4-FFF2-40B4-BE49-F238E27FC236}">
                      <a16:creationId xmlns:a16="http://schemas.microsoft.com/office/drawing/2014/main" id="{1ADE9670-4714-4121-A560-6713844B7F0F}"/>
                    </a:ext>
                  </a:extLst>
                </p:cNvPr>
                <p:cNvSpPr/>
                <p:nvPr/>
              </p:nvSpPr>
              <p:spPr>
                <a:xfrm>
                  <a:off x="6210306" y="6660208"/>
                  <a:ext cx="13803" cy="112514"/>
                </a:xfrm>
                <a:custGeom>
                  <a:avLst/>
                  <a:gdLst>
                    <a:gd name="connsiteX0" fmla="*/ 515 w 13803"/>
                    <a:gd name="connsiteY0" fmla="*/ 113225 h 112514"/>
                    <a:gd name="connsiteX1" fmla="*/ 515 w 13803"/>
                    <a:gd name="connsiteY1" fmla="*/ 711 h 112514"/>
                    <a:gd name="connsiteX2" fmla="*/ 14319 w 13803"/>
                    <a:gd name="connsiteY2" fmla="*/ 711 h 112514"/>
                    <a:gd name="connsiteX3" fmla="*/ 14319 w 13803"/>
                    <a:gd name="connsiteY3" fmla="*/ 113225 h 11251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3803" h="112514">
                      <a:moveTo>
                        <a:pt x="515" y="113225"/>
                      </a:moveTo>
                      <a:lnTo>
                        <a:pt x="515" y="711"/>
                      </a:lnTo>
                      <a:lnTo>
                        <a:pt x="14319" y="711"/>
                      </a:lnTo>
                      <a:lnTo>
                        <a:pt x="14319" y="113225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7" name="Freihandform: Form 206">
                  <a:extLst>
                    <a:ext uri="{FF2B5EF4-FFF2-40B4-BE49-F238E27FC236}">
                      <a16:creationId xmlns:a16="http://schemas.microsoft.com/office/drawing/2014/main" id="{B3C9B050-618D-41B8-95D5-105A68548180}"/>
                    </a:ext>
                  </a:extLst>
                </p:cNvPr>
                <p:cNvSpPr/>
                <p:nvPr/>
              </p:nvSpPr>
              <p:spPr>
                <a:xfrm>
                  <a:off x="6249466" y="6756984"/>
                  <a:ext cx="15701" cy="15738"/>
                </a:xfrm>
                <a:custGeom>
                  <a:avLst/>
                  <a:gdLst>
                    <a:gd name="connsiteX0" fmla="*/ 519 w 15701"/>
                    <a:gd name="connsiteY0" fmla="*/ 16450 h 15738"/>
                    <a:gd name="connsiteX1" fmla="*/ 519 w 15701"/>
                    <a:gd name="connsiteY1" fmla="*/ 711 h 15738"/>
                    <a:gd name="connsiteX2" fmla="*/ 16220 w 15701"/>
                    <a:gd name="connsiteY2" fmla="*/ 711 h 15738"/>
                    <a:gd name="connsiteX3" fmla="*/ 16220 w 15701"/>
                    <a:gd name="connsiteY3" fmla="*/ 16450 h 1573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5701" h="15738">
                      <a:moveTo>
                        <a:pt x="519" y="16450"/>
                      </a:moveTo>
                      <a:lnTo>
                        <a:pt x="519" y="711"/>
                      </a:lnTo>
                      <a:lnTo>
                        <a:pt x="16220" y="711"/>
                      </a:lnTo>
                      <a:lnTo>
                        <a:pt x="16220" y="1645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8" name="Freihandform: Form 207">
                  <a:extLst>
                    <a:ext uri="{FF2B5EF4-FFF2-40B4-BE49-F238E27FC236}">
                      <a16:creationId xmlns:a16="http://schemas.microsoft.com/office/drawing/2014/main" id="{506BE38D-3DB2-4584-BFAB-74101F4FC91B}"/>
                    </a:ext>
                  </a:extLst>
                </p:cNvPr>
                <p:cNvSpPr/>
                <p:nvPr/>
              </p:nvSpPr>
              <p:spPr>
                <a:xfrm>
                  <a:off x="6278841" y="6772722"/>
                  <a:ext cx="9525" cy="9525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525" h="9525"/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9" name="Freihandform: Form 208">
                  <a:extLst>
                    <a:ext uri="{FF2B5EF4-FFF2-40B4-BE49-F238E27FC236}">
                      <a16:creationId xmlns:a16="http://schemas.microsoft.com/office/drawing/2014/main" id="{B3B70FCA-F188-42E7-BA28-62DA7B2CD5EC}"/>
                    </a:ext>
                  </a:extLst>
                </p:cNvPr>
                <p:cNvSpPr/>
                <p:nvPr/>
              </p:nvSpPr>
              <p:spPr>
                <a:xfrm>
                  <a:off x="6324523" y="6691239"/>
                  <a:ext cx="74711" cy="81483"/>
                </a:xfrm>
                <a:custGeom>
                  <a:avLst/>
                  <a:gdLst>
                    <a:gd name="connsiteX0" fmla="*/ 31521 w 74711"/>
                    <a:gd name="connsiteY0" fmla="*/ 82194 h 81483"/>
                    <a:gd name="connsiteX1" fmla="*/ 528 w 74711"/>
                    <a:gd name="connsiteY1" fmla="*/ 711 h 81483"/>
                    <a:gd name="connsiteX2" fmla="*/ 15113 w 74711"/>
                    <a:gd name="connsiteY2" fmla="*/ 711 h 81483"/>
                    <a:gd name="connsiteX3" fmla="*/ 32600 w 74711"/>
                    <a:gd name="connsiteY3" fmla="*/ 49490 h 81483"/>
                    <a:gd name="connsiteX4" fmla="*/ 37809 w 74711"/>
                    <a:gd name="connsiteY4" fmla="*/ 65935 h 81483"/>
                    <a:gd name="connsiteX5" fmla="*/ 42944 w 74711"/>
                    <a:gd name="connsiteY5" fmla="*/ 50420 h 81483"/>
                    <a:gd name="connsiteX6" fmla="*/ 61064 w 74711"/>
                    <a:gd name="connsiteY6" fmla="*/ 711 h 81483"/>
                    <a:gd name="connsiteX7" fmla="*/ 75240 w 74711"/>
                    <a:gd name="connsiteY7" fmla="*/ 711 h 81483"/>
                    <a:gd name="connsiteX8" fmla="*/ 44395 w 74711"/>
                    <a:gd name="connsiteY8" fmla="*/ 82194 h 814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74711" h="81483">
                      <a:moveTo>
                        <a:pt x="31521" y="82194"/>
                      </a:moveTo>
                      <a:lnTo>
                        <a:pt x="528" y="711"/>
                      </a:lnTo>
                      <a:lnTo>
                        <a:pt x="15113" y="711"/>
                      </a:lnTo>
                      <a:lnTo>
                        <a:pt x="32600" y="49490"/>
                      </a:lnTo>
                      <a:cubicBezTo>
                        <a:pt x="34461" y="54773"/>
                        <a:pt x="36209" y="60280"/>
                        <a:pt x="37809" y="65935"/>
                      </a:cubicBezTo>
                      <a:cubicBezTo>
                        <a:pt x="39037" y="61693"/>
                        <a:pt x="40749" y="56522"/>
                        <a:pt x="42944" y="50420"/>
                      </a:cubicBezTo>
                      <a:lnTo>
                        <a:pt x="61064" y="711"/>
                      </a:lnTo>
                      <a:lnTo>
                        <a:pt x="75240" y="711"/>
                      </a:lnTo>
                      <a:lnTo>
                        <a:pt x="44395" y="8219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0" name="Freihandform: Form 209">
                  <a:extLst>
                    <a:ext uri="{FF2B5EF4-FFF2-40B4-BE49-F238E27FC236}">
                      <a16:creationId xmlns:a16="http://schemas.microsoft.com/office/drawing/2014/main" id="{98BC638F-2981-4E21-A739-B4391AF9069B}"/>
                    </a:ext>
                  </a:extLst>
                </p:cNvPr>
                <p:cNvSpPr/>
                <p:nvPr/>
              </p:nvSpPr>
              <p:spPr>
                <a:xfrm>
                  <a:off x="6406787" y="6689378"/>
                  <a:ext cx="75046" cy="85204"/>
                </a:xfrm>
                <a:custGeom>
                  <a:avLst/>
                  <a:gdLst>
                    <a:gd name="connsiteX0" fmla="*/ 58393 w 75046"/>
                    <a:gd name="connsiteY0" fmla="*/ 74009 h 85204"/>
                    <a:gd name="connsiteX1" fmla="*/ 43622 w 75046"/>
                    <a:gd name="connsiteY1" fmla="*/ 83236 h 85204"/>
                    <a:gd name="connsiteX2" fmla="*/ 28367 w 75046"/>
                    <a:gd name="connsiteY2" fmla="*/ 85915 h 85204"/>
                    <a:gd name="connsiteX3" fmla="*/ 7717 w 75046"/>
                    <a:gd name="connsiteY3" fmla="*/ 79367 h 85204"/>
                    <a:gd name="connsiteX4" fmla="*/ 536 w 75046"/>
                    <a:gd name="connsiteY4" fmla="*/ 62549 h 85204"/>
                    <a:gd name="connsiteX5" fmla="*/ 3252 w 75046"/>
                    <a:gd name="connsiteY5" fmla="*/ 51648 h 85204"/>
                    <a:gd name="connsiteX6" fmla="*/ 10359 w 75046"/>
                    <a:gd name="connsiteY6" fmla="*/ 43722 h 85204"/>
                    <a:gd name="connsiteX7" fmla="*/ 20330 w 75046"/>
                    <a:gd name="connsiteY7" fmla="*/ 39146 h 85204"/>
                    <a:gd name="connsiteX8" fmla="*/ 32608 w 75046"/>
                    <a:gd name="connsiteY8" fmla="*/ 37100 h 85204"/>
                    <a:gd name="connsiteX9" fmla="*/ 57240 w 75046"/>
                    <a:gd name="connsiteY9" fmla="*/ 32337 h 85204"/>
                    <a:gd name="connsiteX10" fmla="*/ 57314 w 75046"/>
                    <a:gd name="connsiteY10" fmla="*/ 28728 h 85204"/>
                    <a:gd name="connsiteX11" fmla="*/ 53407 w 75046"/>
                    <a:gd name="connsiteY11" fmla="*/ 16822 h 85204"/>
                    <a:gd name="connsiteX12" fmla="*/ 37669 w 75046"/>
                    <a:gd name="connsiteY12" fmla="*/ 12134 h 85204"/>
                    <a:gd name="connsiteX13" fmla="*/ 23270 w 75046"/>
                    <a:gd name="connsiteY13" fmla="*/ 15557 h 85204"/>
                    <a:gd name="connsiteX14" fmla="*/ 16423 w 75046"/>
                    <a:gd name="connsiteY14" fmla="*/ 27649 h 85204"/>
                    <a:gd name="connsiteX15" fmla="*/ 2917 w 75046"/>
                    <a:gd name="connsiteY15" fmla="*/ 25826 h 85204"/>
                    <a:gd name="connsiteX16" fmla="*/ 8945 w 75046"/>
                    <a:gd name="connsiteY16" fmla="*/ 11836 h 85204"/>
                    <a:gd name="connsiteX17" fmla="*/ 21149 w 75046"/>
                    <a:gd name="connsiteY17" fmla="*/ 3613 h 85204"/>
                    <a:gd name="connsiteX18" fmla="*/ 39641 w 75046"/>
                    <a:gd name="connsiteY18" fmla="*/ 711 h 85204"/>
                    <a:gd name="connsiteX19" fmla="*/ 56607 w 75046"/>
                    <a:gd name="connsiteY19" fmla="*/ 3167 h 85204"/>
                    <a:gd name="connsiteX20" fmla="*/ 66206 w 75046"/>
                    <a:gd name="connsiteY20" fmla="*/ 9343 h 85204"/>
                    <a:gd name="connsiteX21" fmla="*/ 70522 w 75046"/>
                    <a:gd name="connsiteY21" fmla="*/ 18756 h 85204"/>
                    <a:gd name="connsiteX22" fmla="*/ 71192 w 75046"/>
                    <a:gd name="connsiteY22" fmla="*/ 31481 h 85204"/>
                    <a:gd name="connsiteX23" fmla="*/ 71192 w 75046"/>
                    <a:gd name="connsiteY23" fmla="*/ 49899 h 85204"/>
                    <a:gd name="connsiteX24" fmla="*/ 72085 w 75046"/>
                    <a:gd name="connsiteY24" fmla="*/ 74269 h 85204"/>
                    <a:gd name="connsiteX25" fmla="*/ 75583 w 75046"/>
                    <a:gd name="connsiteY25" fmla="*/ 84055 h 85204"/>
                    <a:gd name="connsiteX26" fmla="*/ 61146 w 75046"/>
                    <a:gd name="connsiteY26" fmla="*/ 84055 h 85204"/>
                    <a:gd name="connsiteX27" fmla="*/ 58393 w 75046"/>
                    <a:gd name="connsiteY27" fmla="*/ 74009 h 85204"/>
                    <a:gd name="connsiteX28" fmla="*/ 57240 w 75046"/>
                    <a:gd name="connsiteY28" fmla="*/ 43164 h 85204"/>
                    <a:gd name="connsiteX29" fmla="*/ 34655 w 75046"/>
                    <a:gd name="connsiteY29" fmla="*/ 48373 h 85204"/>
                    <a:gd name="connsiteX30" fmla="*/ 22637 w 75046"/>
                    <a:gd name="connsiteY30" fmla="*/ 51127 h 85204"/>
                    <a:gd name="connsiteX31" fmla="*/ 17168 w 75046"/>
                    <a:gd name="connsiteY31" fmla="*/ 55629 h 85204"/>
                    <a:gd name="connsiteX32" fmla="*/ 15270 w 75046"/>
                    <a:gd name="connsiteY32" fmla="*/ 62177 h 85204"/>
                    <a:gd name="connsiteX33" fmla="*/ 19437 w 75046"/>
                    <a:gd name="connsiteY33" fmla="*/ 71404 h 85204"/>
                    <a:gd name="connsiteX34" fmla="*/ 31678 w 75046"/>
                    <a:gd name="connsiteY34" fmla="*/ 75088 h 85204"/>
                    <a:gd name="connsiteX35" fmla="*/ 45854 w 75046"/>
                    <a:gd name="connsiteY35" fmla="*/ 71590 h 85204"/>
                    <a:gd name="connsiteX36" fmla="*/ 55007 w 75046"/>
                    <a:gd name="connsiteY36" fmla="*/ 62028 h 85204"/>
                    <a:gd name="connsiteX37" fmla="*/ 57240 w 75046"/>
                    <a:gd name="connsiteY37" fmla="*/ 48224 h 8520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</a:cxnLst>
                  <a:rect l="l" t="t" r="r" b="b"/>
                  <a:pathLst>
                    <a:path w="75046" h="85204">
                      <a:moveTo>
                        <a:pt x="58393" y="74009"/>
                      </a:moveTo>
                      <a:cubicBezTo>
                        <a:pt x="53258" y="78362"/>
                        <a:pt x="48347" y="81450"/>
                        <a:pt x="43622" y="83236"/>
                      </a:cubicBezTo>
                      <a:cubicBezTo>
                        <a:pt x="38859" y="85022"/>
                        <a:pt x="33762" y="85878"/>
                        <a:pt x="28367" y="85915"/>
                      </a:cubicBezTo>
                      <a:cubicBezTo>
                        <a:pt x="19400" y="85878"/>
                        <a:pt x="12517" y="83720"/>
                        <a:pt x="7717" y="79367"/>
                      </a:cubicBezTo>
                      <a:cubicBezTo>
                        <a:pt x="2917" y="74976"/>
                        <a:pt x="536" y="69395"/>
                        <a:pt x="536" y="62549"/>
                      </a:cubicBezTo>
                      <a:cubicBezTo>
                        <a:pt x="536" y="58605"/>
                        <a:pt x="1429" y="54959"/>
                        <a:pt x="3252" y="51648"/>
                      </a:cubicBezTo>
                      <a:cubicBezTo>
                        <a:pt x="5038" y="48373"/>
                        <a:pt x="7419" y="45732"/>
                        <a:pt x="10359" y="43722"/>
                      </a:cubicBezTo>
                      <a:cubicBezTo>
                        <a:pt x="13298" y="41750"/>
                        <a:pt x="16610" y="40225"/>
                        <a:pt x="20330" y="39146"/>
                      </a:cubicBezTo>
                      <a:cubicBezTo>
                        <a:pt x="23009" y="38476"/>
                        <a:pt x="27102" y="37806"/>
                        <a:pt x="32608" y="37100"/>
                      </a:cubicBezTo>
                      <a:cubicBezTo>
                        <a:pt x="43733" y="35797"/>
                        <a:pt x="51956" y="34197"/>
                        <a:pt x="57240" y="32337"/>
                      </a:cubicBezTo>
                      <a:cubicBezTo>
                        <a:pt x="57277" y="30477"/>
                        <a:pt x="57277" y="29286"/>
                        <a:pt x="57314" y="28728"/>
                      </a:cubicBezTo>
                      <a:cubicBezTo>
                        <a:pt x="57277" y="23147"/>
                        <a:pt x="55975" y="19166"/>
                        <a:pt x="53407" y="16822"/>
                      </a:cubicBezTo>
                      <a:cubicBezTo>
                        <a:pt x="49835" y="13734"/>
                        <a:pt x="44589" y="12171"/>
                        <a:pt x="37669" y="12134"/>
                      </a:cubicBezTo>
                      <a:cubicBezTo>
                        <a:pt x="31120" y="12171"/>
                        <a:pt x="26321" y="13324"/>
                        <a:pt x="23270" y="15557"/>
                      </a:cubicBezTo>
                      <a:cubicBezTo>
                        <a:pt x="20144" y="17863"/>
                        <a:pt x="17875" y="21882"/>
                        <a:pt x="16423" y="27649"/>
                      </a:cubicBezTo>
                      <a:lnTo>
                        <a:pt x="2917" y="25826"/>
                      </a:lnTo>
                      <a:cubicBezTo>
                        <a:pt x="4108" y="20096"/>
                        <a:pt x="6117" y="15408"/>
                        <a:pt x="8945" y="11836"/>
                      </a:cubicBezTo>
                      <a:cubicBezTo>
                        <a:pt x="11735" y="8264"/>
                        <a:pt x="15791" y="5548"/>
                        <a:pt x="21149" y="3613"/>
                      </a:cubicBezTo>
                      <a:cubicBezTo>
                        <a:pt x="26432" y="1716"/>
                        <a:pt x="32608" y="748"/>
                        <a:pt x="39641" y="711"/>
                      </a:cubicBezTo>
                      <a:cubicBezTo>
                        <a:pt x="46598" y="748"/>
                        <a:pt x="52254" y="1567"/>
                        <a:pt x="56607" y="3167"/>
                      </a:cubicBezTo>
                      <a:cubicBezTo>
                        <a:pt x="60960" y="4841"/>
                        <a:pt x="64160" y="6887"/>
                        <a:pt x="66206" y="9343"/>
                      </a:cubicBezTo>
                      <a:cubicBezTo>
                        <a:pt x="68253" y="11836"/>
                        <a:pt x="69704" y="14961"/>
                        <a:pt x="70522" y="18756"/>
                      </a:cubicBezTo>
                      <a:cubicBezTo>
                        <a:pt x="70969" y="21138"/>
                        <a:pt x="71192" y="25379"/>
                        <a:pt x="71192" y="31481"/>
                      </a:cubicBezTo>
                      <a:lnTo>
                        <a:pt x="71192" y="49899"/>
                      </a:lnTo>
                      <a:cubicBezTo>
                        <a:pt x="71192" y="62772"/>
                        <a:pt x="71490" y="70921"/>
                        <a:pt x="72085" y="74269"/>
                      </a:cubicBezTo>
                      <a:cubicBezTo>
                        <a:pt x="72681" y="77692"/>
                        <a:pt x="73834" y="80929"/>
                        <a:pt x="75583" y="84055"/>
                      </a:cubicBezTo>
                      <a:lnTo>
                        <a:pt x="61146" y="84055"/>
                      </a:lnTo>
                      <a:cubicBezTo>
                        <a:pt x="59695" y="81190"/>
                        <a:pt x="58765" y="77841"/>
                        <a:pt x="58393" y="74009"/>
                      </a:cubicBezTo>
                      <a:close/>
                      <a:moveTo>
                        <a:pt x="57240" y="43164"/>
                      </a:moveTo>
                      <a:cubicBezTo>
                        <a:pt x="52217" y="45211"/>
                        <a:pt x="44664" y="46959"/>
                        <a:pt x="34655" y="48373"/>
                      </a:cubicBezTo>
                      <a:cubicBezTo>
                        <a:pt x="28962" y="49229"/>
                        <a:pt x="24981" y="50122"/>
                        <a:pt x="22637" y="51127"/>
                      </a:cubicBezTo>
                      <a:cubicBezTo>
                        <a:pt x="20256" y="52168"/>
                        <a:pt x="18433" y="53694"/>
                        <a:pt x="17168" y="55629"/>
                      </a:cubicBezTo>
                      <a:cubicBezTo>
                        <a:pt x="15903" y="57638"/>
                        <a:pt x="15270" y="59796"/>
                        <a:pt x="15270" y="62177"/>
                      </a:cubicBezTo>
                      <a:cubicBezTo>
                        <a:pt x="15270" y="65898"/>
                        <a:pt x="16647" y="68986"/>
                        <a:pt x="19437" y="71404"/>
                      </a:cubicBezTo>
                      <a:cubicBezTo>
                        <a:pt x="22190" y="73897"/>
                        <a:pt x="26283" y="75125"/>
                        <a:pt x="31678" y="75088"/>
                      </a:cubicBezTo>
                      <a:cubicBezTo>
                        <a:pt x="36962" y="75125"/>
                        <a:pt x="41687" y="73972"/>
                        <a:pt x="45854" y="71590"/>
                      </a:cubicBezTo>
                      <a:cubicBezTo>
                        <a:pt x="50021" y="69284"/>
                        <a:pt x="53072" y="66084"/>
                        <a:pt x="55007" y="62028"/>
                      </a:cubicBezTo>
                      <a:cubicBezTo>
                        <a:pt x="56495" y="58940"/>
                        <a:pt x="57240" y="54326"/>
                        <a:pt x="57240" y="48224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1" name="Freihandform: Form 210">
                  <a:extLst>
                    <a:ext uri="{FF2B5EF4-FFF2-40B4-BE49-F238E27FC236}">
                      <a16:creationId xmlns:a16="http://schemas.microsoft.com/office/drawing/2014/main" id="{17112CF4-B5C7-4439-A3C0-8A238C313ADB}"/>
                    </a:ext>
                  </a:extLst>
                </p:cNvPr>
                <p:cNvSpPr/>
                <p:nvPr/>
              </p:nvSpPr>
              <p:spPr>
                <a:xfrm>
                  <a:off x="6498691" y="6689378"/>
                  <a:ext cx="44276" cy="83343"/>
                </a:xfrm>
                <a:custGeom>
                  <a:avLst/>
                  <a:gdLst>
                    <a:gd name="connsiteX0" fmla="*/ 545 w 44276"/>
                    <a:gd name="connsiteY0" fmla="*/ 84055 h 83343"/>
                    <a:gd name="connsiteX1" fmla="*/ 545 w 44276"/>
                    <a:gd name="connsiteY1" fmla="*/ 2571 h 83343"/>
                    <a:gd name="connsiteX2" fmla="*/ 12972 w 44276"/>
                    <a:gd name="connsiteY2" fmla="*/ 2571 h 83343"/>
                    <a:gd name="connsiteX3" fmla="*/ 12972 w 44276"/>
                    <a:gd name="connsiteY3" fmla="*/ 14924 h 83343"/>
                    <a:gd name="connsiteX4" fmla="*/ 21753 w 44276"/>
                    <a:gd name="connsiteY4" fmla="*/ 3502 h 83343"/>
                    <a:gd name="connsiteX5" fmla="*/ 30646 w 44276"/>
                    <a:gd name="connsiteY5" fmla="*/ 711 h 83343"/>
                    <a:gd name="connsiteX6" fmla="*/ 44822 w 44276"/>
                    <a:gd name="connsiteY6" fmla="*/ 5176 h 83343"/>
                    <a:gd name="connsiteX7" fmla="*/ 40059 w 44276"/>
                    <a:gd name="connsiteY7" fmla="*/ 17975 h 83343"/>
                    <a:gd name="connsiteX8" fmla="*/ 29939 w 44276"/>
                    <a:gd name="connsiteY8" fmla="*/ 14999 h 83343"/>
                    <a:gd name="connsiteX9" fmla="*/ 21828 w 44276"/>
                    <a:gd name="connsiteY9" fmla="*/ 17715 h 83343"/>
                    <a:gd name="connsiteX10" fmla="*/ 16656 w 44276"/>
                    <a:gd name="connsiteY10" fmla="*/ 25268 h 83343"/>
                    <a:gd name="connsiteX11" fmla="*/ 14386 w 44276"/>
                    <a:gd name="connsiteY11" fmla="*/ 41378 h 83343"/>
                    <a:gd name="connsiteX12" fmla="*/ 14386 w 44276"/>
                    <a:gd name="connsiteY12" fmla="*/ 84055 h 8334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44276" h="83343">
                      <a:moveTo>
                        <a:pt x="545" y="84055"/>
                      </a:moveTo>
                      <a:lnTo>
                        <a:pt x="545" y="2571"/>
                      </a:lnTo>
                      <a:lnTo>
                        <a:pt x="12972" y="2571"/>
                      </a:lnTo>
                      <a:lnTo>
                        <a:pt x="12972" y="14924"/>
                      </a:lnTo>
                      <a:cubicBezTo>
                        <a:pt x="16098" y="9157"/>
                        <a:pt x="19037" y="5362"/>
                        <a:pt x="21753" y="3502"/>
                      </a:cubicBezTo>
                      <a:cubicBezTo>
                        <a:pt x="24432" y="1678"/>
                        <a:pt x="27409" y="748"/>
                        <a:pt x="30646" y="711"/>
                      </a:cubicBezTo>
                      <a:cubicBezTo>
                        <a:pt x="35259" y="748"/>
                        <a:pt x="39985" y="2237"/>
                        <a:pt x="44822" y="5176"/>
                      </a:cubicBezTo>
                      <a:lnTo>
                        <a:pt x="40059" y="17975"/>
                      </a:lnTo>
                      <a:cubicBezTo>
                        <a:pt x="36673" y="16003"/>
                        <a:pt x="33287" y="15036"/>
                        <a:pt x="29939" y="14999"/>
                      </a:cubicBezTo>
                      <a:cubicBezTo>
                        <a:pt x="26888" y="15036"/>
                        <a:pt x="24209" y="15929"/>
                        <a:pt x="21828" y="17715"/>
                      </a:cubicBezTo>
                      <a:cubicBezTo>
                        <a:pt x="19409" y="19538"/>
                        <a:pt x="17660" y="22068"/>
                        <a:pt x="16656" y="25268"/>
                      </a:cubicBezTo>
                      <a:cubicBezTo>
                        <a:pt x="15093" y="30216"/>
                        <a:pt x="14349" y="35574"/>
                        <a:pt x="14386" y="41378"/>
                      </a:cubicBezTo>
                      <a:lnTo>
                        <a:pt x="14386" y="84055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grpSp>
            <p:nvGrpSpPr>
              <p:cNvPr id="212" name="Grafik 3">
                <a:extLst>
                  <a:ext uri="{FF2B5EF4-FFF2-40B4-BE49-F238E27FC236}">
                    <a16:creationId xmlns:a16="http://schemas.microsoft.com/office/drawing/2014/main" id="{DAA6B4BA-F016-42FC-B09A-64541C4069E0}"/>
                  </a:ext>
                </a:extLst>
              </p:cNvPr>
              <p:cNvGrpSpPr/>
              <p:nvPr/>
            </p:nvGrpSpPr>
            <p:grpSpPr>
              <a:xfrm>
                <a:off x="-30410" y="2683678"/>
                <a:ext cx="195655" cy="1793940"/>
                <a:chOff x="1345667" y="2696396"/>
                <a:chExt cx="145628" cy="1335246"/>
              </a:xfrm>
              <a:solidFill>
                <a:srgbClr val="000000"/>
              </a:solidFill>
            </p:grpSpPr>
            <p:sp>
              <p:nvSpPr>
                <p:cNvPr id="213" name="Freihandform: Form 212">
                  <a:extLst>
                    <a:ext uri="{FF2B5EF4-FFF2-40B4-BE49-F238E27FC236}">
                      <a16:creationId xmlns:a16="http://schemas.microsoft.com/office/drawing/2014/main" id="{6765391E-D528-44C1-A268-D5CD6B5EBF61}"/>
                    </a:ext>
                  </a:extLst>
                </p:cNvPr>
                <p:cNvSpPr/>
                <p:nvPr/>
              </p:nvSpPr>
              <p:spPr>
                <a:xfrm>
                  <a:off x="1347564" y="3945768"/>
                  <a:ext cx="112514" cy="85874"/>
                </a:xfrm>
                <a:custGeom>
                  <a:avLst/>
                  <a:gdLst>
                    <a:gd name="connsiteX0" fmla="*/ 112531 w 112514"/>
                    <a:gd name="connsiteY0" fmla="*/ 86299 h 85874"/>
                    <a:gd name="connsiteX1" fmla="*/ 17 w 112514"/>
                    <a:gd name="connsiteY1" fmla="*/ 86299 h 85874"/>
                    <a:gd name="connsiteX2" fmla="*/ 17 w 112514"/>
                    <a:gd name="connsiteY2" fmla="*/ 43883 h 85874"/>
                    <a:gd name="connsiteX3" fmla="*/ 1096 w 112514"/>
                    <a:gd name="connsiteY3" fmla="*/ 26767 h 85874"/>
                    <a:gd name="connsiteX4" fmla="*/ 6380 w 112514"/>
                    <a:gd name="connsiteY4" fmla="*/ 12889 h 85874"/>
                    <a:gd name="connsiteX5" fmla="*/ 17244 w 112514"/>
                    <a:gd name="connsiteY5" fmla="*/ 3848 h 85874"/>
                    <a:gd name="connsiteX6" fmla="*/ 32573 w 112514"/>
                    <a:gd name="connsiteY6" fmla="*/ 425 h 85874"/>
                    <a:gd name="connsiteX7" fmla="*/ 56870 w 112514"/>
                    <a:gd name="connsiteY7" fmla="*/ 9578 h 85874"/>
                    <a:gd name="connsiteX8" fmla="*/ 66804 w 112514"/>
                    <a:gd name="connsiteY8" fmla="*/ 42543 h 85874"/>
                    <a:gd name="connsiteX9" fmla="*/ 66804 w 112514"/>
                    <a:gd name="connsiteY9" fmla="*/ 71416 h 85874"/>
                    <a:gd name="connsiteX10" fmla="*/ 112531 w 112514"/>
                    <a:gd name="connsiteY10" fmla="*/ 71416 h 85874"/>
                    <a:gd name="connsiteX11" fmla="*/ 53521 w 112514"/>
                    <a:gd name="connsiteY11" fmla="*/ 71416 h 85874"/>
                    <a:gd name="connsiteX12" fmla="*/ 53521 w 112514"/>
                    <a:gd name="connsiteY12" fmla="*/ 42320 h 85874"/>
                    <a:gd name="connsiteX13" fmla="*/ 48163 w 112514"/>
                    <a:gd name="connsiteY13" fmla="*/ 21856 h 85874"/>
                    <a:gd name="connsiteX14" fmla="*/ 33020 w 112514"/>
                    <a:gd name="connsiteY14" fmla="*/ 15791 h 85874"/>
                    <a:gd name="connsiteX15" fmla="*/ 20965 w 112514"/>
                    <a:gd name="connsiteY15" fmla="*/ 19363 h 85874"/>
                    <a:gd name="connsiteX16" fmla="*/ 14305 w 112514"/>
                    <a:gd name="connsiteY16" fmla="*/ 28739 h 85874"/>
                    <a:gd name="connsiteX17" fmla="*/ 13300 w 112514"/>
                    <a:gd name="connsiteY17" fmla="*/ 42655 h 85874"/>
                    <a:gd name="connsiteX18" fmla="*/ 13300 w 112514"/>
                    <a:gd name="connsiteY18" fmla="*/ 71416 h 8587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112514" h="85874">
                      <a:moveTo>
                        <a:pt x="112531" y="86299"/>
                      </a:moveTo>
                      <a:lnTo>
                        <a:pt x="17" y="86299"/>
                      </a:lnTo>
                      <a:lnTo>
                        <a:pt x="17" y="43883"/>
                      </a:lnTo>
                      <a:cubicBezTo>
                        <a:pt x="17" y="36441"/>
                        <a:pt x="390" y="30711"/>
                        <a:pt x="1096" y="26767"/>
                      </a:cubicBezTo>
                      <a:cubicBezTo>
                        <a:pt x="2026" y="21261"/>
                        <a:pt x="3775" y="16647"/>
                        <a:pt x="6380" y="12889"/>
                      </a:cubicBezTo>
                      <a:cubicBezTo>
                        <a:pt x="8984" y="9169"/>
                        <a:pt x="12630" y="6155"/>
                        <a:pt x="17244" y="3848"/>
                      </a:cubicBezTo>
                      <a:cubicBezTo>
                        <a:pt x="21932" y="1578"/>
                        <a:pt x="27030" y="425"/>
                        <a:pt x="32573" y="425"/>
                      </a:cubicBezTo>
                      <a:cubicBezTo>
                        <a:pt x="42173" y="425"/>
                        <a:pt x="50284" y="3476"/>
                        <a:pt x="56870" y="9578"/>
                      </a:cubicBezTo>
                      <a:cubicBezTo>
                        <a:pt x="63530" y="15680"/>
                        <a:pt x="66841" y="26693"/>
                        <a:pt x="66804" y="42543"/>
                      </a:cubicBezTo>
                      <a:lnTo>
                        <a:pt x="66804" y="71416"/>
                      </a:lnTo>
                      <a:lnTo>
                        <a:pt x="112531" y="71416"/>
                      </a:lnTo>
                      <a:close/>
                      <a:moveTo>
                        <a:pt x="53521" y="71416"/>
                      </a:moveTo>
                      <a:lnTo>
                        <a:pt x="53521" y="42320"/>
                      </a:lnTo>
                      <a:cubicBezTo>
                        <a:pt x="53558" y="32758"/>
                        <a:pt x="51772" y="25912"/>
                        <a:pt x="48163" y="21856"/>
                      </a:cubicBezTo>
                      <a:cubicBezTo>
                        <a:pt x="44591" y="17838"/>
                        <a:pt x="39531" y="15829"/>
                        <a:pt x="33020" y="15791"/>
                      </a:cubicBezTo>
                      <a:cubicBezTo>
                        <a:pt x="28369" y="15829"/>
                        <a:pt x="24351" y="17019"/>
                        <a:pt x="20965" y="19363"/>
                      </a:cubicBezTo>
                      <a:cubicBezTo>
                        <a:pt x="17616" y="21745"/>
                        <a:pt x="15384" y="24870"/>
                        <a:pt x="14305" y="28739"/>
                      </a:cubicBezTo>
                      <a:cubicBezTo>
                        <a:pt x="13635" y="31270"/>
                        <a:pt x="13300" y="35920"/>
                        <a:pt x="13300" y="42655"/>
                      </a:cubicBezTo>
                      <a:lnTo>
                        <a:pt x="13300" y="7141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4" name="Freihandform: Form 213">
                  <a:extLst>
                    <a:ext uri="{FF2B5EF4-FFF2-40B4-BE49-F238E27FC236}">
                      <a16:creationId xmlns:a16="http://schemas.microsoft.com/office/drawing/2014/main" id="{36298295-0320-4DA9-A52B-33B578FAE09B}"/>
                    </a:ext>
                  </a:extLst>
                </p:cNvPr>
                <p:cNvSpPr/>
                <p:nvPr/>
              </p:nvSpPr>
              <p:spPr>
                <a:xfrm>
                  <a:off x="1345667" y="3831681"/>
                  <a:ext cx="116346" cy="99454"/>
                </a:xfrm>
                <a:custGeom>
                  <a:avLst/>
                  <a:gdLst>
                    <a:gd name="connsiteX0" fmla="*/ 74989 w 116346"/>
                    <a:gd name="connsiteY0" fmla="*/ 15296 h 99454"/>
                    <a:gd name="connsiteX1" fmla="*/ 78747 w 116346"/>
                    <a:gd name="connsiteY1" fmla="*/ 414 h 99454"/>
                    <a:gd name="connsiteX2" fmla="*/ 106727 w 116346"/>
                    <a:gd name="connsiteY2" fmla="*/ 17231 h 99454"/>
                    <a:gd name="connsiteX3" fmla="*/ 116363 w 116346"/>
                    <a:gd name="connsiteY3" fmla="*/ 46997 h 99454"/>
                    <a:gd name="connsiteX4" fmla="*/ 108959 w 116346"/>
                    <a:gd name="connsiteY4" fmla="*/ 76576 h 99454"/>
                    <a:gd name="connsiteX5" fmla="*/ 87528 w 116346"/>
                    <a:gd name="connsiteY5" fmla="*/ 93915 h 99454"/>
                    <a:gd name="connsiteX6" fmla="*/ 57353 w 116346"/>
                    <a:gd name="connsiteY6" fmla="*/ 99868 h 99454"/>
                    <a:gd name="connsiteX7" fmla="*/ 26695 w 116346"/>
                    <a:gd name="connsiteY7" fmla="*/ 93170 h 99454"/>
                    <a:gd name="connsiteX8" fmla="*/ 6826 w 116346"/>
                    <a:gd name="connsiteY8" fmla="*/ 74046 h 99454"/>
                    <a:gd name="connsiteX9" fmla="*/ 17 w 116346"/>
                    <a:gd name="connsiteY9" fmla="*/ 46736 h 99454"/>
                    <a:gd name="connsiteX10" fmla="*/ 8612 w 116346"/>
                    <a:gd name="connsiteY10" fmla="*/ 18384 h 99454"/>
                    <a:gd name="connsiteX11" fmla="*/ 32797 w 116346"/>
                    <a:gd name="connsiteY11" fmla="*/ 2311 h 99454"/>
                    <a:gd name="connsiteX12" fmla="*/ 36220 w 116346"/>
                    <a:gd name="connsiteY12" fmla="*/ 16970 h 99454"/>
                    <a:gd name="connsiteX13" fmla="*/ 18361 w 116346"/>
                    <a:gd name="connsiteY13" fmla="*/ 28319 h 99454"/>
                    <a:gd name="connsiteX14" fmla="*/ 12742 w 116346"/>
                    <a:gd name="connsiteY14" fmla="*/ 47071 h 99454"/>
                    <a:gd name="connsiteX15" fmla="*/ 18956 w 116346"/>
                    <a:gd name="connsiteY15" fmla="*/ 68726 h 99454"/>
                    <a:gd name="connsiteX16" fmla="*/ 35661 w 116346"/>
                    <a:gd name="connsiteY16" fmla="*/ 80967 h 99454"/>
                    <a:gd name="connsiteX17" fmla="*/ 57241 w 116346"/>
                    <a:gd name="connsiteY17" fmla="*/ 84501 h 99454"/>
                    <a:gd name="connsiteX18" fmla="*/ 82319 w 116346"/>
                    <a:gd name="connsiteY18" fmla="*/ 80334 h 99454"/>
                    <a:gd name="connsiteX19" fmla="*/ 98318 w 116346"/>
                    <a:gd name="connsiteY19" fmla="*/ 67312 h 99454"/>
                    <a:gd name="connsiteX20" fmla="*/ 103601 w 116346"/>
                    <a:gd name="connsiteY20" fmla="*/ 48224 h 99454"/>
                    <a:gd name="connsiteX21" fmla="*/ 96383 w 116346"/>
                    <a:gd name="connsiteY21" fmla="*/ 27016 h 99454"/>
                    <a:gd name="connsiteX22" fmla="*/ 74989 w 116346"/>
                    <a:gd name="connsiteY22" fmla="*/ 15296 h 994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</a:cxnLst>
                  <a:rect l="l" t="t" r="r" b="b"/>
                  <a:pathLst>
                    <a:path w="116346" h="99454">
                      <a:moveTo>
                        <a:pt x="74989" y="15296"/>
                      </a:moveTo>
                      <a:lnTo>
                        <a:pt x="78747" y="414"/>
                      </a:lnTo>
                      <a:cubicBezTo>
                        <a:pt x="91026" y="3539"/>
                        <a:pt x="100327" y="9157"/>
                        <a:pt x="106727" y="17231"/>
                      </a:cubicBezTo>
                      <a:cubicBezTo>
                        <a:pt x="113126" y="25379"/>
                        <a:pt x="116326" y="35314"/>
                        <a:pt x="116363" y="46997"/>
                      </a:cubicBezTo>
                      <a:cubicBezTo>
                        <a:pt x="116326" y="59126"/>
                        <a:pt x="113871" y="68986"/>
                        <a:pt x="108959" y="76576"/>
                      </a:cubicBezTo>
                      <a:cubicBezTo>
                        <a:pt x="104048" y="84204"/>
                        <a:pt x="96904" y="89971"/>
                        <a:pt x="87528" y="93915"/>
                      </a:cubicBezTo>
                      <a:cubicBezTo>
                        <a:pt x="78152" y="97896"/>
                        <a:pt x="68106" y="99868"/>
                        <a:pt x="57353" y="99868"/>
                      </a:cubicBezTo>
                      <a:cubicBezTo>
                        <a:pt x="45633" y="99868"/>
                        <a:pt x="35401" y="97635"/>
                        <a:pt x="26695" y="93170"/>
                      </a:cubicBezTo>
                      <a:cubicBezTo>
                        <a:pt x="17988" y="88706"/>
                        <a:pt x="11365" y="82343"/>
                        <a:pt x="6826" y="74046"/>
                      </a:cubicBezTo>
                      <a:cubicBezTo>
                        <a:pt x="2287" y="65786"/>
                        <a:pt x="17" y="56670"/>
                        <a:pt x="17" y="46736"/>
                      </a:cubicBezTo>
                      <a:cubicBezTo>
                        <a:pt x="17" y="35500"/>
                        <a:pt x="2882" y="26049"/>
                        <a:pt x="8612" y="18384"/>
                      </a:cubicBezTo>
                      <a:cubicBezTo>
                        <a:pt x="14342" y="10720"/>
                        <a:pt x="22416" y="5362"/>
                        <a:pt x="32797" y="2311"/>
                      </a:cubicBezTo>
                      <a:lnTo>
                        <a:pt x="36220" y="16970"/>
                      </a:lnTo>
                      <a:cubicBezTo>
                        <a:pt x="28071" y="19612"/>
                        <a:pt x="22118" y="23370"/>
                        <a:pt x="18361" y="28319"/>
                      </a:cubicBezTo>
                      <a:cubicBezTo>
                        <a:pt x="14639" y="33304"/>
                        <a:pt x="12742" y="39555"/>
                        <a:pt x="12742" y="47071"/>
                      </a:cubicBezTo>
                      <a:cubicBezTo>
                        <a:pt x="12742" y="55703"/>
                        <a:pt x="14826" y="62921"/>
                        <a:pt x="18956" y="68726"/>
                      </a:cubicBezTo>
                      <a:cubicBezTo>
                        <a:pt x="23123" y="74530"/>
                        <a:pt x="28704" y="78623"/>
                        <a:pt x="35661" y="80967"/>
                      </a:cubicBezTo>
                      <a:cubicBezTo>
                        <a:pt x="42656" y="83348"/>
                        <a:pt x="49837" y="84538"/>
                        <a:pt x="57241" y="84501"/>
                      </a:cubicBezTo>
                      <a:cubicBezTo>
                        <a:pt x="66841" y="84538"/>
                        <a:pt x="75212" y="83125"/>
                        <a:pt x="82319" y="80334"/>
                      </a:cubicBezTo>
                      <a:cubicBezTo>
                        <a:pt x="89500" y="77544"/>
                        <a:pt x="94821" y="73227"/>
                        <a:pt x="98318" y="67312"/>
                      </a:cubicBezTo>
                      <a:cubicBezTo>
                        <a:pt x="101853" y="61470"/>
                        <a:pt x="103601" y="55108"/>
                        <a:pt x="103601" y="48224"/>
                      </a:cubicBezTo>
                      <a:cubicBezTo>
                        <a:pt x="103601" y="39890"/>
                        <a:pt x="101220" y="32821"/>
                        <a:pt x="96383" y="27016"/>
                      </a:cubicBezTo>
                      <a:cubicBezTo>
                        <a:pt x="91621" y="21287"/>
                        <a:pt x="84477" y="17380"/>
                        <a:pt x="74989" y="15296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5" name="Freihandform: Form 214">
                  <a:extLst>
                    <a:ext uri="{FF2B5EF4-FFF2-40B4-BE49-F238E27FC236}">
                      <a16:creationId xmlns:a16="http://schemas.microsoft.com/office/drawing/2014/main" id="{AE217BA5-4C8A-435E-B72A-8FD788B686B0}"/>
                    </a:ext>
                  </a:extLst>
                </p:cNvPr>
                <p:cNvSpPr/>
                <p:nvPr/>
              </p:nvSpPr>
              <p:spPr>
                <a:xfrm>
                  <a:off x="1347117" y="3746347"/>
                  <a:ext cx="112960" cy="74363"/>
                </a:xfrm>
                <a:custGeom>
                  <a:avLst/>
                  <a:gdLst>
                    <a:gd name="connsiteX0" fmla="*/ 99695 w 112960"/>
                    <a:gd name="connsiteY0" fmla="*/ 402 h 74363"/>
                    <a:gd name="connsiteX1" fmla="*/ 112978 w 112960"/>
                    <a:gd name="connsiteY1" fmla="*/ 402 h 74363"/>
                    <a:gd name="connsiteX2" fmla="*/ 112978 w 112960"/>
                    <a:gd name="connsiteY2" fmla="*/ 74741 h 74363"/>
                    <a:gd name="connsiteX3" fmla="*/ 103379 w 112960"/>
                    <a:gd name="connsiteY3" fmla="*/ 73141 h 74363"/>
                    <a:gd name="connsiteX4" fmla="*/ 88421 w 112960"/>
                    <a:gd name="connsiteY4" fmla="*/ 64026 h 74363"/>
                    <a:gd name="connsiteX5" fmla="*/ 71381 w 112960"/>
                    <a:gd name="connsiteY5" fmla="*/ 45980 h 74363"/>
                    <a:gd name="connsiteX6" fmla="*/ 47568 w 112960"/>
                    <a:gd name="connsiteY6" fmla="*/ 21200 h 74363"/>
                    <a:gd name="connsiteX7" fmla="*/ 30937 w 112960"/>
                    <a:gd name="connsiteY7" fmla="*/ 14726 h 74363"/>
                    <a:gd name="connsiteX8" fmla="*/ 17096 w 112960"/>
                    <a:gd name="connsiteY8" fmla="*/ 20605 h 74363"/>
                    <a:gd name="connsiteX9" fmla="*/ 11440 w 112960"/>
                    <a:gd name="connsiteY9" fmla="*/ 35897 h 74363"/>
                    <a:gd name="connsiteX10" fmla="*/ 17431 w 112960"/>
                    <a:gd name="connsiteY10" fmla="*/ 51896 h 74363"/>
                    <a:gd name="connsiteX11" fmla="*/ 34025 w 112960"/>
                    <a:gd name="connsiteY11" fmla="*/ 57924 h 74363"/>
                    <a:gd name="connsiteX12" fmla="*/ 32536 w 112960"/>
                    <a:gd name="connsiteY12" fmla="*/ 72137 h 74363"/>
                    <a:gd name="connsiteX13" fmla="*/ 8352 w 112960"/>
                    <a:gd name="connsiteY13" fmla="*/ 61161 h 74363"/>
                    <a:gd name="connsiteX14" fmla="*/ 17 w 112960"/>
                    <a:gd name="connsiteY14" fmla="*/ 35599 h 74363"/>
                    <a:gd name="connsiteX15" fmla="*/ 9021 w 112960"/>
                    <a:gd name="connsiteY15" fmla="*/ 10001 h 74363"/>
                    <a:gd name="connsiteX16" fmla="*/ 31234 w 112960"/>
                    <a:gd name="connsiteY16" fmla="*/ 551 h 74363"/>
                    <a:gd name="connsiteX17" fmla="*/ 44554 w 112960"/>
                    <a:gd name="connsiteY17" fmla="*/ 3304 h 74363"/>
                    <a:gd name="connsiteX18" fmla="*/ 58284 w 112960"/>
                    <a:gd name="connsiteY18" fmla="*/ 12494 h 74363"/>
                    <a:gd name="connsiteX19" fmla="*/ 78078 w 112960"/>
                    <a:gd name="connsiteY19" fmla="*/ 33776 h 74363"/>
                    <a:gd name="connsiteX20" fmla="*/ 92217 w 112960"/>
                    <a:gd name="connsiteY20" fmla="*/ 49738 h 74363"/>
                    <a:gd name="connsiteX21" fmla="*/ 99695 w 112960"/>
                    <a:gd name="connsiteY21" fmla="*/ 55543 h 7436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112960" h="74363">
                      <a:moveTo>
                        <a:pt x="99695" y="402"/>
                      </a:moveTo>
                      <a:lnTo>
                        <a:pt x="112978" y="402"/>
                      </a:lnTo>
                      <a:lnTo>
                        <a:pt x="112978" y="74741"/>
                      </a:lnTo>
                      <a:cubicBezTo>
                        <a:pt x="109667" y="74890"/>
                        <a:pt x="106467" y="74332"/>
                        <a:pt x="103379" y="73141"/>
                      </a:cubicBezTo>
                      <a:cubicBezTo>
                        <a:pt x="98319" y="71244"/>
                        <a:pt x="93333" y="68230"/>
                        <a:pt x="88421" y="64026"/>
                      </a:cubicBezTo>
                      <a:cubicBezTo>
                        <a:pt x="83510" y="59896"/>
                        <a:pt x="77855" y="53868"/>
                        <a:pt x="71381" y="45980"/>
                      </a:cubicBezTo>
                      <a:cubicBezTo>
                        <a:pt x="61409" y="33776"/>
                        <a:pt x="53447" y="25516"/>
                        <a:pt x="47568" y="21200"/>
                      </a:cubicBezTo>
                      <a:cubicBezTo>
                        <a:pt x="41727" y="16922"/>
                        <a:pt x="36183" y="14764"/>
                        <a:pt x="30937" y="14726"/>
                      </a:cubicBezTo>
                      <a:cubicBezTo>
                        <a:pt x="25467" y="14764"/>
                        <a:pt x="20853" y="16736"/>
                        <a:pt x="17096" y="20605"/>
                      </a:cubicBezTo>
                      <a:cubicBezTo>
                        <a:pt x="13338" y="24549"/>
                        <a:pt x="11478" y="29646"/>
                        <a:pt x="11440" y="35897"/>
                      </a:cubicBezTo>
                      <a:cubicBezTo>
                        <a:pt x="11478" y="42594"/>
                        <a:pt x="13449" y="47915"/>
                        <a:pt x="17431" y="51896"/>
                      </a:cubicBezTo>
                      <a:cubicBezTo>
                        <a:pt x="21449" y="55877"/>
                        <a:pt x="26993" y="57887"/>
                        <a:pt x="34025" y="57924"/>
                      </a:cubicBezTo>
                      <a:lnTo>
                        <a:pt x="32536" y="72137"/>
                      </a:lnTo>
                      <a:cubicBezTo>
                        <a:pt x="22007" y="71169"/>
                        <a:pt x="13933" y="67523"/>
                        <a:pt x="8352" y="61161"/>
                      </a:cubicBezTo>
                      <a:cubicBezTo>
                        <a:pt x="2808" y="54836"/>
                        <a:pt x="17" y="46315"/>
                        <a:pt x="17" y="35599"/>
                      </a:cubicBezTo>
                      <a:cubicBezTo>
                        <a:pt x="17" y="24847"/>
                        <a:pt x="3031" y="16326"/>
                        <a:pt x="9021" y="10001"/>
                      </a:cubicBezTo>
                      <a:cubicBezTo>
                        <a:pt x="15012" y="3750"/>
                        <a:pt x="22416" y="588"/>
                        <a:pt x="31234" y="551"/>
                      </a:cubicBezTo>
                      <a:cubicBezTo>
                        <a:pt x="35773" y="588"/>
                        <a:pt x="40201" y="1518"/>
                        <a:pt x="44554" y="3304"/>
                      </a:cubicBezTo>
                      <a:cubicBezTo>
                        <a:pt x="48908" y="5164"/>
                        <a:pt x="53484" y="8215"/>
                        <a:pt x="58284" y="12494"/>
                      </a:cubicBezTo>
                      <a:cubicBezTo>
                        <a:pt x="63083" y="16773"/>
                        <a:pt x="69706" y="23879"/>
                        <a:pt x="78078" y="33776"/>
                      </a:cubicBezTo>
                      <a:cubicBezTo>
                        <a:pt x="85073" y="42111"/>
                        <a:pt x="89761" y="47431"/>
                        <a:pt x="92217" y="49738"/>
                      </a:cubicBezTo>
                      <a:cubicBezTo>
                        <a:pt x="94709" y="52119"/>
                        <a:pt x="97202" y="54054"/>
                        <a:pt x="99695" y="55543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6" name="Freihandform: Form 215">
                  <a:extLst>
                    <a:ext uri="{FF2B5EF4-FFF2-40B4-BE49-F238E27FC236}">
                      <a16:creationId xmlns:a16="http://schemas.microsoft.com/office/drawing/2014/main" id="{72818873-D025-44DE-A14B-CD9BC5ED6941}"/>
                    </a:ext>
                  </a:extLst>
                </p:cNvPr>
                <p:cNvSpPr/>
                <p:nvPr/>
              </p:nvSpPr>
              <p:spPr>
                <a:xfrm>
                  <a:off x="1378595" y="3708124"/>
                  <a:ext cx="81483" cy="15701"/>
                </a:xfrm>
                <a:custGeom>
                  <a:avLst/>
                  <a:gdLst>
                    <a:gd name="connsiteX0" fmla="*/ 15719 w 81483"/>
                    <a:gd name="connsiteY0" fmla="*/ 16094 h 15701"/>
                    <a:gd name="connsiteX1" fmla="*/ 17 w 81483"/>
                    <a:gd name="connsiteY1" fmla="*/ 16094 h 15701"/>
                    <a:gd name="connsiteX2" fmla="*/ 17 w 81483"/>
                    <a:gd name="connsiteY2" fmla="*/ 392 h 15701"/>
                    <a:gd name="connsiteX3" fmla="*/ 15719 w 81483"/>
                    <a:gd name="connsiteY3" fmla="*/ 392 h 15701"/>
                    <a:gd name="connsiteX4" fmla="*/ 81501 w 81483"/>
                    <a:gd name="connsiteY4" fmla="*/ 16094 h 15701"/>
                    <a:gd name="connsiteX5" fmla="*/ 65762 w 81483"/>
                    <a:gd name="connsiteY5" fmla="*/ 16094 h 15701"/>
                    <a:gd name="connsiteX6" fmla="*/ 65762 w 81483"/>
                    <a:gd name="connsiteY6" fmla="*/ 392 h 15701"/>
                    <a:gd name="connsiteX7" fmla="*/ 81501 w 81483"/>
                    <a:gd name="connsiteY7" fmla="*/ 392 h 1570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81483" h="15701">
                      <a:moveTo>
                        <a:pt x="15719" y="16094"/>
                      </a:moveTo>
                      <a:lnTo>
                        <a:pt x="17" y="16094"/>
                      </a:lnTo>
                      <a:lnTo>
                        <a:pt x="17" y="392"/>
                      </a:lnTo>
                      <a:lnTo>
                        <a:pt x="15719" y="392"/>
                      </a:lnTo>
                      <a:close/>
                      <a:moveTo>
                        <a:pt x="81501" y="16094"/>
                      </a:moveTo>
                      <a:lnTo>
                        <a:pt x="65762" y="16094"/>
                      </a:lnTo>
                      <a:lnTo>
                        <a:pt x="65762" y="392"/>
                      </a:lnTo>
                      <a:lnTo>
                        <a:pt x="81501" y="39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7" name="Freihandform: Form 216">
                  <a:extLst>
                    <a:ext uri="{FF2B5EF4-FFF2-40B4-BE49-F238E27FC236}">
                      <a16:creationId xmlns:a16="http://schemas.microsoft.com/office/drawing/2014/main" id="{D1CF3967-00AE-40ED-BD73-656AD0235894}"/>
                    </a:ext>
                  </a:extLst>
                </p:cNvPr>
                <p:cNvSpPr/>
                <p:nvPr/>
              </p:nvSpPr>
              <p:spPr>
                <a:xfrm>
                  <a:off x="1460078" y="3694376"/>
                  <a:ext cx="9525" cy="9525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525" h="9525"/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8" name="Freihandform: Form 217">
                  <a:extLst>
                    <a:ext uri="{FF2B5EF4-FFF2-40B4-BE49-F238E27FC236}">
                      <a16:creationId xmlns:a16="http://schemas.microsoft.com/office/drawing/2014/main" id="{B3FF5900-C40F-4584-8D95-5242CA2D05DD}"/>
                    </a:ext>
                  </a:extLst>
                </p:cNvPr>
                <p:cNvSpPr/>
                <p:nvPr/>
              </p:nvSpPr>
              <p:spPr>
                <a:xfrm>
                  <a:off x="1347117" y="3571611"/>
                  <a:ext cx="112960" cy="74363"/>
                </a:xfrm>
                <a:custGeom>
                  <a:avLst/>
                  <a:gdLst>
                    <a:gd name="connsiteX0" fmla="*/ 99695 w 112960"/>
                    <a:gd name="connsiteY0" fmla="*/ 383 h 74363"/>
                    <a:gd name="connsiteX1" fmla="*/ 112978 w 112960"/>
                    <a:gd name="connsiteY1" fmla="*/ 383 h 74363"/>
                    <a:gd name="connsiteX2" fmla="*/ 112978 w 112960"/>
                    <a:gd name="connsiteY2" fmla="*/ 74723 h 74363"/>
                    <a:gd name="connsiteX3" fmla="*/ 103379 w 112960"/>
                    <a:gd name="connsiteY3" fmla="*/ 73123 h 74363"/>
                    <a:gd name="connsiteX4" fmla="*/ 88421 w 112960"/>
                    <a:gd name="connsiteY4" fmla="*/ 64007 h 74363"/>
                    <a:gd name="connsiteX5" fmla="*/ 71381 w 112960"/>
                    <a:gd name="connsiteY5" fmla="*/ 45962 h 74363"/>
                    <a:gd name="connsiteX6" fmla="*/ 47568 w 112960"/>
                    <a:gd name="connsiteY6" fmla="*/ 21182 h 74363"/>
                    <a:gd name="connsiteX7" fmla="*/ 30937 w 112960"/>
                    <a:gd name="connsiteY7" fmla="*/ 14708 h 74363"/>
                    <a:gd name="connsiteX8" fmla="*/ 17096 w 112960"/>
                    <a:gd name="connsiteY8" fmla="*/ 20587 h 74363"/>
                    <a:gd name="connsiteX9" fmla="*/ 11440 w 112960"/>
                    <a:gd name="connsiteY9" fmla="*/ 35879 h 74363"/>
                    <a:gd name="connsiteX10" fmla="*/ 17431 w 112960"/>
                    <a:gd name="connsiteY10" fmla="*/ 51878 h 74363"/>
                    <a:gd name="connsiteX11" fmla="*/ 34025 w 112960"/>
                    <a:gd name="connsiteY11" fmla="*/ 57905 h 74363"/>
                    <a:gd name="connsiteX12" fmla="*/ 32536 w 112960"/>
                    <a:gd name="connsiteY12" fmla="*/ 72118 h 74363"/>
                    <a:gd name="connsiteX13" fmla="*/ 8352 w 112960"/>
                    <a:gd name="connsiteY13" fmla="*/ 61142 h 74363"/>
                    <a:gd name="connsiteX14" fmla="*/ 17 w 112960"/>
                    <a:gd name="connsiteY14" fmla="*/ 35581 h 74363"/>
                    <a:gd name="connsiteX15" fmla="*/ 9021 w 112960"/>
                    <a:gd name="connsiteY15" fmla="*/ 9983 h 74363"/>
                    <a:gd name="connsiteX16" fmla="*/ 31234 w 112960"/>
                    <a:gd name="connsiteY16" fmla="*/ 532 h 74363"/>
                    <a:gd name="connsiteX17" fmla="*/ 44554 w 112960"/>
                    <a:gd name="connsiteY17" fmla="*/ 3285 h 74363"/>
                    <a:gd name="connsiteX18" fmla="*/ 58284 w 112960"/>
                    <a:gd name="connsiteY18" fmla="*/ 12476 h 74363"/>
                    <a:gd name="connsiteX19" fmla="*/ 78078 w 112960"/>
                    <a:gd name="connsiteY19" fmla="*/ 33758 h 74363"/>
                    <a:gd name="connsiteX20" fmla="*/ 92217 w 112960"/>
                    <a:gd name="connsiteY20" fmla="*/ 49720 h 74363"/>
                    <a:gd name="connsiteX21" fmla="*/ 99695 w 112960"/>
                    <a:gd name="connsiteY21" fmla="*/ 55524 h 7436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112960" h="74363">
                      <a:moveTo>
                        <a:pt x="99695" y="383"/>
                      </a:moveTo>
                      <a:lnTo>
                        <a:pt x="112978" y="383"/>
                      </a:lnTo>
                      <a:lnTo>
                        <a:pt x="112978" y="74723"/>
                      </a:lnTo>
                      <a:cubicBezTo>
                        <a:pt x="109667" y="74872"/>
                        <a:pt x="106467" y="74314"/>
                        <a:pt x="103379" y="73123"/>
                      </a:cubicBezTo>
                      <a:cubicBezTo>
                        <a:pt x="98319" y="71225"/>
                        <a:pt x="93333" y="68212"/>
                        <a:pt x="88421" y="64007"/>
                      </a:cubicBezTo>
                      <a:cubicBezTo>
                        <a:pt x="83510" y="59877"/>
                        <a:pt x="77855" y="53850"/>
                        <a:pt x="71381" y="45962"/>
                      </a:cubicBezTo>
                      <a:cubicBezTo>
                        <a:pt x="61409" y="33758"/>
                        <a:pt x="53447" y="25498"/>
                        <a:pt x="47568" y="21182"/>
                      </a:cubicBezTo>
                      <a:cubicBezTo>
                        <a:pt x="41727" y="16903"/>
                        <a:pt x="36183" y="14745"/>
                        <a:pt x="30937" y="14708"/>
                      </a:cubicBezTo>
                      <a:cubicBezTo>
                        <a:pt x="25467" y="14745"/>
                        <a:pt x="20853" y="16717"/>
                        <a:pt x="17096" y="20587"/>
                      </a:cubicBezTo>
                      <a:cubicBezTo>
                        <a:pt x="13338" y="24531"/>
                        <a:pt x="11478" y="29628"/>
                        <a:pt x="11440" y="35879"/>
                      </a:cubicBezTo>
                      <a:cubicBezTo>
                        <a:pt x="11478" y="42576"/>
                        <a:pt x="13449" y="47897"/>
                        <a:pt x="17431" y="51878"/>
                      </a:cubicBezTo>
                      <a:cubicBezTo>
                        <a:pt x="21449" y="55859"/>
                        <a:pt x="26993" y="57868"/>
                        <a:pt x="34025" y="57905"/>
                      </a:cubicBezTo>
                      <a:lnTo>
                        <a:pt x="32536" y="72118"/>
                      </a:lnTo>
                      <a:cubicBezTo>
                        <a:pt x="22007" y="71151"/>
                        <a:pt x="13933" y="67505"/>
                        <a:pt x="8352" y="61142"/>
                      </a:cubicBezTo>
                      <a:cubicBezTo>
                        <a:pt x="2808" y="54817"/>
                        <a:pt x="17" y="46297"/>
                        <a:pt x="17" y="35581"/>
                      </a:cubicBezTo>
                      <a:cubicBezTo>
                        <a:pt x="17" y="24828"/>
                        <a:pt x="3031" y="16308"/>
                        <a:pt x="9021" y="9983"/>
                      </a:cubicBezTo>
                      <a:cubicBezTo>
                        <a:pt x="15012" y="3732"/>
                        <a:pt x="22416" y="569"/>
                        <a:pt x="31234" y="532"/>
                      </a:cubicBezTo>
                      <a:cubicBezTo>
                        <a:pt x="35773" y="569"/>
                        <a:pt x="40201" y="1500"/>
                        <a:pt x="44554" y="3285"/>
                      </a:cubicBezTo>
                      <a:cubicBezTo>
                        <a:pt x="48908" y="5146"/>
                        <a:pt x="53484" y="8197"/>
                        <a:pt x="58284" y="12476"/>
                      </a:cubicBezTo>
                      <a:cubicBezTo>
                        <a:pt x="63083" y="16754"/>
                        <a:pt x="69706" y="23861"/>
                        <a:pt x="78078" y="33758"/>
                      </a:cubicBezTo>
                      <a:cubicBezTo>
                        <a:pt x="85073" y="42092"/>
                        <a:pt x="89761" y="47413"/>
                        <a:pt x="92217" y="49720"/>
                      </a:cubicBezTo>
                      <a:cubicBezTo>
                        <a:pt x="94709" y="52101"/>
                        <a:pt x="97202" y="54036"/>
                        <a:pt x="99695" y="55524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9" name="Freihandform: Form 218">
                  <a:extLst>
                    <a:ext uri="{FF2B5EF4-FFF2-40B4-BE49-F238E27FC236}">
                      <a16:creationId xmlns:a16="http://schemas.microsoft.com/office/drawing/2014/main" id="{8A52F503-7922-4DD4-BC46-F89FCA112871}"/>
                    </a:ext>
                  </a:extLst>
                </p:cNvPr>
                <p:cNvSpPr/>
                <p:nvPr/>
              </p:nvSpPr>
              <p:spPr>
                <a:xfrm>
                  <a:off x="1347117" y="3483046"/>
                  <a:ext cx="114969" cy="73669"/>
                </a:xfrm>
                <a:custGeom>
                  <a:avLst/>
                  <a:gdLst>
                    <a:gd name="connsiteX0" fmla="*/ 83287 w 114969"/>
                    <a:gd name="connsiteY0" fmla="*/ 74044 h 73669"/>
                    <a:gd name="connsiteX1" fmla="*/ 81427 w 114969"/>
                    <a:gd name="connsiteY1" fmla="*/ 60203 h 73669"/>
                    <a:gd name="connsiteX2" fmla="*/ 98356 w 114969"/>
                    <a:gd name="connsiteY2" fmla="*/ 52129 h 73669"/>
                    <a:gd name="connsiteX3" fmla="*/ 103527 w 114969"/>
                    <a:gd name="connsiteY3" fmla="*/ 38176 h 73669"/>
                    <a:gd name="connsiteX4" fmla="*/ 96793 w 114969"/>
                    <a:gd name="connsiteY4" fmla="*/ 21768 h 73669"/>
                    <a:gd name="connsiteX5" fmla="*/ 80050 w 114969"/>
                    <a:gd name="connsiteY5" fmla="*/ 15034 h 73669"/>
                    <a:gd name="connsiteX6" fmla="*/ 64348 w 114969"/>
                    <a:gd name="connsiteY6" fmla="*/ 21247 h 73669"/>
                    <a:gd name="connsiteX7" fmla="*/ 58172 w 114969"/>
                    <a:gd name="connsiteY7" fmla="*/ 37023 h 73669"/>
                    <a:gd name="connsiteX8" fmla="*/ 59735 w 114969"/>
                    <a:gd name="connsiteY8" fmla="*/ 46771 h 73669"/>
                    <a:gd name="connsiteX9" fmla="*/ 47605 w 114969"/>
                    <a:gd name="connsiteY9" fmla="*/ 45246 h 73669"/>
                    <a:gd name="connsiteX10" fmla="*/ 47754 w 114969"/>
                    <a:gd name="connsiteY10" fmla="*/ 43013 h 73669"/>
                    <a:gd name="connsiteX11" fmla="*/ 43140 w 114969"/>
                    <a:gd name="connsiteY11" fmla="*/ 27163 h 73669"/>
                    <a:gd name="connsiteX12" fmla="*/ 28965 w 114969"/>
                    <a:gd name="connsiteY12" fmla="*/ 20094 h 73669"/>
                    <a:gd name="connsiteX13" fmla="*/ 16352 w 114969"/>
                    <a:gd name="connsiteY13" fmla="*/ 25228 h 73669"/>
                    <a:gd name="connsiteX14" fmla="*/ 11365 w 114969"/>
                    <a:gd name="connsiteY14" fmla="*/ 38511 h 73669"/>
                    <a:gd name="connsiteX15" fmla="*/ 16463 w 114969"/>
                    <a:gd name="connsiteY15" fmla="*/ 51943 h 73669"/>
                    <a:gd name="connsiteX16" fmla="*/ 31644 w 114969"/>
                    <a:gd name="connsiteY16" fmla="*/ 58826 h 73669"/>
                    <a:gd name="connsiteX17" fmla="*/ 29188 w 114969"/>
                    <a:gd name="connsiteY17" fmla="*/ 72630 h 73669"/>
                    <a:gd name="connsiteX18" fmla="*/ 7645 w 114969"/>
                    <a:gd name="connsiteY18" fmla="*/ 61133 h 73669"/>
                    <a:gd name="connsiteX19" fmla="*/ 17 w 114969"/>
                    <a:gd name="connsiteY19" fmla="*/ 38809 h 73669"/>
                    <a:gd name="connsiteX20" fmla="*/ 3962 w 114969"/>
                    <a:gd name="connsiteY20" fmla="*/ 21843 h 73669"/>
                    <a:gd name="connsiteX21" fmla="*/ 14752 w 114969"/>
                    <a:gd name="connsiteY21" fmla="*/ 10011 h 73669"/>
                    <a:gd name="connsiteX22" fmla="*/ 29262 w 114969"/>
                    <a:gd name="connsiteY22" fmla="*/ 5881 h 73669"/>
                    <a:gd name="connsiteX23" fmla="*/ 42545 w 114969"/>
                    <a:gd name="connsiteY23" fmla="*/ 9825 h 73669"/>
                    <a:gd name="connsiteX24" fmla="*/ 52033 w 114969"/>
                    <a:gd name="connsiteY24" fmla="*/ 21396 h 73669"/>
                    <a:gd name="connsiteX25" fmla="*/ 61595 w 114969"/>
                    <a:gd name="connsiteY25" fmla="*/ 5918 h 73669"/>
                    <a:gd name="connsiteX26" fmla="*/ 79752 w 114969"/>
                    <a:gd name="connsiteY26" fmla="*/ 374 h 73669"/>
                    <a:gd name="connsiteX27" fmla="*/ 104755 w 114969"/>
                    <a:gd name="connsiteY27" fmla="*/ 11127 h 73669"/>
                    <a:gd name="connsiteX28" fmla="*/ 114987 w 114969"/>
                    <a:gd name="connsiteY28" fmla="*/ 38288 h 73669"/>
                    <a:gd name="connsiteX29" fmla="*/ 106169 w 114969"/>
                    <a:gd name="connsiteY29" fmla="*/ 62882 h 73669"/>
                    <a:gd name="connsiteX30" fmla="*/ 83287 w 114969"/>
                    <a:gd name="connsiteY30" fmla="*/ 74044 h 736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</a:cxnLst>
                  <a:rect l="l" t="t" r="r" b="b"/>
                  <a:pathLst>
                    <a:path w="114969" h="73669">
                      <a:moveTo>
                        <a:pt x="83287" y="74044"/>
                      </a:moveTo>
                      <a:lnTo>
                        <a:pt x="81427" y="60203"/>
                      </a:lnTo>
                      <a:cubicBezTo>
                        <a:pt x="89314" y="58640"/>
                        <a:pt x="94933" y="55961"/>
                        <a:pt x="98356" y="52129"/>
                      </a:cubicBezTo>
                      <a:cubicBezTo>
                        <a:pt x="101816" y="48334"/>
                        <a:pt x="103565" y="43683"/>
                        <a:pt x="103527" y="38176"/>
                      </a:cubicBezTo>
                      <a:cubicBezTo>
                        <a:pt x="103565" y="31740"/>
                        <a:pt x="101295" y="26270"/>
                        <a:pt x="96793" y="21768"/>
                      </a:cubicBezTo>
                      <a:cubicBezTo>
                        <a:pt x="92291" y="17303"/>
                        <a:pt x="86710" y="15071"/>
                        <a:pt x="80050" y="15034"/>
                      </a:cubicBezTo>
                      <a:cubicBezTo>
                        <a:pt x="73725" y="15071"/>
                        <a:pt x="68516" y="17117"/>
                        <a:pt x="64348" y="21247"/>
                      </a:cubicBezTo>
                      <a:cubicBezTo>
                        <a:pt x="60256" y="25414"/>
                        <a:pt x="58172" y="30698"/>
                        <a:pt x="58172" y="37023"/>
                      </a:cubicBezTo>
                      <a:cubicBezTo>
                        <a:pt x="58172" y="39702"/>
                        <a:pt x="58693" y="42939"/>
                        <a:pt x="59735" y="46771"/>
                      </a:cubicBezTo>
                      <a:lnTo>
                        <a:pt x="47605" y="45246"/>
                      </a:lnTo>
                      <a:cubicBezTo>
                        <a:pt x="47754" y="44353"/>
                        <a:pt x="47791" y="43609"/>
                        <a:pt x="47754" y="43013"/>
                      </a:cubicBezTo>
                      <a:cubicBezTo>
                        <a:pt x="47791" y="37135"/>
                        <a:pt x="46266" y="31851"/>
                        <a:pt x="43140" y="27163"/>
                      </a:cubicBezTo>
                      <a:cubicBezTo>
                        <a:pt x="40090" y="22475"/>
                        <a:pt x="35364" y="20131"/>
                        <a:pt x="28965" y="20094"/>
                      </a:cubicBezTo>
                      <a:cubicBezTo>
                        <a:pt x="23904" y="20131"/>
                        <a:pt x="19700" y="21843"/>
                        <a:pt x="16352" y="25228"/>
                      </a:cubicBezTo>
                      <a:cubicBezTo>
                        <a:pt x="13077" y="28689"/>
                        <a:pt x="11403" y="33116"/>
                        <a:pt x="11365" y="38511"/>
                      </a:cubicBezTo>
                      <a:cubicBezTo>
                        <a:pt x="11403" y="43906"/>
                        <a:pt x="13114" y="48371"/>
                        <a:pt x="16463" y="51943"/>
                      </a:cubicBezTo>
                      <a:cubicBezTo>
                        <a:pt x="19886" y="55515"/>
                        <a:pt x="24946" y="57822"/>
                        <a:pt x="31644" y="58826"/>
                      </a:cubicBezTo>
                      <a:lnTo>
                        <a:pt x="29188" y="72630"/>
                      </a:lnTo>
                      <a:cubicBezTo>
                        <a:pt x="19961" y="70993"/>
                        <a:pt x="12780" y="67161"/>
                        <a:pt x="7645" y="61133"/>
                      </a:cubicBezTo>
                      <a:cubicBezTo>
                        <a:pt x="2585" y="55180"/>
                        <a:pt x="17" y="47739"/>
                        <a:pt x="17" y="38809"/>
                      </a:cubicBezTo>
                      <a:cubicBezTo>
                        <a:pt x="17" y="32707"/>
                        <a:pt x="1357" y="27052"/>
                        <a:pt x="3962" y="21843"/>
                      </a:cubicBezTo>
                      <a:cubicBezTo>
                        <a:pt x="6640" y="16708"/>
                        <a:pt x="10212" y="12764"/>
                        <a:pt x="14752" y="10011"/>
                      </a:cubicBezTo>
                      <a:cubicBezTo>
                        <a:pt x="19328" y="7295"/>
                        <a:pt x="24165" y="5918"/>
                        <a:pt x="29262" y="5881"/>
                      </a:cubicBezTo>
                      <a:cubicBezTo>
                        <a:pt x="34136" y="5918"/>
                        <a:pt x="38564" y="7220"/>
                        <a:pt x="42545" y="9825"/>
                      </a:cubicBezTo>
                      <a:cubicBezTo>
                        <a:pt x="46563" y="12466"/>
                        <a:pt x="49726" y="16336"/>
                        <a:pt x="52033" y="21396"/>
                      </a:cubicBezTo>
                      <a:cubicBezTo>
                        <a:pt x="53596" y="14773"/>
                        <a:pt x="56795" y="9601"/>
                        <a:pt x="61595" y="5918"/>
                      </a:cubicBezTo>
                      <a:cubicBezTo>
                        <a:pt x="66469" y="2234"/>
                        <a:pt x="72534" y="374"/>
                        <a:pt x="79752" y="374"/>
                      </a:cubicBezTo>
                      <a:cubicBezTo>
                        <a:pt x="89612" y="374"/>
                        <a:pt x="97946" y="3983"/>
                        <a:pt x="104755" y="11127"/>
                      </a:cubicBezTo>
                      <a:cubicBezTo>
                        <a:pt x="111601" y="18308"/>
                        <a:pt x="114987" y="27349"/>
                        <a:pt x="114987" y="38288"/>
                      </a:cubicBezTo>
                      <a:cubicBezTo>
                        <a:pt x="114987" y="48185"/>
                        <a:pt x="112048" y="56371"/>
                        <a:pt x="106169" y="62882"/>
                      </a:cubicBezTo>
                      <a:cubicBezTo>
                        <a:pt x="100290" y="69393"/>
                        <a:pt x="92663" y="73114"/>
                        <a:pt x="83287" y="74044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0" name="Freihandform: Form 219">
                  <a:extLst>
                    <a:ext uri="{FF2B5EF4-FFF2-40B4-BE49-F238E27FC236}">
                      <a16:creationId xmlns:a16="http://schemas.microsoft.com/office/drawing/2014/main" id="{4B6F9B67-7BE6-4EBD-9A4F-A505663C4D78}"/>
                    </a:ext>
                  </a:extLst>
                </p:cNvPr>
                <p:cNvSpPr/>
                <p:nvPr/>
              </p:nvSpPr>
              <p:spPr>
                <a:xfrm>
                  <a:off x="1345667" y="3345825"/>
                  <a:ext cx="118541" cy="120960"/>
                </a:xfrm>
                <a:custGeom>
                  <a:avLst/>
                  <a:gdLst>
                    <a:gd name="connsiteX0" fmla="*/ 28927 w 118541"/>
                    <a:gd name="connsiteY0" fmla="*/ 121325 h 120960"/>
                    <a:gd name="connsiteX1" fmla="*/ 8463 w 118541"/>
                    <a:gd name="connsiteY1" fmla="*/ 115260 h 120960"/>
                    <a:gd name="connsiteX2" fmla="*/ 17 w 118541"/>
                    <a:gd name="connsiteY2" fmla="*/ 97661 h 120960"/>
                    <a:gd name="connsiteX3" fmla="*/ 7570 w 118541"/>
                    <a:gd name="connsiteY3" fmla="*/ 80136 h 120960"/>
                    <a:gd name="connsiteX4" fmla="*/ 29783 w 118541"/>
                    <a:gd name="connsiteY4" fmla="*/ 73179 h 120960"/>
                    <a:gd name="connsiteX5" fmla="*/ 51772 w 118541"/>
                    <a:gd name="connsiteY5" fmla="*/ 80211 h 120960"/>
                    <a:gd name="connsiteX6" fmla="*/ 59474 w 118541"/>
                    <a:gd name="connsiteY6" fmla="*/ 97512 h 120960"/>
                    <a:gd name="connsiteX7" fmla="*/ 51884 w 118541"/>
                    <a:gd name="connsiteY7" fmla="*/ 114516 h 120960"/>
                    <a:gd name="connsiteX8" fmla="*/ 28927 w 118541"/>
                    <a:gd name="connsiteY8" fmla="*/ 121325 h 120960"/>
                    <a:gd name="connsiteX9" fmla="*/ 9542 w 118541"/>
                    <a:gd name="connsiteY9" fmla="*/ 97289 h 120960"/>
                    <a:gd name="connsiteX10" fmla="*/ 14007 w 118541"/>
                    <a:gd name="connsiteY10" fmla="*/ 105846 h 120960"/>
                    <a:gd name="connsiteX11" fmla="*/ 30341 w 118541"/>
                    <a:gd name="connsiteY11" fmla="*/ 109269 h 120960"/>
                    <a:gd name="connsiteX12" fmla="*/ 45559 w 118541"/>
                    <a:gd name="connsiteY12" fmla="*/ 105809 h 120960"/>
                    <a:gd name="connsiteX13" fmla="*/ 49986 w 118541"/>
                    <a:gd name="connsiteY13" fmla="*/ 97289 h 120960"/>
                    <a:gd name="connsiteX14" fmla="*/ 45521 w 118541"/>
                    <a:gd name="connsiteY14" fmla="*/ 88657 h 120960"/>
                    <a:gd name="connsiteX15" fmla="*/ 29262 w 118541"/>
                    <a:gd name="connsiteY15" fmla="*/ 85234 h 120960"/>
                    <a:gd name="connsiteX16" fmla="*/ 13970 w 118541"/>
                    <a:gd name="connsiteY16" fmla="*/ 88694 h 120960"/>
                    <a:gd name="connsiteX17" fmla="*/ 9542 w 118541"/>
                    <a:gd name="connsiteY17" fmla="*/ 97289 h 120960"/>
                    <a:gd name="connsiteX18" fmla="*/ 118559 w 118541"/>
                    <a:gd name="connsiteY18" fmla="*/ 97214 h 120960"/>
                    <a:gd name="connsiteX19" fmla="*/ 17 w 118541"/>
                    <a:gd name="connsiteY19" fmla="*/ 35674 h 120960"/>
                    <a:gd name="connsiteX20" fmla="*/ 17 w 118541"/>
                    <a:gd name="connsiteY20" fmla="*/ 24475 h 120960"/>
                    <a:gd name="connsiteX21" fmla="*/ 118559 w 118541"/>
                    <a:gd name="connsiteY21" fmla="*/ 85792 h 120960"/>
                    <a:gd name="connsiteX22" fmla="*/ 88049 w 118541"/>
                    <a:gd name="connsiteY22" fmla="*/ 48548 h 120960"/>
                    <a:gd name="connsiteX23" fmla="*/ 67511 w 118541"/>
                    <a:gd name="connsiteY23" fmla="*/ 42483 h 120960"/>
                    <a:gd name="connsiteX24" fmla="*/ 59102 w 118541"/>
                    <a:gd name="connsiteY24" fmla="*/ 24847 h 120960"/>
                    <a:gd name="connsiteX25" fmla="*/ 66655 w 118541"/>
                    <a:gd name="connsiteY25" fmla="*/ 7322 h 120960"/>
                    <a:gd name="connsiteX26" fmla="*/ 88868 w 118541"/>
                    <a:gd name="connsiteY26" fmla="*/ 365 h 120960"/>
                    <a:gd name="connsiteX27" fmla="*/ 110857 w 118541"/>
                    <a:gd name="connsiteY27" fmla="*/ 7396 h 120960"/>
                    <a:gd name="connsiteX28" fmla="*/ 118559 w 118541"/>
                    <a:gd name="connsiteY28" fmla="*/ 24772 h 120960"/>
                    <a:gd name="connsiteX29" fmla="*/ 110931 w 118541"/>
                    <a:gd name="connsiteY29" fmla="*/ 41776 h 120960"/>
                    <a:gd name="connsiteX30" fmla="*/ 88049 w 118541"/>
                    <a:gd name="connsiteY30" fmla="*/ 48548 h 120960"/>
                    <a:gd name="connsiteX31" fmla="*/ 68627 w 118541"/>
                    <a:gd name="connsiteY31" fmla="*/ 24475 h 120960"/>
                    <a:gd name="connsiteX32" fmla="*/ 73092 w 118541"/>
                    <a:gd name="connsiteY32" fmla="*/ 33106 h 120960"/>
                    <a:gd name="connsiteX33" fmla="*/ 89426 w 118541"/>
                    <a:gd name="connsiteY33" fmla="*/ 36530 h 120960"/>
                    <a:gd name="connsiteX34" fmla="*/ 104606 w 118541"/>
                    <a:gd name="connsiteY34" fmla="*/ 33069 h 120960"/>
                    <a:gd name="connsiteX35" fmla="*/ 109071 w 118541"/>
                    <a:gd name="connsiteY35" fmla="*/ 24549 h 120960"/>
                    <a:gd name="connsiteX36" fmla="*/ 104606 w 118541"/>
                    <a:gd name="connsiteY36" fmla="*/ 15843 h 120960"/>
                    <a:gd name="connsiteX37" fmla="*/ 88347 w 118541"/>
                    <a:gd name="connsiteY37" fmla="*/ 12420 h 120960"/>
                    <a:gd name="connsiteX38" fmla="*/ 73055 w 118541"/>
                    <a:gd name="connsiteY38" fmla="*/ 15880 h 120960"/>
                    <a:gd name="connsiteX39" fmla="*/ 68627 w 118541"/>
                    <a:gd name="connsiteY39" fmla="*/ 24475 h 1209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</a:cxnLst>
                  <a:rect l="l" t="t" r="r" b="b"/>
                  <a:pathLst>
                    <a:path w="118541" h="120960">
                      <a:moveTo>
                        <a:pt x="28927" y="121325"/>
                      </a:moveTo>
                      <a:cubicBezTo>
                        <a:pt x="20927" y="121362"/>
                        <a:pt x="14119" y="119315"/>
                        <a:pt x="8463" y="115260"/>
                      </a:cubicBezTo>
                      <a:cubicBezTo>
                        <a:pt x="2845" y="111241"/>
                        <a:pt x="17" y="105400"/>
                        <a:pt x="17" y="97661"/>
                      </a:cubicBezTo>
                      <a:cubicBezTo>
                        <a:pt x="17" y="90666"/>
                        <a:pt x="2547" y="84824"/>
                        <a:pt x="7570" y="80136"/>
                      </a:cubicBezTo>
                      <a:cubicBezTo>
                        <a:pt x="12630" y="75523"/>
                        <a:pt x="20034" y="73179"/>
                        <a:pt x="29783" y="73179"/>
                      </a:cubicBezTo>
                      <a:cubicBezTo>
                        <a:pt x="39345" y="73179"/>
                        <a:pt x="46675" y="75523"/>
                        <a:pt x="51772" y="80211"/>
                      </a:cubicBezTo>
                      <a:cubicBezTo>
                        <a:pt x="56944" y="84899"/>
                        <a:pt x="59511" y="90666"/>
                        <a:pt x="59474" y="97512"/>
                      </a:cubicBezTo>
                      <a:cubicBezTo>
                        <a:pt x="59511" y="104321"/>
                        <a:pt x="56981" y="110014"/>
                        <a:pt x="51884" y="114516"/>
                      </a:cubicBezTo>
                      <a:cubicBezTo>
                        <a:pt x="46861" y="119092"/>
                        <a:pt x="39196" y="121362"/>
                        <a:pt x="28927" y="121325"/>
                      </a:cubicBezTo>
                      <a:close/>
                      <a:moveTo>
                        <a:pt x="9542" y="97289"/>
                      </a:moveTo>
                      <a:cubicBezTo>
                        <a:pt x="9579" y="100712"/>
                        <a:pt x="11067" y="103577"/>
                        <a:pt x="14007" y="105846"/>
                      </a:cubicBezTo>
                      <a:cubicBezTo>
                        <a:pt x="16983" y="108153"/>
                        <a:pt x="22416" y="109307"/>
                        <a:pt x="30341" y="109269"/>
                      </a:cubicBezTo>
                      <a:cubicBezTo>
                        <a:pt x="37559" y="109307"/>
                        <a:pt x="42619" y="108153"/>
                        <a:pt x="45559" y="105809"/>
                      </a:cubicBezTo>
                      <a:cubicBezTo>
                        <a:pt x="48535" y="103540"/>
                        <a:pt x="50023" y="100675"/>
                        <a:pt x="49986" y="97289"/>
                      </a:cubicBezTo>
                      <a:cubicBezTo>
                        <a:pt x="50023" y="93829"/>
                        <a:pt x="48535" y="90964"/>
                        <a:pt x="45521" y="88657"/>
                      </a:cubicBezTo>
                      <a:cubicBezTo>
                        <a:pt x="42582" y="86387"/>
                        <a:pt x="37150" y="85234"/>
                        <a:pt x="29262" y="85234"/>
                      </a:cubicBezTo>
                      <a:cubicBezTo>
                        <a:pt x="22007" y="85234"/>
                        <a:pt x="16909" y="86387"/>
                        <a:pt x="13970" y="88694"/>
                      </a:cubicBezTo>
                      <a:cubicBezTo>
                        <a:pt x="11030" y="91001"/>
                        <a:pt x="9579" y="93866"/>
                        <a:pt x="9542" y="97289"/>
                      </a:cubicBezTo>
                      <a:close/>
                      <a:moveTo>
                        <a:pt x="118559" y="97214"/>
                      </a:moveTo>
                      <a:lnTo>
                        <a:pt x="17" y="35674"/>
                      </a:lnTo>
                      <a:lnTo>
                        <a:pt x="17" y="24475"/>
                      </a:lnTo>
                      <a:lnTo>
                        <a:pt x="118559" y="85792"/>
                      </a:lnTo>
                      <a:close/>
                      <a:moveTo>
                        <a:pt x="88049" y="48548"/>
                      </a:moveTo>
                      <a:cubicBezTo>
                        <a:pt x="79975" y="48585"/>
                        <a:pt x="73129" y="46538"/>
                        <a:pt x="67511" y="42483"/>
                      </a:cubicBezTo>
                      <a:cubicBezTo>
                        <a:pt x="61930" y="38464"/>
                        <a:pt x="59139" y="32586"/>
                        <a:pt x="59102" y="24847"/>
                      </a:cubicBezTo>
                      <a:cubicBezTo>
                        <a:pt x="59139" y="17778"/>
                        <a:pt x="61632" y="11936"/>
                        <a:pt x="66655" y="7322"/>
                      </a:cubicBezTo>
                      <a:cubicBezTo>
                        <a:pt x="71715" y="2708"/>
                        <a:pt x="79119" y="402"/>
                        <a:pt x="88868" y="365"/>
                      </a:cubicBezTo>
                      <a:cubicBezTo>
                        <a:pt x="98393" y="402"/>
                        <a:pt x="105722" y="2746"/>
                        <a:pt x="110857" y="7396"/>
                      </a:cubicBezTo>
                      <a:cubicBezTo>
                        <a:pt x="115991" y="12122"/>
                        <a:pt x="118559" y="17926"/>
                        <a:pt x="118559" y="24772"/>
                      </a:cubicBezTo>
                      <a:cubicBezTo>
                        <a:pt x="118559" y="31618"/>
                        <a:pt x="116029" y="37274"/>
                        <a:pt x="110931" y="41776"/>
                      </a:cubicBezTo>
                      <a:cubicBezTo>
                        <a:pt x="105871" y="46315"/>
                        <a:pt x="98244" y="48585"/>
                        <a:pt x="88049" y="48548"/>
                      </a:cubicBezTo>
                      <a:close/>
                      <a:moveTo>
                        <a:pt x="68627" y="24475"/>
                      </a:moveTo>
                      <a:cubicBezTo>
                        <a:pt x="68664" y="27972"/>
                        <a:pt x="70152" y="30837"/>
                        <a:pt x="73092" y="33106"/>
                      </a:cubicBezTo>
                      <a:cubicBezTo>
                        <a:pt x="76068" y="35414"/>
                        <a:pt x="81501" y="36567"/>
                        <a:pt x="89426" y="36530"/>
                      </a:cubicBezTo>
                      <a:cubicBezTo>
                        <a:pt x="96569" y="36567"/>
                        <a:pt x="101630" y="35414"/>
                        <a:pt x="104606" y="33069"/>
                      </a:cubicBezTo>
                      <a:cubicBezTo>
                        <a:pt x="107583" y="30800"/>
                        <a:pt x="109071" y="27972"/>
                        <a:pt x="109071" y="24549"/>
                      </a:cubicBezTo>
                      <a:cubicBezTo>
                        <a:pt x="109071" y="21051"/>
                        <a:pt x="107583" y="18149"/>
                        <a:pt x="104606" y="15843"/>
                      </a:cubicBezTo>
                      <a:cubicBezTo>
                        <a:pt x="101630" y="13610"/>
                        <a:pt x="96234" y="12457"/>
                        <a:pt x="88347" y="12420"/>
                      </a:cubicBezTo>
                      <a:cubicBezTo>
                        <a:pt x="81128" y="12457"/>
                        <a:pt x="76031" y="13610"/>
                        <a:pt x="73055" y="15880"/>
                      </a:cubicBezTo>
                      <a:cubicBezTo>
                        <a:pt x="70152" y="18224"/>
                        <a:pt x="68664" y="21088"/>
                        <a:pt x="68627" y="24475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1" name="Freihandform: Form 220">
                  <a:extLst>
                    <a:ext uri="{FF2B5EF4-FFF2-40B4-BE49-F238E27FC236}">
                      <a16:creationId xmlns:a16="http://schemas.microsoft.com/office/drawing/2014/main" id="{23F65AE0-1E49-4A9D-8676-5555B1DF9DC0}"/>
                    </a:ext>
                  </a:extLst>
                </p:cNvPr>
                <p:cNvSpPr/>
                <p:nvPr/>
              </p:nvSpPr>
              <p:spPr>
                <a:xfrm>
                  <a:off x="1460078" y="3336159"/>
                  <a:ext cx="9525" cy="9525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525" h="9525"/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2" name="Freihandform: Form 221">
                  <a:extLst>
                    <a:ext uri="{FF2B5EF4-FFF2-40B4-BE49-F238E27FC236}">
                      <a16:creationId xmlns:a16="http://schemas.microsoft.com/office/drawing/2014/main" id="{75277243-F826-4358-8478-4736939576CB}"/>
                    </a:ext>
                  </a:extLst>
                </p:cNvPr>
                <p:cNvSpPr/>
                <p:nvPr/>
              </p:nvSpPr>
              <p:spPr>
                <a:xfrm>
                  <a:off x="1376734" y="3211599"/>
                  <a:ext cx="85204" cy="75121"/>
                </a:xfrm>
                <a:custGeom>
                  <a:avLst/>
                  <a:gdLst>
                    <a:gd name="connsiteX0" fmla="*/ 57130 w 85204"/>
                    <a:gd name="connsiteY0" fmla="*/ 15080 h 75121"/>
                    <a:gd name="connsiteX1" fmla="*/ 58879 w 85204"/>
                    <a:gd name="connsiteY1" fmla="*/ 792 h 75121"/>
                    <a:gd name="connsiteX2" fmla="*/ 78301 w 85204"/>
                    <a:gd name="connsiteY2" fmla="*/ 13331 h 75121"/>
                    <a:gd name="connsiteX3" fmla="*/ 85221 w 85204"/>
                    <a:gd name="connsiteY3" fmla="*/ 36660 h 75121"/>
                    <a:gd name="connsiteX4" fmla="*/ 74208 w 85204"/>
                    <a:gd name="connsiteY4" fmla="*/ 65012 h 75121"/>
                    <a:gd name="connsiteX5" fmla="*/ 43289 w 85204"/>
                    <a:gd name="connsiteY5" fmla="*/ 75467 h 75121"/>
                    <a:gd name="connsiteX6" fmla="*/ 11403 w 85204"/>
                    <a:gd name="connsiteY6" fmla="*/ 64900 h 75121"/>
                    <a:gd name="connsiteX7" fmla="*/ 17 w 85204"/>
                    <a:gd name="connsiteY7" fmla="*/ 37404 h 75121"/>
                    <a:gd name="connsiteX8" fmla="*/ 11142 w 85204"/>
                    <a:gd name="connsiteY8" fmla="*/ 10726 h 75121"/>
                    <a:gd name="connsiteX9" fmla="*/ 42471 w 85204"/>
                    <a:gd name="connsiteY9" fmla="*/ 346 h 75121"/>
                    <a:gd name="connsiteX10" fmla="*/ 46154 w 85204"/>
                    <a:gd name="connsiteY10" fmla="*/ 420 h 75121"/>
                    <a:gd name="connsiteX11" fmla="*/ 46154 w 85204"/>
                    <a:gd name="connsiteY11" fmla="*/ 61216 h 75121"/>
                    <a:gd name="connsiteX12" fmla="*/ 66730 w 85204"/>
                    <a:gd name="connsiteY12" fmla="*/ 53626 h 75121"/>
                    <a:gd name="connsiteX13" fmla="*/ 73836 w 85204"/>
                    <a:gd name="connsiteY13" fmla="*/ 36585 h 75121"/>
                    <a:gd name="connsiteX14" fmla="*/ 69855 w 85204"/>
                    <a:gd name="connsiteY14" fmla="*/ 23600 h 75121"/>
                    <a:gd name="connsiteX15" fmla="*/ 57130 w 85204"/>
                    <a:gd name="connsiteY15" fmla="*/ 15080 h 75121"/>
                    <a:gd name="connsiteX16" fmla="*/ 34769 w 85204"/>
                    <a:gd name="connsiteY16" fmla="*/ 60435 h 75121"/>
                    <a:gd name="connsiteX17" fmla="*/ 34769 w 85204"/>
                    <a:gd name="connsiteY17" fmla="*/ 14931 h 75121"/>
                    <a:gd name="connsiteX18" fmla="*/ 19365 w 85204"/>
                    <a:gd name="connsiteY18" fmla="*/ 20140 h 75121"/>
                    <a:gd name="connsiteX19" fmla="*/ 11365 w 85204"/>
                    <a:gd name="connsiteY19" fmla="*/ 37255 h 75121"/>
                    <a:gd name="connsiteX20" fmla="*/ 17765 w 85204"/>
                    <a:gd name="connsiteY20" fmla="*/ 53254 h 75121"/>
                    <a:gd name="connsiteX21" fmla="*/ 34769 w 85204"/>
                    <a:gd name="connsiteY21" fmla="*/ 60435 h 7512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85204" h="75121">
                      <a:moveTo>
                        <a:pt x="57130" y="15080"/>
                      </a:moveTo>
                      <a:lnTo>
                        <a:pt x="58879" y="792"/>
                      </a:lnTo>
                      <a:cubicBezTo>
                        <a:pt x="67250" y="3099"/>
                        <a:pt x="73724" y="7266"/>
                        <a:pt x="78301" y="13331"/>
                      </a:cubicBezTo>
                      <a:cubicBezTo>
                        <a:pt x="82915" y="19433"/>
                        <a:pt x="85184" y="27209"/>
                        <a:pt x="85221" y="36660"/>
                      </a:cubicBezTo>
                      <a:cubicBezTo>
                        <a:pt x="85184" y="48603"/>
                        <a:pt x="81538" y="58054"/>
                        <a:pt x="74208" y="65012"/>
                      </a:cubicBezTo>
                      <a:cubicBezTo>
                        <a:pt x="66878" y="72006"/>
                        <a:pt x="56572" y="75504"/>
                        <a:pt x="43289" y="75467"/>
                      </a:cubicBezTo>
                      <a:cubicBezTo>
                        <a:pt x="29597" y="75504"/>
                        <a:pt x="18993" y="71969"/>
                        <a:pt x="11403" y="64900"/>
                      </a:cubicBezTo>
                      <a:cubicBezTo>
                        <a:pt x="3850" y="57868"/>
                        <a:pt x="55" y="48715"/>
                        <a:pt x="17" y="37404"/>
                      </a:cubicBezTo>
                      <a:cubicBezTo>
                        <a:pt x="55" y="26539"/>
                        <a:pt x="3738" y="17647"/>
                        <a:pt x="11142" y="10726"/>
                      </a:cubicBezTo>
                      <a:cubicBezTo>
                        <a:pt x="18584" y="3843"/>
                        <a:pt x="29039" y="383"/>
                        <a:pt x="42471" y="346"/>
                      </a:cubicBezTo>
                      <a:cubicBezTo>
                        <a:pt x="43326" y="383"/>
                        <a:pt x="44554" y="383"/>
                        <a:pt x="46154" y="420"/>
                      </a:cubicBezTo>
                      <a:lnTo>
                        <a:pt x="46154" y="61216"/>
                      </a:lnTo>
                      <a:cubicBezTo>
                        <a:pt x="55121" y="60733"/>
                        <a:pt x="61967" y="58203"/>
                        <a:pt x="66730" y="53626"/>
                      </a:cubicBezTo>
                      <a:cubicBezTo>
                        <a:pt x="71492" y="49087"/>
                        <a:pt x="73873" y="43394"/>
                        <a:pt x="73836" y="36585"/>
                      </a:cubicBezTo>
                      <a:cubicBezTo>
                        <a:pt x="73873" y="31525"/>
                        <a:pt x="72534" y="27209"/>
                        <a:pt x="69855" y="23600"/>
                      </a:cubicBezTo>
                      <a:cubicBezTo>
                        <a:pt x="67213" y="20065"/>
                        <a:pt x="62972" y="17238"/>
                        <a:pt x="57130" y="15080"/>
                      </a:cubicBezTo>
                      <a:close/>
                      <a:moveTo>
                        <a:pt x="34769" y="60435"/>
                      </a:moveTo>
                      <a:lnTo>
                        <a:pt x="34769" y="14931"/>
                      </a:lnTo>
                      <a:cubicBezTo>
                        <a:pt x="27960" y="15563"/>
                        <a:pt x="22825" y="17312"/>
                        <a:pt x="19365" y="20140"/>
                      </a:cubicBezTo>
                      <a:cubicBezTo>
                        <a:pt x="14044" y="24567"/>
                        <a:pt x="11365" y="30260"/>
                        <a:pt x="11365" y="37255"/>
                      </a:cubicBezTo>
                      <a:cubicBezTo>
                        <a:pt x="11365" y="43617"/>
                        <a:pt x="13523" y="48975"/>
                        <a:pt x="17765" y="53254"/>
                      </a:cubicBezTo>
                      <a:cubicBezTo>
                        <a:pt x="22044" y="57607"/>
                        <a:pt x="27699" y="59989"/>
                        <a:pt x="34769" y="60435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3" name="Freihandform: Form 222">
                  <a:extLst>
                    <a:ext uri="{FF2B5EF4-FFF2-40B4-BE49-F238E27FC236}">
                      <a16:creationId xmlns:a16="http://schemas.microsoft.com/office/drawing/2014/main" id="{E97156BB-627D-4B0D-B42F-B518ADF580AE}"/>
                    </a:ext>
                  </a:extLst>
                </p:cNvPr>
                <p:cNvSpPr/>
                <p:nvPr/>
              </p:nvSpPr>
              <p:spPr>
                <a:xfrm>
                  <a:off x="1378595" y="3127658"/>
                  <a:ext cx="81483" cy="76274"/>
                </a:xfrm>
                <a:custGeom>
                  <a:avLst/>
                  <a:gdLst>
                    <a:gd name="connsiteX0" fmla="*/ 81501 w 81483"/>
                    <a:gd name="connsiteY0" fmla="*/ 76611 h 76274"/>
                    <a:gd name="connsiteX1" fmla="*/ 39159 w 81483"/>
                    <a:gd name="connsiteY1" fmla="*/ 46845 h 76274"/>
                    <a:gd name="connsiteX2" fmla="*/ 17 w 81483"/>
                    <a:gd name="connsiteY2" fmla="*/ 74379 h 76274"/>
                    <a:gd name="connsiteX3" fmla="*/ 17 w 81483"/>
                    <a:gd name="connsiteY3" fmla="*/ 57114 h 76274"/>
                    <a:gd name="connsiteX4" fmla="*/ 19105 w 81483"/>
                    <a:gd name="connsiteY4" fmla="*/ 44613 h 76274"/>
                    <a:gd name="connsiteX5" fmla="*/ 28257 w 81483"/>
                    <a:gd name="connsiteY5" fmla="*/ 38920 h 76274"/>
                    <a:gd name="connsiteX6" fmla="*/ 19253 w 81483"/>
                    <a:gd name="connsiteY6" fmla="*/ 32707 h 76274"/>
                    <a:gd name="connsiteX7" fmla="*/ 17 w 81483"/>
                    <a:gd name="connsiteY7" fmla="*/ 18977 h 76274"/>
                    <a:gd name="connsiteX8" fmla="*/ 17 w 81483"/>
                    <a:gd name="connsiteY8" fmla="*/ 2495 h 76274"/>
                    <a:gd name="connsiteX9" fmla="*/ 38378 w 81483"/>
                    <a:gd name="connsiteY9" fmla="*/ 30660 h 76274"/>
                    <a:gd name="connsiteX10" fmla="*/ 81501 w 81483"/>
                    <a:gd name="connsiteY10" fmla="*/ 336 h 76274"/>
                    <a:gd name="connsiteX11" fmla="*/ 81501 w 81483"/>
                    <a:gd name="connsiteY11" fmla="*/ 17303 h 76274"/>
                    <a:gd name="connsiteX12" fmla="*/ 56163 w 81483"/>
                    <a:gd name="connsiteY12" fmla="*/ 34009 h 76274"/>
                    <a:gd name="connsiteX13" fmla="*/ 49354 w 81483"/>
                    <a:gd name="connsiteY13" fmla="*/ 38474 h 76274"/>
                    <a:gd name="connsiteX14" fmla="*/ 81501 w 81483"/>
                    <a:gd name="connsiteY14" fmla="*/ 59868 h 7627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</a:cxnLst>
                  <a:rect l="l" t="t" r="r" b="b"/>
                  <a:pathLst>
                    <a:path w="81483" h="76274">
                      <a:moveTo>
                        <a:pt x="81501" y="76611"/>
                      </a:moveTo>
                      <a:lnTo>
                        <a:pt x="39159" y="46845"/>
                      </a:lnTo>
                      <a:lnTo>
                        <a:pt x="17" y="74379"/>
                      </a:lnTo>
                      <a:lnTo>
                        <a:pt x="17" y="57114"/>
                      </a:lnTo>
                      <a:lnTo>
                        <a:pt x="19105" y="44613"/>
                      </a:lnTo>
                      <a:cubicBezTo>
                        <a:pt x="22751" y="42269"/>
                        <a:pt x="25802" y="40371"/>
                        <a:pt x="28257" y="38920"/>
                      </a:cubicBezTo>
                      <a:cubicBezTo>
                        <a:pt x="24872" y="36688"/>
                        <a:pt x="21895" y="34641"/>
                        <a:pt x="19253" y="32707"/>
                      </a:cubicBezTo>
                      <a:lnTo>
                        <a:pt x="17" y="18977"/>
                      </a:lnTo>
                      <a:lnTo>
                        <a:pt x="17" y="2495"/>
                      </a:lnTo>
                      <a:lnTo>
                        <a:pt x="38378" y="30660"/>
                      </a:lnTo>
                      <a:lnTo>
                        <a:pt x="81501" y="336"/>
                      </a:lnTo>
                      <a:lnTo>
                        <a:pt x="81501" y="17303"/>
                      </a:lnTo>
                      <a:lnTo>
                        <a:pt x="56163" y="34009"/>
                      </a:lnTo>
                      <a:lnTo>
                        <a:pt x="49354" y="38474"/>
                      </a:lnTo>
                      <a:lnTo>
                        <a:pt x="81501" y="5986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4" name="Freihandform: Form 223">
                  <a:extLst>
                    <a:ext uri="{FF2B5EF4-FFF2-40B4-BE49-F238E27FC236}">
                      <a16:creationId xmlns:a16="http://schemas.microsoft.com/office/drawing/2014/main" id="{85FC9DBA-6CF3-443C-BA3F-49956D38F60B}"/>
                    </a:ext>
                  </a:extLst>
                </p:cNvPr>
                <p:cNvSpPr/>
                <p:nvPr/>
              </p:nvSpPr>
              <p:spPr>
                <a:xfrm>
                  <a:off x="1376734" y="3045393"/>
                  <a:ext cx="114560" cy="70767"/>
                </a:xfrm>
                <a:custGeom>
                  <a:avLst/>
                  <a:gdLst>
                    <a:gd name="connsiteX0" fmla="*/ 114578 w 114560"/>
                    <a:gd name="connsiteY0" fmla="*/ 71096 h 70767"/>
                    <a:gd name="connsiteX1" fmla="*/ 1878 w 114560"/>
                    <a:gd name="connsiteY1" fmla="*/ 71096 h 70767"/>
                    <a:gd name="connsiteX2" fmla="*/ 1878 w 114560"/>
                    <a:gd name="connsiteY2" fmla="*/ 58483 h 70767"/>
                    <a:gd name="connsiteX3" fmla="*/ 12444 w 114560"/>
                    <a:gd name="connsiteY3" fmla="*/ 58483 h 70767"/>
                    <a:gd name="connsiteX4" fmla="*/ 3143 w 114560"/>
                    <a:gd name="connsiteY4" fmla="*/ 48474 h 70767"/>
                    <a:gd name="connsiteX5" fmla="*/ 17 w 114560"/>
                    <a:gd name="connsiteY5" fmla="*/ 34856 h 70767"/>
                    <a:gd name="connsiteX6" fmla="*/ 5412 w 114560"/>
                    <a:gd name="connsiteY6" fmla="*/ 16476 h 70767"/>
                    <a:gd name="connsiteX7" fmla="*/ 20556 w 114560"/>
                    <a:gd name="connsiteY7" fmla="*/ 4421 h 70767"/>
                    <a:gd name="connsiteX8" fmla="*/ 41987 w 114560"/>
                    <a:gd name="connsiteY8" fmla="*/ 328 h 70767"/>
                    <a:gd name="connsiteX9" fmla="*/ 64534 w 114560"/>
                    <a:gd name="connsiteY9" fmla="*/ 4830 h 70767"/>
                    <a:gd name="connsiteX10" fmla="*/ 79901 w 114560"/>
                    <a:gd name="connsiteY10" fmla="*/ 17853 h 70767"/>
                    <a:gd name="connsiteX11" fmla="*/ 85221 w 114560"/>
                    <a:gd name="connsiteY11" fmla="*/ 35861 h 70767"/>
                    <a:gd name="connsiteX12" fmla="*/ 82319 w 114560"/>
                    <a:gd name="connsiteY12" fmla="*/ 48251 h 70767"/>
                    <a:gd name="connsiteX13" fmla="*/ 74915 w 114560"/>
                    <a:gd name="connsiteY13" fmla="*/ 57255 h 70767"/>
                    <a:gd name="connsiteX14" fmla="*/ 114578 w 114560"/>
                    <a:gd name="connsiteY14" fmla="*/ 57255 h 70767"/>
                    <a:gd name="connsiteX15" fmla="*/ 43066 w 114560"/>
                    <a:gd name="connsiteY15" fmla="*/ 58557 h 70767"/>
                    <a:gd name="connsiteX16" fmla="*/ 66320 w 114560"/>
                    <a:gd name="connsiteY16" fmla="*/ 52195 h 70767"/>
                    <a:gd name="connsiteX17" fmla="*/ 73836 w 114560"/>
                    <a:gd name="connsiteY17" fmla="*/ 36791 h 70767"/>
                    <a:gd name="connsiteX18" fmla="*/ 66060 w 114560"/>
                    <a:gd name="connsiteY18" fmla="*/ 21015 h 70767"/>
                    <a:gd name="connsiteX19" fmla="*/ 41912 w 114560"/>
                    <a:gd name="connsiteY19" fmla="*/ 14430 h 70767"/>
                    <a:gd name="connsiteX20" fmla="*/ 18621 w 114560"/>
                    <a:gd name="connsiteY20" fmla="*/ 20866 h 70767"/>
                    <a:gd name="connsiteX21" fmla="*/ 10845 w 114560"/>
                    <a:gd name="connsiteY21" fmla="*/ 36159 h 70767"/>
                    <a:gd name="connsiteX22" fmla="*/ 19105 w 114560"/>
                    <a:gd name="connsiteY22" fmla="*/ 51786 h 70767"/>
                    <a:gd name="connsiteX23" fmla="*/ 43066 w 114560"/>
                    <a:gd name="connsiteY23" fmla="*/ 58557 h 7076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</a:cxnLst>
                  <a:rect l="l" t="t" r="r" b="b"/>
                  <a:pathLst>
                    <a:path w="114560" h="70767">
                      <a:moveTo>
                        <a:pt x="114578" y="71096"/>
                      </a:moveTo>
                      <a:lnTo>
                        <a:pt x="1878" y="71096"/>
                      </a:lnTo>
                      <a:lnTo>
                        <a:pt x="1878" y="58483"/>
                      </a:lnTo>
                      <a:lnTo>
                        <a:pt x="12444" y="58483"/>
                      </a:lnTo>
                      <a:cubicBezTo>
                        <a:pt x="8314" y="55581"/>
                        <a:pt x="5226" y="52232"/>
                        <a:pt x="3143" y="48474"/>
                      </a:cubicBezTo>
                      <a:cubicBezTo>
                        <a:pt x="1096" y="44753"/>
                        <a:pt x="55" y="40214"/>
                        <a:pt x="17" y="34856"/>
                      </a:cubicBezTo>
                      <a:cubicBezTo>
                        <a:pt x="55" y="27936"/>
                        <a:pt x="1840" y="21797"/>
                        <a:pt x="5412" y="16476"/>
                      </a:cubicBezTo>
                      <a:cubicBezTo>
                        <a:pt x="9021" y="11155"/>
                        <a:pt x="14082" y="7137"/>
                        <a:pt x="20556" y="4421"/>
                      </a:cubicBezTo>
                      <a:cubicBezTo>
                        <a:pt x="27104" y="1705"/>
                        <a:pt x="34248" y="365"/>
                        <a:pt x="41987" y="328"/>
                      </a:cubicBezTo>
                      <a:cubicBezTo>
                        <a:pt x="50396" y="365"/>
                        <a:pt x="57911" y="1854"/>
                        <a:pt x="64534" y="4830"/>
                      </a:cubicBezTo>
                      <a:cubicBezTo>
                        <a:pt x="71232" y="7844"/>
                        <a:pt x="76329" y="12197"/>
                        <a:pt x="79901" y="17853"/>
                      </a:cubicBezTo>
                      <a:cubicBezTo>
                        <a:pt x="83435" y="23583"/>
                        <a:pt x="85184" y="29573"/>
                        <a:pt x="85221" y="35861"/>
                      </a:cubicBezTo>
                      <a:cubicBezTo>
                        <a:pt x="85184" y="40475"/>
                        <a:pt x="84254" y="44605"/>
                        <a:pt x="82319" y="48251"/>
                      </a:cubicBezTo>
                      <a:cubicBezTo>
                        <a:pt x="80384" y="51934"/>
                        <a:pt x="77929" y="54948"/>
                        <a:pt x="74915" y="57255"/>
                      </a:cubicBezTo>
                      <a:lnTo>
                        <a:pt x="114578" y="57255"/>
                      </a:lnTo>
                      <a:close/>
                      <a:moveTo>
                        <a:pt x="43066" y="58557"/>
                      </a:moveTo>
                      <a:cubicBezTo>
                        <a:pt x="53558" y="58557"/>
                        <a:pt x="61334" y="56436"/>
                        <a:pt x="66320" y="52195"/>
                      </a:cubicBezTo>
                      <a:cubicBezTo>
                        <a:pt x="71380" y="47953"/>
                        <a:pt x="73873" y="42819"/>
                        <a:pt x="73836" y="36791"/>
                      </a:cubicBezTo>
                      <a:cubicBezTo>
                        <a:pt x="73873" y="30652"/>
                        <a:pt x="71269" y="25406"/>
                        <a:pt x="66060" y="21015"/>
                      </a:cubicBezTo>
                      <a:cubicBezTo>
                        <a:pt x="60888" y="16662"/>
                        <a:pt x="52851" y="14467"/>
                        <a:pt x="41912" y="14430"/>
                      </a:cubicBezTo>
                      <a:cubicBezTo>
                        <a:pt x="31569" y="14467"/>
                        <a:pt x="23793" y="16625"/>
                        <a:pt x="18621" y="20866"/>
                      </a:cubicBezTo>
                      <a:cubicBezTo>
                        <a:pt x="13449" y="25182"/>
                        <a:pt x="10882" y="30280"/>
                        <a:pt x="10845" y="36159"/>
                      </a:cubicBezTo>
                      <a:cubicBezTo>
                        <a:pt x="10882" y="42075"/>
                        <a:pt x="13635" y="47283"/>
                        <a:pt x="19105" y="51786"/>
                      </a:cubicBezTo>
                      <a:cubicBezTo>
                        <a:pt x="24611" y="56325"/>
                        <a:pt x="32573" y="58557"/>
                        <a:pt x="43066" y="58557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5" name="Freihandform: Form 224">
                  <a:extLst>
                    <a:ext uri="{FF2B5EF4-FFF2-40B4-BE49-F238E27FC236}">
                      <a16:creationId xmlns:a16="http://schemas.microsoft.com/office/drawing/2014/main" id="{E4600285-D69C-4C12-B933-48F89AEB69DF}"/>
                    </a:ext>
                  </a:extLst>
                </p:cNvPr>
                <p:cNvSpPr/>
                <p:nvPr/>
              </p:nvSpPr>
              <p:spPr>
                <a:xfrm>
                  <a:off x="1347564" y="3015244"/>
                  <a:ext cx="112514" cy="13803"/>
                </a:xfrm>
                <a:custGeom>
                  <a:avLst/>
                  <a:gdLst>
                    <a:gd name="connsiteX0" fmla="*/ 112531 w 112514"/>
                    <a:gd name="connsiteY0" fmla="*/ 14123 h 13803"/>
                    <a:gd name="connsiteX1" fmla="*/ 17 w 112514"/>
                    <a:gd name="connsiteY1" fmla="*/ 14123 h 13803"/>
                    <a:gd name="connsiteX2" fmla="*/ 17 w 112514"/>
                    <a:gd name="connsiteY2" fmla="*/ 319 h 13803"/>
                    <a:gd name="connsiteX3" fmla="*/ 112531 w 112514"/>
                    <a:gd name="connsiteY3" fmla="*/ 319 h 138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2514" h="13803">
                      <a:moveTo>
                        <a:pt x="112531" y="14123"/>
                      </a:moveTo>
                      <a:lnTo>
                        <a:pt x="17" y="14123"/>
                      </a:lnTo>
                      <a:lnTo>
                        <a:pt x="17" y="319"/>
                      </a:lnTo>
                      <a:lnTo>
                        <a:pt x="112531" y="31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6" name="Freihandform: Form 225">
                  <a:extLst>
                    <a:ext uri="{FF2B5EF4-FFF2-40B4-BE49-F238E27FC236}">
                      <a16:creationId xmlns:a16="http://schemas.microsoft.com/office/drawing/2014/main" id="{9B033F31-BBFF-45F7-91B7-A2D6A1C5009D}"/>
                    </a:ext>
                  </a:extLst>
                </p:cNvPr>
                <p:cNvSpPr/>
                <p:nvPr/>
              </p:nvSpPr>
              <p:spPr>
                <a:xfrm>
                  <a:off x="1444340" y="2974196"/>
                  <a:ext cx="15738" cy="15701"/>
                </a:xfrm>
                <a:custGeom>
                  <a:avLst/>
                  <a:gdLst>
                    <a:gd name="connsiteX0" fmla="*/ 15756 w 15738"/>
                    <a:gd name="connsiteY0" fmla="*/ 16017 h 15701"/>
                    <a:gd name="connsiteX1" fmla="*/ 17 w 15738"/>
                    <a:gd name="connsiteY1" fmla="*/ 16017 h 15701"/>
                    <a:gd name="connsiteX2" fmla="*/ 17 w 15738"/>
                    <a:gd name="connsiteY2" fmla="*/ 315 h 15701"/>
                    <a:gd name="connsiteX3" fmla="*/ 15756 w 15738"/>
                    <a:gd name="connsiteY3" fmla="*/ 315 h 1570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5738" h="15701">
                      <a:moveTo>
                        <a:pt x="15756" y="16017"/>
                      </a:moveTo>
                      <a:lnTo>
                        <a:pt x="17" y="16017"/>
                      </a:lnTo>
                      <a:lnTo>
                        <a:pt x="17" y="315"/>
                      </a:lnTo>
                      <a:lnTo>
                        <a:pt x="15756" y="315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7" name="Freihandform: Form 226">
                  <a:extLst>
                    <a:ext uri="{FF2B5EF4-FFF2-40B4-BE49-F238E27FC236}">
                      <a16:creationId xmlns:a16="http://schemas.microsoft.com/office/drawing/2014/main" id="{FCE61B8F-B18A-4A92-84C5-6023C0D4C988}"/>
                    </a:ext>
                  </a:extLst>
                </p:cNvPr>
                <p:cNvSpPr/>
                <p:nvPr/>
              </p:nvSpPr>
              <p:spPr>
                <a:xfrm>
                  <a:off x="1460078" y="2960512"/>
                  <a:ext cx="9525" cy="9525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525" h="9525"/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8" name="Freihandform: Form 227">
                  <a:extLst>
                    <a:ext uri="{FF2B5EF4-FFF2-40B4-BE49-F238E27FC236}">
                      <a16:creationId xmlns:a16="http://schemas.microsoft.com/office/drawing/2014/main" id="{54189B27-E047-4D9B-BA08-DC762625D283}"/>
                    </a:ext>
                  </a:extLst>
                </p:cNvPr>
                <p:cNvSpPr/>
                <p:nvPr/>
              </p:nvSpPr>
              <p:spPr>
                <a:xfrm>
                  <a:off x="1378595" y="2840129"/>
                  <a:ext cx="81483" cy="74711"/>
                </a:xfrm>
                <a:custGeom>
                  <a:avLst/>
                  <a:gdLst>
                    <a:gd name="connsiteX0" fmla="*/ 81501 w 81483"/>
                    <a:gd name="connsiteY0" fmla="*/ 44025 h 74711"/>
                    <a:gd name="connsiteX1" fmla="*/ 17 w 81483"/>
                    <a:gd name="connsiteY1" fmla="*/ 75018 h 74711"/>
                    <a:gd name="connsiteX2" fmla="*/ 17 w 81483"/>
                    <a:gd name="connsiteY2" fmla="*/ 60433 h 74711"/>
                    <a:gd name="connsiteX3" fmla="*/ 48796 w 81483"/>
                    <a:gd name="connsiteY3" fmla="*/ 42946 h 74711"/>
                    <a:gd name="connsiteX4" fmla="*/ 65241 w 81483"/>
                    <a:gd name="connsiteY4" fmla="*/ 37737 h 74711"/>
                    <a:gd name="connsiteX5" fmla="*/ 49726 w 81483"/>
                    <a:gd name="connsiteY5" fmla="*/ 32602 h 74711"/>
                    <a:gd name="connsiteX6" fmla="*/ 17 w 81483"/>
                    <a:gd name="connsiteY6" fmla="*/ 14482 h 74711"/>
                    <a:gd name="connsiteX7" fmla="*/ 17 w 81483"/>
                    <a:gd name="connsiteY7" fmla="*/ 306 h 74711"/>
                    <a:gd name="connsiteX8" fmla="*/ 81501 w 81483"/>
                    <a:gd name="connsiteY8" fmla="*/ 31151 h 7471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81483" h="74711">
                      <a:moveTo>
                        <a:pt x="81501" y="44025"/>
                      </a:moveTo>
                      <a:lnTo>
                        <a:pt x="17" y="75018"/>
                      </a:lnTo>
                      <a:lnTo>
                        <a:pt x="17" y="60433"/>
                      </a:lnTo>
                      <a:lnTo>
                        <a:pt x="48796" y="42946"/>
                      </a:lnTo>
                      <a:cubicBezTo>
                        <a:pt x="54079" y="41085"/>
                        <a:pt x="59586" y="39336"/>
                        <a:pt x="65241" y="37737"/>
                      </a:cubicBezTo>
                      <a:cubicBezTo>
                        <a:pt x="61000" y="36509"/>
                        <a:pt x="55828" y="34797"/>
                        <a:pt x="49726" y="32602"/>
                      </a:cubicBezTo>
                      <a:lnTo>
                        <a:pt x="17" y="14482"/>
                      </a:lnTo>
                      <a:lnTo>
                        <a:pt x="17" y="306"/>
                      </a:lnTo>
                      <a:lnTo>
                        <a:pt x="81501" y="31151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9" name="Freihandform: Form 228">
                  <a:extLst>
                    <a:ext uri="{FF2B5EF4-FFF2-40B4-BE49-F238E27FC236}">
                      <a16:creationId xmlns:a16="http://schemas.microsoft.com/office/drawing/2014/main" id="{77FFD374-315B-43EB-8FF2-E8BC5E14FF9C}"/>
                    </a:ext>
                  </a:extLst>
                </p:cNvPr>
                <p:cNvSpPr/>
                <p:nvPr/>
              </p:nvSpPr>
              <p:spPr>
                <a:xfrm>
                  <a:off x="1376734" y="2757529"/>
                  <a:ext cx="85204" cy="75046"/>
                </a:xfrm>
                <a:custGeom>
                  <a:avLst/>
                  <a:gdLst>
                    <a:gd name="connsiteX0" fmla="*/ 73315 w 85204"/>
                    <a:gd name="connsiteY0" fmla="*/ 17488 h 75046"/>
                    <a:gd name="connsiteX1" fmla="*/ 82542 w 85204"/>
                    <a:gd name="connsiteY1" fmla="*/ 32259 h 75046"/>
                    <a:gd name="connsiteX2" fmla="*/ 85221 w 85204"/>
                    <a:gd name="connsiteY2" fmla="*/ 47514 h 75046"/>
                    <a:gd name="connsiteX3" fmla="*/ 78673 w 85204"/>
                    <a:gd name="connsiteY3" fmla="*/ 68164 h 75046"/>
                    <a:gd name="connsiteX4" fmla="*/ 61855 w 85204"/>
                    <a:gd name="connsiteY4" fmla="*/ 75345 h 75046"/>
                    <a:gd name="connsiteX5" fmla="*/ 50954 w 85204"/>
                    <a:gd name="connsiteY5" fmla="*/ 72628 h 75046"/>
                    <a:gd name="connsiteX6" fmla="*/ 43029 w 85204"/>
                    <a:gd name="connsiteY6" fmla="*/ 65522 h 75046"/>
                    <a:gd name="connsiteX7" fmla="*/ 38452 w 85204"/>
                    <a:gd name="connsiteY7" fmla="*/ 55550 h 75046"/>
                    <a:gd name="connsiteX8" fmla="*/ 36406 w 85204"/>
                    <a:gd name="connsiteY8" fmla="*/ 43272 h 75046"/>
                    <a:gd name="connsiteX9" fmla="*/ 31643 w 85204"/>
                    <a:gd name="connsiteY9" fmla="*/ 18641 h 75046"/>
                    <a:gd name="connsiteX10" fmla="*/ 28034 w 85204"/>
                    <a:gd name="connsiteY10" fmla="*/ 18567 h 75046"/>
                    <a:gd name="connsiteX11" fmla="*/ 16128 w 85204"/>
                    <a:gd name="connsiteY11" fmla="*/ 22473 h 75046"/>
                    <a:gd name="connsiteX12" fmla="*/ 11440 w 85204"/>
                    <a:gd name="connsiteY12" fmla="*/ 38212 h 75046"/>
                    <a:gd name="connsiteX13" fmla="*/ 14863 w 85204"/>
                    <a:gd name="connsiteY13" fmla="*/ 52611 h 75046"/>
                    <a:gd name="connsiteX14" fmla="*/ 26955 w 85204"/>
                    <a:gd name="connsiteY14" fmla="*/ 59457 h 75046"/>
                    <a:gd name="connsiteX15" fmla="*/ 25132 w 85204"/>
                    <a:gd name="connsiteY15" fmla="*/ 72963 h 75046"/>
                    <a:gd name="connsiteX16" fmla="*/ 11142 w 85204"/>
                    <a:gd name="connsiteY16" fmla="*/ 66936 h 75046"/>
                    <a:gd name="connsiteX17" fmla="*/ 2919 w 85204"/>
                    <a:gd name="connsiteY17" fmla="*/ 54732 h 75046"/>
                    <a:gd name="connsiteX18" fmla="*/ 17 w 85204"/>
                    <a:gd name="connsiteY18" fmla="*/ 36203 h 75046"/>
                    <a:gd name="connsiteX19" fmla="*/ 2473 w 85204"/>
                    <a:gd name="connsiteY19" fmla="*/ 19273 h 75046"/>
                    <a:gd name="connsiteX20" fmla="*/ 8649 w 85204"/>
                    <a:gd name="connsiteY20" fmla="*/ 9674 h 75046"/>
                    <a:gd name="connsiteX21" fmla="*/ 18063 w 85204"/>
                    <a:gd name="connsiteY21" fmla="*/ 5358 h 75046"/>
                    <a:gd name="connsiteX22" fmla="*/ 30788 w 85204"/>
                    <a:gd name="connsiteY22" fmla="*/ 4688 h 75046"/>
                    <a:gd name="connsiteX23" fmla="*/ 49205 w 85204"/>
                    <a:gd name="connsiteY23" fmla="*/ 4688 h 75046"/>
                    <a:gd name="connsiteX24" fmla="*/ 73576 w 85204"/>
                    <a:gd name="connsiteY24" fmla="*/ 3795 h 75046"/>
                    <a:gd name="connsiteX25" fmla="*/ 83361 w 85204"/>
                    <a:gd name="connsiteY25" fmla="*/ 298 h 75046"/>
                    <a:gd name="connsiteX26" fmla="*/ 83361 w 85204"/>
                    <a:gd name="connsiteY26" fmla="*/ 14734 h 75046"/>
                    <a:gd name="connsiteX27" fmla="*/ 73315 w 85204"/>
                    <a:gd name="connsiteY27" fmla="*/ 17488 h 75046"/>
                    <a:gd name="connsiteX28" fmla="*/ 42471 w 85204"/>
                    <a:gd name="connsiteY28" fmla="*/ 18641 h 75046"/>
                    <a:gd name="connsiteX29" fmla="*/ 47680 w 85204"/>
                    <a:gd name="connsiteY29" fmla="*/ 41226 h 75046"/>
                    <a:gd name="connsiteX30" fmla="*/ 50433 w 85204"/>
                    <a:gd name="connsiteY30" fmla="*/ 53244 h 75046"/>
                    <a:gd name="connsiteX31" fmla="*/ 54935 w 85204"/>
                    <a:gd name="connsiteY31" fmla="*/ 58713 h 75046"/>
                    <a:gd name="connsiteX32" fmla="*/ 61483 w 85204"/>
                    <a:gd name="connsiteY32" fmla="*/ 60611 h 75046"/>
                    <a:gd name="connsiteX33" fmla="*/ 70711 w 85204"/>
                    <a:gd name="connsiteY33" fmla="*/ 56443 h 75046"/>
                    <a:gd name="connsiteX34" fmla="*/ 74394 w 85204"/>
                    <a:gd name="connsiteY34" fmla="*/ 44202 h 75046"/>
                    <a:gd name="connsiteX35" fmla="*/ 70897 w 85204"/>
                    <a:gd name="connsiteY35" fmla="*/ 30026 h 75046"/>
                    <a:gd name="connsiteX36" fmla="*/ 61334 w 85204"/>
                    <a:gd name="connsiteY36" fmla="*/ 20873 h 75046"/>
                    <a:gd name="connsiteX37" fmla="*/ 47531 w 85204"/>
                    <a:gd name="connsiteY37" fmla="*/ 18641 h 7504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</a:cxnLst>
                  <a:rect l="l" t="t" r="r" b="b"/>
                  <a:pathLst>
                    <a:path w="85204" h="75046">
                      <a:moveTo>
                        <a:pt x="73315" y="17488"/>
                      </a:moveTo>
                      <a:cubicBezTo>
                        <a:pt x="77668" y="22622"/>
                        <a:pt x="80757" y="27533"/>
                        <a:pt x="82542" y="32259"/>
                      </a:cubicBezTo>
                      <a:cubicBezTo>
                        <a:pt x="84328" y="37021"/>
                        <a:pt x="85184" y="42119"/>
                        <a:pt x="85221" y="47514"/>
                      </a:cubicBezTo>
                      <a:cubicBezTo>
                        <a:pt x="85184" y="56481"/>
                        <a:pt x="83026" y="63364"/>
                        <a:pt x="78673" y="68164"/>
                      </a:cubicBezTo>
                      <a:cubicBezTo>
                        <a:pt x="74283" y="72963"/>
                        <a:pt x="68701" y="75345"/>
                        <a:pt x="61855" y="75345"/>
                      </a:cubicBezTo>
                      <a:cubicBezTo>
                        <a:pt x="57911" y="75345"/>
                        <a:pt x="54265" y="74452"/>
                        <a:pt x="50954" y="72628"/>
                      </a:cubicBezTo>
                      <a:cubicBezTo>
                        <a:pt x="47680" y="70843"/>
                        <a:pt x="45038" y="68461"/>
                        <a:pt x="43029" y="65522"/>
                      </a:cubicBezTo>
                      <a:cubicBezTo>
                        <a:pt x="41057" y="62583"/>
                        <a:pt x="39531" y="59271"/>
                        <a:pt x="38452" y="55550"/>
                      </a:cubicBezTo>
                      <a:cubicBezTo>
                        <a:pt x="37782" y="52872"/>
                        <a:pt x="37113" y="48779"/>
                        <a:pt x="36406" y="43272"/>
                      </a:cubicBezTo>
                      <a:cubicBezTo>
                        <a:pt x="35103" y="32147"/>
                        <a:pt x="33504" y="23924"/>
                        <a:pt x="31643" y="18641"/>
                      </a:cubicBezTo>
                      <a:cubicBezTo>
                        <a:pt x="29783" y="18604"/>
                        <a:pt x="28592" y="18604"/>
                        <a:pt x="28034" y="18567"/>
                      </a:cubicBezTo>
                      <a:cubicBezTo>
                        <a:pt x="22453" y="18604"/>
                        <a:pt x="18472" y="19906"/>
                        <a:pt x="16128" y="22473"/>
                      </a:cubicBezTo>
                      <a:cubicBezTo>
                        <a:pt x="13040" y="26045"/>
                        <a:pt x="11477" y="31291"/>
                        <a:pt x="11440" y="38212"/>
                      </a:cubicBezTo>
                      <a:cubicBezTo>
                        <a:pt x="11477" y="44760"/>
                        <a:pt x="12630" y="49560"/>
                        <a:pt x="14863" y="52611"/>
                      </a:cubicBezTo>
                      <a:cubicBezTo>
                        <a:pt x="17170" y="55736"/>
                        <a:pt x="21188" y="58006"/>
                        <a:pt x="26955" y="59457"/>
                      </a:cubicBezTo>
                      <a:lnTo>
                        <a:pt x="25132" y="72963"/>
                      </a:lnTo>
                      <a:cubicBezTo>
                        <a:pt x="19402" y="71773"/>
                        <a:pt x="14714" y="69764"/>
                        <a:pt x="11142" y="66936"/>
                      </a:cubicBezTo>
                      <a:cubicBezTo>
                        <a:pt x="7570" y="64145"/>
                        <a:pt x="4854" y="60090"/>
                        <a:pt x="2919" y="54732"/>
                      </a:cubicBezTo>
                      <a:cubicBezTo>
                        <a:pt x="1022" y="49448"/>
                        <a:pt x="55" y="43272"/>
                        <a:pt x="17" y="36203"/>
                      </a:cubicBezTo>
                      <a:cubicBezTo>
                        <a:pt x="55" y="29282"/>
                        <a:pt x="873" y="23627"/>
                        <a:pt x="2473" y="19273"/>
                      </a:cubicBezTo>
                      <a:cubicBezTo>
                        <a:pt x="4147" y="14920"/>
                        <a:pt x="6194" y="11721"/>
                        <a:pt x="8649" y="9674"/>
                      </a:cubicBezTo>
                      <a:cubicBezTo>
                        <a:pt x="11142" y="7628"/>
                        <a:pt x="14268" y="6177"/>
                        <a:pt x="18063" y="5358"/>
                      </a:cubicBezTo>
                      <a:cubicBezTo>
                        <a:pt x="20444" y="4912"/>
                        <a:pt x="24686" y="4688"/>
                        <a:pt x="30788" y="4688"/>
                      </a:cubicBezTo>
                      <a:lnTo>
                        <a:pt x="49205" y="4688"/>
                      </a:lnTo>
                      <a:cubicBezTo>
                        <a:pt x="62079" y="4688"/>
                        <a:pt x="70227" y="4391"/>
                        <a:pt x="73576" y="3795"/>
                      </a:cubicBezTo>
                      <a:cubicBezTo>
                        <a:pt x="76999" y="3200"/>
                        <a:pt x="80236" y="2047"/>
                        <a:pt x="83361" y="298"/>
                      </a:cubicBezTo>
                      <a:lnTo>
                        <a:pt x="83361" y="14734"/>
                      </a:lnTo>
                      <a:cubicBezTo>
                        <a:pt x="80533" y="16185"/>
                        <a:pt x="77185" y="17116"/>
                        <a:pt x="73315" y="17488"/>
                      </a:cubicBezTo>
                      <a:close/>
                      <a:moveTo>
                        <a:pt x="42471" y="18641"/>
                      </a:moveTo>
                      <a:cubicBezTo>
                        <a:pt x="44517" y="23664"/>
                        <a:pt x="46266" y="31217"/>
                        <a:pt x="47680" y="41226"/>
                      </a:cubicBezTo>
                      <a:cubicBezTo>
                        <a:pt x="48535" y="46918"/>
                        <a:pt x="49428" y="50900"/>
                        <a:pt x="50433" y="53244"/>
                      </a:cubicBezTo>
                      <a:cubicBezTo>
                        <a:pt x="51475" y="55625"/>
                        <a:pt x="53000" y="57448"/>
                        <a:pt x="54935" y="58713"/>
                      </a:cubicBezTo>
                      <a:cubicBezTo>
                        <a:pt x="56944" y="59978"/>
                        <a:pt x="59102" y="60611"/>
                        <a:pt x="61483" y="60611"/>
                      </a:cubicBezTo>
                      <a:cubicBezTo>
                        <a:pt x="65204" y="60611"/>
                        <a:pt x="68292" y="59234"/>
                        <a:pt x="70711" y="56443"/>
                      </a:cubicBezTo>
                      <a:cubicBezTo>
                        <a:pt x="73203" y="53690"/>
                        <a:pt x="74431" y="49597"/>
                        <a:pt x="74394" y="44202"/>
                      </a:cubicBezTo>
                      <a:cubicBezTo>
                        <a:pt x="74431" y="38919"/>
                        <a:pt x="73278" y="34194"/>
                        <a:pt x="70897" y="30026"/>
                      </a:cubicBezTo>
                      <a:cubicBezTo>
                        <a:pt x="68590" y="25859"/>
                        <a:pt x="65390" y="22808"/>
                        <a:pt x="61334" y="20873"/>
                      </a:cubicBezTo>
                      <a:cubicBezTo>
                        <a:pt x="58246" y="19385"/>
                        <a:pt x="53633" y="18641"/>
                        <a:pt x="47531" y="18641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0" name="Freihandform: Form 229">
                  <a:extLst>
                    <a:ext uri="{FF2B5EF4-FFF2-40B4-BE49-F238E27FC236}">
                      <a16:creationId xmlns:a16="http://schemas.microsoft.com/office/drawing/2014/main" id="{109690B4-625C-4215-98EE-5714A6CFB03E}"/>
                    </a:ext>
                  </a:extLst>
                </p:cNvPr>
                <p:cNvSpPr/>
                <p:nvPr/>
              </p:nvSpPr>
              <p:spPr>
                <a:xfrm>
                  <a:off x="1376734" y="2696396"/>
                  <a:ext cx="83343" cy="44276"/>
                </a:xfrm>
                <a:custGeom>
                  <a:avLst/>
                  <a:gdLst>
                    <a:gd name="connsiteX0" fmla="*/ 83361 w 83343"/>
                    <a:gd name="connsiteY0" fmla="*/ 44565 h 44276"/>
                    <a:gd name="connsiteX1" fmla="*/ 1878 w 83343"/>
                    <a:gd name="connsiteY1" fmla="*/ 44565 h 44276"/>
                    <a:gd name="connsiteX2" fmla="*/ 1878 w 83343"/>
                    <a:gd name="connsiteY2" fmla="*/ 32138 h 44276"/>
                    <a:gd name="connsiteX3" fmla="*/ 14230 w 83343"/>
                    <a:gd name="connsiteY3" fmla="*/ 32138 h 44276"/>
                    <a:gd name="connsiteX4" fmla="*/ 2808 w 83343"/>
                    <a:gd name="connsiteY4" fmla="*/ 23357 h 44276"/>
                    <a:gd name="connsiteX5" fmla="*/ 17 w 83343"/>
                    <a:gd name="connsiteY5" fmla="*/ 14465 h 44276"/>
                    <a:gd name="connsiteX6" fmla="*/ 4482 w 83343"/>
                    <a:gd name="connsiteY6" fmla="*/ 289 h 44276"/>
                    <a:gd name="connsiteX7" fmla="*/ 17281 w 83343"/>
                    <a:gd name="connsiteY7" fmla="*/ 5051 h 44276"/>
                    <a:gd name="connsiteX8" fmla="*/ 14305 w 83343"/>
                    <a:gd name="connsiteY8" fmla="*/ 15172 h 44276"/>
                    <a:gd name="connsiteX9" fmla="*/ 17021 w 83343"/>
                    <a:gd name="connsiteY9" fmla="*/ 23283 h 44276"/>
                    <a:gd name="connsiteX10" fmla="*/ 24574 w 83343"/>
                    <a:gd name="connsiteY10" fmla="*/ 28455 h 44276"/>
                    <a:gd name="connsiteX11" fmla="*/ 40685 w 83343"/>
                    <a:gd name="connsiteY11" fmla="*/ 30724 h 44276"/>
                    <a:gd name="connsiteX12" fmla="*/ 83361 w 83343"/>
                    <a:gd name="connsiteY12" fmla="*/ 30724 h 4427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83343" h="44276">
                      <a:moveTo>
                        <a:pt x="83361" y="44565"/>
                      </a:moveTo>
                      <a:lnTo>
                        <a:pt x="1878" y="44565"/>
                      </a:lnTo>
                      <a:lnTo>
                        <a:pt x="1878" y="32138"/>
                      </a:lnTo>
                      <a:lnTo>
                        <a:pt x="14230" y="32138"/>
                      </a:lnTo>
                      <a:cubicBezTo>
                        <a:pt x="8463" y="29013"/>
                        <a:pt x="4668" y="26073"/>
                        <a:pt x="2808" y="23357"/>
                      </a:cubicBezTo>
                      <a:cubicBezTo>
                        <a:pt x="985" y="20678"/>
                        <a:pt x="55" y="17702"/>
                        <a:pt x="17" y="14465"/>
                      </a:cubicBezTo>
                      <a:cubicBezTo>
                        <a:pt x="55" y="9814"/>
                        <a:pt x="1543" y="5089"/>
                        <a:pt x="4482" y="289"/>
                      </a:cubicBezTo>
                      <a:lnTo>
                        <a:pt x="17281" y="5051"/>
                      </a:lnTo>
                      <a:cubicBezTo>
                        <a:pt x="15309" y="8437"/>
                        <a:pt x="14342" y="11823"/>
                        <a:pt x="14305" y="15172"/>
                      </a:cubicBezTo>
                      <a:cubicBezTo>
                        <a:pt x="14342" y="18223"/>
                        <a:pt x="15235" y="20901"/>
                        <a:pt x="17021" y="23283"/>
                      </a:cubicBezTo>
                      <a:cubicBezTo>
                        <a:pt x="18844" y="25701"/>
                        <a:pt x="21374" y="27450"/>
                        <a:pt x="24574" y="28455"/>
                      </a:cubicBezTo>
                      <a:cubicBezTo>
                        <a:pt x="29523" y="30017"/>
                        <a:pt x="34880" y="30761"/>
                        <a:pt x="40685" y="30724"/>
                      </a:cubicBezTo>
                      <a:lnTo>
                        <a:pt x="83361" y="3072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grpSp>
            <p:nvGrpSpPr>
              <p:cNvPr id="264" name="Gruppieren 263">
                <a:extLst>
                  <a:ext uri="{FF2B5EF4-FFF2-40B4-BE49-F238E27FC236}">
                    <a16:creationId xmlns:a16="http://schemas.microsoft.com/office/drawing/2014/main" id="{D98DD9D8-7DCC-47E8-BD11-58D90DEDFCE0}"/>
                  </a:ext>
                </a:extLst>
              </p:cNvPr>
              <p:cNvGrpSpPr/>
              <p:nvPr/>
            </p:nvGrpSpPr>
            <p:grpSpPr>
              <a:xfrm>
                <a:off x="248319" y="1100933"/>
                <a:ext cx="6420436" cy="4992450"/>
                <a:chOff x="333729" y="1039620"/>
                <a:chExt cx="6925155" cy="5384914"/>
              </a:xfrm>
            </p:grpSpPr>
            <p:sp>
              <p:nvSpPr>
                <p:cNvPr id="9" name="Freihandform: Form 8">
                  <a:extLst>
                    <a:ext uri="{FF2B5EF4-FFF2-40B4-BE49-F238E27FC236}">
                      <a16:creationId xmlns:a16="http://schemas.microsoft.com/office/drawing/2014/main" id="{684A0920-4DA4-4A54-B7F3-5E0F99BB2559}"/>
                    </a:ext>
                  </a:extLst>
                </p:cNvPr>
                <p:cNvSpPr/>
                <p:nvPr/>
              </p:nvSpPr>
              <p:spPr>
                <a:xfrm>
                  <a:off x="593004" y="1244130"/>
                  <a:ext cx="6665848" cy="5017293"/>
                </a:xfrm>
                <a:custGeom>
                  <a:avLst/>
                  <a:gdLst>
                    <a:gd name="connsiteX0" fmla="*/ 0 w 8210210"/>
                    <a:gd name="connsiteY0" fmla="*/ 6179714 h 6179713"/>
                    <a:gd name="connsiteX1" fmla="*/ 8210211 w 8210210"/>
                    <a:gd name="connsiteY1" fmla="*/ 6179714 h 6179713"/>
                    <a:gd name="connsiteX2" fmla="*/ 8210211 w 8210210"/>
                    <a:gd name="connsiteY2" fmla="*/ 0 h 6179713"/>
                    <a:gd name="connsiteX3" fmla="*/ 0 w 8210210"/>
                    <a:gd name="connsiteY3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8210210" h="6179713">
                      <a:moveTo>
                        <a:pt x="0" y="6179714"/>
                      </a:moveTo>
                      <a:lnTo>
                        <a:pt x="8210211" y="6179714"/>
                      </a:lnTo>
                      <a:lnTo>
                        <a:pt x="821021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" name="Freihandform: Form 9">
                  <a:extLst>
                    <a:ext uri="{FF2B5EF4-FFF2-40B4-BE49-F238E27FC236}">
                      <a16:creationId xmlns:a16="http://schemas.microsoft.com/office/drawing/2014/main" id="{FBCB9CAC-AC99-4A22-A97B-7DE3C1CE47B1}"/>
                    </a:ext>
                  </a:extLst>
                </p:cNvPr>
                <p:cNvSpPr/>
                <p:nvPr/>
              </p:nvSpPr>
              <p:spPr>
                <a:xfrm>
                  <a:off x="593004" y="5154506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" name="Freihandform: Form 10">
                  <a:extLst>
                    <a:ext uri="{FF2B5EF4-FFF2-40B4-BE49-F238E27FC236}">
                      <a16:creationId xmlns:a16="http://schemas.microsoft.com/office/drawing/2014/main" id="{A3F997FB-172F-44C2-B0EA-F15A9B20D016}"/>
                    </a:ext>
                  </a:extLst>
                </p:cNvPr>
                <p:cNvSpPr/>
                <p:nvPr/>
              </p:nvSpPr>
              <p:spPr>
                <a:xfrm>
                  <a:off x="593004" y="4006410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" name="Freihandform: Form 11">
                  <a:extLst>
                    <a:ext uri="{FF2B5EF4-FFF2-40B4-BE49-F238E27FC236}">
                      <a16:creationId xmlns:a16="http://schemas.microsoft.com/office/drawing/2014/main" id="{AC31D529-E39D-4AAF-AD2A-4E7C0611586B}"/>
                    </a:ext>
                  </a:extLst>
                </p:cNvPr>
                <p:cNvSpPr/>
                <p:nvPr/>
              </p:nvSpPr>
              <p:spPr>
                <a:xfrm>
                  <a:off x="593004" y="2858282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" name="Freihandform: Form 12">
                  <a:extLst>
                    <a:ext uri="{FF2B5EF4-FFF2-40B4-BE49-F238E27FC236}">
                      <a16:creationId xmlns:a16="http://schemas.microsoft.com/office/drawing/2014/main" id="{69BD67DF-1EB3-4FB4-8EB6-B46245ED5827}"/>
                    </a:ext>
                  </a:extLst>
                </p:cNvPr>
                <p:cNvSpPr/>
                <p:nvPr/>
              </p:nvSpPr>
              <p:spPr>
                <a:xfrm>
                  <a:off x="593004" y="1710154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" name="Freihandform: Form 13">
                  <a:extLst>
                    <a:ext uri="{FF2B5EF4-FFF2-40B4-BE49-F238E27FC236}">
                      <a16:creationId xmlns:a16="http://schemas.microsoft.com/office/drawing/2014/main" id="{61737E5F-6C86-45A3-ADE8-EC4A817E6A8C}"/>
                    </a:ext>
                  </a:extLst>
                </p:cNvPr>
                <p:cNvSpPr/>
                <p:nvPr/>
              </p:nvSpPr>
              <p:spPr>
                <a:xfrm>
                  <a:off x="2112118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" name="Freihandform: Form 14">
                  <a:extLst>
                    <a:ext uri="{FF2B5EF4-FFF2-40B4-BE49-F238E27FC236}">
                      <a16:creationId xmlns:a16="http://schemas.microsoft.com/office/drawing/2014/main" id="{4DC8C21E-DBED-4B78-BB29-BEEA72222BD3}"/>
                    </a:ext>
                  </a:extLst>
                </p:cNvPr>
                <p:cNvSpPr/>
                <p:nvPr/>
              </p:nvSpPr>
              <p:spPr>
                <a:xfrm>
                  <a:off x="3725668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" name="Freihandform: Form 15">
                  <a:extLst>
                    <a:ext uri="{FF2B5EF4-FFF2-40B4-BE49-F238E27FC236}">
                      <a16:creationId xmlns:a16="http://schemas.microsoft.com/office/drawing/2014/main" id="{4D6AEDE0-1579-49D5-8F81-1759877FD16B}"/>
                    </a:ext>
                  </a:extLst>
                </p:cNvPr>
                <p:cNvSpPr/>
                <p:nvPr/>
              </p:nvSpPr>
              <p:spPr>
                <a:xfrm>
                  <a:off x="5339210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" name="Freihandform: Form 16">
                  <a:extLst>
                    <a:ext uri="{FF2B5EF4-FFF2-40B4-BE49-F238E27FC236}">
                      <a16:creationId xmlns:a16="http://schemas.microsoft.com/office/drawing/2014/main" id="{A493DF7B-132A-43FB-973D-8899A18164D9}"/>
                    </a:ext>
                  </a:extLst>
                </p:cNvPr>
                <p:cNvSpPr/>
                <p:nvPr/>
              </p:nvSpPr>
              <p:spPr>
                <a:xfrm>
                  <a:off x="6952753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5081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" name="Freihandform: Form 17">
                  <a:extLst>
                    <a:ext uri="{FF2B5EF4-FFF2-40B4-BE49-F238E27FC236}">
                      <a16:creationId xmlns:a16="http://schemas.microsoft.com/office/drawing/2014/main" id="{F873B3BF-EC0F-4BDE-837A-010E7BEB53D6}"/>
                    </a:ext>
                  </a:extLst>
                </p:cNvPr>
                <p:cNvSpPr/>
                <p:nvPr/>
              </p:nvSpPr>
              <p:spPr>
                <a:xfrm>
                  <a:off x="593004" y="5728582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" name="Freihandform: Form 18">
                  <a:extLst>
                    <a:ext uri="{FF2B5EF4-FFF2-40B4-BE49-F238E27FC236}">
                      <a16:creationId xmlns:a16="http://schemas.microsoft.com/office/drawing/2014/main" id="{A7299823-A1AC-4DD5-9457-DAC7B842B147}"/>
                    </a:ext>
                  </a:extLst>
                </p:cNvPr>
                <p:cNvSpPr/>
                <p:nvPr/>
              </p:nvSpPr>
              <p:spPr>
                <a:xfrm>
                  <a:off x="593004" y="4580454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" name="Freihandform: Form 19">
                  <a:extLst>
                    <a:ext uri="{FF2B5EF4-FFF2-40B4-BE49-F238E27FC236}">
                      <a16:creationId xmlns:a16="http://schemas.microsoft.com/office/drawing/2014/main" id="{A70DC199-9045-41F5-8DB4-C7C6F7200A42}"/>
                    </a:ext>
                  </a:extLst>
                </p:cNvPr>
                <p:cNvSpPr/>
                <p:nvPr/>
              </p:nvSpPr>
              <p:spPr>
                <a:xfrm>
                  <a:off x="593004" y="3432327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" name="Freihandform: Form 20">
                  <a:extLst>
                    <a:ext uri="{FF2B5EF4-FFF2-40B4-BE49-F238E27FC236}">
                      <a16:creationId xmlns:a16="http://schemas.microsoft.com/office/drawing/2014/main" id="{D8C976D5-4B6E-4DDA-9907-F7F4596149B4}"/>
                    </a:ext>
                  </a:extLst>
                </p:cNvPr>
                <p:cNvSpPr/>
                <p:nvPr/>
              </p:nvSpPr>
              <p:spPr>
                <a:xfrm>
                  <a:off x="593004" y="2284199"/>
                  <a:ext cx="6665880" cy="7733"/>
                </a:xfrm>
                <a:custGeom>
                  <a:avLst/>
                  <a:gdLst>
                    <a:gd name="connsiteX0" fmla="*/ 0 w 8210249"/>
                    <a:gd name="connsiteY0" fmla="*/ 0 h 9525"/>
                    <a:gd name="connsiteX1" fmla="*/ 8210249 w 8210249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210249" h="9525">
                      <a:moveTo>
                        <a:pt x="0" y="0"/>
                      </a:moveTo>
                      <a:lnTo>
                        <a:pt x="8210249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" name="Freihandform: Form 21">
                  <a:extLst>
                    <a:ext uri="{FF2B5EF4-FFF2-40B4-BE49-F238E27FC236}">
                      <a16:creationId xmlns:a16="http://schemas.microsoft.com/office/drawing/2014/main" id="{FE86740C-DE36-4625-8308-A98408926ABE}"/>
                    </a:ext>
                  </a:extLst>
                </p:cNvPr>
                <p:cNvSpPr/>
                <p:nvPr/>
              </p:nvSpPr>
              <p:spPr>
                <a:xfrm>
                  <a:off x="1305347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" name="Freihandform: Form 22">
                  <a:extLst>
                    <a:ext uri="{FF2B5EF4-FFF2-40B4-BE49-F238E27FC236}">
                      <a16:creationId xmlns:a16="http://schemas.microsoft.com/office/drawing/2014/main" id="{8B761646-E07C-4326-AE32-AEC79B14C92E}"/>
                    </a:ext>
                  </a:extLst>
                </p:cNvPr>
                <p:cNvSpPr/>
                <p:nvPr/>
              </p:nvSpPr>
              <p:spPr>
                <a:xfrm>
                  <a:off x="2918890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" name="Freihandform: Form 23">
                  <a:extLst>
                    <a:ext uri="{FF2B5EF4-FFF2-40B4-BE49-F238E27FC236}">
                      <a16:creationId xmlns:a16="http://schemas.microsoft.com/office/drawing/2014/main" id="{67DE6296-1D33-4090-84A5-427862C522F8}"/>
                    </a:ext>
                  </a:extLst>
                </p:cNvPr>
                <p:cNvSpPr/>
                <p:nvPr/>
              </p:nvSpPr>
              <p:spPr>
                <a:xfrm>
                  <a:off x="4532440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" name="Freihandform: Form 24">
                  <a:extLst>
                    <a:ext uri="{FF2B5EF4-FFF2-40B4-BE49-F238E27FC236}">
                      <a16:creationId xmlns:a16="http://schemas.microsoft.com/office/drawing/2014/main" id="{CC8402B4-98F5-4017-A0B5-2D90494C644B}"/>
                    </a:ext>
                  </a:extLst>
                </p:cNvPr>
                <p:cNvSpPr/>
                <p:nvPr/>
              </p:nvSpPr>
              <p:spPr>
                <a:xfrm>
                  <a:off x="6145981" y="1244130"/>
                  <a:ext cx="7733" cy="5017293"/>
                </a:xfrm>
                <a:custGeom>
                  <a:avLst/>
                  <a:gdLst>
                    <a:gd name="connsiteX0" fmla="*/ 0 w 9525"/>
                    <a:gd name="connsiteY0" fmla="*/ 6179714 h 6179713"/>
                    <a:gd name="connsiteX1" fmla="*/ 0 w 9525"/>
                    <a:gd name="connsiteY1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6179713">
                      <a:moveTo>
                        <a:pt x="0" y="617971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EBEBEB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" name="Freihandform: Form 25">
                  <a:extLst>
                    <a:ext uri="{FF2B5EF4-FFF2-40B4-BE49-F238E27FC236}">
                      <a16:creationId xmlns:a16="http://schemas.microsoft.com/office/drawing/2014/main" id="{BCB7D885-03AE-415B-A85D-551A693D964A}"/>
                    </a:ext>
                  </a:extLst>
                </p:cNvPr>
                <p:cNvSpPr/>
                <p:nvPr/>
              </p:nvSpPr>
              <p:spPr>
                <a:xfrm>
                  <a:off x="6868352" y="3471597"/>
                  <a:ext cx="93495" cy="93465"/>
                </a:xfrm>
                <a:custGeom>
                  <a:avLst/>
                  <a:gdLst>
                    <a:gd name="connsiteX0" fmla="*/ 115157 w 115156"/>
                    <a:gd name="connsiteY0" fmla="*/ 57560 h 115119"/>
                    <a:gd name="connsiteX1" fmla="*/ 57598 w 115156"/>
                    <a:gd name="connsiteY1" fmla="*/ 115119 h 115119"/>
                    <a:gd name="connsiteX2" fmla="*/ 0 w 115156"/>
                    <a:gd name="connsiteY2" fmla="*/ 57560 h 115119"/>
                    <a:gd name="connsiteX3" fmla="*/ 57598 w 115156"/>
                    <a:gd name="connsiteY3" fmla="*/ 0 h 115119"/>
                    <a:gd name="connsiteX4" fmla="*/ 115157 w 115156"/>
                    <a:gd name="connsiteY4" fmla="*/ 57560 h 11511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56" h="115119">
                      <a:moveTo>
                        <a:pt x="115157" y="57560"/>
                      </a:moveTo>
                      <a:cubicBezTo>
                        <a:pt x="115157" y="89373"/>
                        <a:pt x="89373" y="115119"/>
                        <a:pt x="57598" y="115119"/>
                      </a:cubicBezTo>
                      <a:cubicBezTo>
                        <a:pt x="25784" y="115119"/>
                        <a:pt x="0" y="89373"/>
                        <a:pt x="0" y="57560"/>
                      </a:cubicBezTo>
                      <a:cubicBezTo>
                        <a:pt x="0" y="25784"/>
                        <a:pt x="25784" y="0"/>
                        <a:pt x="57598" y="0"/>
                      </a:cubicBezTo>
                      <a:cubicBezTo>
                        <a:pt x="89373" y="0"/>
                        <a:pt x="115157" y="25784"/>
                        <a:pt x="115157" y="57560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" name="Freihandform: Form 26">
                  <a:extLst>
                    <a:ext uri="{FF2B5EF4-FFF2-40B4-BE49-F238E27FC236}">
                      <a16:creationId xmlns:a16="http://schemas.microsoft.com/office/drawing/2014/main" id="{FF066090-382D-4A85-9854-A4088932D79A}"/>
                    </a:ext>
                  </a:extLst>
                </p:cNvPr>
                <p:cNvSpPr/>
                <p:nvPr/>
              </p:nvSpPr>
              <p:spPr>
                <a:xfrm>
                  <a:off x="6909137" y="2463187"/>
                  <a:ext cx="93496" cy="93496"/>
                </a:xfrm>
                <a:custGeom>
                  <a:avLst/>
                  <a:gdLst>
                    <a:gd name="connsiteX0" fmla="*/ 115158 w 115157"/>
                    <a:gd name="connsiteY0" fmla="*/ 57560 h 115157"/>
                    <a:gd name="connsiteX1" fmla="*/ 57560 w 115157"/>
                    <a:gd name="connsiteY1" fmla="*/ 115157 h 115157"/>
                    <a:gd name="connsiteX2" fmla="*/ 0 w 115157"/>
                    <a:gd name="connsiteY2" fmla="*/ 57560 h 115157"/>
                    <a:gd name="connsiteX3" fmla="*/ 57560 w 115157"/>
                    <a:gd name="connsiteY3" fmla="*/ 0 h 115157"/>
                    <a:gd name="connsiteX4" fmla="*/ 115158 w 115157"/>
                    <a:gd name="connsiteY4" fmla="*/ 57560 h 11515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57" h="115157">
                      <a:moveTo>
                        <a:pt x="115158" y="57560"/>
                      </a:moveTo>
                      <a:cubicBezTo>
                        <a:pt x="115158" y="89373"/>
                        <a:pt x="89373" y="115157"/>
                        <a:pt x="57560" y="115157"/>
                      </a:cubicBezTo>
                      <a:cubicBezTo>
                        <a:pt x="25784" y="115157"/>
                        <a:pt x="0" y="89373"/>
                        <a:pt x="0" y="57560"/>
                      </a:cubicBezTo>
                      <a:cubicBezTo>
                        <a:pt x="0" y="25784"/>
                        <a:pt x="25784" y="0"/>
                        <a:pt x="57560" y="0"/>
                      </a:cubicBezTo>
                      <a:cubicBezTo>
                        <a:pt x="89373" y="0"/>
                        <a:pt x="115158" y="25784"/>
                        <a:pt x="115158" y="57560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" name="Freihandform: Form 27">
                  <a:extLst>
                    <a:ext uri="{FF2B5EF4-FFF2-40B4-BE49-F238E27FC236}">
                      <a16:creationId xmlns:a16="http://schemas.microsoft.com/office/drawing/2014/main" id="{4380D36D-6885-4A85-B7CA-F3EF143CBD4F}"/>
                    </a:ext>
                  </a:extLst>
                </p:cNvPr>
                <p:cNvSpPr/>
                <p:nvPr/>
              </p:nvSpPr>
              <p:spPr>
                <a:xfrm>
                  <a:off x="6157883" y="2751554"/>
                  <a:ext cx="93465" cy="93465"/>
                </a:xfrm>
                <a:custGeom>
                  <a:avLst/>
                  <a:gdLst>
                    <a:gd name="connsiteX0" fmla="*/ 115119 w 115119"/>
                    <a:gd name="connsiteY0" fmla="*/ 57560 h 115119"/>
                    <a:gd name="connsiteX1" fmla="*/ 57560 w 115119"/>
                    <a:gd name="connsiteY1" fmla="*/ 115119 h 115119"/>
                    <a:gd name="connsiteX2" fmla="*/ 0 w 115119"/>
                    <a:gd name="connsiteY2" fmla="*/ 57560 h 115119"/>
                    <a:gd name="connsiteX3" fmla="*/ 57560 w 115119"/>
                    <a:gd name="connsiteY3" fmla="*/ 0 h 115119"/>
                    <a:gd name="connsiteX4" fmla="*/ 115119 w 115119"/>
                    <a:gd name="connsiteY4" fmla="*/ 57560 h 11511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19" h="115119">
                      <a:moveTo>
                        <a:pt x="115119" y="57560"/>
                      </a:moveTo>
                      <a:cubicBezTo>
                        <a:pt x="115119" y="89335"/>
                        <a:pt x="89335" y="115119"/>
                        <a:pt x="57560" y="115119"/>
                      </a:cubicBezTo>
                      <a:cubicBezTo>
                        <a:pt x="25784" y="115119"/>
                        <a:pt x="0" y="89335"/>
                        <a:pt x="0" y="57560"/>
                      </a:cubicBezTo>
                      <a:cubicBezTo>
                        <a:pt x="0" y="25746"/>
                        <a:pt x="25784" y="0"/>
                        <a:pt x="57560" y="0"/>
                      </a:cubicBezTo>
                      <a:cubicBezTo>
                        <a:pt x="89335" y="0"/>
                        <a:pt x="115119" y="25746"/>
                        <a:pt x="115119" y="57560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9" name="Freihandform: Form 28">
                  <a:extLst>
                    <a:ext uri="{FF2B5EF4-FFF2-40B4-BE49-F238E27FC236}">
                      <a16:creationId xmlns:a16="http://schemas.microsoft.com/office/drawing/2014/main" id="{E99CA9AE-C1BA-4BDB-B9E9-6C1BFA2CB574}"/>
                    </a:ext>
                  </a:extLst>
                </p:cNvPr>
                <p:cNvSpPr/>
                <p:nvPr/>
              </p:nvSpPr>
              <p:spPr>
                <a:xfrm>
                  <a:off x="5895283" y="5986619"/>
                  <a:ext cx="93465" cy="93496"/>
                </a:xfrm>
                <a:custGeom>
                  <a:avLst/>
                  <a:gdLst>
                    <a:gd name="connsiteX0" fmla="*/ 115119 w 115119"/>
                    <a:gd name="connsiteY0" fmla="*/ 57560 h 115157"/>
                    <a:gd name="connsiteX1" fmla="*/ 57559 w 115119"/>
                    <a:gd name="connsiteY1" fmla="*/ 115158 h 115157"/>
                    <a:gd name="connsiteX2" fmla="*/ 0 w 115119"/>
                    <a:gd name="connsiteY2" fmla="*/ 57560 h 115157"/>
                    <a:gd name="connsiteX3" fmla="*/ 57559 w 115119"/>
                    <a:gd name="connsiteY3" fmla="*/ 0 h 115157"/>
                    <a:gd name="connsiteX4" fmla="*/ 115119 w 115119"/>
                    <a:gd name="connsiteY4" fmla="*/ 57560 h 11515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19" h="115157">
                      <a:moveTo>
                        <a:pt x="115119" y="57560"/>
                      </a:moveTo>
                      <a:cubicBezTo>
                        <a:pt x="115119" y="89374"/>
                        <a:pt x="89335" y="115158"/>
                        <a:pt x="57559" y="115158"/>
                      </a:cubicBezTo>
                      <a:cubicBezTo>
                        <a:pt x="25746" y="115158"/>
                        <a:pt x="0" y="89374"/>
                        <a:pt x="0" y="57560"/>
                      </a:cubicBezTo>
                      <a:cubicBezTo>
                        <a:pt x="0" y="25784"/>
                        <a:pt x="25746" y="0"/>
                        <a:pt x="57559" y="0"/>
                      </a:cubicBezTo>
                      <a:cubicBezTo>
                        <a:pt x="89335" y="0"/>
                        <a:pt x="115119" y="25784"/>
                        <a:pt x="115119" y="57560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0" name="Freihandform: Form 29">
                  <a:extLst>
                    <a:ext uri="{FF2B5EF4-FFF2-40B4-BE49-F238E27FC236}">
                      <a16:creationId xmlns:a16="http://schemas.microsoft.com/office/drawing/2014/main" id="{1C8056B7-EE6B-4C43-8758-CDDF20F7D56C}"/>
                    </a:ext>
                  </a:extLst>
                </p:cNvPr>
                <p:cNvSpPr/>
                <p:nvPr/>
              </p:nvSpPr>
              <p:spPr>
                <a:xfrm>
                  <a:off x="6578476" y="1425441"/>
                  <a:ext cx="93465" cy="93464"/>
                </a:xfrm>
                <a:custGeom>
                  <a:avLst/>
                  <a:gdLst>
                    <a:gd name="connsiteX0" fmla="*/ 115119 w 115119"/>
                    <a:gd name="connsiteY0" fmla="*/ 57559 h 115118"/>
                    <a:gd name="connsiteX1" fmla="*/ 57560 w 115119"/>
                    <a:gd name="connsiteY1" fmla="*/ 115118 h 115118"/>
                    <a:gd name="connsiteX2" fmla="*/ 0 w 115119"/>
                    <a:gd name="connsiteY2" fmla="*/ 57559 h 115118"/>
                    <a:gd name="connsiteX3" fmla="*/ 57560 w 115119"/>
                    <a:gd name="connsiteY3" fmla="*/ 0 h 115118"/>
                    <a:gd name="connsiteX4" fmla="*/ 115119 w 115119"/>
                    <a:gd name="connsiteY4" fmla="*/ 57559 h 1151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19" h="115118">
                      <a:moveTo>
                        <a:pt x="115119" y="57559"/>
                      </a:moveTo>
                      <a:cubicBezTo>
                        <a:pt x="115119" y="89371"/>
                        <a:pt x="89373" y="115118"/>
                        <a:pt x="57560" y="115118"/>
                      </a:cubicBezTo>
                      <a:cubicBezTo>
                        <a:pt x="25784" y="115118"/>
                        <a:pt x="0" y="89371"/>
                        <a:pt x="0" y="57559"/>
                      </a:cubicBezTo>
                      <a:cubicBezTo>
                        <a:pt x="0" y="25784"/>
                        <a:pt x="25784" y="0"/>
                        <a:pt x="57560" y="0"/>
                      </a:cubicBezTo>
                      <a:cubicBezTo>
                        <a:pt x="89373" y="0"/>
                        <a:pt x="115119" y="25784"/>
                        <a:pt x="115119" y="57559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1" name="Freihandform: Form 30">
                  <a:extLst>
                    <a:ext uri="{FF2B5EF4-FFF2-40B4-BE49-F238E27FC236}">
                      <a16:creationId xmlns:a16="http://schemas.microsoft.com/office/drawing/2014/main" id="{5CB154A1-F571-4733-A89E-78E4C6AF7368}"/>
                    </a:ext>
                  </a:extLst>
                </p:cNvPr>
                <p:cNvSpPr/>
                <p:nvPr/>
              </p:nvSpPr>
              <p:spPr>
                <a:xfrm>
                  <a:off x="6303757" y="3226032"/>
                  <a:ext cx="93465" cy="93496"/>
                </a:xfrm>
                <a:custGeom>
                  <a:avLst/>
                  <a:gdLst>
                    <a:gd name="connsiteX0" fmla="*/ 115119 w 115119"/>
                    <a:gd name="connsiteY0" fmla="*/ 57598 h 115157"/>
                    <a:gd name="connsiteX1" fmla="*/ 57559 w 115119"/>
                    <a:gd name="connsiteY1" fmla="*/ 115157 h 115157"/>
                    <a:gd name="connsiteX2" fmla="*/ 0 w 115119"/>
                    <a:gd name="connsiteY2" fmla="*/ 57598 h 115157"/>
                    <a:gd name="connsiteX3" fmla="*/ 57559 w 115119"/>
                    <a:gd name="connsiteY3" fmla="*/ 0 h 115157"/>
                    <a:gd name="connsiteX4" fmla="*/ 115119 w 115119"/>
                    <a:gd name="connsiteY4" fmla="*/ 57598 h 11515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19" h="115157">
                      <a:moveTo>
                        <a:pt x="115119" y="57598"/>
                      </a:moveTo>
                      <a:cubicBezTo>
                        <a:pt x="115119" y="89373"/>
                        <a:pt x="89335" y="115157"/>
                        <a:pt x="57559" y="115157"/>
                      </a:cubicBezTo>
                      <a:cubicBezTo>
                        <a:pt x="25794" y="115157"/>
                        <a:pt x="0" y="89373"/>
                        <a:pt x="0" y="57598"/>
                      </a:cubicBezTo>
                      <a:cubicBezTo>
                        <a:pt x="0" y="25793"/>
                        <a:pt x="25794" y="0"/>
                        <a:pt x="57559" y="0"/>
                      </a:cubicBezTo>
                      <a:cubicBezTo>
                        <a:pt x="89335" y="0"/>
                        <a:pt x="115119" y="25793"/>
                        <a:pt x="115119" y="57598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2" name="Freihandform: Form 31">
                  <a:extLst>
                    <a:ext uri="{FF2B5EF4-FFF2-40B4-BE49-F238E27FC236}">
                      <a16:creationId xmlns:a16="http://schemas.microsoft.com/office/drawing/2014/main" id="{77306E8C-102E-46FB-BA01-D4C003BD3A52}"/>
                    </a:ext>
                  </a:extLst>
                </p:cNvPr>
                <p:cNvSpPr/>
                <p:nvPr/>
              </p:nvSpPr>
              <p:spPr>
                <a:xfrm>
                  <a:off x="6038651" y="2372684"/>
                  <a:ext cx="93465" cy="93465"/>
                </a:xfrm>
                <a:custGeom>
                  <a:avLst/>
                  <a:gdLst>
                    <a:gd name="connsiteX0" fmla="*/ 115119 w 115119"/>
                    <a:gd name="connsiteY0" fmla="*/ 57560 h 115119"/>
                    <a:gd name="connsiteX1" fmla="*/ 57559 w 115119"/>
                    <a:gd name="connsiteY1" fmla="*/ 115119 h 115119"/>
                    <a:gd name="connsiteX2" fmla="*/ 0 w 115119"/>
                    <a:gd name="connsiteY2" fmla="*/ 57560 h 115119"/>
                    <a:gd name="connsiteX3" fmla="*/ 57559 w 115119"/>
                    <a:gd name="connsiteY3" fmla="*/ 0 h 115119"/>
                    <a:gd name="connsiteX4" fmla="*/ 115119 w 115119"/>
                    <a:gd name="connsiteY4" fmla="*/ 57560 h 11511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19" h="115119">
                      <a:moveTo>
                        <a:pt x="115119" y="57560"/>
                      </a:moveTo>
                      <a:cubicBezTo>
                        <a:pt x="115119" y="89373"/>
                        <a:pt x="89335" y="115119"/>
                        <a:pt x="57559" y="115119"/>
                      </a:cubicBezTo>
                      <a:cubicBezTo>
                        <a:pt x="25746" y="115119"/>
                        <a:pt x="0" y="89373"/>
                        <a:pt x="0" y="57560"/>
                      </a:cubicBezTo>
                      <a:cubicBezTo>
                        <a:pt x="0" y="25784"/>
                        <a:pt x="25746" y="0"/>
                        <a:pt x="57559" y="0"/>
                      </a:cubicBezTo>
                      <a:cubicBezTo>
                        <a:pt x="89335" y="0"/>
                        <a:pt x="115119" y="25784"/>
                        <a:pt x="115119" y="57560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3" name="Freihandform: Form 32">
                  <a:extLst>
                    <a:ext uri="{FF2B5EF4-FFF2-40B4-BE49-F238E27FC236}">
                      <a16:creationId xmlns:a16="http://schemas.microsoft.com/office/drawing/2014/main" id="{A896A802-3177-4E55-BD9E-12463F467863}"/>
                    </a:ext>
                  </a:extLst>
                </p:cNvPr>
                <p:cNvSpPr/>
                <p:nvPr/>
              </p:nvSpPr>
              <p:spPr>
                <a:xfrm>
                  <a:off x="5192246" y="5466980"/>
                  <a:ext cx="125906" cy="109024"/>
                </a:xfrm>
                <a:custGeom>
                  <a:avLst/>
                  <a:gdLst>
                    <a:gd name="connsiteX0" fmla="*/ 77544 w 155076"/>
                    <a:gd name="connsiteY0" fmla="*/ 0 h 134283"/>
                    <a:gd name="connsiteX1" fmla="*/ 155077 w 155076"/>
                    <a:gd name="connsiteY1" fmla="*/ 134283 h 134283"/>
                    <a:gd name="connsiteX2" fmla="*/ 0 w 155076"/>
                    <a:gd name="connsiteY2" fmla="*/ 134283 h 1342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76" h="134283">
                      <a:moveTo>
                        <a:pt x="77544" y="0"/>
                      </a:moveTo>
                      <a:lnTo>
                        <a:pt x="155077" y="134283"/>
                      </a:lnTo>
                      <a:lnTo>
                        <a:pt x="0" y="134283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4" name="Freihandform: Form 33">
                  <a:extLst>
                    <a:ext uri="{FF2B5EF4-FFF2-40B4-BE49-F238E27FC236}">
                      <a16:creationId xmlns:a16="http://schemas.microsoft.com/office/drawing/2014/main" id="{99E830DB-FF0C-4175-9B2A-34BE4246386A}"/>
                    </a:ext>
                  </a:extLst>
                </p:cNvPr>
                <p:cNvSpPr/>
                <p:nvPr/>
              </p:nvSpPr>
              <p:spPr>
                <a:xfrm>
                  <a:off x="833069" y="3919827"/>
                  <a:ext cx="125878" cy="109024"/>
                </a:xfrm>
                <a:custGeom>
                  <a:avLst/>
                  <a:gdLst>
                    <a:gd name="connsiteX0" fmla="*/ 77502 w 155042"/>
                    <a:gd name="connsiteY0" fmla="*/ 0 h 134283"/>
                    <a:gd name="connsiteX1" fmla="*/ 155042 w 155042"/>
                    <a:gd name="connsiteY1" fmla="*/ 134283 h 134283"/>
                    <a:gd name="connsiteX2" fmla="*/ 0 w 155042"/>
                    <a:gd name="connsiteY2" fmla="*/ 134283 h 1342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42" h="134283">
                      <a:moveTo>
                        <a:pt x="77502" y="0"/>
                      </a:moveTo>
                      <a:lnTo>
                        <a:pt x="155042" y="134283"/>
                      </a:lnTo>
                      <a:lnTo>
                        <a:pt x="0" y="134283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5" name="Freihandform: Form 34">
                  <a:extLst>
                    <a:ext uri="{FF2B5EF4-FFF2-40B4-BE49-F238E27FC236}">
                      <a16:creationId xmlns:a16="http://schemas.microsoft.com/office/drawing/2014/main" id="{A957936B-A5BA-4EE4-895F-7A06EB321E41}"/>
                    </a:ext>
                  </a:extLst>
                </p:cNvPr>
                <p:cNvSpPr/>
                <p:nvPr/>
              </p:nvSpPr>
              <p:spPr>
                <a:xfrm>
                  <a:off x="3192007" y="1615753"/>
                  <a:ext cx="125875" cy="109022"/>
                </a:xfrm>
                <a:custGeom>
                  <a:avLst/>
                  <a:gdLst>
                    <a:gd name="connsiteX0" fmla="*/ 77496 w 155038"/>
                    <a:gd name="connsiteY0" fmla="*/ 0 h 134280"/>
                    <a:gd name="connsiteX1" fmla="*/ 155039 w 155038"/>
                    <a:gd name="connsiteY1" fmla="*/ 134281 h 134280"/>
                    <a:gd name="connsiteX2" fmla="*/ 0 w 155038"/>
                    <a:gd name="connsiteY2" fmla="*/ 134281 h 1342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38" h="134280">
                      <a:moveTo>
                        <a:pt x="77496" y="0"/>
                      </a:moveTo>
                      <a:lnTo>
                        <a:pt x="155039" y="134281"/>
                      </a:lnTo>
                      <a:lnTo>
                        <a:pt x="0" y="134281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6" name="Freihandform: Form 35">
                  <a:extLst>
                    <a:ext uri="{FF2B5EF4-FFF2-40B4-BE49-F238E27FC236}">
                      <a16:creationId xmlns:a16="http://schemas.microsoft.com/office/drawing/2014/main" id="{A77BD8C2-379B-4005-8621-DC1E4665F739}"/>
                    </a:ext>
                  </a:extLst>
                </p:cNvPr>
                <p:cNvSpPr/>
                <p:nvPr/>
              </p:nvSpPr>
              <p:spPr>
                <a:xfrm>
                  <a:off x="1384521" y="3748975"/>
                  <a:ext cx="125875" cy="109017"/>
                </a:xfrm>
                <a:custGeom>
                  <a:avLst/>
                  <a:gdLst>
                    <a:gd name="connsiteX0" fmla="*/ 77505 w 155038"/>
                    <a:gd name="connsiteY0" fmla="*/ 0 h 134274"/>
                    <a:gd name="connsiteX1" fmla="*/ 155038 w 155038"/>
                    <a:gd name="connsiteY1" fmla="*/ 134274 h 134274"/>
                    <a:gd name="connsiteX2" fmla="*/ 0 w 155038"/>
                    <a:gd name="connsiteY2" fmla="*/ 134274 h 13427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38" h="134274">
                      <a:moveTo>
                        <a:pt x="77505" y="0"/>
                      </a:moveTo>
                      <a:lnTo>
                        <a:pt x="155038" y="134274"/>
                      </a:lnTo>
                      <a:lnTo>
                        <a:pt x="0" y="134274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7" name="Freihandform: Form 36">
                  <a:extLst>
                    <a:ext uri="{FF2B5EF4-FFF2-40B4-BE49-F238E27FC236}">
                      <a16:creationId xmlns:a16="http://schemas.microsoft.com/office/drawing/2014/main" id="{B48B5B08-657F-464C-A80B-2B6D37D1588B}"/>
                    </a:ext>
                  </a:extLst>
                </p:cNvPr>
                <p:cNvSpPr/>
                <p:nvPr/>
              </p:nvSpPr>
              <p:spPr>
                <a:xfrm>
                  <a:off x="3800705" y="2591212"/>
                  <a:ext cx="125906" cy="109016"/>
                </a:xfrm>
                <a:custGeom>
                  <a:avLst/>
                  <a:gdLst>
                    <a:gd name="connsiteX0" fmla="*/ 77534 w 155076"/>
                    <a:gd name="connsiteY0" fmla="*/ 0 h 134273"/>
                    <a:gd name="connsiteX1" fmla="*/ 155077 w 155076"/>
                    <a:gd name="connsiteY1" fmla="*/ 134274 h 134273"/>
                    <a:gd name="connsiteX2" fmla="*/ 0 w 155076"/>
                    <a:gd name="connsiteY2" fmla="*/ 134274 h 13427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76" h="134273">
                      <a:moveTo>
                        <a:pt x="77534" y="0"/>
                      </a:moveTo>
                      <a:lnTo>
                        <a:pt x="155077" y="134274"/>
                      </a:lnTo>
                      <a:lnTo>
                        <a:pt x="0" y="134274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8" name="Freihandform: Form 37">
                  <a:extLst>
                    <a:ext uri="{FF2B5EF4-FFF2-40B4-BE49-F238E27FC236}">
                      <a16:creationId xmlns:a16="http://schemas.microsoft.com/office/drawing/2014/main" id="{9C0E2127-CC60-4BA0-898C-43CC680736FF}"/>
                    </a:ext>
                  </a:extLst>
                </p:cNvPr>
                <p:cNvSpPr/>
                <p:nvPr/>
              </p:nvSpPr>
              <p:spPr>
                <a:xfrm>
                  <a:off x="2994870" y="3493195"/>
                  <a:ext cx="125875" cy="109024"/>
                </a:xfrm>
                <a:custGeom>
                  <a:avLst/>
                  <a:gdLst>
                    <a:gd name="connsiteX0" fmla="*/ 77496 w 155038"/>
                    <a:gd name="connsiteY0" fmla="*/ 0 h 134283"/>
                    <a:gd name="connsiteX1" fmla="*/ 155039 w 155038"/>
                    <a:gd name="connsiteY1" fmla="*/ 134283 h 134283"/>
                    <a:gd name="connsiteX2" fmla="*/ 0 w 155038"/>
                    <a:gd name="connsiteY2" fmla="*/ 134283 h 1342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38" h="134283">
                      <a:moveTo>
                        <a:pt x="77496" y="0"/>
                      </a:moveTo>
                      <a:lnTo>
                        <a:pt x="155039" y="134283"/>
                      </a:lnTo>
                      <a:lnTo>
                        <a:pt x="0" y="134283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" name="Freihandform: Form 38">
                  <a:extLst>
                    <a:ext uri="{FF2B5EF4-FFF2-40B4-BE49-F238E27FC236}">
                      <a16:creationId xmlns:a16="http://schemas.microsoft.com/office/drawing/2014/main" id="{8C547D94-A29A-46B6-9FD8-08DE85465297}"/>
                    </a:ext>
                  </a:extLst>
                </p:cNvPr>
                <p:cNvSpPr/>
                <p:nvPr/>
              </p:nvSpPr>
              <p:spPr>
                <a:xfrm>
                  <a:off x="2034661" y="3049860"/>
                  <a:ext cx="125882" cy="109024"/>
                </a:xfrm>
                <a:custGeom>
                  <a:avLst/>
                  <a:gdLst>
                    <a:gd name="connsiteX0" fmla="*/ 77505 w 155047"/>
                    <a:gd name="connsiteY0" fmla="*/ 0 h 134283"/>
                    <a:gd name="connsiteX1" fmla="*/ 155048 w 155047"/>
                    <a:gd name="connsiteY1" fmla="*/ 134283 h 134283"/>
                    <a:gd name="connsiteX2" fmla="*/ 0 w 155047"/>
                    <a:gd name="connsiteY2" fmla="*/ 134283 h 1342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47" h="134283">
                      <a:moveTo>
                        <a:pt x="77505" y="0"/>
                      </a:moveTo>
                      <a:lnTo>
                        <a:pt x="155048" y="134283"/>
                      </a:lnTo>
                      <a:lnTo>
                        <a:pt x="0" y="134283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" name="Freihandform: Form 39">
                  <a:extLst>
                    <a:ext uri="{FF2B5EF4-FFF2-40B4-BE49-F238E27FC236}">
                      <a16:creationId xmlns:a16="http://schemas.microsoft.com/office/drawing/2014/main" id="{742D7A43-47BF-4B15-AA4C-FA775A953833}"/>
                    </a:ext>
                  </a:extLst>
                </p:cNvPr>
                <p:cNvSpPr/>
                <p:nvPr/>
              </p:nvSpPr>
              <p:spPr>
                <a:xfrm>
                  <a:off x="593004" y="1244130"/>
                  <a:ext cx="6665848" cy="5017293"/>
                </a:xfrm>
                <a:custGeom>
                  <a:avLst/>
                  <a:gdLst>
                    <a:gd name="connsiteX0" fmla="*/ 0 w 8210210"/>
                    <a:gd name="connsiteY0" fmla="*/ 6179714 h 6179713"/>
                    <a:gd name="connsiteX1" fmla="*/ 8210211 w 8210210"/>
                    <a:gd name="connsiteY1" fmla="*/ 6179714 h 6179713"/>
                    <a:gd name="connsiteX2" fmla="*/ 8210211 w 8210210"/>
                    <a:gd name="connsiteY2" fmla="*/ 0 h 6179713"/>
                    <a:gd name="connsiteX3" fmla="*/ 0 w 8210210"/>
                    <a:gd name="connsiteY3" fmla="*/ 0 h 61797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8210210" h="6179713">
                      <a:moveTo>
                        <a:pt x="0" y="6179714"/>
                      </a:moveTo>
                      <a:lnTo>
                        <a:pt x="8210211" y="6179714"/>
                      </a:lnTo>
                      <a:lnTo>
                        <a:pt x="821021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10163" cap="rnd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" name="Freihandform: Form 40">
                  <a:extLst>
                    <a:ext uri="{FF2B5EF4-FFF2-40B4-BE49-F238E27FC236}">
                      <a16:creationId xmlns:a16="http://schemas.microsoft.com/office/drawing/2014/main" id="{82F6A401-FBFA-45CF-8756-5DF2B4E9CCA1}"/>
                    </a:ext>
                  </a:extLst>
                </p:cNvPr>
                <p:cNvSpPr/>
                <p:nvPr/>
              </p:nvSpPr>
              <p:spPr>
                <a:xfrm>
                  <a:off x="593005" y="1058138"/>
                  <a:ext cx="6665848" cy="277456"/>
                </a:xfrm>
                <a:custGeom>
                  <a:avLst/>
                  <a:gdLst>
                    <a:gd name="connsiteX0" fmla="*/ 0 w 8210210"/>
                    <a:gd name="connsiteY0" fmla="*/ 229083 h 229083"/>
                    <a:gd name="connsiteX1" fmla="*/ 8210211 w 8210210"/>
                    <a:gd name="connsiteY1" fmla="*/ 229083 h 229083"/>
                    <a:gd name="connsiteX2" fmla="*/ 8210211 w 8210210"/>
                    <a:gd name="connsiteY2" fmla="*/ 0 h 229083"/>
                    <a:gd name="connsiteX3" fmla="*/ 0 w 8210210"/>
                    <a:gd name="connsiteY3" fmla="*/ 0 h 2290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8210210" h="229083">
                      <a:moveTo>
                        <a:pt x="0" y="229083"/>
                      </a:moveTo>
                      <a:lnTo>
                        <a:pt x="8210211" y="229083"/>
                      </a:lnTo>
                      <a:lnTo>
                        <a:pt x="821021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D9D9D9"/>
                </a:solidFill>
                <a:ln w="10163" cap="rnd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8" name="Freihandform: Form 157">
                  <a:extLst>
                    <a:ext uri="{FF2B5EF4-FFF2-40B4-BE49-F238E27FC236}">
                      <a16:creationId xmlns:a16="http://schemas.microsoft.com/office/drawing/2014/main" id="{CC607D31-3CE8-4EAE-9E13-04F0F845AE51}"/>
                    </a:ext>
                  </a:extLst>
                </p:cNvPr>
                <p:cNvSpPr/>
                <p:nvPr/>
              </p:nvSpPr>
              <p:spPr>
                <a:xfrm>
                  <a:off x="1305347" y="6261424"/>
                  <a:ext cx="7733" cy="21182"/>
                </a:xfrm>
                <a:custGeom>
                  <a:avLst/>
                  <a:gdLst>
                    <a:gd name="connsiteX0" fmla="*/ 0 w 9525"/>
                    <a:gd name="connsiteY0" fmla="*/ 26089 h 26089"/>
                    <a:gd name="connsiteX1" fmla="*/ 0 w 9525"/>
                    <a:gd name="connsiteY1" fmla="*/ 0 h 2608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26089">
                      <a:moveTo>
                        <a:pt x="0" y="26089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9" name="Freihandform: Form 158">
                  <a:extLst>
                    <a:ext uri="{FF2B5EF4-FFF2-40B4-BE49-F238E27FC236}">
                      <a16:creationId xmlns:a16="http://schemas.microsoft.com/office/drawing/2014/main" id="{30294E40-CBEE-4A3F-9904-331033917B67}"/>
                    </a:ext>
                  </a:extLst>
                </p:cNvPr>
                <p:cNvSpPr/>
                <p:nvPr/>
              </p:nvSpPr>
              <p:spPr>
                <a:xfrm>
                  <a:off x="2918890" y="6261424"/>
                  <a:ext cx="7733" cy="21182"/>
                </a:xfrm>
                <a:custGeom>
                  <a:avLst/>
                  <a:gdLst>
                    <a:gd name="connsiteX0" fmla="*/ 0 w 9525"/>
                    <a:gd name="connsiteY0" fmla="*/ 26089 h 26089"/>
                    <a:gd name="connsiteX1" fmla="*/ 0 w 9525"/>
                    <a:gd name="connsiteY1" fmla="*/ 0 h 2608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26089">
                      <a:moveTo>
                        <a:pt x="0" y="26089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0" name="Freihandform: Form 159">
                  <a:extLst>
                    <a:ext uri="{FF2B5EF4-FFF2-40B4-BE49-F238E27FC236}">
                      <a16:creationId xmlns:a16="http://schemas.microsoft.com/office/drawing/2014/main" id="{40BF130C-798C-46A3-97BB-B267E1B08C77}"/>
                    </a:ext>
                  </a:extLst>
                </p:cNvPr>
                <p:cNvSpPr/>
                <p:nvPr/>
              </p:nvSpPr>
              <p:spPr>
                <a:xfrm>
                  <a:off x="4532440" y="6261424"/>
                  <a:ext cx="7733" cy="21182"/>
                </a:xfrm>
                <a:custGeom>
                  <a:avLst/>
                  <a:gdLst>
                    <a:gd name="connsiteX0" fmla="*/ 0 w 9525"/>
                    <a:gd name="connsiteY0" fmla="*/ 26089 h 26089"/>
                    <a:gd name="connsiteX1" fmla="*/ 0 w 9525"/>
                    <a:gd name="connsiteY1" fmla="*/ 0 h 2608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26089">
                      <a:moveTo>
                        <a:pt x="0" y="26089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1" name="Freihandform: Form 160">
                  <a:extLst>
                    <a:ext uri="{FF2B5EF4-FFF2-40B4-BE49-F238E27FC236}">
                      <a16:creationId xmlns:a16="http://schemas.microsoft.com/office/drawing/2014/main" id="{6C362262-294E-451C-ADAC-D677D3B77E93}"/>
                    </a:ext>
                  </a:extLst>
                </p:cNvPr>
                <p:cNvSpPr/>
                <p:nvPr/>
              </p:nvSpPr>
              <p:spPr>
                <a:xfrm>
                  <a:off x="6145981" y="6261424"/>
                  <a:ext cx="7733" cy="21182"/>
                </a:xfrm>
                <a:custGeom>
                  <a:avLst/>
                  <a:gdLst>
                    <a:gd name="connsiteX0" fmla="*/ 0 w 9525"/>
                    <a:gd name="connsiteY0" fmla="*/ 26089 h 26089"/>
                    <a:gd name="connsiteX1" fmla="*/ 0 w 9525"/>
                    <a:gd name="connsiteY1" fmla="*/ 0 h 2608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525" h="26089">
                      <a:moveTo>
                        <a:pt x="0" y="26089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grpSp>
              <p:nvGrpSpPr>
                <p:cNvPr id="162" name="Grafik 3">
                  <a:extLst>
                    <a:ext uri="{FF2B5EF4-FFF2-40B4-BE49-F238E27FC236}">
                      <a16:creationId xmlns:a16="http://schemas.microsoft.com/office/drawing/2014/main" id="{9FD88B64-D956-4CFF-8AB0-1E7A902005FA}"/>
                    </a:ext>
                  </a:extLst>
                </p:cNvPr>
                <p:cNvGrpSpPr/>
                <p:nvPr/>
              </p:nvGrpSpPr>
              <p:grpSpPr>
                <a:xfrm>
                  <a:off x="1185687" y="6313937"/>
                  <a:ext cx="206648" cy="110597"/>
                  <a:chOff x="2546338" y="6507581"/>
                  <a:chExt cx="186036" cy="99565"/>
                </a:xfrm>
              </p:grpSpPr>
              <p:sp>
                <p:nvSpPr>
                  <p:cNvPr id="163" name="Freihandform: Form 162">
                    <a:extLst>
                      <a:ext uri="{FF2B5EF4-FFF2-40B4-BE49-F238E27FC236}">
                        <a16:creationId xmlns:a16="http://schemas.microsoft.com/office/drawing/2014/main" id="{5FDE659F-584A-452A-BAC0-90784A586F19}"/>
                      </a:ext>
                    </a:extLst>
                  </p:cNvPr>
                  <p:cNvSpPr/>
                  <p:nvPr/>
                </p:nvSpPr>
                <p:spPr>
                  <a:xfrm>
                    <a:off x="2546338" y="6564173"/>
                    <a:ext cx="36797" cy="12055"/>
                  </a:xfrm>
                  <a:custGeom>
                    <a:avLst/>
                    <a:gdLst>
                      <a:gd name="connsiteX0" fmla="*/ 131 w 36797"/>
                      <a:gd name="connsiteY0" fmla="*/ 12749 h 12055"/>
                      <a:gd name="connsiteX1" fmla="*/ 131 w 36797"/>
                      <a:gd name="connsiteY1" fmla="*/ 693 h 12055"/>
                      <a:gd name="connsiteX2" fmla="*/ 36929 w 36797"/>
                      <a:gd name="connsiteY2" fmla="*/ 693 h 12055"/>
                      <a:gd name="connsiteX3" fmla="*/ 36929 w 36797"/>
                      <a:gd name="connsiteY3" fmla="*/ 12749 h 1205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36797" h="12055">
                        <a:moveTo>
                          <a:pt x="131" y="12749"/>
                        </a:moveTo>
                        <a:lnTo>
                          <a:pt x="131" y="693"/>
                        </a:lnTo>
                        <a:lnTo>
                          <a:pt x="36929" y="693"/>
                        </a:lnTo>
                        <a:lnTo>
                          <a:pt x="36929" y="12749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64" name="Freihandform: Form 163">
                    <a:extLst>
                      <a:ext uri="{FF2B5EF4-FFF2-40B4-BE49-F238E27FC236}">
                        <a16:creationId xmlns:a16="http://schemas.microsoft.com/office/drawing/2014/main" id="{EBAC5273-E383-4509-8D91-4E1409703366}"/>
                      </a:ext>
                    </a:extLst>
                  </p:cNvPr>
                  <p:cNvSpPr/>
                  <p:nvPr/>
                </p:nvSpPr>
                <p:spPr>
                  <a:xfrm>
                    <a:off x="2591493" y="6507581"/>
                    <a:ext cx="64459" cy="97891"/>
                  </a:xfrm>
                  <a:custGeom>
                    <a:avLst/>
                    <a:gdLst>
                      <a:gd name="connsiteX0" fmla="*/ 64595 w 64459"/>
                      <a:gd name="connsiteY0" fmla="*/ 87088 h 97891"/>
                      <a:gd name="connsiteX1" fmla="*/ 64595 w 64459"/>
                      <a:gd name="connsiteY1" fmla="*/ 98585 h 97891"/>
                      <a:gd name="connsiteX2" fmla="*/ 152 w 64459"/>
                      <a:gd name="connsiteY2" fmla="*/ 98585 h 97891"/>
                      <a:gd name="connsiteX3" fmla="*/ 1529 w 64459"/>
                      <a:gd name="connsiteY3" fmla="*/ 90288 h 97891"/>
                      <a:gd name="connsiteX4" fmla="*/ 9417 w 64459"/>
                      <a:gd name="connsiteY4" fmla="*/ 77302 h 97891"/>
                      <a:gd name="connsiteX5" fmla="*/ 25081 w 64459"/>
                      <a:gd name="connsiteY5" fmla="*/ 62531 h 97891"/>
                      <a:gd name="connsiteX6" fmla="*/ 46550 w 64459"/>
                      <a:gd name="connsiteY6" fmla="*/ 41881 h 97891"/>
                      <a:gd name="connsiteX7" fmla="*/ 52168 w 64459"/>
                      <a:gd name="connsiteY7" fmla="*/ 27482 h 97891"/>
                      <a:gd name="connsiteX8" fmla="*/ 47070 w 64459"/>
                      <a:gd name="connsiteY8" fmla="*/ 15501 h 97891"/>
                      <a:gd name="connsiteX9" fmla="*/ 33787 w 64459"/>
                      <a:gd name="connsiteY9" fmla="*/ 10590 h 97891"/>
                      <a:gd name="connsiteX10" fmla="*/ 19946 w 64459"/>
                      <a:gd name="connsiteY10" fmla="*/ 15799 h 97891"/>
                      <a:gd name="connsiteX11" fmla="*/ 14700 w 64459"/>
                      <a:gd name="connsiteY11" fmla="*/ 30161 h 97891"/>
                      <a:gd name="connsiteX12" fmla="*/ 2422 w 64459"/>
                      <a:gd name="connsiteY12" fmla="*/ 28896 h 97891"/>
                      <a:gd name="connsiteX13" fmla="*/ 11910 w 64459"/>
                      <a:gd name="connsiteY13" fmla="*/ 7911 h 97891"/>
                      <a:gd name="connsiteX14" fmla="*/ 34048 w 64459"/>
                      <a:gd name="connsiteY14" fmla="*/ 693 h 97891"/>
                      <a:gd name="connsiteX15" fmla="*/ 56261 w 64459"/>
                      <a:gd name="connsiteY15" fmla="*/ 8469 h 97891"/>
                      <a:gd name="connsiteX16" fmla="*/ 64446 w 64459"/>
                      <a:gd name="connsiteY16" fmla="*/ 27743 h 97891"/>
                      <a:gd name="connsiteX17" fmla="*/ 62065 w 64459"/>
                      <a:gd name="connsiteY17" fmla="*/ 39277 h 97891"/>
                      <a:gd name="connsiteX18" fmla="*/ 54103 w 64459"/>
                      <a:gd name="connsiteY18" fmla="*/ 51183 h 97891"/>
                      <a:gd name="connsiteX19" fmla="*/ 35648 w 64459"/>
                      <a:gd name="connsiteY19" fmla="*/ 68335 h 97891"/>
                      <a:gd name="connsiteX20" fmla="*/ 21807 w 64459"/>
                      <a:gd name="connsiteY20" fmla="*/ 80614 h 97891"/>
                      <a:gd name="connsiteX21" fmla="*/ 16784 w 64459"/>
                      <a:gd name="connsiteY21" fmla="*/ 87088 h 9789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4459" h="97891">
                        <a:moveTo>
                          <a:pt x="64595" y="87088"/>
                        </a:moveTo>
                        <a:lnTo>
                          <a:pt x="64595" y="98585"/>
                        </a:lnTo>
                        <a:lnTo>
                          <a:pt x="152" y="98585"/>
                        </a:lnTo>
                        <a:cubicBezTo>
                          <a:pt x="41" y="95720"/>
                          <a:pt x="487" y="92967"/>
                          <a:pt x="1529" y="90288"/>
                        </a:cubicBezTo>
                        <a:cubicBezTo>
                          <a:pt x="3129" y="85934"/>
                          <a:pt x="5771" y="81618"/>
                          <a:pt x="9417" y="77302"/>
                        </a:cubicBezTo>
                        <a:cubicBezTo>
                          <a:pt x="13026" y="73061"/>
                          <a:pt x="18235" y="68112"/>
                          <a:pt x="25081" y="62531"/>
                        </a:cubicBezTo>
                        <a:cubicBezTo>
                          <a:pt x="35648" y="53862"/>
                          <a:pt x="42792" y="46979"/>
                          <a:pt x="46550" y="41881"/>
                        </a:cubicBezTo>
                        <a:cubicBezTo>
                          <a:pt x="50270" y="36821"/>
                          <a:pt x="52168" y="32021"/>
                          <a:pt x="52168" y="27482"/>
                        </a:cubicBezTo>
                        <a:cubicBezTo>
                          <a:pt x="52168" y="22757"/>
                          <a:pt x="50456" y="18776"/>
                          <a:pt x="47070" y="15501"/>
                        </a:cubicBezTo>
                        <a:cubicBezTo>
                          <a:pt x="43647" y="12264"/>
                          <a:pt x="39220" y="10627"/>
                          <a:pt x="33787" y="10590"/>
                        </a:cubicBezTo>
                        <a:cubicBezTo>
                          <a:pt x="28020" y="10627"/>
                          <a:pt x="23407" y="12376"/>
                          <a:pt x="19946" y="15799"/>
                        </a:cubicBezTo>
                        <a:cubicBezTo>
                          <a:pt x="16486" y="19297"/>
                          <a:pt x="14737" y="24059"/>
                          <a:pt x="14700" y="30161"/>
                        </a:cubicBezTo>
                        <a:lnTo>
                          <a:pt x="2422" y="28896"/>
                        </a:lnTo>
                        <a:cubicBezTo>
                          <a:pt x="3241" y="19743"/>
                          <a:pt x="6403" y="12748"/>
                          <a:pt x="11910" y="7911"/>
                        </a:cubicBezTo>
                        <a:cubicBezTo>
                          <a:pt x="17379" y="3112"/>
                          <a:pt x="24746" y="693"/>
                          <a:pt x="34048" y="693"/>
                        </a:cubicBezTo>
                        <a:cubicBezTo>
                          <a:pt x="43387" y="693"/>
                          <a:pt x="50791" y="3298"/>
                          <a:pt x="56261" y="8469"/>
                        </a:cubicBezTo>
                        <a:cubicBezTo>
                          <a:pt x="61693" y="13678"/>
                          <a:pt x="64446" y="20115"/>
                          <a:pt x="64446" y="27743"/>
                        </a:cubicBezTo>
                        <a:cubicBezTo>
                          <a:pt x="64446" y="31687"/>
                          <a:pt x="63628" y="35519"/>
                          <a:pt x="62065" y="39277"/>
                        </a:cubicBezTo>
                        <a:cubicBezTo>
                          <a:pt x="60428" y="43035"/>
                          <a:pt x="57786" y="47016"/>
                          <a:pt x="54103" y="51183"/>
                        </a:cubicBezTo>
                        <a:cubicBezTo>
                          <a:pt x="50382" y="55387"/>
                          <a:pt x="44243" y="61080"/>
                          <a:pt x="35648" y="68335"/>
                        </a:cubicBezTo>
                        <a:cubicBezTo>
                          <a:pt x="28467" y="74363"/>
                          <a:pt x="23853" y="78456"/>
                          <a:pt x="21807" y="80614"/>
                        </a:cubicBezTo>
                        <a:cubicBezTo>
                          <a:pt x="19760" y="82772"/>
                          <a:pt x="18086" y="84930"/>
                          <a:pt x="16784" y="87088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65" name="Freihandform: Form 164">
                    <a:extLst>
                      <a:ext uri="{FF2B5EF4-FFF2-40B4-BE49-F238E27FC236}">
                        <a16:creationId xmlns:a16="http://schemas.microsoft.com/office/drawing/2014/main" id="{2D61E83F-0AB4-496E-9957-151E94D78D37}"/>
                      </a:ext>
                    </a:extLst>
                  </p:cNvPr>
                  <p:cNvSpPr/>
                  <p:nvPr/>
                </p:nvSpPr>
                <p:spPr>
                  <a:xfrm>
                    <a:off x="2668787" y="6507581"/>
                    <a:ext cx="63587" cy="99565"/>
                  </a:xfrm>
                  <a:custGeom>
                    <a:avLst/>
                    <a:gdLst>
                      <a:gd name="connsiteX0" fmla="*/ 144 w 63587"/>
                      <a:gd name="connsiteY0" fmla="*/ 50513 h 99565"/>
                      <a:gd name="connsiteX1" fmla="*/ 3679 w 63587"/>
                      <a:gd name="connsiteY1" fmla="*/ 22682 h 99565"/>
                      <a:gd name="connsiteX2" fmla="*/ 14246 w 63587"/>
                      <a:gd name="connsiteY2" fmla="*/ 6423 h 99565"/>
                      <a:gd name="connsiteX3" fmla="*/ 31919 w 63587"/>
                      <a:gd name="connsiteY3" fmla="*/ 693 h 99565"/>
                      <a:gd name="connsiteX4" fmla="*/ 45686 w 63587"/>
                      <a:gd name="connsiteY4" fmla="*/ 3856 h 99565"/>
                      <a:gd name="connsiteX5" fmla="*/ 55471 w 63587"/>
                      <a:gd name="connsiteY5" fmla="*/ 12971 h 99565"/>
                      <a:gd name="connsiteX6" fmla="*/ 61536 w 63587"/>
                      <a:gd name="connsiteY6" fmla="*/ 27482 h 99565"/>
                      <a:gd name="connsiteX7" fmla="*/ 63731 w 63587"/>
                      <a:gd name="connsiteY7" fmla="*/ 50513 h 99565"/>
                      <a:gd name="connsiteX8" fmla="*/ 60197 w 63587"/>
                      <a:gd name="connsiteY8" fmla="*/ 78195 h 99565"/>
                      <a:gd name="connsiteX9" fmla="*/ 49630 w 63587"/>
                      <a:gd name="connsiteY9" fmla="*/ 94492 h 99565"/>
                      <a:gd name="connsiteX10" fmla="*/ 31919 w 63587"/>
                      <a:gd name="connsiteY10" fmla="*/ 100259 h 99565"/>
                      <a:gd name="connsiteX11" fmla="*/ 9781 w 63587"/>
                      <a:gd name="connsiteY11" fmla="*/ 90139 h 99565"/>
                      <a:gd name="connsiteX12" fmla="*/ 144 w 63587"/>
                      <a:gd name="connsiteY12" fmla="*/ 50513 h 99565"/>
                      <a:gd name="connsiteX13" fmla="*/ 12460 w 63587"/>
                      <a:gd name="connsiteY13" fmla="*/ 50513 h 99565"/>
                      <a:gd name="connsiteX14" fmla="*/ 18078 w 63587"/>
                      <a:gd name="connsiteY14" fmla="*/ 82474 h 99565"/>
                      <a:gd name="connsiteX15" fmla="*/ 31919 w 63587"/>
                      <a:gd name="connsiteY15" fmla="*/ 90399 h 99565"/>
                      <a:gd name="connsiteX16" fmla="*/ 45797 w 63587"/>
                      <a:gd name="connsiteY16" fmla="*/ 82437 h 99565"/>
                      <a:gd name="connsiteX17" fmla="*/ 51416 w 63587"/>
                      <a:gd name="connsiteY17" fmla="*/ 50513 h 99565"/>
                      <a:gd name="connsiteX18" fmla="*/ 45797 w 63587"/>
                      <a:gd name="connsiteY18" fmla="*/ 18515 h 99565"/>
                      <a:gd name="connsiteX19" fmla="*/ 31808 w 63587"/>
                      <a:gd name="connsiteY19" fmla="*/ 10590 h 99565"/>
                      <a:gd name="connsiteX20" fmla="*/ 18636 w 63587"/>
                      <a:gd name="connsiteY20" fmla="*/ 17585 h 99565"/>
                      <a:gd name="connsiteX21" fmla="*/ 12460 w 63587"/>
                      <a:gd name="connsiteY21" fmla="*/ 50513 h 995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3587" h="99565">
                        <a:moveTo>
                          <a:pt x="144" y="50513"/>
                        </a:moveTo>
                        <a:cubicBezTo>
                          <a:pt x="107" y="39016"/>
                          <a:pt x="1298" y="29715"/>
                          <a:pt x="3679" y="22682"/>
                        </a:cubicBezTo>
                        <a:cubicBezTo>
                          <a:pt x="6023" y="15650"/>
                          <a:pt x="9558" y="10255"/>
                          <a:pt x="14246" y="6423"/>
                        </a:cubicBezTo>
                        <a:cubicBezTo>
                          <a:pt x="18934" y="2628"/>
                          <a:pt x="24813" y="693"/>
                          <a:pt x="31919" y="693"/>
                        </a:cubicBezTo>
                        <a:cubicBezTo>
                          <a:pt x="37128" y="693"/>
                          <a:pt x="41705" y="1772"/>
                          <a:pt x="45686" y="3856"/>
                        </a:cubicBezTo>
                        <a:cubicBezTo>
                          <a:pt x="49593" y="6014"/>
                          <a:pt x="52867" y="9027"/>
                          <a:pt x="55471" y="12971"/>
                        </a:cubicBezTo>
                        <a:cubicBezTo>
                          <a:pt x="58039" y="16953"/>
                          <a:pt x="60048" y="21789"/>
                          <a:pt x="61536" y="27482"/>
                        </a:cubicBezTo>
                        <a:cubicBezTo>
                          <a:pt x="62950" y="33175"/>
                          <a:pt x="63694" y="40877"/>
                          <a:pt x="63731" y="50513"/>
                        </a:cubicBezTo>
                        <a:cubicBezTo>
                          <a:pt x="63694" y="61973"/>
                          <a:pt x="62503" y="71200"/>
                          <a:pt x="60197" y="78195"/>
                        </a:cubicBezTo>
                        <a:cubicBezTo>
                          <a:pt x="57815" y="85265"/>
                          <a:pt x="54318" y="90697"/>
                          <a:pt x="49630" y="94492"/>
                        </a:cubicBezTo>
                        <a:cubicBezTo>
                          <a:pt x="44942" y="98362"/>
                          <a:pt x="39026" y="100259"/>
                          <a:pt x="31919" y="100259"/>
                        </a:cubicBezTo>
                        <a:cubicBezTo>
                          <a:pt x="22506" y="100259"/>
                          <a:pt x="15139" y="96910"/>
                          <a:pt x="9781" y="90139"/>
                        </a:cubicBezTo>
                        <a:cubicBezTo>
                          <a:pt x="3344" y="82065"/>
                          <a:pt x="107" y="68856"/>
                          <a:pt x="144" y="50513"/>
                        </a:cubicBezTo>
                        <a:close/>
                        <a:moveTo>
                          <a:pt x="12460" y="50513"/>
                        </a:moveTo>
                        <a:cubicBezTo>
                          <a:pt x="12460" y="66550"/>
                          <a:pt x="14320" y="77191"/>
                          <a:pt x="18078" y="82474"/>
                        </a:cubicBezTo>
                        <a:cubicBezTo>
                          <a:pt x="21799" y="87795"/>
                          <a:pt x="26413" y="90436"/>
                          <a:pt x="31919" y="90399"/>
                        </a:cubicBezTo>
                        <a:cubicBezTo>
                          <a:pt x="37389" y="90436"/>
                          <a:pt x="42002" y="87795"/>
                          <a:pt x="45797" y="82437"/>
                        </a:cubicBezTo>
                        <a:cubicBezTo>
                          <a:pt x="49518" y="77154"/>
                          <a:pt x="51416" y="66512"/>
                          <a:pt x="51416" y="50513"/>
                        </a:cubicBezTo>
                        <a:cubicBezTo>
                          <a:pt x="51416" y="34514"/>
                          <a:pt x="49518" y="23836"/>
                          <a:pt x="45797" y="18515"/>
                        </a:cubicBezTo>
                        <a:cubicBezTo>
                          <a:pt x="42002" y="13269"/>
                          <a:pt x="37351" y="10627"/>
                          <a:pt x="31808" y="10590"/>
                        </a:cubicBezTo>
                        <a:cubicBezTo>
                          <a:pt x="26264" y="10627"/>
                          <a:pt x="21873" y="12971"/>
                          <a:pt x="18636" y="17585"/>
                        </a:cubicBezTo>
                        <a:cubicBezTo>
                          <a:pt x="14506" y="23538"/>
                          <a:pt x="12460" y="34514"/>
                          <a:pt x="12460" y="50513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66" name="Grafik 3">
                  <a:extLst>
                    <a:ext uri="{FF2B5EF4-FFF2-40B4-BE49-F238E27FC236}">
                      <a16:creationId xmlns:a16="http://schemas.microsoft.com/office/drawing/2014/main" id="{8688579E-27E3-4B5F-8FE5-88AAE5B8FCDA}"/>
                    </a:ext>
                  </a:extLst>
                </p:cNvPr>
                <p:cNvGrpSpPr/>
                <p:nvPr/>
              </p:nvGrpSpPr>
              <p:grpSpPr>
                <a:xfrm>
                  <a:off x="2799260" y="6313937"/>
                  <a:ext cx="206648" cy="110597"/>
                  <a:chOff x="4533748" y="6507581"/>
                  <a:chExt cx="186036" cy="99565"/>
                </a:xfrm>
              </p:grpSpPr>
              <p:sp>
                <p:nvSpPr>
                  <p:cNvPr id="167" name="Freihandform: Form 166">
                    <a:extLst>
                      <a:ext uri="{FF2B5EF4-FFF2-40B4-BE49-F238E27FC236}">
                        <a16:creationId xmlns:a16="http://schemas.microsoft.com/office/drawing/2014/main" id="{2A8FADE2-1583-463D-8BBC-4EDC9A0CD8E1}"/>
                      </a:ext>
                    </a:extLst>
                  </p:cNvPr>
                  <p:cNvSpPr/>
                  <p:nvPr/>
                </p:nvSpPr>
                <p:spPr>
                  <a:xfrm>
                    <a:off x="4533748" y="6564173"/>
                    <a:ext cx="36797" cy="12055"/>
                  </a:xfrm>
                  <a:custGeom>
                    <a:avLst/>
                    <a:gdLst>
                      <a:gd name="connsiteX0" fmla="*/ 340 w 36797"/>
                      <a:gd name="connsiteY0" fmla="*/ 12749 h 12055"/>
                      <a:gd name="connsiteX1" fmla="*/ 340 w 36797"/>
                      <a:gd name="connsiteY1" fmla="*/ 693 h 12055"/>
                      <a:gd name="connsiteX2" fmla="*/ 37137 w 36797"/>
                      <a:gd name="connsiteY2" fmla="*/ 693 h 12055"/>
                      <a:gd name="connsiteX3" fmla="*/ 37137 w 36797"/>
                      <a:gd name="connsiteY3" fmla="*/ 12749 h 1205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36797" h="12055">
                        <a:moveTo>
                          <a:pt x="340" y="12749"/>
                        </a:moveTo>
                        <a:lnTo>
                          <a:pt x="340" y="693"/>
                        </a:lnTo>
                        <a:lnTo>
                          <a:pt x="37137" y="693"/>
                        </a:lnTo>
                        <a:lnTo>
                          <a:pt x="37137" y="12749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68" name="Freihandform: Form 167">
                    <a:extLst>
                      <a:ext uri="{FF2B5EF4-FFF2-40B4-BE49-F238E27FC236}">
                        <a16:creationId xmlns:a16="http://schemas.microsoft.com/office/drawing/2014/main" id="{17A56B66-F73B-41D8-B34D-738C50ECFD5A}"/>
                      </a:ext>
                    </a:extLst>
                  </p:cNvPr>
                  <p:cNvSpPr/>
                  <p:nvPr/>
                </p:nvSpPr>
                <p:spPr>
                  <a:xfrm>
                    <a:off x="4589636" y="6507581"/>
                    <a:ext cx="35904" cy="97891"/>
                  </a:xfrm>
                  <a:custGeom>
                    <a:avLst/>
                    <a:gdLst>
                      <a:gd name="connsiteX0" fmla="*/ 36249 w 35904"/>
                      <a:gd name="connsiteY0" fmla="*/ 98585 h 97891"/>
                      <a:gd name="connsiteX1" fmla="*/ 24268 w 35904"/>
                      <a:gd name="connsiteY1" fmla="*/ 98585 h 97891"/>
                      <a:gd name="connsiteX2" fmla="*/ 24268 w 35904"/>
                      <a:gd name="connsiteY2" fmla="*/ 22310 h 97891"/>
                      <a:gd name="connsiteX3" fmla="*/ 12920 w 35904"/>
                      <a:gd name="connsiteY3" fmla="*/ 30570 h 97891"/>
                      <a:gd name="connsiteX4" fmla="*/ 344 w 35904"/>
                      <a:gd name="connsiteY4" fmla="*/ 36747 h 97891"/>
                      <a:gd name="connsiteX5" fmla="*/ 344 w 35904"/>
                      <a:gd name="connsiteY5" fmla="*/ 25175 h 97891"/>
                      <a:gd name="connsiteX6" fmla="*/ 17869 w 35904"/>
                      <a:gd name="connsiteY6" fmla="*/ 13753 h 97891"/>
                      <a:gd name="connsiteX7" fmla="*/ 28547 w 35904"/>
                      <a:gd name="connsiteY7" fmla="*/ 693 h 97891"/>
                      <a:gd name="connsiteX8" fmla="*/ 36249 w 35904"/>
                      <a:gd name="connsiteY8" fmla="*/ 693 h 9789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35904" h="97891">
                        <a:moveTo>
                          <a:pt x="36249" y="98585"/>
                        </a:moveTo>
                        <a:lnTo>
                          <a:pt x="24268" y="98585"/>
                        </a:lnTo>
                        <a:lnTo>
                          <a:pt x="24268" y="22310"/>
                        </a:lnTo>
                        <a:cubicBezTo>
                          <a:pt x="21366" y="25101"/>
                          <a:pt x="17571" y="27854"/>
                          <a:pt x="12920" y="30570"/>
                        </a:cubicBezTo>
                        <a:cubicBezTo>
                          <a:pt x="8232" y="33324"/>
                          <a:pt x="4065" y="35370"/>
                          <a:pt x="344" y="36747"/>
                        </a:cubicBezTo>
                        <a:lnTo>
                          <a:pt x="344" y="25175"/>
                        </a:lnTo>
                        <a:cubicBezTo>
                          <a:pt x="7042" y="22050"/>
                          <a:pt x="12883" y="18218"/>
                          <a:pt x="17869" y="13753"/>
                        </a:cubicBezTo>
                        <a:cubicBezTo>
                          <a:pt x="22855" y="9288"/>
                          <a:pt x="26389" y="4935"/>
                          <a:pt x="28547" y="693"/>
                        </a:cubicBezTo>
                        <a:lnTo>
                          <a:pt x="36249" y="693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69" name="Freihandform: Form 168">
                    <a:extLst>
                      <a:ext uri="{FF2B5EF4-FFF2-40B4-BE49-F238E27FC236}">
                        <a16:creationId xmlns:a16="http://schemas.microsoft.com/office/drawing/2014/main" id="{C0FCC502-AD4F-4204-9845-D7290646506A}"/>
                      </a:ext>
                    </a:extLst>
                  </p:cNvPr>
                  <p:cNvSpPr/>
                  <p:nvPr/>
                </p:nvSpPr>
                <p:spPr>
                  <a:xfrm>
                    <a:off x="4656197" y="6507581"/>
                    <a:ext cx="63587" cy="99565"/>
                  </a:xfrm>
                  <a:custGeom>
                    <a:avLst/>
                    <a:gdLst>
                      <a:gd name="connsiteX0" fmla="*/ 353 w 63587"/>
                      <a:gd name="connsiteY0" fmla="*/ 50513 h 99565"/>
                      <a:gd name="connsiteX1" fmla="*/ 3888 w 63587"/>
                      <a:gd name="connsiteY1" fmla="*/ 22682 h 99565"/>
                      <a:gd name="connsiteX2" fmla="*/ 14455 w 63587"/>
                      <a:gd name="connsiteY2" fmla="*/ 6423 h 99565"/>
                      <a:gd name="connsiteX3" fmla="*/ 32128 w 63587"/>
                      <a:gd name="connsiteY3" fmla="*/ 693 h 99565"/>
                      <a:gd name="connsiteX4" fmla="*/ 45894 w 63587"/>
                      <a:gd name="connsiteY4" fmla="*/ 3856 h 99565"/>
                      <a:gd name="connsiteX5" fmla="*/ 55680 w 63587"/>
                      <a:gd name="connsiteY5" fmla="*/ 12971 h 99565"/>
                      <a:gd name="connsiteX6" fmla="*/ 61745 w 63587"/>
                      <a:gd name="connsiteY6" fmla="*/ 27482 h 99565"/>
                      <a:gd name="connsiteX7" fmla="*/ 63940 w 63587"/>
                      <a:gd name="connsiteY7" fmla="*/ 50513 h 99565"/>
                      <a:gd name="connsiteX8" fmla="*/ 60405 w 63587"/>
                      <a:gd name="connsiteY8" fmla="*/ 78195 h 99565"/>
                      <a:gd name="connsiteX9" fmla="*/ 49838 w 63587"/>
                      <a:gd name="connsiteY9" fmla="*/ 94492 h 99565"/>
                      <a:gd name="connsiteX10" fmla="*/ 32128 w 63587"/>
                      <a:gd name="connsiteY10" fmla="*/ 100259 h 99565"/>
                      <a:gd name="connsiteX11" fmla="*/ 9990 w 63587"/>
                      <a:gd name="connsiteY11" fmla="*/ 90139 h 99565"/>
                      <a:gd name="connsiteX12" fmla="*/ 353 w 63587"/>
                      <a:gd name="connsiteY12" fmla="*/ 50513 h 99565"/>
                      <a:gd name="connsiteX13" fmla="*/ 12669 w 63587"/>
                      <a:gd name="connsiteY13" fmla="*/ 50513 h 99565"/>
                      <a:gd name="connsiteX14" fmla="*/ 18287 w 63587"/>
                      <a:gd name="connsiteY14" fmla="*/ 82474 h 99565"/>
                      <a:gd name="connsiteX15" fmla="*/ 32128 w 63587"/>
                      <a:gd name="connsiteY15" fmla="*/ 90399 h 99565"/>
                      <a:gd name="connsiteX16" fmla="*/ 46006 w 63587"/>
                      <a:gd name="connsiteY16" fmla="*/ 82437 h 99565"/>
                      <a:gd name="connsiteX17" fmla="*/ 51624 w 63587"/>
                      <a:gd name="connsiteY17" fmla="*/ 50513 h 99565"/>
                      <a:gd name="connsiteX18" fmla="*/ 46006 w 63587"/>
                      <a:gd name="connsiteY18" fmla="*/ 18515 h 99565"/>
                      <a:gd name="connsiteX19" fmla="*/ 32016 w 63587"/>
                      <a:gd name="connsiteY19" fmla="*/ 10590 h 99565"/>
                      <a:gd name="connsiteX20" fmla="*/ 18845 w 63587"/>
                      <a:gd name="connsiteY20" fmla="*/ 17585 h 99565"/>
                      <a:gd name="connsiteX21" fmla="*/ 12669 w 63587"/>
                      <a:gd name="connsiteY21" fmla="*/ 50513 h 995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3587" h="99565">
                        <a:moveTo>
                          <a:pt x="353" y="50513"/>
                        </a:moveTo>
                        <a:cubicBezTo>
                          <a:pt x="316" y="39016"/>
                          <a:pt x="1507" y="29715"/>
                          <a:pt x="3888" y="22682"/>
                        </a:cubicBezTo>
                        <a:cubicBezTo>
                          <a:pt x="6232" y="15650"/>
                          <a:pt x="9766" y="10255"/>
                          <a:pt x="14455" y="6423"/>
                        </a:cubicBezTo>
                        <a:cubicBezTo>
                          <a:pt x="19143" y="2628"/>
                          <a:pt x="25021" y="693"/>
                          <a:pt x="32128" y="693"/>
                        </a:cubicBezTo>
                        <a:cubicBezTo>
                          <a:pt x="37337" y="693"/>
                          <a:pt x="41913" y="1772"/>
                          <a:pt x="45894" y="3856"/>
                        </a:cubicBezTo>
                        <a:cubicBezTo>
                          <a:pt x="49801" y="6014"/>
                          <a:pt x="53075" y="9027"/>
                          <a:pt x="55680" y="12971"/>
                        </a:cubicBezTo>
                        <a:cubicBezTo>
                          <a:pt x="58247" y="16953"/>
                          <a:pt x="60256" y="21789"/>
                          <a:pt x="61745" y="27482"/>
                        </a:cubicBezTo>
                        <a:cubicBezTo>
                          <a:pt x="63159" y="33175"/>
                          <a:pt x="63903" y="40877"/>
                          <a:pt x="63940" y="50513"/>
                        </a:cubicBezTo>
                        <a:cubicBezTo>
                          <a:pt x="63903" y="61973"/>
                          <a:pt x="62712" y="71200"/>
                          <a:pt x="60405" y="78195"/>
                        </a:cubicBezTo>
                        <a:cubicBezTo>
                          <a:pt x="58024" y="85265"/>
                          <a:pt x="54527" y="90697"/>
                          <a:pt x="49838" y="94492"/>
                        </a:cubicBezTo>
                        <a:cubicBezTo>
                          <a:pt x="45150" y="98362"/>
                          <a:pt x="39234" y="100259"/>
                          <a:pt x="32128" y="100259"/>
                        </a:cubicBezTo>
                        <a:cubicBezTo>
                          <a:pt x="22715" y="100259"/>
                          <a:pt x="15348" y="96910"/>
                          <a:pt x="9990" y="90139"/>
                        </a:cubicBezTo>
                        <a:cubicBezTo>
                          <a:pt x="3553" y="82065"/>
                          <a:pt x="316" y="68856"/>
                          <a:pt x="353" y="50513"/>
                        </a:cubicBezTo>
                        <a:close/>
                        <a:moveTo>
                          <a:pt x="12669" y="50513"/>
                        </a:moveTo>
                        <a:cubicBezTo>
                          <a:pt x="12669" y="66550"/>
                          <a:pt x="14529" y="77191"/>
                          <a:pt x="18287" y="82474"/>
                        </a:cubicBezTo>
                        <a:cubicBezTo>
                          <a:pt x="22008" y="87795"/>
                          <a:pt x="26621" y="90436"/>
                          <a:pt x="32128" y="90399"/>
                        </a:cubicBezTo>
                        <a:cubicBezTo>
                          <a:pt x="37597" y="90436"/>
                          <a:pt x="42211" y="87795"/>
                          <a:pt x="46006" y="82437"/>
                        </a:cubicBezTo>
                        <a:cubicBezTo>
                          <a:pt x="49727" y="77154"/>
                          <a:pt x="51624" y="66512"/>
                          <a:pt x="51624" y="50513"/>
                        </a:cubicBezTo>
                        <a:cubicBezTo>
                          <a:pt x="51624" y="34514"/>
                          <a:pt x="49727" y="23836"/>
                          <a:pt x="46006" y="18515"/>
                        </a:cubicBezTo>
                        <a:cubicBezTo>
                          <a:pt x="42211" y="13269"/>
                          <a:pt x="37560" y="10627"/>
                          <a:pt x="32016" y="10590"/>
                        </a:cubicBezTo>
                        <a:cubicBezTo>
                          <a:pt x="26472" y="10627"/>
                          <a:pt x="22082" y="12971"/>
                          <a:pt x="18845" y="17585"/>
                        </a:cubicBezTo>
                        <a:cubicBezTo>
                          <a:pt x="14715" y="23538"/>
                          <a:pt x="12669" y="34514"/>
                          <a:pt x="12669" y="50513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sp>
              <p:nvSpPr>
                <p:cNvPr id="170" name="Freihandform: Form 169">
                  <a:extLst>
                    <a:ext uri="{FF2B5EF4-FFF2-40B4-BE49-F238E27FC236}">
                      <a16:creationId xmlns:a16="http://schemas.microsoft.com/office/drawing/2014/main" id="{4EF7B91C-26F5-40C3-A962-E4F6D26173EC}"/>
                    </a:ext>
                  </a:extLst>
                </p:cNvPr>
                <p:cNvSpPr/>
                <p:nvPr/>
              </p:nvSpPr>
              <p:spPr>
                <a:xfrm>
                  <a:off x="4499642" y="6313937"/>
                  <a:ext cx="70633" cy="110597"/>
                </a:xfrm>
                <a:custGeom>
                  <a:avLst/>
                  <a:gdLst>
                    <a:gd name="connsiteX0" fmla="*/ 555 w 63587"/>
                    <a:gd name="connsiteY0" fmla="*/ 50513 h 99565"/>
                    <a:gd name="connsiteX1" fmla="*/ 4090 w 63587"/>
                    <a:gd name="connsiteY1" fmla="*/ 22682 h 99565"/>
                    <a:gd name="connsiteX2" fmla="*/ 14657 w 63587"/>
                    <a:gd name="connsiteY2" fmla="*/ 6423 h 99565"/>
                    <a:gd name="connsiteX3" fmla="*/ 32330 w 63587"/>
                    <a:gd name="connsiteY3" fmla="*/ 693 h 99565"/>
                    <a:gd name="connsiteX4" fmla="*/ 46097 w 63587"/>
                    <a:gd name="connsiteY4" fmla="*/ 3856 h 99565"/>
                    <a:gd name="connsiteX5" fmla="*/ 55882 w 63587"/>
                    <a:gd name="connsiteY5" fmla="*/ 12971 h 99565"/>
                    <a:gd name="connsiteX6" fmla="*/ 61947 w 63587"/>
                    <a:gd name="connsiteY6" fmla="*/ 27482 h 99565"/>
                    <a:gd name="connsiteX7" fmla="*/ 64142 w 63587"/>
                    <a:gd name="connsiteY7" fmla="*/ 50513 h 99565"/>
                    <a:gd name="connsiteX8" fmla="*/ 60608 w 63587"/>
                    <a:gd name="connsiteY8" fmla="*/ 78195 h 99565"/>
                    <a:gd name="connsiteX9" fmla="*/ 50041 w 63587"/>
                    <a:gd name="connsiteY9" fmla="*/ 94492 h 99565"/>
                    <a:gd name="connsiteX10" fmla="*/ 32330 w 63587"/>
                    <a:gd name="connsiteY10" fmla="*/ 100259 h 99565"/>
                    <a:gd name="connsiteX11" fmla="*/ 10192 w 63587"/>
                    <a:gd name="connsiteY11" fmla="*/ 90139 h 99565"/>
                    <a:gd name="connsiteX12" fmla="*/ 555 w 63587"/>
                    <a:gd name="connsiteY12" fmla="*/ 50513 h 99565"/>
                    <a:gd name="connsiteX13" fmla="*/ 12871 w 63587"/>
                    <a:gd name="connsiteY13" fmla="*/ 50513 h 99565"/>
                    <a:gd name="connsiteX14" fmla="*/ 18489 w 63587"/>
                    <a:gd name="connsiteY14" fmla="*/ 82474 h 99565"/>
                    <a:gd name="connsiteX15" fmla="*/ 32330 w 63587"/>
                    <a:gd name="connsiteY15" fmla="*/ 90399 h 99565"/>
                    <a:gd name="connsiteX16" fmla="*/ 46208 w 63587"/>
                    <a:gd name="connsiteY16" fmla="*/ 82437 h 99565"/>
                    <a:gd name="connsiteX17" fmla="*/ 51827 w 63587"/>
                    <a:gd name="connsiteY17" fmla="*/ 50513 h 99565"/>
                    <a:gd name="connsiteX18" fmla="*/ 46208 w 63587"/>
                    <a:gd name="connsiteY18" fmla="*/ 18515 h 99565"/>
                    <a:gd name="connsiteX19" fmla="*/ 32219 w 63587"/>
                    <a:gd name="connsiteY19" fmla="*/ 10590 h 99565"/>
                    <a:gd name="connsiteX20" fmla="*/ 19047 w 63587"/>
                    <a:gd name="connsiteY20" fmla="*/ 17585 h 99565"/>
                    <a:gd name="connsiteX21" fmla="*/ 12871 w 63587"/>
                    <a:gd name="connsiteY21" fmla="*/ 50513 h 9956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63587" h="99565">
                      <a:moveTo>
                        <a:pt x="555" y="50513"/>
                      </a:moveTo>
                      <a:cubicBezTo>
                        <a:pt x="518" y="39016"/>
                        <a:pt x="1709" y="29715"/>
                        <a:pt x="4090" y="22682"/>
                      </a:cubicBezTo>
                      <a:cubicBezTo>
                        <a:pt x="6434" y="15650"/>
                        <a:pt x="9969" y="10255"/>
                        <a:pt x="14657" y="6423"/>
                      </a:cubicBezTo>
                      <a:cubicBezTo>
                        <a:pt x="19345" y="2628"/>
                        <a:pt x="25224" y="693"/>
                        <a:pt x="32330" y="693"/>
                      </a:cubicBezTo>
                      <a:cubicBezTo>
                        <a:pt x="37539" y="693"/>
                        <a:pt x="42116" y="1772"/>
                        <a:pt x="46097" y="3856"/>
                      </a:cubicBezTo>
                      <a:cubicBezTo>
                        <a:pt x="50004" y="6014"/>
                        <a:pt x="53278" y="9027"/>
                        <a:pt x="55882" y="12971"/>
                      </a:cubicBezTo>
                      <a:cubicBezTo>
                        <a:pt x="58450" y="16953"/>
                        <a:pt x="60459" y="21789"/>
                        <a:pt x="61947" y="27482"/>
                      </a:cubicBezTo>
                      <a:cubicBezTo>
                        <a:pt x="63361" y="33175"/>
                        <a:pt x="64105" y="40877"/>
                        <a:pt x="64142" y="50513"/>
                      </a:cubicBezTo>
                      <a:cubicBezTo>
                        <a:pt x="64105" y="61973"/>
                        <a:pt x="62914" y="71200"/>
                        <a:pt x="60608" y="78195"/>
                      </a:cubicBezTo>
                      <a:cubicBezTo>
                        <a:pt x="58226" y="85265"/>
                        <a:pt x="54729" y="90697"/>
                        <a:pt x="50041" y="94492"/>
                      </a:cubicBezTo>
                      <a:cubicBezTo>
                        <a:pt x="45353" y="98362"/>
                        <a:pt x="39437" y="100259"/>
                        <a:pt x="32330" y="100259"/>
                      </a:cubicBezTo>
                      <a:cubicBezTo>
                        <a:pt x="22917" y="100259"/>
                        <a:pt x="15550" y="96910"/>
                        <a:pt x="10192" y="90139"/>
                      </a:cubicBezTo>
                      <a:cubicBezTo>
                        <a:pt x="3755" y="82065"/>
                        <a:pt x="518" y="68856"/>
                        <a:pt x="555" y="50513"/>
                      </a:cubicBezTo>
                      <a:close/>
                      <a:moveTo>
                        <a:pt x="12871" y="50513"/>
                      </a:moveTo>
                      <a:cubicBezTo>
                        <a:pt x="12871" y="66550"/>
                        <a:pt x="14731" y="77191"/>
                        <a:pt x="18489" y="82474"/>
                      </a:cubicBezTo>
                      <a:cubicBezTo>
                        <a:pt x="22210" y="87795"/>
                        <a:pt x="26824" y="90436"/>
                        <a:pt x="32330" y="90399"/>
                      </a:cubicBezTo>
                      <a:cubicBezTo>
                        <a:pt x="37800" y="90436"/>
                        <a:pt x="42413" y="87795"/>
                        <a:pt x="46208" y="82437"/>
                      </a:cubicBezTo>
                      <a:cubicBezTo>
                        <a:pt x="49929" y="77154"/>
                        <a:pt x="51827" y="66512"/>
                        <a:pt x="51827" y="50513"/>
                      </a:cubicBezTo>
                      <a:cubicBezTo>
                        <a:pt x="51827" y="34514"/>
                        <a:pt x="49929" y="23836"/>
                        <a:pt x="46208" y="18515"/>
                      </a:cubicBezTo>
                      <a:cubicBezTo>
                        <a:pt x="42413" y="13269"/>
                        <a:pt x="37762" y="10627"/>
                        <a:pt x="32219" y="10590"/>
                      </a:cubicBezTo>
                      <a:cubicBezTo>
                        <a:pt x="26675" y="10627"/>
                        <a:pt x="22284" y="12971"/>
                        <a:pt x="19047" y="17585"/>
                      </a:cubicBezTo>
                      <a:cubicBezTo>
                        <a:pt x="14917" y="23538"/>
                        <a:pt x="12871" y="34514"/>
                        <a:pt x="12871" y="50513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grpSp>
              <p:nvGrpSpPr>
                <p:cNvPr id="171" name="Grafik 3">
                  <a:extLst>
                    <a:ext uri="{FF2B5EF4-FFF2-40B4-BE49-F238E27FC236}">
                      <a16:creationId xmlns:a16="http://schemas.microsoft.com/office/drawing/2014/main" id="{D865FFCC-6D6F-4B4F-A0D5-11CE4E2550DB}"/>
                    </a:ext>
                  </a:extLst>
                </p:cNvPr>
                <p:cNvGrpSpPr/>
                <p:nvPr/>
              </p:nvGrpSpPr>
              <p:grpSpPr>
                <a:xfrm>
                  <a:off x="6070004" y="6313937"/>
                  <a:ext cx="144570" cy="110597"/>
                  <a:chOff x="8541692" y="6507581"/>
                  <a:chExt cx="130149" cy="99565"/>
                </a:xfrm>
              </p:grpSpPr>
              <p:sp>
                <p:nvSpPr>
                  <p:cNvPr id="172" name="Freihandform: Form 171">
                    <a:extLst>
                      <a:ext uri="{FF2B5EF4-FFF2-40B4-BE49-F238E27FC236}">
                        <a16:creationId xmlns:a16="http://schemas.microsoft.com/office/drawing/2014/main" id="{3D183729-BA7D-40DF-8779-16F59EE7CC7F}"/>
                      </a:ext>
                    </a:extLst>
                  </p:cNvPr>
                  <p:cNvSpPr/>
                  <p:nvPr/>
                </p:nvSpPr>
                <p:spPr>
                  <a:xfrm>
                    <a:off x="8541692" y="6507581"/>
                    <a:ext cx="35904" cy="97891"/>
                  </a:xfrm>
                  <a:custGeom>
                    <a:avLst/>
                    <a:gdLst>
                      <a:gd name="connsiteX0" fmla="*/ 36664 w 35904"/>
                      <a:gd name="connsiteY0" fmla="*/ 98585 h 97891"/>
                      <a:gd name="connsiteX1" fmla="*/ 24683 w 35904"/>
                      <a:gd name="connsiteY1" fmla="*/ 98585 h 97891"/>
                      <a:gd name="connsiteX2" fmla="*/ 24683 w 35904"/>
                      <a:gd name="connsiteY2" fmla="*/ 22310 h 97891"/>
                      <a:gd name="connsiteX3" fmla="*/ 13335 w 35904"/>
                      <a:gd name="connsiteY3" fmla="*/ 30570 h 97891"/>
                      <a:gd name="connsiteX4" fmla="*/ 759 w 35904"/>
                      <a:gd name="connsiteY4" fmla="*/ 36747 h 97891"/>
                      <a:gd name="connsiteX5" fmla="*/ 759 w 35904"/>
                      <a:gd name="connsiteY5" fmla="*/ 25175 h 97891"/>
                      <a:gd name="connsiteX6" fmla="*/ 18284 w 35904"/>
                      <a:gd name="connsiteY6" fmla="*/ 13753 h 97891"/>
                      <a:gd name="connsiteX7" fmla="*/ 28962 w 35904"/>
                      <a:gd name="connsiteY7" fmla="*/ 693 h 97891"/>
                      <a:gd name="connsiteX8" fmla="*/ 36664 w 35904"/>
                      <a:gd name="connsiteY8" fmla="*/ 693 h 9789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35904" h="97891">
                        <a:moveTo>
                          <a:pt x="36664" y="98585"/>
                        </a:moveTo>
                        <a:lnTo>
                          <a:pt x="24683" y="98585"/>
                        </a:lnTo>
                        <a:lnTo>
                          <a:pt x="24683" y="22310"/>
                        </a:lnTo>
                        <a:cubicBezTo>
                          <a:pt x="21781" y="25101"/>
                          <a:pt x="17986" y="27854"/>
                          <a:pt x="13335" y="30570"/>
                        </a:cubicBezTo>
                        <a:cubicBezTo>
                          <a:pt x="8647" y="33324"/>
                          <a:pt x="4480" y="35370"/>
                          <a:pt x="759" y="36747"/>
                        </a:cubicBezTo>
                        <a:lnTo>
                          <a:pt x="759" y="25175"/>
                        </a:lnTo>
                        <a:cubicBezTo>
                          <a:pt x="7457" y="22050"/>
                          <a:pt x="13298" y="18218"/>
                          <a:pt x="18284" y="13753"/>
                        </a:cubicBezTo>
                        <a:cubicBezTo>
                          <a:pt x="23270" y="9288"/>
                          <a:pt x="26804" y="4935"/>
                          <a:pt x="28962" y="693"/>
                        </a:cubicBezTo>
                        <a:lnTo>
                          <a:pt x="36664" y="693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73" name="Freihandform: Form 172">
                    <a:extLst>
                      <a:ext uri="{FF2B5EF4-FFF2-40B4-BE49-F238E27FC236}">
                        <a16:creationId xmlns:a16="http://schemas.microsoft.com/office/drawing/2014/main" id="{4033D535-C3D6-41AA-9EA3-4C721F729DD7}"/>
                      </a:ext>
                    </a:extLst>
                  </p:cNvPr>
                  <p:cNvSpPr/>
                  <p:nvPr/>
                </p:nvSpPr>
                <p:spPr>
                  <a:xfrm>
                    <a:off x="8608253" y="6507581"/>
                    <a:ext cx="63587" cy="99565"/>
                  </a:xfrm>
                  <a:custGeom>
                    <a:avLst/>
                    <a:gdLst>
                      <a:gd name="connsiteX0" fmla="*/ 768 w 63587"/>
                      <a:gd name="connsiteY0" fmla="*/ 50513 h 99565"/>
                      <a:gd name="connsiteX1" fmla="*/ 4303 w 63587"/>
                      <a:gd name="connsiteY1" fmla="*/ 22682 h 99565"/>
                      <a:gd name="connsiteX2" fmla="*/ 14869 w 63587"/>
                      <a:gd name="connsiteY2" fmla="*/ 6423 h 99565"/>
                      <a:gd name="connsiteX3" fmla="*/ 32543 w 63587"/>
                      <a:gd name="connsiteY3" fmla="*/ 693 h 99565"/>
                      <a:gd name="connsiteX4" fmla="*/ 46309 w 63587"/>
                      <a:gd name="connsiteY4" fmla="*/ 3856 h 99565"/>
                      <a:gd name="connsiteX5" fmla="*/ 56095 w 63587"/>
                      <a:gd name="connsiteY5" fmla="*/ 12971 h 99565"/>
                      <a:gd name="connsiteX6" fmla="*/ 62160 w 63587"/>
                      <a:gd name="connsiteY6" fmla="*/ 27482 h 99565"/>
                      <a:gd name="connsiteX7" fmla="*/ 64355 w 63587"/>
                      <a:gd name="connsiteY7" fmla="*/ 50513 h 99565"/>
                      <a:gd name="connsiteX8" fmla="*/ 60820 w 63587"/>
                      <a:gd name="connsiteY8" fmla="*/ 78195 h 99565"/>
                      <a:gd name="connsiteX9" fmla="*/ 50253 w 63587"/>
                      <a:gd name="connsiteY9" fmla="*/ 94492 h 99565"/>
                      <a:gd name="connsiteX10" fmla="*/ 32543 w 63587"/>
                      <a:gd name="connsiteY10" fmla="*/ 100259 h 99565"/>
                      <a:gd name="connsiteX11" fmla="*/ 10405 w 63587"/>
                      <a:gd name="connsiteY11" fmla="*/ 90139 h 99565"/>
                      <a:gd name="connsiteX12" fmla="*/ 768 w 63587"/>
                      <a:gd name="connsiteY12" fmla="*/ 50513 h 99565"/>
                      <a:gd name="connsiteX13" fmla="*/ 13084 w 63587"/>
                      <a:gd name="connsiteY13" fmla="*/ 50513 h 99565"/>
                      <a:gd name="connsiteX14" fmla="*/ 18702 w 63587"/>
                      <a:gd name="connsiteY14" fmla="*/ 82474 h 99565"/>
                      <a:gd name="connsiteX15" fmla="*/ 32543 w 63587"/>
                      <a:gd name="connsiteY15" fmla="*/ 90399 h 99565"/>
                      <a:gd name="connsiteX16" fmla="*/ 46421 w 63587"/>
                      <a:gd name="connsiteY16" fmla="*/ 82437 h 99565"/>
                      <a:gd name="connsiteX17" fmla="*/ 52039 w 63587"/>
                      <a:gd name="connsiteY17" fmla="*/ 50513 h 99565"/>
                      <a:gd name="connsiteX18" fmla="*/ 46421 w 63587"/>
                      <a:gd name="connsiteY18" fmla="*/ 18515 h 99565"/>
                      <a:gd name="connsiteX19" fmla="*/ 32431 w 63587"/>
                      <a:gd name="connsiteY19" fmla="*/ 10590 h 99565"/>
                      <a:gd name="connsiteX20" fmla="*/ 19260 w 63587"/>
                      <a:gd name="connsiteY20" fmla="*/ 17585 h 99565"/>
                      <a:gd name="connsiteX21" fmla="*/ 13084 w 63587"/>
                      <a:gd name="connsiteY21" fmla="*/ 50513 h 995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3587" h="99565">
                        <a:moveTo>
                          <a:pt x="768" y="50513"/>
                        </a:moveTo>
                        <a:cubicBezTo>
                          <a:pt x="731" y="39016"/>
                          <a:pt x="1921" y="29715"/>
                          <a:pt x="4303" y="22682"/>
                        </a:cubicBezTo>
                        <a:cubicBezTo>
                          <a:pt x="6647" y="15650"/>
                          <a:pt x="10181" y="10255"/>
                          <a:pt x="14869" y="6423"/>
                        </a:cubicBezTo>
                        <a:cubicBezTo>
                          <a:pt x="19558" y="2628"/>
                          <a:pt x="25436" y="693"/>
                          <a:pt x="32543" y="693"/>
                        </a:cubicBezTo>
                        <a:cubicBezTo>
                          <a:pt x="37752" y="693"/>
                          <a:pt x="42328" y="1772"/>
                          <a:pt x="46309" y="3856"/>
                        </a:cubicBezTo>
                        <a:cubicBezTo>
                          <a:pt x="50216" y="6014"/>
                          <a:pt x="53490" y="9027"/>
                          <a:pt x="56095" y="12971"/>
                        </a:cubicBezTo>
                        <a:cubicBezTo>
                          <a:pt x="58662" y="16953"/>
                          <a:pt x="60671" y="21789"/>
                          <a:pt x="62160" y="27482"/>
                        </a:cubicBezTo>
                        <a:cubicBezTo>
                          <a:pt x="63573" y="33175"/>
                          <a:pt x="64318" y="40877"/>
                          <a:pt x="64355" y="50513"/>
                        </a:cubicBezTo>
                        <a:cubicBezTo>
                          <a:pt x="64318" y="61973"/>
                          <a:pt x="63127" y="71200"/>
                          <a:pt x="60820" y="78195"/>
                        </a:cubicBezTo>
                        <a:cubicBezTo>
                          <a:pt x="58439" y="85265"/>
                          <a:pt x="54941" y="90697"/>
                          <a:pt x="50253" y="94492"/>
                        </a:cubicBezTo>
                        <a:cubicBezTo>
                          <a:pt x="45565" y="98362"/>
                          <a:pt x="39649" y="100259"/>
                          <a:pt x="32543" y="100259"/>
                        </a:cubicBezTo>
                        <a:cubicBezTo>
                          <a:pt x="23129" y="100259"/>
                          <a:pt x="15762" y="96910"/>
                          <a:pt x="10405" y="90139"/>
                        </a:cubicBezTo>
                        <a:cubicBezTo>
                          <a:pt x="3968" y="82065"/>
                          <a:pt x="731" y="68856"/>
                          <a:pt x="768" y="50513"/>
                        </a:cubicBezTo>
                        <a:close/>
                        <a:moveTo>
                          <a:pt x="13084" y="50513"/>
                        </a:moveTo>
                        <a:cubicBezTo>
                          <a:pt x="13084" y="66550"/>
                          <a:pt x="14944" y="77191"/>
                          <a:pt x="18702" y="82474"/>
                        </a:cubicBezTo>
                        <a:cubicBezTo>
                          <a:pt x="22423" y="87795"/>
                          <a:pt x="27036" y="90436"/>
                          <a:pt x="32543" y="90399"/>
                        </a:cubicBezTo>
                        <a:cubicBezTo>
                          <a:pt x="38012" y="90436"/>
                          <a:pt x="42626" y="87795"/>
                          <a:pt x="46421" y="82437"/>
                        </a:cubicBezTo>
                        <a:cubicBezTo>
                          <a:pt x="50142" y="77154"/>
                          <a:pt x="52039" y="66512"/>
                          <a:pt x="52039" y="50513"/>
                        </a:cubicBezTo>
                        <a:cubicBezTo>
                          <a:pt x="52039" y="34514"/>
                          <a:pt x="50142" y="23836"/>
                          <a:pt x="46421" y="18515"/>
                        </a:cubicBezTo>
                        <a:cubicBezTo>
                          <a:pt x="42626" y="13269"/>
                          <a:pt x="37975" y="10627"/>
                          <a:pt x="32431" y="10590"/>
                        </a:cubicBezTo>
                        <a:cubicBezTo>
                          <a:pt x="26887" y="10627"/>
                          <a:pt x="22497" y="12971"/>
                          <a:pt x="19260" y="17585"/>
                        </a:cubicBezTo>
                        <a:cubicBezTo>
                          <a:pt x="15130" y="23538"/>
                          <a:pt x="13084" y="34514"/>
                          <a:pt x="13084" y="50513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74" name="Grafik 3">
                  <a:extLst>
                    <a:ext uri="{FF2B5EF4-FFF2-40B4-BE49-F238E27FC236}">
                      <a16:creationId xmlns:a16="http://schemas.microsoft.com/office/drawing/2014/main" id="{32F69AF3-A1EB-4DCB-8729-E8656660BE53}"/>
                    </a:ext>
                  </a:extLst>
                </p:cNvPr>
                <p:cNvGrpSpPr/>
                <p:nvPr/>
              </p:nvGrpSpPr>
              <p:grpSpPr>
                <a:xfrm>
                  <a:off x="333729" y="5661637"/>
                  <a:ext cx="215866" cy="115530"/>
                  <a:chOff x="1523590" y="5755554"/>
                  <a:chExt cx="186036" cy="99565"/>
                </a:xfrm>
              </p:grpSpPr>
              <p:sp>
                <p:nvSpPr>
                  <p:cNvPr id="175" name="Freihandform: Form 174">
                    <a:extLst>
                      <a:ext uri="{FF2B5EF4-FFF2-40B4-BE49-F238E27FC236}">
                        <a16:creationId xmlns:a16="http://schemas.microsoft.com/office/drawing/2014/main" id="{691125D2-0465-4D41-BB49-0A7FD3E4FBAE}"/>
                      </a:ext>
                    </a:extLst>
                  </p:cNvPr>
                  <p:cNvSpPr/>
                  <p:nvPr/>
                </p:nvSpPr>
                <p:spPr>
                  <a:xfrm>
                    <a:off x="1523590" y="5812146"/>
                    <a:ext cx="36797" cy="12055"/>
                  </a:xfrm>
                  <a:custGeom>
                    <a:avLst/>
                    <a:gdLst>
                      <a:gd name="connsiteX0" fmla="*/ 24 w 36797"/>
                      <a:gd name="connsiteY0" fmla="*/ 12670 h 12055"/>
                      <a:gd name="connsiteX1" fmla="*/ 24 w 36797"/>
                      <a:gd name="connsiteY1" fmla="*/ 615 h 12055"/>
                      <a:gd name="connsiteX2" fmla="*/ 36821 w 36797"/>
                      <a:gd name="connsiteY2" fmla="*/ 615 h 12055"/>
                      <a:gd name="connsiteX3" fmla="*/ 36821 w 36797"/>
                      <a:gd name="connsiteY3" fmla="*/ 12670 h 1205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36797" h="12055">
                        <a:moveTo>
                          <a:pt x="24" y="12670"/>
                        </a:moveTo>
                        <a:lnTo>
                          <a:pt x="24" y="615"/>
                        </a:lnTo>
                        <a:lnTo>
                          <a:pt x="36821" y="615"/>
                        </a:lnTo>
                        <a:lnTo>
                          <a:pt x="36821" y="1267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76" name="Freihandform: Form 175">
                    <a:extLst>
                      <a:ext uri="{FF2B5EF4-FFF2-40B4-BE49-F238E27FC236}">
                        <a16:creationId xmlns:a16="http://schemas.microsoft.com/office/drawing/2014/main" id="{3DD3F36B-AAF8-4AA2-B8A1-0D4496F1E646}"/>
                      </a:ext>
                    </a:extLst>
                  </p:cNvPr>
                  <p:cNvSpPr/>
                  <p:nvPr/>
                </p:nvSpPr>
                <p:spPr>
                  <a:xfrm>
                    <a:off x="1568745" y="5755554"/>
                    <a:ext cx="64459" cy="97891"/>
                  </a:xfrm>
                  <a:custGeom>
                    <a:avLst/>
                    <a:gdLst>
                      <a:gd name="connsiteX0" fmla="*/ 64488 w 64459"/>
                      <a:gd name="connsiteY0" fmla="*/ 87009 h 97891"/>
                      <a:gd name="connsiteX1" fmla="*/ 64488 w 64459"/>
                      <a:gd name="connsiteY1" fmla="*/ 98506 h 97891"/>
                      <a:gd name="connsiteX2" fmla="*/ 45 w 64459"/>
                      <a:gd name="connsiteY2" fmla="*/ 98506 h 97891"/>
                      <a:gd name="connsiteX3" fmla="*/ 1422 w 64459"/>
                      <a:gd name="connsiteY3" fmla="*/ 90209 h 97891"/>
                      <a:gd name="connsiteX4" fmla="*/ 9310 w 64459"/>
                      <a:gd name="connsiteY4" fmla="*/ 77223 h 97891"/>
                      <a:gd name="connsiteX5" fmla="*/ 24974 w 64459"/>
                      <a:gd name="connsiteY5" fmla="*/ 62452 h 97891"/>
                      <a:gd name="connsiteX6" fmla="*/ 46442 w 64459"/>
                      <a:gd name="connsiteY6" fmla="*/ 41802 h 97891"/>
                      <a:gd name="connsiteX7" fmla="*/ 52060 w 64459"/>
                      <a:gd name="connsiteY7" fmla="*/ 27403 h 97891"/>
                      <a:gd name="connsiteX8" fmla="*/ 46963 w 64459"/>
                      <a:gd name="connsiteY8" fmla="*/ 15422 h 97891"/>
                      <a:gd name="connsiteX9" fmla="*/ 33680 w 64459"/>
                      <a:gd name="connsiteY9" fmla="*/ 10511 h 97891"/>
                      <a:gd name="connsiteX10" fmla="*/ 19839 w 64459"/>
                      <a:gd name="connsiteY10" fmla="*/ 15720 h 97891"/>
                      <a:gd name="connsiteX11" fmla="*/ 14593 w 64459"/>
                      <a:gd name="connsiteY11" fmla="*/ 30082 h 97891"/>
                      <a:gd name="connsiteX12" fmla="*/ 2315 w 64459"/>
                      <a:gd name="connsiteY12" fmla="*/ 28817 h 97891"/>
                      <a:gd name="connsiteX13" fmla="*/ 11802 w 64459"/>
                      <a:gd name="connsiteY13" fmla="*/ 7832 h 97891"/>
                      <a:gd name="connsiteX14" fmla="*/ 33941 w 64459"/>
                      <a:gd name="connsiteY14" fmla="*/ 615 h 97891"/>
                      <a:gd name="connsiteX15" fmla="*/ 56153 w 64459"/>
                      <a:gd name="connsiteY15" fmla="*/ 8390 h 97891"/>
                      <a:gd name="connsiteX16" fmla="*/ 64339 w 64459"/>
                      <a:gd name="connsiteY16" fmla="*/ 27664 h 97891"/>
                      <a:gd name="connsiteX17" fmla="*/ 61957 w 64459"/>
                      <a:gd name="connsiteY17" fmla="*/ 39198 h 97891"/>
                      <a:gd name="connsiteX18" fmla="*/ 53995 w 64459"/>
                      <a:gd name="connsiteY18" fmla="*/ 51104 h 97891"/>
                      <a:gd name="connsiteX19" fmla="*/ 35541 w 64459"/>
                      <a:gd name="connsiteY19" fmla="*/ 68257 h 97891"/>
                      <a:gd name="connsiteX20" fmla="*/ 21699 w 64459"/>
                      <a:gd name="connsiteY20" fmla="*/ 80535 h 97891"/>
                      <a:gd name="connsiteX21" fmla="*/ 16677 w 64459"/>
                      <a:gd name="connsiteY21" fmla="*/ 87009 h 9789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4459" h="97891">
                        <a:moveTo>
                          <a:pt x="64488" y="87009"/>
                        </a:moveTo>
                        <a:lnTo>
                          <a:pt x="64488" y="98506"/>
                        </a:lnTo>
                        <a:lnTo>
                          <a:pt x="45" y="98506"/>
                        </a:lnTo>
                        <a:cubicBezTo>
                          <a:pt x="-67" y="95641"/>
                          <a:pt x="380" y="92888"/>
                          <a:pt x="1422" y="90209"/>
                        </a:cubicBezTo>
                        <a:cubicBezTo>
                          <a:pt x="3022" y="85855"/>
                          <a:pt x="5663" y="81539"/>
                          <a:pt x="9310" y="77223"/>
                        </a:cubicBezTo>
                        <a:cubicBezTo>
                          <a:pt x="12919" y="72982"/>
                          <a:pt x="18128" y="68033"/>
                          <a:pt x="24974" y="62452"/>
                        </a:cubicBezTo>
                        <a:cubicBezTo>
                          <a:pt x="35541" y="53783"/>
                          <a:pt x="42684" y="46900"/>
                          <a:pt x="46442" y="41802"/>
                        </a:cubicBezTo>
                        <a:cubicBezTo>
                          <a:pt x="50163" y="36742"/>
                          <a:pt x="52060" y="31942"/>
                          <a:pt x="52060" y="27403"/>
                        </a:cubicBezTo>
                        <a:cubicBezTo>
                          <a:pt x="52060" y="22678"/>
                          <a:pt x="50349" y="18697"/>
                          <a:pt x="46963" y="15422"/>
                        </a:cubicBezTo>
                        <a:cubicBezTo>
                          <a:pt x="43540" y="12186"/>
                          <a:pt x="39112" y="10548"/>
                          <a:pt x="33680" y="10511"/>
                        </a:cubicBezTo>
                        <a:cubicBezTo>
                          <a:pt x="27913" y="10548"/>
                          <a:pt x="23299" y="12297"/>
                          <a:pt x="19839" y="15720"/>
                        </a:cubicBezTo>
                        <a:cubicBezTo>
                          <a:pt x="16379" y="19218"/>
                          <a:pt x="14630" y="23980"/>
                          <a:pt x="14593" y="30082"/>
                        </a:cubicBezTo>
                        <a:lnTo>
                          <a:pt x="2315" y="28817"/>
                        </a:lnTo>
                        <a:cubicBezTo>
                          <a:pt x="3133" y="19664"/>
                          <a:pt x="6296" y="12669"/>
                          <a:pt x="11802" y="7832"/>
                        </a:cubicBezTo>
                        <a:cubicBezTo>
                          <a:pt x="17272" y="3033"/>
                          <a:pt x="24639" y="615"/>
                          <a:pt x="33941" y="615"/>
                        </a:cubicBezTo>
                        <a:cubicBezTo>
                          <a:pt x="43280" y="615"/>
                          <a:pt x="50684" y="3219"/>
                          <a:pt x="56153" y="8390"/>
                        </a:cubicBezTo>
                        <a:cubicBezTo>
                          <a:pt x="61585" y="13599"/>
                          <a:pt x="64339" y="20036"/>
                          <a:pt x="64339" y="27664"/>
                        </a:cubicBezTo>
                        <a:cubicBezTo>
                          <a:pt x="64339" y="31608"/>
                          <a:pt x="63520" y="35440"/>
                          <a:pt x="61957" y="39198"/>
                        </a:cubicBezTo>
                        <a:cubicBezTo>
                          <a:pt x="60320" y="42956"/>
                          <a:pt x="57679" y="46937"/>
                          <a:pt x="53995" y="51104"/>
                        </a:cubicBezTo>
                        <a:cubicBezTo>
                          <a:pt x="50274" y="55308"/>
                          <a:pt x="44135" y="61001"/>
                          <a:pt x="35541" y="68257"/>
                        </a:cubicBezTo>
                        <a:cubicBezTo>
                          <a:pt x="28360" y="74284"/>
                          <a:pt x="23746" y="78377"/>
                          <a:pt x="21699" y="80535"/>
                        </a:cubicBezTo>
                        <a:cubicBezTo>
                          <a:pt x="19653" y="82693"/>
                          <a:pt x="17979" y="84851"/>
                          <a:pt x="16677" y="87009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77" name="Freihandform: Form 176">
                    <a:extLst>
                      <a:ext uri="{FF2B5EF4-FFF2-40B4-BE49-F238E27FC236}">
                        <a16:creationId xmlns:a16="http://schemas.microsoft.com/office/drawing/2014/main" id="{EA82786A-4968-4022-9024-97F8269306C7}"/>
                      </a:ext>
                    </a:extLst>
                  </p:cNvPr>
                  <p:cNvSpPr/>
                  <p:nvPr/>
                </p:nvSpPr>
                <p:spPr>
                  <a:xfrm>
                    <a:off x="1646039" y="5755554"/>
                    <a:ext cx="63587" cy="99565"/>
                  </a:xfrm>
                  <a:custGeom>
                    <a:avLst/>
                    <a:gdLst>
                      <a:gd name="connsiteX0" fmla="*/ 37 w 63587"/>
                      <a:gd name="connsiteY0" fmla="*/ 50434 h 99565"/>
                      <a:gd name="connsiteX1" fmla="*/ 3572 w 63587"/>
                      <a:gd name="connsiteY1" fmla="*/ 22603 h 99565"/>
                      <a:gd name="connsiteX2" fmla="*/ 14139 w 63587"/>
                      <a:gd name="connsiteY2" fmla="*/ 6344 h 99565"/>
                      <a:gd name="connsiteX3" fmla="*/ 31812 w 63587"/>
                      <a:gd name="connsiteY3" fmla="*/ 615 h 99565"/>
                      <a:gd name="connsiteX4" fmla="*/ 45578 w 63587"/>
                      <a:gd name="connsiteY4" fmla="*/ 3777 h 99565"/>
                      <a:gd name="connsiteX5" fmla="*/ 55364 w 63587"/>
                      <a:gd name="connsiteY5" fmla="*/ 12892 h 99565"/>
                      <a:gd name="connsiteX6" fmla="*/ 61429 w 63587"/>
                      <a:gd name="connsiteY6" fmla="*/ 27403 h 99565"/>
                      <a:gd name="connsiteX7" fmla="*/ 63624 w 63587"/>
                      <a:gd name="connsiteY7" fmla="*/ 50434 h 99565"/>
                      <a:gd name="connsiteX8" fmla="*/ 60089 w 63587"/>
                      <a:gd name="connsiteY8" fmla="*/ 78116 h 99565"/>
                      <a:gd name="connsiteX9" fmla="*/ 49522 w 63587"/>
                      <a:gd name="connsiteY9" fmla="*/ 94413 h 99565"/>
                      <a:gd name="connsiteX10" fmla="*/ 31812 w 63587"/>
                      <a:gd name="connsiteY10" fmla="*/ 100180 h 99565"/>
                      <a:gd name="connsiteX11" fmla="*/ 9674 w 63587"/>
                      <a:gd name="connsiteY11" fmla="*/ 90060 h 99565"/>
                      <a:gd name="connsiteX12" fmla="*/ 37 w 63587"/>
                      <a:gd name="connsiteY12" fmla="*/ 50434 h 99565"/>
                      <a:gd name="connsiteX13" fmla="*/ 12353 w 63587"/>
                      <a:gd name="connsiteY13" fmla="*/ 50434 h 99565"/>
                      <a:gd name="connsiteX14" fmla="*/ 17971 w 63587"/>
                      <a:gd name="connsiteY14" fmla="*/ 82395 h 99565"/>
                      <a:gd name="connsiteX15" fmla="*/ 31812 w 63587"/>
                      <a:gd name="connsiteY15" fmla="*/ 90320 h 99565"/>
                      <a:gd name="connsiteX16" fmla="*/ 45690 w 63587"/>
                      <a:gd name="connsiteY16" fmla="*/ 82358 h 99565"/>
                      <a:gd name="connsiteX17" fmla="*/ 51308 w 63587"/>
                      <a:gd name="connsiteY17" fmla="*/ 50434 h 99565"/>
                      <a:gd name="connsiteX18" fmla="*/ 45690 w 63587"/>
                      <a:gd name="connsiteY18" fmla="*/ 18436 h 99565"/>
                      <a:gd name="connsiteX19" fmla="*/ 31700 w 63587"/>
                      <a:gd name="connsiteY19" fmla="*/ 10511 h 99565"/>
                      <a:gd name="connsiteX20" fmla="*/ 18529 w 63587"/>
                      <a:gd name="connsiteY20" fmla="*/ 17506 h 99565"/>
                      <a:gd name="connsiteX21" fmla="*/ 12353 w 63587"/>
                      <a:gd name="connsiteY21" fmla="*/ 50434 h 995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3587" h="99565">
                        <a:moveTo>
                          <a:pt x="37" y="50434"/>
                        </a:moveTo>
                        <a:cubicBezTo>
                          <a:pt x="0" y="38937"/>
                          <a:pt x="1190" y="29636"/>
                          <a:pt x="3572" y="22603"/>
                        </a:cubicBezTo>
                        <a:cubicBezTo>
                          <a:pt x="5916" y="15571"/>
                          <a:pt x="9450" y="10176"/>
                          <a:pt x="14139" y="6344"/>
                        </a:cubicBezTo>
                        <a:cubicBezTo>
                          <a:pt x="18827" y="2549"/>
                          <a:pt x="24705" y="615"/>
                          <a:pt x="31812" y="615"/>
                        </a:cubicBezTo>
                        <a:cubicBezTo>
                          <a:pt x="37021" y="615"/>
                          <a:pt x="41597" y="1693"/>
                          <a:pt x="45578" y="3777"/>
                        </a:cubicBezTo>
                        <a:cubicBezTo>
                          <a:pt x="49485" y="5935"/>
                          <a:pt x="52759" y="8949"/>
                          <a:pt x="55364" y="12892"/>
                        </a:cubicBezTo>
                        <a:cubicBezTo>
                          <a:pt x="57931" y="16874"/>
                          <a:pt x="59940" y="21711"/>
                          <a:pt x="61429" y="27403"/>
                        </a:cubicBezTo>
                        <a:cubicBezTo>
                          <a:pt x="62843" y="33096"/>
                          <a:pt x="63587" y="40798"/>
                          <a:pt x="63624" y="50434"/>
                        </a:cubicBezTo>
                        <a:cubicBezTo>
                          <a:pt x="63587" y="61894"/>
                          <a:pt x="62396" y="71121"/>
                          <a:pt x="60089" y="78116"/>
                        </a:cubicBezTo>
                        <a:cubicBezTo>
                          <a:pt x="57708" y="85186"/>
                          <a:pt x="54211" y="90618"/>
                          <a:pt x="49522" y="94413"/>
                        </a:cubicBezTo>
                        <a:cubicBezTo>
                          <a:pt x="44834" y="98283"/>
                          <a:pt x="38918" y="100180"/>
                          <a:pt x="31812" y="100180"/>
                        </a:cubicBezTo>
                        <a:cubicBezTo>
                          <a:pt x="22399" y="100180"/>
                          <a:pt x="15032" y="96832"/>
                          <a:pt x="9674" y="90060"/>
                        </a:cubicBezTo>
                        <a:cubicBezTo>
                          <a:pt x="3237" y="81986"/>
                          <a:pt x="0" y="68777"/>
                          <a:pt x="37" y="50434"/>
                        </a:cubicBezTo>
                        <a:close/>
                        <a:moveTo>
                          <a:pt x="12353" y="50434"/>
                        </a:moveTo>
                        <a:cubicBezTo>
                          <a:pt x="12353" y="66471"/>
                          <a:pt x="14213" y="77112"/>
                          <a:pt x="17971" y="82395"/>
                        </a:cubicBezTo>
                        <a:cubicBezTo>
                          <a:pt x="21692" y="87716"/>
                          <a:pt x="26305" y="90357"/>
                          <a:pt x="31812" y="90320"/>
                        </a:cubicBezTo>
                        <a:cubicBezTo>
                          <a:pt x="37281" y="90357"/>
                          <a:pt x="41895" y="87716"/>
                          <a:pt x="45690" y="82358"/>
                        </a:cubicBezTo>
                        <a:cubicBezTo>
                          <a:pt x="49411" y="77075"/>
                          <a:pt x="51308" y="66433"/>
                          <a:pt x="51308" y="50434"/>
                        </a:cubicBezTo>
                        <a:cubicBezTo>
                          <a:pt x="51308" y="34435"/>
                          <a:pt x="49411" y="23757"/>
                          <a:pt x="45690" y="18436"/>
                        </a:cubicBezTo>
                        <a:cubicBezTo>
                          <a:pt x="41895" y="13190"/>
                          <a:pt x="37244" y="10548"/>
                          <a:pt x="31700" y="10511"/>
                        </a:cubicBezTo>
                        <a:cubicBezTo>
                          <a:pt x="26156" y="10548"/>
                          <a:pt x="21766" y="12892"/>
                          <a:pt x="18529" y="17506"/>
                        </a:cubicBezTo>
                        <a:cubicBezTo>
                          <a:pt x="14399" y="23459"/>
                          <a:pt x="12353" y="34435"/>
                          <a:pt x="12353" y="50434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178" name="Grafik 3">
                  <a:extLst>
                    <a:ext uri="{FF2B5EF4-FFF2-40B4-BE49-F238E27FC236}">
                      <a16:creationId xmlns:a16="http://schemas.microsoft.com/office/drawing/2014/main" id="{827621AB-56F7-4A0F-A875-EEBD33D00015}"/>
                    </a:ext>
                  </a:extLst>
                </p:cNvPr>
                <p:cNvGrpSpPr/>
                <p:nvPr/>
              </p:nvGrpSpPr>
              <p:grpSpPr>
                <a:xfrm>
                  <a:off x="333729" y="4513509"/>
                  <a:ext cx="215866" cy="115530"/>
                  <a:chOff x="1523590" y="4341425"/>
                  <a:chExt cx="186036" cy="99565"/>
                </a:xfrm>
              </p:grpSpPr>
              <p:sp>
                <p:nvSpPr>
                  <p:cNvPr id="179" name="Freihandform: Form 178">
                    <a:extLst>
                      <a:ext uri="{FF2B5EF4-FFF2-40B4-BE49-F238E27FC236}">
                        <a16:creationId xmlns:a16="http://schemas.microsoft.com/office/drawing/2014/main" id="{BDB11579-8475-4C49-ACF5-272A189B860D}"/>
                      </a:ext>
                    </a:extLst>
                  </p:cNvPr>
                  <p:cNvSpPr/>
                  <p:nvPr/>
                </p:nvSpPr>
                <p:spPr>
                  <a:xfrm>
                    <a:off x="1523590" y="4398016"/>
                    <a:ext cx="36797" cy="12055"/>
                  </a:xfrm>
                  <a:custGeom>
                    <a:avLst/>
                    <a:gdLst>
                      <a:gd name="connsiteX0" fmla="*/ 24 w 36797"/>
                      <a:gd name="connsiteY0" fmla="*/ 12521 h 12055"/>
                      <a:gd name="connsiteX1" fmla="*/ 24 w 36797"/>
                      <a:gd name="connsiteY1" fmla="*/ 466 h 12055"/>
                      <a:gd name="connsiteX2" fmla="*/ 36821 w 36797"/>
                      <a:gd name="connsiteY2" fmla="*/ 466 h 12055"/>
                      <a:gd name="connsiteX3" fmla="*/ 36821 w 36797"/>
                      <a:gd name="connsiteY3" fmla="*/ 12521 h 1205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36797" h="12055">
                        <a:moveTo>
                          <a:pt x="24" y="12521"/>
                        </a:moveTo>
                        <a:lnTo>
                          <a:pt x="24" y="466"/>
                        </a:lnTo>
                        <a:lnTo>
                          <a:pt x="36821" y="466"/>
                        </a:lnTo>
                        <a:lnTo>
                          <a:pt x="36821" y="12521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80" name="Freihandform: Form 179">
                    <a:extLst>
                      <a:ext uri="{FF2B5EF4-FFF2-40B4-BE49-F238E27FC236}">
                        <a16:creationId xmlns:a16="http://schemas.microsoft.com/office/drawing/2014/main" id="{E4DCCD6F-C3CC-40E6-BA52-5ABDD4ABC560}"/>
                      </a:ext>
                    </a:extLst>
                  </p:cNvPr>
                  <p:cNvSpPr/>
                  <p:nvPr/>
                </p:nvSpPr>
                <p:spPr>
                  <a:xfrm>
                    <a:off x="1579478" y="4341425"/>
                    <a:ext cx="35904" cy="97891"/>
                  </a:xfrm>
                  <a:custGeom>
                    <a:avLst/>
                    <a:gdLst>
                      <a:gd name="connsiteX0" fmla="*/ 35933 w 35904"/>
                      <a:gd name="connsiteY0" fmla="*/ 98357 h 97891"/>
                      <a:gd name="connsiteX1" fmla="*/ 23952 w 35904"/>
                      <a:gd name="connsiteY1" fmla="*/ 98357 h 97891"/>
                      <a:gd name="connsiteX2" fmla="*/ 23952 w 35904"/>
                      <a:gd name="connsiteY2" fmla="*/ 22083 h 97891"/>
                      <a:gd name="connsiteX3" fmla="*/ 12604 w 35904"/>
                      <a:gd name="connsiteY3" fmla="*/ 30343 h 97891"/>
                      <a:gd name="connsiteX4" fmla="*/ 28 w 35904"/>
                      <a:gd name="connsiteY4" fmla="*/ 36519 h 97891"/>
                      <a:gd name="connsiteX5" fmla="*/ 28 w 35904"/>
                      <a:gd name="connsiteY5" fmla="*/ 24948 h 97891"/>
                      <a:gd name="connsiteX6" fmla="*/ 17553 w 35904"/>
                      <a:gd name="connsiteY6" fmla="*/ 13525 h 97891"/>
                      <a:gd name="connsiteX7" fmla="*/ 28231 w 35904"/>
                      <a:gd name="connsiteY7" fmla="*/ 466 h 97891"/>
                      <a:gd name="connsiteX8" fmla="*/ 35933 w 35904"/>
                      <a:gd name="connsiteY8" fmla="*/ 466 h 9789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35904" h="97891">
                        <a:moveTo>
                          <a:pt x="35933" y="98357"/>
                        </a:moveTo>
                        <a:lnTo>
                          <a:pt x="23952" y="98357"/>
                        </a:lnTo>
                        <a:lnTo>
                          <a:pt x="23952" y="22083"/>
                        </a:lnTo>
                        <a:cubicBezTo>
                          <a:pt x="21050" y="24874"/>
                          <a:pt x="17255" y="27627"/>
                          <a:pt x="12604" y="30343"/>
                        </a:cubicBezTo>
                        <a:cubicBezTo>
                          <a:pt x="7916" y="33096"/>
                          <a:pt x="3749" y="35143"/>
                          <a:pt x="28" y="36519"/>
                        </a:cubicBezTo>
                        <a:lnTo>
                          <a:pt x="28" y="24948"/>
                        </a:lnTo>
                        <a:cubicBezTo>
                          <a:pt x="6726" y="21822"/>
                          <a:pt x="12567" y="17990"/>
                          <a:pt x="17553" y="13525"/>
                        </a:cubicBezTo>
                        <a:cubicBezTo>
                          <a:pt x="22539" y="9060"/>
                          <a:pt x="26073" y="4707"/>
                          <a:pt x="28231" y="466"/>
                        </a:cubicBezTo>
                        <a:lnTo>
                          <a:pt x="35933" y="466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81" name="Freihandform: Form 180">
                    <a:extLst>
                      <a:ext uri="{FF2B5EF4-FFF2-40B4-BE49-F238E27FC236}">
                        <a16:creationId xmlns:a16="http://schemas.microsoft.com/office/drawing/2014/main" id="{E2FE97FB-F94F-4133-902F-11C8FD6ED636}"/>
                      </a:ext>
                    </a:extLst>
                  </p:cNvPr>
                  <p:cNvSpPr/>
                  <p:nvPr/>
                </p:nvSpPr>
                <p:spPr>
                  <a:xfrm>
                    <a:off x="1646039" y="4341425"/>
                    <a:ext cx="63587" cy="99565"/>
                  </a:xfrm>
                  <a:custGeom>
                    <a:avLst/>
                    <a:gdLst>
                      <a:gd name="connsiteX0" fmla="*/ 37 w 63587"/>
                      <a:gd name="connsiteY0" fmla="*/ 50286 h 99565"/>
                      <a:gd name="connsiteX1" fmla="*/ 3572 w 63587"/>
                      <a:gd name="connsiteY1" fmla="*/ 22455 h 99565"/>
                      <a:gd name="connsiteX2" fmla="*/ 14139 w 63587"/>
                      <a:gd name="connsiteY2" fmla="*/ 6196 h 99565"/>
                      <a:gd name="connsiteX3" fmla="*/ 31812 w 63587"/>
                      <a:gd name="connsiteY3" fmla="*/ 466 h 99565"/>
                      <a:gd name="connsiteX4" fmla="*/ 45578 w 63587"/>
                      <a:gd name="connsiteY4" fmla="*/ 3628 h 99565"/>
                      <a:gd name="connsiteX5" fmla="*/ 55364 w 63587"/>
                      <a:gd name="connsiteY5" fmla="*/ 12744 h 99565"/>
                      <a:gd name="connsiteX6" fmla="*/ 61429 w 63587"/>
                      <a:gd name="connsiteY6" fmla="*/ 27255 h 99565"/>
                      <a:gd name="connsiteX7" fmla="*/ 63624 w 63587"/>
                      <a:gd name="connsiteY7" fmla="*/ 50286 h 99565"/>
                      <a:gd name="connsiteX8" fmla="*/ 60089 w 63587"/>
                      <a:gd name="connsiteY8" fmla="*/ 77968 h 99565"/>
                      <a:gd name="connsiteX9" fmla="*/ 49522 w 63587"/>
                      <a:gd name="connsiteY9" fmla="*/ 94265 h 99565"/>
                      <a:gd name="connsiteX10" fmla="*/ 31812 w 63587"/>
                      <a:gd name="connsiteY10" fmla="*/ 100032 h 99565"/>
                      <a:gd name="connsiteX11" fmla="*/ 9674 w 63587"/>
                      <a:gd name="connsiteY11" fmla="*/ 89911 h 99565"/>
                      <a:gd name="connsiteX12" fmla="*/ 37 w 63587"/>
                      <a:gd name="connsiteY12" fmla="*/ 50286 h 99565"/>
                      <a:gd name="connsiteX13" fmla="*/ 12353 w 63587"/>
                      <a:gd name="connsiteY13" fmla="*/ 50286 h 99565"/>
                      <a:gd name="connsiteX14" fmla="*/ 17971 w 63587"/>
                      <a:gd name="connsiteY14" fmla="*/ 82247 h 99565"/>
                      <a:gd name="connsiteX15" fmla="*/ 31812 w 63587"/>
                      <a:gd name="connsiteY15" fmla="*/ 90172 h 99565"/>
                      <a:gd name="connsiteX16" fmla="*/ 45690 w 63587"/>
                      <a:gd name="connsiteY16" fmla="*/ 82210 h 99565"/>
                      <a:gd name="connsiteX17" fmla="*/ 51308 w 63587"/>
                      <a:gd name="connsiteY17" fmla="*/ 50286 h 99565"/>
                      <a:gd name="connsiteX18" fmla="*/ 45690 w 63587"/>
                      <a:gd name="connsiteY18" fmla="*/ 18288 h 99565"/>
                      <a:gd name="connsiteX19" fmla="*/ 31700 w 63587"/>
                      <a:gd name="connsiteY19" fmla="*/ 10363 h 99565"/>
                      <a:gd name="connsiteX20" fmla="*/ 18529 w 63587"/>
                      <a:gd name="connsiteY20" fmla="*/ 17358 h 99565"/>
                      <a:gd name="connsiteX21" fmla="*/ 12353 w 63587"/>
                      <a:gd name="connsiteY21" fmla="*/ 50286 h 995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3587" h="99565">
                        <a:moveTo>
                          <a:pt x="37" y="50286"/>
                        </a:moveTo>
                        <a:cubicBezTo>
                          <a:pt x="0" y="38789"/>
                          <a:pt x="1190" y="29487"/>
                          <a:pt x="3572" y="22455"/>
                        </a:cubicBezTo>
                        <a:cubicBezTo>
                          <a:pt x="5916" y="15423"/>
                          <a:pt x="9450" y="10028"/>
                          <a:pt x="14139" y="6196"/>
                        </a:cubicBezTo>
                        <a:cubicBezTo>
                          <a:pt x="18827" y="2401"/>
                          <a:pt x="24705" y="466"/>
                          <a:pt x="31812" y="466"/>
                        </a:cubicBezTo>
                        <a:cubicBezTo>
                          <a:pt x="37021" y="466"/>
                          <a:pt x="41597" y="1544"/>
                          <a:pt x="45578" y="3628"/>
                        </a:cubicBezTo>
                        <a:cubicBezTo>
                          <a:pt x="49485" y="5786"/>
                          <a:pt x="52759" y="8800"/>
                          <a:pt x="55364" y="12744"/>
                        </a:cubicBezTo>
                        <a:cubicBezTo>
                          <a:pt x="57931" y="16725"/>
                          <a:pt x="59940" y="21562"/>
                          <a:pt x="61429" y="27255"/>
                        </a:cubicBezTo>
                        <a:cubicBezTo>
                          <a:pt x="62843" y="32947"/>
                          <a:pt x="63587" y="40649"/>
                          <a:pt x="63624" y="50286"/>
                        </a:cubicBezTo>
                        <a:cubicBezTo>
                          <a:pt x="63587" y="61746"/>
                          <a:pt x="62396" y="70973"/>
                          <a:pt x="60089" y="77968"/>
                        </a:cubicBezTo>
                        <a:cubicBezTo>
                          <a:pt x="57708" y="85037"/>
                          <a:pt x="54211" y="90469"/>
                          <a:pt x="49522" y="94265"/>
                        </a:cubicBezTo>
                        <a:cubicBezTo>
                          <a:pt x="44834" y="98134"/>
                          <a:pt x="38918" y="100032"/>
                          <a:pt x="31812" y="100032"/>
                        </a:cubicBezTo>
                        <a:cubicBezTo>
                          <a:pt x="22399" y="100032"/>
                          <a:pt x="15032" y="96683"/>
                          <a:pt x="9674" y="89911"/>
                        </a:cubicBezTo>
                        <a:cubicBezTo>
                          <a:pt x="3237" y="81837"/>
                          <a:pt x="0" y="68629"/>
                          <a:pt x="37" y="50286"/>
                        </a:cubicBezTo>
                        <a:close/>
                        <a:moveTo>
                          <a:pt x="12353" y="50286"/>
                        </a:moveTo>
                        <a:cubicBezTo>
                          <a:pt x="12353" y="66322"/>
                          <a:pt x="14213" y="76963"/>
                          <a:pt x="17971" y="82247"/>
                        </a:cubicBezTo>
                        <a:cubicBezTo>
                          <a:pt x="21692" y="87567"/>
                          <a:pt x="26305" y="90209"/>
                          <a:pt x="31812" y="90172"/>
                        </a:cubicBezTo>
                        <a:cubicBezTo>
                          <a:pt x="37281" y="90209"/>
                          <a:pt x="41895" y="87567"/>
                          <a:pt x="45690" y="82210"/>
                        </a:cubicBezTo>
                        <a:cubicBezTo>
                          <a:pt x="49411" y="76926"/>
                          <a:pt x="51308" y="66285"/>
                          <a:pt x="51308" y="50286"/>
                        </a:cubicBezTo>
                        <a:cubicBezTo>
                          <a:pt x="51308" y="34287"/>
                          <a:pt x="49411" y="23608"/>
                          <a:pt x="45690" y="18288"/>
                        </a:cubicBezTo>
                        <a:cubicBezTo>
                          <a:pt x="41895" y="13042"/>
                          <a:pt x="37244" y="10400"/>
                          <a:pt x="31700" y="10363"/>
                        </a:cubicBezTo>
                        <a:cubicBezTo>
                          <a:pt x="26156" y="10400"/>
                          <a:pt x="21766" y="12744"/>
                          <a:pt x="18529" y="17358"/>
                        </a:cubicBezTo>
                        <a:cubicBezTo>
                          <a:pt x="14399" y="23311"/>
                          <a:pt x="12353" y="34287"/>
                          <a:pt x="12353" y="50286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sp>
              <p:nvSpPr>
                <p:cNvPr id="182" name="Freihandform: Form 181">
                  <a:extLst>
                    <a:ext uri="{FF2B5EF4-FFF2-40B4-BE49-F238E27FC236}">
                      <a16:creationId xmlns:a16="http://schemas.microsoft.com/office/drawing/2014/main" id="{B5E3C706-D803-4535-A7C4-471F1AC4082A}"/>
                    </a:ext>
                  </a:extLst>
                </p:cNvPr>
                <p:cNvSpPr/>
                <p:nvPr/>
              </p:nvSpPr>
              <p:spPr>
                <a:xfrm>
                  <a:off x="475812" y="3365382"/>
                  <a:ext cx="73783" cy="115530"/>
                </a:xfrm>
                <a:custGeom>
                  <a:avLst/>
                  <a:gdLst>
                    <a:gd name="connsiteX0" fmla="*/ 37 w 63587"/>
                    <a:gd name="connsiteY0" fmla="*/ 50137 h 99565"/>
                    <a:gd name="connsiteX1" fmla="*/ 3572 w 63587"/>
                    <a:gd name="connsiteY1" fmla="*/ 22307 h 99565"/>
                    <a:gd name="connsiteX2" fmla="*/ 14139 w 63587"/>
                    <a:gd name="connsiteY2" fmla="*/ 6047 h 99565"/>
                    <a:gd name="connsiteX3" fmla="*/ 31812 w 63587"/>
                    <a:gd name="connsiteY3" fmla="*/ 318 h 99565"/>
                    <a:gd name="connsiteX4" fmla="*/ 45578 w 63587"/>
                    <a:gd name="connsiteY4" fmla="*/ 3480 h 99565"/>
                    <a:gd name="connsiteX5" fmla="*/ 55364 w 63587"/>
                    <a:gd name="connsiteY5" fmla="*/ 12596 h 99565"/>
                    <a:gd name="connsiteX6" fmla="*/ 61429 w 63587"/>
                    <a:gd name="connsiteY6" fmla="*/ 27106 h 99565"/>
                    <a:gd name="connsiteX7" fmla="*/ 63624 w 63587"/>
                    <a:gd name="connsiteY7" fmla="*/ 50137 h 99565"/>
                    <a:gd name="connsiteX8" fmla="*/ 60089 w 63587"/>
                    <a:gd name="connsiteY8" fmla="*/ 77819 h 99565"/>
                    <a:gd name="connsiteX9" fmla="*/ 49522 w 63587"/>
                    <a:gd name="connsiteY9" fmla="*/ 94116 h 99565"/>
                    <a:gd name="connsiteX10" fmla="*/ 31812 w 63587"/>
                    <a:gd name="connsiteY10" fmla="*/ 99883 h 99565"/>
                    <a:gd name="connsiteX11" fmla="*/ 9674 w 63587"/>
                    <a:gd name="connsiteY11" fmla="*/ 89763 h 99565"/>
                    <a:gd name="connsiteX12" fmla="*/ 37 w 63587"/>
                    <a:gd name="connsiteY12" fmla="*/ 50137 h 99565"/>
                    <a:gd name="connsiteX13" fmla="*/ 12353 w 63587"/>
                    <a:gd name="connsiteY13" fmla="*/ 50137 h 99565"/>
                    <a:gd name="connsiteX14" fmla="*/ 17971 w 63587"/>
                    <a:gd name="connsiteY14" fmla="*/ 82098 h 99565"/>
                    <a:gd name="connsiteX15" fmla="*/ 31812 w 63587"/>
                    <a:gd name="connsiteY15" fmla="*/ 90023 h 99565"/>
                    <a:gd name="connsiteX16" fmla="*/ 45690 w 63587"/>
                    <a:gd name="connsiteY16" fmla="*/ 82061 h 99565"/>
                    <a:gd name="connsiteX17" fmla="*/ 51308 w 63587"/>
                    <a:gd name="connsiteY17" fmla="*/ 50137 h 99565"/>
                    <a:gd name="connsiteX18" fmla="*/ 45690 w 63587"/>
                    <a:gd name="connsiteY18" fmla="*/ 18139 h 99565"/>
                    <a:gd name="connsiteX19" fmla="*/ 31700 w 63587"/>
                    <a:gd name="connsiteY19" fmla="*/ 10214 h 99565"/>
                    <a:gd name="connsiteX20" fmla="*/ 18529 w 63587"/>
                    <a:gd name="connsiteY20" fmla="*/ 17209 h 99565"/>
                    <a:gd name="connsiteX21" fmla="*/ 12353 w 63587"/>
                    <a:gd name="connsiteY21" fmla="*/ 50137 h 9956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</a:cxnLst>
                  <a:rect l="l" t="t" r="r" b="b"/>
                  <a:pathLst>
                    <a:path w="63587" h="99565">
                      <a:moveTo>
                        <a:pt x="37" y="50137"/>
                      </a:moveTo>
                      <a:cubicBezTo>
                        <a:pt x="0" y="38640"/>
                        <a:pt x="1190" y="29339"/>
                        <a:pt x="3572" y="22307"/>
                      </a:cubicBezTo>
                      <a:cubicBezTo>
                        <a:pt x="5916" y="15274"/>
                        <a:pt x="9450" y="9879"/>
                        <a:pt x="14139" y="6047"/>
                      </a:cubicBezTo>
                      <a:cubicBezTo>
                        <a:pt x="18827" y="2252"/>
                        <a:pt x="24705" y="318"/>
                        <a:pt x="31812" y="318"/>
                      </a:cubicBezTo>
                      <a:cubicBezTo>
                        <a:pt x="37021" y="318"/>
                        <a:pt x="41597" y="1396"/>
                        <a:pt x="45578" y="3480"/>
                      </a:cubicBezTo>
                      <a:cubicBezTo>
                        <a:pt x="49485" y="5638"/>
                        <a:pt x="52759" y="8652"/>
                        <a:pt x="55364" y="12596"/>
                      </a:cubicBezTo>
                      <a:cubicBezTo>
                        <a:pt x="57931" y="16577"/>
                        <a:pt x="59940" y="21414"/>
                        <a:pt x="61429" y="27106"/>
                      </a:cubicBezTo>
                      <a:cubicBezTo>
                        <a:pt x="62843" y="32799"/>
                        <a:pt x="63587" y="40501"/>
                        <a:pt x="63624" y="50137"/>
                      </a:cubicBezTo>
                      <a:cubicBezTo>
                        <a:pt x="63587" y="61597"/>
                        <a:pt x="62396" y="70825"/>
                        <a:pt x="60089" y="77819"/>
                      </a:cubicBezTo>
                      <a:cubicBezTo>
                        <a:pt x="57708" y="84889"/>
                        <a:pt x="54211" y="90321"/>
                        <a:pt x="49522" y="94116"/>
                      </a:cubicBezTo>
                      <a:cubicBezTo>
                        <a:pt x="44834" y="97986"/>
                        <a:pt x="38918" y="99883"/>
                        <a:pt x="31812" y="99883"/>
                      </a:cubicBezTo>
                      <a:cubicBezTo>
                        <a:pt x="22399" y="99883"/>
                        <a:pt x="15032" y="96535"/>
                        <a:pt x="9674" y="89763"/>
                      </a:cubicBezTo>
                      <a:cubicBezTo>
                        <a:pt x="3237" y="81689"/>
                        <a:pt x="0" y="68481"/>
                        <a:pt x="37" y="50137"/>
                      </a:cubicBezTo>
                      <a:close/>
                      <a:moveTo>
                        <a:pt x="12353" y="50137"/>
                      </a:moveTo>
                      <a:cubicBezTo>
                        <a:pt x="12353" y="66174"/>
                        <a:pt x="14213" y="76815"/>
                        <a:pt x="17971" y="82098"/>
                      </a:cubicBezTo>
                      <a:cubicBezTo>
                        <a:pt x="21692" y="87419"/>
                        <a:pt x="26305" y="90061"/>
                        <a:pt x="31812" y="90023"/>
                      </a:cubicBezTo>
                      <a:cubicBezTo>
                        <a:pt x="37281" y="90061"/>
                        <a:pt x="41895" y="87419"/>
                        <a:pt x="45690" y="82061"/>
                      </a:cubicBezTo>
                      <a:cubicBezTo>
                        <a:pt x="49411" y="76778"/>
                        <a:pt x="51308" y="66136"/>
                        <a:pt x="51308" y="50137"/>
                      </a:cubicBezTo>
                      <a:cubicBezTo>
                        <a:pt x="51308" y="34138"/>
                        <a:pt x="49411" y="23460"/>
                        <a:pt x="45690" y="18139"/>
                      </a:cubicBezTo>
                      <a:cubicBezTo>
                        <a:pt x="41895" y="12893"/>
                        <a:pt x="37244" y="10251"/>
                        <a:pt x="31700" y="10214"/>
                      </a:cubicBezTo>
                      <a:cubicBezTo>
                        <a:pt x="26156" y="10251"/>
                        <a:pt x="21766" y="12596"/>
                        <a:pt x="18529" y="17209"/>
                      </a:cubicBezTo>
                      <a:cubicBezTo>
                        <a:pt x="14399" y="23162"/>
                        <a:pt x="12353" y="34138"/>
                        <a:pt x="12353" y="50137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grpSp>
              <p:nvGrpSpPr>
                <p:cNvPr id="183" name="Grafik 3">
                  <a:extLst>
                    <a:ext uri="{FF2B5EF4-FFF2-40B4-BE49-F238E27FC236}">
                      <a16:creationId xmlns:a16="http://schemas.microsoft.com/office/drawing/2014/main" id="{3DBA5DA7-4DF6-49A9-AA03-003DACE448E1}"/>
                    </a:ext>
                  </a:extLst>
                </p:cNvPr>
                <p:cNvGrpSpPr/>
                <p:nvPr/>
              </p:nvGrpSpPr>
              <p:grpSpPr>
                <a:xfrm>
                  <a:off x="398577" y="2217292"/>
                  <a:ext cx="151018" cy="115530"/>
                  <a:chOff x="1579475" y="1513214"/>
                  <a:chExt cx="130149" cy="99565"/>
                </a:xfrm>
              </p:grpSpPr>
              <p:sp>
                <p:nvSpPr>
                  <p:cNvPr id="184" name="Freihandform: Form 183">
                    <a:extLst>
                      <a:ext uri="{FF2B5EF4-FFF2-40B4-BE49-F238E27FC236}">
                        <a16:creationId xmlns:a16="http://schemas.microsoft.com/office/drawing/2014/main" id="{D0488B6D-BC51-409A-95C8-474762F9A196}"/>
                      </a:ext>
                    </a:extLst>
                  </p:cNvPr>
                  <p:cNvSpPr/>
                  <p:nvPr/>
                </p:nvSpPr>
                <p:spPr>
                  <a:xfrm>
                    <a:off x="1579475" y="1513214"/>
                    <a:ext cx="35904" cy="97891"/>
                  </a:xfrm>
                  <a:custGeom>
                    <a:avLst/>
                    <a:gdLst>
                      <a:gd name="connsiteX0" fmla="*/ 35933 w 35904"/>
                      <a:gd name="connsiteY0" fmla="*/ 98060 h 97891"/>
                      <a:gd name="connsiteX1" fmla="*/ 23952 w 35904"/>
                      <a:gd name="connsiteY1" fmla="*/ 98060 h 97891"/>
                      <a:gd name="connsiteX2" fmla="*/ 23952 w 35904"/>
                      <a:gd name="connsiteY2" fmla="*/ 21786 h 97891"/>
                      <a:gd name="connsiteX3" fmla="*/ 12604 w 35904"/>
                      <a:gd name="connsiteY3" fmla="*/ 30046 h 97891"/>
                      <a:gd name="connsiteX4" fmla="*/ 28 w 35904"/>
                      <a:gd name="connsiteY4" fmla="*/ 36222 h 97891"/>
                      <a:gd name="connsiteX5" fmla="*/ 28 w 35904"/>
                      <a:gd name="connsiteY5" fmla="*/ 24651 h 97891"/>
                      <a:gd name="connsiteX6" fmla="*/ 17553 w 35904"/>
                      <a:gd name="connsiteY6" fmla="*/ 13228 h 97891"/>
                      <a:gd name="connsiteX7" fmla="*/ 28231 w 35904"/>
                      <a:gd name="connsiteY7" fmla="*/ 169 h 97891"/>
                      <a:gd name="connsiteX8" fmla="*/ 35933 w 35904"/>
                      <a:gd name="connsiteY8" fmla="*/ 169 h 9789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35904" h="97891">
                        <a:moveTo>
                          <a:pt x="35933" y="98060"/>
                        </a:moveTo>
                        <a:lnTo>
                          <a:pt x="23952" y="98060"/>
                        </a:lnTo>
                        <a:lnTo>
                          <a:pt x="23952" y="21786"/>
                        </a:lnTo>
                        <a:cubicBezTo>
                          <a:pt x="21050" y="24577"/>
                          <a:pt x="17255" y="27330"/>
                          <a:pt x="12604" y="30046"/>
                        </a:cubicBezTo>
                        <a:cubicBezTo>
                          <a:pt x="7916" y="32799"/>
                          <a:pt x="3749" y="34846"/>
                          <a:pt x="28" y="36222"/>
                        </a:cubicBezTo>
                        <a:lnTo>
                          <a:pt x="28" y="24651"/>
                        </a:lnTo>
                        <a:cubicBezTo>
                          <a:pt x="6726" y="21526"/>
                          <a:pt x="12567" y="17693"/>
                          <a:pt x="17553" y="13228"/>
                        </a:cubicBezTo>
                        <a:cubicBezTo>
                          <a:pt x="22539" y="8764"/>
                          <a:pt x="26073" y="4410"/>
                          <a:pt x="28231" y="169"/>
                        </a:cubicBezTo>
                        <a:lnTo>
                          <a:pt x="35933" y="169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  <p:sp>
                <p:nvSpPr>
                  <p:cNvPr id="185" name="Freihandform: Form 184">
                    <a:extLst>
                      <a:ext uri="{FF2B5EF4-FFF2-40B4-BE49-F238E27FC236}">
                        <a16:creationId xmlns:a16="http://schemas.microsoft.com/office/drawing/2014/main" id="{AEA94175-8990-42BE-B49B-293A07C91F6E}"/>
                      </a:ext>
                    </a:extLst>
                  </p:cNvPr>
                  <p:cNvSpPr/>
                  <p:nvPr/>
                </p:nvSpPr>
                <p:spPr>
                  <a:xfrm>
                    <a:off x="1646036" y="1513214"/>
                    <a:ext cx="63587" cy="99565"/>
                  </a:xfrm>
                  <a:custGeom>
                    <a:avLst/>
                    <a:gdLst>
                      <a:gd name="connsiteX0" fmla="*/ 37 w 63587"/>
                      <a:gd name="connsiteY0" fmla="*/ 49989 h 99565"/>
                      <a:gd name="connsiteX1" fmla="*/ 3572 w 63587"/>
                      <a:gd name="connsiteY1" fmla="*/ 22158 h 99565"/>
                      <a:gd name="connsiteX2" fmla="*/ 14139 w 63587"/>
                      <a:gd name="connsiteY2" fmla="*/ 5899 h 99565"/>
                      <a:gd name="connsiteX3" fmla="*/ 31812 w 63587"/>
                      <a:gd name="connsiteY3" fmla="*/ 169 h 99565"/>
                      <a:gd name="connsiteX4" fmla="*/ 45578 w 63587"/>
                      <a:gd name="connsiteY4" fmla="*/ 3331 h 99565"/>
                      <a:gd name="connsiteX5" fmla="*/ 55364 w 63587"/>
                      <a:gd name="connsiteY5" fmla="*/ 12447 h 99565"/>
                      <a:gd name="connsiteX6" fmla="*/ 61429 w 63587"/>
                      <a:gd name="connsiteY6" fmla="*/ 26958 h 99565"/>
                      <a:gd name="connsiteX7" fmla="*/ 63624 w 63587"/>
                      <a:gd name="connsiteY7" fmla="*/ 49989 h 99565"/>
                      <a:gd name="connsiteX8" fmla="*/ 60089 w 63587"/>
                      <a:gd name="connsiteY8" fmla="*/ 77671 h 99565"/>
                      <a:gd name="connsiteX9" fmla="*/ 49522 w 63587"/>
                      <a:gd name="connsiteY9" fmla="*/ 93968 h 99565"/>
                      <a:gd name="connsiteX10" fmla="*/ 31812 w 63587"/>
                      <a:gd name="connsiteY10" fmla="*/ 99735 h 99565"/>
                      <a:gd name="connsiteX11" fmla="*/ 9674 w 63587"/>
                      <a:gd name="connsiteY11" fmla="*/ 89614 h 99565"/>
                      <a:gd name="connsiteX12" fmla="*/ 37 w 63587"/>
                      <a:gd name="connsiteY12" fmla="*/ 49989 h 99565"/>
                      <a:gd name="connsiteX13" fmla="*/ 12353 w 63587"/>
                      <a:gd name="connsiteY13" fmla="*/ 49989 h 99565"/>
                      <a:gd name="connsiteX14" fmla="*/ 17971 w 63587"/>
                      <a:gd name="connsiteY14" fmla="*/ 81950 h 99565"/>
                      <a:gd name="connsiteX15" fmla="*/ 31812 w 63587"/>
                      <a:gd name="connsiteY15" fmla="*/ 89875 h 99565"/>
                      <a:gd name="connsiteX16" fmla="*/ 45690 w 63587"/>
                      <a:gd name="connsiteY16" fmla="*/ 81913 h 99565"/>
                      <a:gd name="connsiteX17" fmla="*/ 51308 w 63587"/>
                      <a:gd name="connsiteY17" fmla="*/ 49989 h 99565"/>
                      <a:gd name="connsiteX18" fmla="*/ 45690 w 63587"/>
                      <a:gd name="connsiteY18" fmla="*/ 17991 h 99565"/>
                      <a:gd name="connsiteX19" fmla="*/ 31700 w 63587"/>
                      <a:gd name="connsiteY19" fmla="*/ 10066 h 99565"/>
                      <a:gd name="connsiteX20" fmla="*/ 18529 w 63587"/>
                      <a:gd name="connsiteY20" fmla="*/ 17061 h 99565"/>
                      <a:gd name="connsiteX21" fmla="*/ 12353 w 63587"/>
                      <a:gd name="connsiteY21" fmla="*/ 49989 h 995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</a:cxnLst>
                    <a:rect l="l" t="t" r="r" b="b"/>
                    <a:pathLst>
                      <a:path w="63587" h="99565">
                        <a:moveTo>
                          <a:pt x="37" y="49989"/>
                        </a:moveTo>
                        <a:cubicBezTo>
                          <a:pt x="0" y="38492"/>
                          <a:pt x="1190" y="29190"/>
                          <a:pt x="3572" y="22158"/>
                        </a:cubicBezTo>
                        <a:cubicBezTo>
                          <a:pt x="5916" y="15126"/>
                          <a:pt x="9450" y="9731"/>
                          <a:pt x="14139" y="5899"/>
                        </a:cubicBezTo>
                        <a:cubicBezTo>
                          <a:pt x="18827" y="2104"/>
                          <a:pt x="24705" y="169"/>
                          <a:pt x="31812" y="169"/>
                        </a:cubicBezTo>
                        <a:cubicBezTo>
                          <a:pt x="37021" y="169"/>
                          <a:pt x="41597" y="1247"/>
                          <a:pt x="45578" y="3331"/>
                        </a:cubicBezTo>
                        <a:cubicBezTo>
                          <a:pt x="49485" y="5489"/>
                          <a:pt x="52759" y="8503"/>
                          <a:pt x="55364" y="12447"/>
                        </a:cubicBezTo>
                        <a:cubicBezTo>
                          <a:pt x="57931" y="16428"/>
                          <a:pt x="59940" y="21265"/>
                          <a:pt x="61429" y="26958"/>
                        </a:cubicBezTo>
                        <a:cubicBezTo>
                          <a:pt x="62843" y="32650"/>
                          <a:pt x="63587" y="40352"/>
                          <a:pt x="63624" y="49989"/>
                        </a:cubicBezTo>
                        <a:cubicBezTo>
                          <a:pt x="63587" y="61449"/>
                          <a:pt x="62396" y="70676"/>
                          <a:pt x="60089" y="77671"/>
                        </a:cubicBezTo>
                        <a:cubicBezTo>
                          <a:pt x="57708" y="84740"/>
                          <a:pt x="54211" y="90173"/>
                          <a:pt x="49522" y="93968"/>
                        </a:cubicBezTo>
                        <a:cubicBezTo>
                          <a:pt x="44834" y="97837"/>
                          <a:pt x="38918" y="99735"/>
                          <a:pt x="31812" y="99735"/>
                        </a:cubicBezTo>
                        <a:cubicBezTo>
                          <a:pt x="22399" y="99735"/>
                          <a:pt x="15032" y="96386"/>
                          <a:pt x="9674" y="89614"/>
                        </a:cubicBezTo>
                        <a:cubicBezTo>
                          <a:pt x="3237" y="81540"/>
                          <a:pt x="0" y="68332"/>
                          <a:pt x="37" y="49989"/>
                        </a:cubicBezTo>
                        <a:close/>
                        <a:moveTo>
                          <a:pt x="12353" y="49989"/>
                        </a:moveTo>
                        <a:cubicBezTo>
                          <a:pt x="12353" y="66025"/>
                          <a:pt x="14213" y="76666"/>
                          <a:pt x="17971" y="81950"/>
                        </a:cubicBezTo>
                        <a:cubicBezTo>
                          <a:pt x="21692" y="87270"/>
                          <a:pt x="26305" y="89912"/>
                          <a:pt x="31812" y="89875"/>
                        </a:cubicBezTo>
                        <a:cubicBezTo>
                          <a:pt x="37281" y="89912"/>
                          <a:pt x="41895" y="87270"/>
                          <a:pt x="45690" y="81913"/>
                        </a:cubicBezTo>
                        <a:cubicBezTo>
                          <a:pt x="49411" y="76629"/>
                          <a:pt x="51308" y="65988"/>
                          <a:pt x="51308" y="49989"/>
                        </a:cubicBezTo>
                        <a:cubicBezTo>
                          <a:pt x="51308" y="33990"/>
                          <a:pt x="49411" y="23311"/>
                          <a:pt x="45690" y="17991"/>
                        </a:cubicBezTo>
                        <a:cubicBezTo>
                          <a:pt x="41895" y="12745"/>
                          <a:pt x="37244" y="10103"/>
                          <a:pt x="31700" y="10066"/>
                        </a:cubicBezTo>
                        <a:cubicBezTo>
                          <a:pt x="26156" y="10103"/>
                          <a:pt x="21766" y="12447"/>
                          <a:pt x="18529" y="17061"/>
                        </a:cubicBezTo>
                        <a:cubicBezTo>
                          <a:pt x="14399" y="23014"/>
                          <a:pt x="12353" y="33990"/>
                          <a:pt x="12353" y="49989"/>
                        </a:cubicBezTo>
                        <a:close/>
                      </a:path>
                    </a:pathLst>
                  </a:custGeom>
                  <a:solidFill>
                    <a:srgbClr val="000000"/>
                  </a:solidFill>
                  <a:ln w="9525" cap="flat">
                    <a:noFill/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en-US"/>
                  </a:p>
                </p:txBody>
              </p:sp>
            </p:grpSp>
            <p:sp>
              <p:nvSpPr>
                <p:cNvPr id="186" name="Freihandform: Form 185">
                  <a:extLst>
                    <a:ext uri="{FF2B5EF4-FFF2-40B4-BE49-F238E27FC236}">
                      <a16:creationId xmlns:a16="http://schemas.microsoft.com/office/drawing/2014/main" id="{09DCC388-0BD7-420C-A42F-F6CCC37CDC76}"/>
                    </a:ext>
                  </a:extLst>
                </p:cNvPr>
                <p:cNvSpPr/>
                <p:nvPr/>
              </p:nvSpPr>
              <p:spPr>
                <a:xfrm>
                  <a:off x="571828" y="5728582"/>
                  <a:ext cx="21176" cy="7733"/>
                </a:xfrm>
                <a:custGeom>
                  <a:avLst/>
                  <a:gdLst>
                    <a:gd name="connsiteX0" fmla="*/ 0 w 26082"/>
                    <a:gd name="connsiteY0" fmla="*/ 0 h 9525"/>
                    <a:gd name="connsiteX1" fmla="*/ 26082 w 26082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26082" h="9525">
                      <a:moveTo>
                        <a:pt x="0" y="0"/>
                      </a:moveTo>
                      <a:lnTo>
                        <a:pt x="26082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7" name="Freihandform: Form 186">
                  <a:extLst>
                    <a:ext uri="{FF2B5EF4-FFF2-40B4-BE49-F238E27FC236}">
                      <a16:creationId xmlns:a16="http://schemas.microsoft.com/office/drawing/2014/main" id="{8578848A-0F2A-4405-A52E-1B9704FF9012}"/>
                    </a:ext>
                  </a:extLst>
                </p:cNvPr>
                <p:cNvSpPr/>
                <p:nvPr/>
              </p:nvSpPr>
              <p:spPr>
                <a:xfrm>
                  <a:off x="571828" y="4580454"/>
                  <a:ext cx="21176" cy="7733"/>
                </a:xfrm>
                <a:custGeom>
                  <a:avLst/>
                  <a:gdLst>
                    <a:gd name="connsiteX0" fmla="*/ 0 w 26082"/>
                    <a:gd name="connsiteY0" fmla="*/ 0 h 9525"/>
                    <a:gd name="connsiteX1" fmla="*/ 26082 w 26082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26082" h="9525">
                      <a:moveTo>
                        <a:pt x="0" y="0"/>
                      </a:moveTo>
                      <a:lnTo>
                        <a:pt x="26082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8" name="Freihandform: Form 187">
                  <a:extLst>
                    <a:ext uri="{FF2B5EF4-FFF2-40B4-BE49-F238E27FC236}">
                      <a16:creationId xmlns:a16="http://schemas.microsoft.com/office/drawing/2014/main" id="{ACA5146F-8854-4D36-9CED-C07D1E1C2EB2}"/>
                    </a:ext>
                  </a:extLst>
                </p:cNvPr>
                <p:cNvSpPr/>
                <p:nvPr/>
              </p:nvSpPr>
              <p:spPr>
                <a:xfrm>
                  <a:off x="571828" y="3432327"/>
                  <a:ext cx="21176" cy="7733"/>
                </a:xfrm>
                <a:custGeom>
                  <a:avLst/>
                  <a:gdLst>
                    <a:gd name="connsiteX0" fmla="*/ 0 w 26082"/>
                    <a:gd name="connsiteY0" fmla="*/ 0 h 9525"/>
                    <a:gd name="connsiteX1" fmla="*/ 26082 w 26082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26082" h="9525">
                      <a:moveTo>
                        <a:pt x="0" y="0"/>
                      </a:moveTo>
                      <a:lnTo>
                        <a:pt x="26082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1" name="Freihandform: Form 190">
                  <a:extLst>
                    <a:ext uri="{FF2B5EF4-FFF2-40B4-BE49-F238E27FC236}">
                      <a16:creationId xmlns:a16="http://schemas.microsoft.com/office/drawing/2014/main" id="{B58D5633-3341-42C2-9A12-2F9FDD33C075}"/>
                    </a:ext>
                  </a:extLst>
                </p:cNvPr>
                <p:cNvSpPr/>
                <p:nvPr/>
              </p:nvSpPr>
              <p:spPr>
                <a:xfrm>
                  <a:off x="571828" y="2284199"/>
                  <a:ext cx="21176" cy="7733"/>
                </a:xfrm>
                <a:custGeom>
                  <a:avLst/>
                  <a:gdLst>
                    <a:gd name="connsiteX0" fmla="*/ 0 w 26082"/>
                    <a:gd name="connsiteY0" fmla="*/ 0 h 9525"/>
                    <a:gd name="connsiteX1" fmla="*/ 26082 w 26082"/>
                    <a:gd name="connsiteY1" fmla="*/ 0 h 9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26082" h="9525">
                      <a:moveTo>
                        <a:pt x="0" y="0"/>
                      </a:moveTo>
                      <a:lnTo>
                        <a:pt x="26082" y="0"/>
                      </a:lnTo>
                    </a:path>
                  </a:pathLst>
                </a:custGeom>
                <a:noFill/>
                <a:ln w="10163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7" name="Textfeld 256">
                  <a:extLst>
                    <a:ext uri="{FF2B5EF4-FFF2-40B4-BE49-F238E27FC236}">
                      <a16:creationId xmlns:a16="http://schemas.microsoft.com/office/drawing/2014/main" id="{08BDE8CE-4B65-438B-982E-E89A56FA156F}"/>
                    </a:ext>
                  </a:extLst>
                </p:cNvPr>
                <p:cNvSpPr txBox="1"/>
                <p:nvPr/>
              </p:nvSpPr>
              <p:spPr>
                <a:xfrm>
                  <a:off x="592973" y="1039620"/>
                  <a:ext cx="6665846" cy="3140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/>
                    <a:t>Unsupervised principal component analysis of non-dissected proteome data </a:t>
                  </a:r>
                </a:p>
              </p:txBody>
            </p:sp>
          </p:grpSp>
        </p:grpSp>
        <p:grpSp>
          <p:nvGrpSpPr>
            <p:cNvPr id="266" name="Gruppieren 265">
              <a:extLst>
                <a:ext uri="{FF2B5EF4-FFF2-40B4-BE49-F238E27FC236}">
                  <a16:creationId xmlns:a16="http://schemas.microsoft.com/office/drawing/2014/main" id="{07AE5A60-215A-4111-9420-84A37EEC5F7E}"/>
                </a:ext>
              </a:extLst>
            </p:cNvPr>
            <p:cNvGrpSpPr/>
            <p:nvPr/>
          </p:nvGrpSpPr>
          <p:grpSpPr>
            <a:xfrm>
              <a:off x="5788912" y="2883732"/>
              <a:ext cx="1370665" cy="1134683"/>
              <a:chOff x="6797829" y="2716946"/>
              <a:chExt cx="1370665" cy="1134683"/>
            </a:xfrm>
          </p:grpSpPr>
          <p:grpSp>
            <p:nvGrpSpPr>
              <p:cNvPr id="261" name="Gruppieren 260">
                <a:extLst>
                  <a:ext uri="{FF2B5EF4-FFF2-40B4-BE49-F238E27FC236}">
                    <a16:creationId xmlns:a16="http://schemas.microsoft.com/office/drawing/2014/main" id="{02DCC22C-FC17-402D-8FA2-6F26D77765FF}"/>
                  </a:ext>
                </a:extLst>
              </p:cNvPr>
              <p:cNvGrpSpPr/>
              <p:nvPr/>
            </p:nvGrpSpPr>
            <p:grpSpPr>
              <a:xfrm>
                <a:off x="6797829" y="2716946"/>
                <a:ext cx="1077211" cy="461665"/>
                <a:chOff x="-1626729" y="2973305"/>
                <a:chExt cx="1161892" cy="497957"/>
              </a:xfrm>
            </p:grpSpPr>
            <p:sp>
              <p:nvSpPr>
                <p:cNvPr id="256" name="Freihandform: Form 255">
                  <a:extLst>
                    <a:ext uri="{FF2B5EF4-FFF2-40B4-BE49-F238E27FC236}">
                      <a16:creationId xmlns:a16="http://schemas.microsoft.com/office/drawing/2014/main" id="{995D8D7B-084E-4E52-9F97-4553C14B82D2}"/>
                    </a:ext>
                  </a:extLst>
                </p:cNvPr>
                <p:cNvSpPr/>
                <p:nvPr/>
              </p:nvSpPr>
              <p:spPr>
                <a:xfrm>
                  <a:off x="-1626729" y="3105931"/>
                  <a:ext cx="232779" cy="232704"/>
                </a:xfrm>
                <a:custGeom>
                  <a:avLst/>
                  <a:gdLst>
                    <a:gd name="connsiteX0" fmla="*/ 115157 w 115156"/>
                    <a:gd name="connsiteY0" fmla="*/ 57560 h 115119"/>
                    <a:gd name="connsiteX1" fmla="*/ 57598 w 115156"/>
                    <a:gd name="connsiteY1" fmla="*/ 115119 h 115119"/>
                    <a:gd name="connsiteX2" fmla="*/ 0 w 115156"/>
                    <a:gd name="connsiteY2" fmla="*/ 57560 h 115119"/>
                    <a:gd name="connsiteX3" fmla="*/ 57598 w 115156"/>
                    <a:gd name="connsiteY3" fmla="*/ 0 h 115119"/>
                    <a:gd name="connsiteX4" fmla="*/ 115157 w 115156"/>
                    <a:gd name="connsiteY4" fmla="*/ 57560 h 11511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5156" h="115119">
                      <a:moveTo>
                        <a:pt x="115157" y="57560"/>
                      </a:moveTo>
                      <a:cubicBezTo>
                        <a:pt x="115157" y="89373"/>
                        <a:pt x="89373" y="115119"/>
                        <a:pt x="57598" y="115119"/>
                      </a:cubicBezTo>
                      <a:cubicBezTo>
                        <a:pt x="25784" y="115119"/>
                        <a:pt x="0" y="89373"/>
                        <a:pt x="0" y="57560"/>
                      </a:cubicBezTo>
                      <a:cubicBezTo>
                        <a:pt x="0" y="25784"/>
                        <a:pt x="25784" y="0"/>
                        <a:pt x="57598" y="0"/>
                      </a:cubicBezTo>
                      <a:cubicBezTo>
                        <a:pt x="89373" y="0"/>
                        <a:pt x="115157" y="25784"/>
                        <a:pt x="115157" y="57560"/>
                      </a:cubicBezTo>
                    </a:path>
                  </a:pathLst>
                </a:custGeom>
                <a:solidFill>
                  <a:schemeClr val="accent1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9" name="Textfeld 258">
                  <a:extLst>
                    <a:ext uri="{FF2B5EF4-FFF2-40B4-BE49-F238E27FC236}">
                      <a16:creationId xmlns:a16="http://schemas.microsoft.com/office/drawing/2014/main" id="{536D13A5-D7AD-4C2E-947B-F5F3A09CF9AE}"/>
                    </a:ext>
                  </a:extLst>
                </p:cNvPr>
                <p:cNvSpPr txBox="1"/>
                <p:nvPr/>
              </p:nvSpPr>
              <p:spPr>
                <a:xfrm>
                  <a:off x="-1393950" y="2973305"/>
                  <a:ext cx="929113" cy="4979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Primary CRC</a:t>
                  </a:r>
                </a:p>
              </p:txBody>
            </p:sp>
          </p:grpSp>
          <p:grpSp>
            <p:nvGrpSpPr>
              <p:cNvPr id="262" name="Gruppieren 261">
                <a:extLst>
                  <a:ext uri="{FF2B5EF4-FFF2-40B4-BE49-F238E27FC236}">
                    <a16:creationId xmlns:a16="http://schemas.microsoft.com/office/drawing/2014/main" id="{2C0B3C03-ABDD-400A-8D69-55C0248B1D9E}"/>
                  </a:ext>
                </a:extLst>
              </p:cNvPr>
              <p:cNvGrpSpPr/>
              <p:nvPr/>
            </p:nvGrpSpPr>
            <p:grpSpPr>
              <a:xfrm>
                <a:off x="6797829" y="3389964"/>
                <a:ext cx="1370665" cy="461665"/>
                <a:chOff x="-1644709" y="3699229"/>
                <a:chExt cx="1478415" cy="497957"/>
              </a:xfrm>
            </p:grpSpPr>
            <p:sp>
              <p:nvSpPr>
                <p:cNvPr id="258" name="Freihandform: Form 257">
                  <a:extLst>
                    <a:ext uri="{FF2B5EF4-FFF2-40B4-BE49-F238E27FC236}">
                      <a16:creationId xmlns:a16="http://schemas.microsoft.com/office/drawing/2014/main" id="{E99DF50B-2C03-43C5-9A85-60B4D556ACC4}"/>
                    </a:ext>
                  </a:extLst>
                </p:cNvPr>
                <p:cNvSpPr/>
                <p:nvPr/>
              </p:nvSpPr>
              <p:spPr>
                <a:xfrm>
                  <a:off x="-1644709" y="3831855"/>
                  <a:ext cx="268737" cy="232704"/>
                </a:xfrm>
                <a:custGeom>
                  <a:avLst/>
                  <a:gdLst>
                    <a:gd name="connsiteX0" fmla="*/ 77544 w 155076"/>
                    <a:gd name="connsiteY0" fmla="*/ 0 h 134283"/>
                    <a:gd name="connsiteX1" fmla="*/ 155077 w 155076"/>
                    <a:gd name="connsiteY1" fmla="*/ 134283 h 134283"/>
                    <a:gd name="connsiteX2" fmla="*/ 0 w 155076"/>
                    <a:gd name="connsiteY2" fmla="*/ 134283 h 1342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55076" h="134283">
                      <a:moveTo>
                        <a:pt x="77544" y="0"/>
                      </a:moveTo>
                      <a:lnTo>
                        <a:pt x="155077" y="134283"/>
                      </a:lnTo>
                      <a:lnTo>
                        <a:pt x="0" y="134283"/>
                      </a:lnTo>
                      <a:close/>
                    </a:path>
                  </a:pathLst>
                </a:custGeom>
                <a:solidFill>
                  <a:schemeClr val="accent4">
                    <a:lumMod val="60000"/>
                    <a:lumOff val="40000"/>
                  </a:schemeClr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0" name="Textfeld 259">
                  <a:extLst>
                    <a:ext uri="{FF2B5EF4-FFF2-40B4-BE49-F238E27FC236}">
                      <a16:creationId xmlns:a16="http://schemas.microsoft.com/office/drawing/2014/main" id="{624D6A7A-8A5C-4B4B-A63C-541197D4B5D8}"/>
                    </a:ext>
                  </a:extLst>
                </p:cNvPr>
                <p:cNvSpPr txBox="1"/>
                <p:nvPr/>
              </p:nvSpPr>
              <p:spPr>
                <a:xfrm>
                  <a:off x="-1375972" y="3699229"/>
                  <a:ext cx="1209678" cy="4979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Liver metastasis</a:t>
                  </a:r>
                </a:p>
              </p:txBody>
            </p:sp>
          </p:grpSp>
        </p:grpSp>
        <p:sp>
          <p:nvSpPr>
            <p:cNvPr id="271" name="Textfeld 270">
              <a:extLst>
                <a:ext uri="{FF2B5EF4-FFF2-40B4-BE49-F238E27FC236}">
                  <a16:creationId xmlns:a16="http://schemas.microsoft.com/office/drawing/2014/main" id="{10EC7F46-396B-4314-99B7-DD0D956C2BD0}"/>
                </a:ext>
              </a:extLst>
            </p:cNvPr>
            <p:cNvSpPr txBox="1"/>
            <p:nvPr/>
          </p:nvSpPr>
          <p:spPr>
            <a:xfrm>
              <a:off x="6730552" y="583860"/>
              <a:ext cx="326392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200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27875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Office PowerPoint</Application>
  <PresentationFormat>Breitbild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Fahrner</dc:creator>
  <cp:lastModifiedBy>Matthias Fahrner</cp:lastModifiedBy>
  <cp:revision>7</cp:revision>
  <dcterms:created xsi:type="dcterms:W3CDTF">2021-07-28T17:16:09Z</dcterms:created>
  <dcterms:modified xsi:type="dcterms:W3CDTF">2021-08-11T12:31:19Z</dcterms:modified>
</cp:coreProperties>
</file>